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" ContentType="image/tiff"/>
  <Default Extension="jpg" ContentType="image/jp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  <p:sldId id="258" r:id="rId4"/>
  </p:sldIdLst>
  <p:sldSz cx="12192000" cy="16262350"/>
  <p:notesSz cx="12192000" cy="16262350"/>
  <p:defaultTextStyle>
    <a:defPPr>
      <a:defRPr kern="0"/>
    </a:def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37" d="100"/>
          <a:sy n="37" d="100"/>
        </p:scale>
        <p:origin x="2218" y="5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914400" y="5041328"/>
            <a:ext cx="10363200" cy="341509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828800" y="9106916"/>
            <a:ext cx="8534400" cy="406558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10/20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10/20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609600" y="3740340"/>
            <a:ext cx="5303520" cy="1073315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6278880" y="3740340"/>
            <a:ext cx="5303520" cy="1073315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10/2023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10/2023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10/2023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609600" y="650494"/>
            <a:ext cx="10972800" cy="260197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609600" y="3740340"/>
            <a:ext cx="10972800" cy="1073315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4145280" y="15123986"/>
            <a:ext cx="3901440" cy="81311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609600" y="15123986"/>
            <a:ext cx="2804160" cy="81311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2/10/20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8778240" y="15123986"/>
            <a:ext cx="2804160" cy="81311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7" Type="http://schemas.openxmlformats.org/officeDocument/2006/relationships/image" Target="../media/image11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10.jpg"/><Relationship Id="rId5" Type="http://schemas.openxmlformats.org/officeDocument/2006/relationships/image" Target="../media/image9.jpg"/><Relationship Id="rId4" Type="http://schemas.openxmlformats.org/officeDocument/2006/relationships/image" Target="../media/image8.jp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991616" y="3796411"/>
            <a:ext cx="3284220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dirty="0">
                <a:latin typeface="Arial"/>
                <a:cs typeface="Arial"/>
              </a:rPr>
              <a:t>a)</a:t>
            </a:r>
            <a:r>
              <a:rPr sz="1200" b="1" spc="-20" dirty="0">
                <a:latin typeface="Arial"/>
                <a:cs typeface="Arial"/>
              </a:rPr>
              <a:t> </a:t>
            </a:r>
            <a:r>
              <a:rPr sz="1200" b="1" spc="-10" dirty="0">
                <a:latin typeface="Arial"/>
                <a:cs typeface="Arial"/>
              </a:rPr>
              <a:t>Temporal</a:t>
            </a:r>
            <a:r>
              <a:rPr sz="1200" b="1" spc="-40" dirty="0">
                <a:latin typeface="Arial"/>
                <a:cs typeface="Arial"/>
              </a:rPr>
              <a:t> </a:t>
            </a:r>
            <a:r>
              <a:rPr sz="1200" b="1" dirty="0">
                <a:latin typeface="Arial"/>
                <a:cs typeface="Arial"/>
              </a:rPr>
              <a:t>CHIA</a:t>
            </a:r>
            <a:r>
              <a:rPr sz="1200" b="1" spc="-50" dirty="0">
                <a:latin typeface="Arial"/>
                <a:cs typeface="Arial"/>
              </a:rPr>
              <a:t> </a:t>
            </a:r>
            <a:r>
              <a:rPr sz="1200" b="1" dirty="0">
                <a:latin typeface="Arial"/>
                <a:cs typeface="Arial"/>
              </a:rPr>
              <a:t>and</a:t>
            </a:r>
            <a:r>
              <a:rPr sz="1200" b="1" spc="-15" dirty="0">
                <a:latin typeface="Arial"/>
                <a:cs typeface="Arial"/>
              </a:rPr>
              <a:t> </a:t>
            </a:r>
            <a:r>
              <a:rPr sz="1200" b="1" spc="-20" dirty="0">
                <a:latin typeface="Arial"/>
                <a:cs typeface="Arial"/>
              </a:rPr>
              <a:t>proV-CATH</a:t>
            </a:r>
            <a:r>
              <a:rPr sz="1200" b="1" spc="5" dirty="0">
                <a:latin typeface="Arial"/>
                <a:cs typeface="Arial"/>
              </a:rPr>
              <a:t> </a:t>
            </a:r>
            <a:r>
              <a:rPr sz="1200" b="1" spc="-10" dirty="0">
                <a:latin typeface="Arial"/>
                <a:cs typeface="Arial"/>
              </a:rPr>
              <a:t>production</a:t>
            </a:r>
            <a:endParaRPr sz="1200">
              <a:latin typeface="Arial"/>
              <a:cs typeface="Arial"/>
            </a:endParaRPr>
          </a:p>
        </p:txBody>
      </p:sp>
      <p:pic>
        <p:nvPicPr>
          <p:cNvPr id="3" name="object 3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7993253" y="5054854"/>
            <a:ext cx="2359279" cy="2703055"/>
          </a:xfrm>
          <a:prstGeom prst="rect">
            <a:avLst/>
          </a:prstGeom>
        </p:spPr>
      </p:pic>
      <p:sp>
        <p:nvSpPr>
          <p:cNvPr id="4" name="object 4"/>
          <p:cNvSpPr txBox="1"/>
          <p:nvPr/>
        </p:nvSpPr>
        <p:spPr>
          <a:xfrm>
            <a:off x="8765540" y="4546219"/>
            <a:ext cx="767715" cy="17780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1000" b="1" spc="-20" dirty="0">
                <a:latin typeface="Arial"/>
                <a:cs typeface="Arial"/>
              </a:rPr>
              <a:t>Anti-</a:t>
            </a:r>
            <a:r>
              <a:rPr sz="1000" b="1" spc="-10" dirty="0">
                <a:latin typeface="Arial"/>
                <a:cs typeface="Arial"/>
              </a:rPr>
              <a:t>GAPDH</a:t>
            </a:r>
            <a:endParaRPr sz="1000">
              <a:latin typeface="Arial"/>
              <a:cs typeface="Arial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8198611" y="5255077"/>
            <a:ext cx="842010" cy="441325"/>
          </a:xfrm>
          <a:prstGeom prst="rect">
            <a:avLst/>
          </a:prstGeom>
        </p:spPr>
        <p:txBody>
          <a:bodyPr vert="horz" wrap="square" lIns="0" tIns="90170" rIns="0" bIns="0" rtlCol="0">
            <a:spAutoFit/>
          </a:bodyPr>
          <a:lstStyle/>
          <a:p>
            <a:pPr marL="36830">
              <a:lnSpc>
                <a:spcPct val="100000"/>
              </a:lnSpc>
              <a:spcBef>
                <a:spcPts val="710"/>
              </a:spcBef>
            </a:pPr>
            <a:r>
              <a:rPr sz="1000" spc="-10" dirty="0">
                <a:latin typeface="Arial"/>
                <a:cs typeface="Arial"/>
              </a:rPr>
              <a:t>AcMNPV-</a:t>
            </a:r>
            <a:r>
              <a:rPr sz="1000" spc="-25" dirty="0">
                <a:latin typeface="Arial"/>
                <a:cs typeface="Arial"/>
              </a:rPr>
              <a:t>Rep</a:t>
            </a:r>
            <a:endParaRPr sz="100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500"/>
              </a:spcBef>
            </a:pPr>
            <a:r>
              <a:rPr sz="800" dirty="0">
                <a:latin typeface="Arial Narrow"/>
                <a:cs typeface="Arial Narrow"/>
              </a:rPr>
              <a:t>8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16</a:t>
            </a:r>
            <a:r>
              <a:rPr sz="800" spc="35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24</a:t>
            </a:r>
            <a:r>
              <a:rPr sz="800" spc="17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32</a:t>
            </a:r>
            <a:r>
              <a:rPr sz="800" spc="1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40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spc="-25" dirty="0">
                <a:latin typeface="Arial Narrow"/>
                <a:cs typeface="Arial Narrow"/>
              </a:rPr>
              <a:t>48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9227248" y="5255077"/>
            <a:ext cx="934085" cy="441325"/>
          </a:xfrm>
          <a:prstGeom prst="rect">
            <a:avLst/>
          </a:prstGeom>
        </p:spPr>
        <p:txBody>
          <a:bodyPr vert="horz" wrap="square" lIns="0" tIns="90170" rIns="0" bIns="0" rtlCol="0">
            <a:spAutoFit/>
          </a:bodyPr>
          <a:lstStyle/>
          <a:p>
            <a:pPr marL="111760">
              <a:lnSpc>
                <a:spcPct val="100000"/>
              </a:lnSpc>
              <a:spcBef>
                <a:spcPts val="710"/>
              </a:spcBef>
            </a:pPr>
            <a:r>
              <a:rPr sz="1000" spc="-10" dirty="0">
                <a:latin typeface="Arial"/>
                <a:cs typeface="Arial"/>
              </a:rPr>
              <a:t>Acp6.9-</a:t>
            </a:r>
            <a:r>
              <a:rPr sz="1000" spc="-20" dirty="0">
                <a:latin typeface="Arial"/>
                <a:cs typeface="Arial"/>
              </a:rPr>
              <a:t>chiA</a:t>
            </a:r>
            <a:endParaRPr sz="100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500"/>
              </a:spcBef>
            </a:pPr>
            <a:r>
              <a:rPr sz="800" dirty="0">
                <a:latin typeface="Arial Narrow"/>
                <a:cs typeface="Arial Narrow"/>
              </a:rPr>
              <a:t>8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16</a:t>
            </a:r>
            <a:r>
              <a:rPr sz="800" spc="1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24</a:t>
            </a:r>
            <a:r>
              <a:rPr sz="800" spc="17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32</a:t>
            </a:r>
            <a:r>
              <a:rPr sz="800" spc="17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40</a:t>
            </a:r>
            <a:r>
              <a:rPr sz="800" spc="1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48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spc="-50" dirty="0">
                <a:latin typeface="Arial Narrow"/>
                <a:cs typeface="Arial Narrow"/>
              </a:rPr>
              <a:t>M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8171433" y="6116596"/>
            <a:ext cx="846455" cy="443865"/>
          </a:xfrm>
          <a:prstGeom prst="rect">
            <a:avLst/>
          </a:prstGeom>
        </p:spPr>
        <p:txBody>
          <a:bodyPr vert="horz" wrap="square" lIns="0" tIns="914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720"/>
              </a:spcBef>
            </a:pPr>
            <a:r>
              <a:rPr sz="1000" spc="-10" dirty="0">
                <a:latin typeface="Arial"/>
                <a:cs typeface="Arial"/>
              </a:rPr>
              <a:t>AcMNPV-</a:t>
            </a:r>
            <a:r>
              <a:rPr sz="1000" spc="-25" dirty="0">
                <a:latin typeface="Arial"/>
                <a:cs typeface="Arial"/>
              </a:rPr>
              <a:t>Rep</a:t>
            </a:r>
            <a:endParaRPr sz="1000">
              <a:latin typeface="Arial"/>
              <a:cs typeface="Arial"/>
            </a:endParaRPr>
          </a:p>
          <a:p>
            <a:pPr marL="16510">
              <a:lnSpc>
                <a:spcPct val="100000"/>
              </a:lnSpc>
              <a:spcBef>
                <a:spcPts val="509"/>
              </a:spcBef>
            </a:pPr>
            <a:r>
              <a:rPr sz="800" dirty="0">
                <a:latin typeface="Arial Narrow"/>
                <a:cs typeface="Arial Narrow"/>
              </a:rPr>
              <a:t>8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16</a:t>
            </a:r>
            <a:r>
              <a:rPr sz="800" spc="35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24</a:t>
            </a:r>
            <a:r>
              <a:rPr sz="800" spc="17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32</a:t>
            </a:r>
            <a:r>
              <a:rPr sz="800" spc="1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40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spc="-25" dirty="0">
                <a:latin typeface="Arial Narrow"/>
                <a:cs typeface="Arial Narrow"/>
              </a:rPr>
              <a:t>48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9129521" y="6160952"/>
            <a:ext cx="1262380" cy="400050"/>
          </a:xfrm>
          <a:prstGeom prst="rect">
            <a:avLst/>
          </a:prstGeom>
        </p:spPr>
        <p:txBody>
          <a:bodyPr vert="horz" wrap="square" lIns="0" tIns="6731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30"/>
              </a:spcBef>
            </a:pPr>
            <a:r>
              <a:rPr sz="1000" spc="-10" dirty="0">
                <a:latin typeface="Arial"/>
                <a:cs typeface="Arial"/>
              </a:rPr>
              <a:t>Acp6.9-chiA/polh-</a:t>
            </a:r>
            <a:r>
              <a:rPr sz="1000" spc="-20" dirty="0">
                <a:latin typeface="Arial"/>
                <a:cs typeface="Arial"/>
              </a:rPr>
              <a:t>cath</a:t>
            </a:r>
            <a:endParaRPr sz="1000">
              <a:latin typeface="Arial"/>
              <a:cs typeface="Arial"/>
            </a:endParaRPr>
          </a:p>
          <a:p>
            <a:pPr marL="86995">
              <a:lnSpc>
                <a:spcPct val="100000"/>
              </a:lnSpc>
              <a:spcBef>
                <a:spcPts val="355"/>
              </a:spcBef>
            </a:pPr>
            <a:r>
              <a:rPr sz="800" dirty="0">
                <a:latin typeface="Arial Narrow"/>
                <a:cs typeface="Arial Narrow"/>
              </a:rPr>
              <a:t>8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16</a:t>
            </a:r>
            <a:r>
              <a:rPr sz="800" spc="1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24</a:t>
            </a:r>
            <a:r>
              <a:rPr sz="800" spc="17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32</a:t>
            </a:r>
            <a:r>
              <a:rPr sz="800" spc="17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40</a:t>
            </a:r>
            <a:r>
              <a:rPr sz="800" spc="1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48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spc="-50" dirty="0">
                <a:latin typeface="Arial Narrow"/>
                <a:cs typeface="Arial Narrow"/>
              </a:rPr>
              <a:t>G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9" name="object 9"/>
          <p:cNvSpPr/>
          <p:nvPr/>
        </p:nvSpPr>
        <p:spPr>
          <a:xfrm>
            <a:off x="7903464" y="6150864"/>
            <a:ext cx="1160145" cy="1150620"/>
          </a:xfrm>
          <a:custGeom>
            <a:avLst/>
            <a:gdLst/>
            <a:ahLst/>
            <a:cxnLst/>
            <a:rect l="l" t="t" r="r" b="b"/>
            <a:pathLst>
              <a:path w="1160145" h="1150620">
                <a:moveTo>
                  <a:pt x="0" y="1150620"/>
                </a:moveTo>
                <a:lnTo>
                  <a:pt x="1159764" y="1150620"/>
                </a:lnTo>
                <a:lnTo>
                  <a:pt x="1159764" y="0"/>
                </a:lnTo>
                <a:lnTo>
                  <a:pt x="0" y="0"/>
                </a:lnTo>
                <a:lnTo>
                  <a:pt x="0" y="1150620"/>
                </a:lnTo>
                <a:close/>
              </a:path>
            </a:pathLst>
          </a:custGeom>
          <a:ln w="12192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pic>
        <p:nvPicPr>
          <p:cNvPr id="10" name="object 10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4835921" y="5077714"/>
            <a:ext cx="2776954" cy="2749322"/>
          </a:xfrm>
          <a:prstGeom prst="rect">
            <a:avLst/>
          </a:prstGeom>
        </p:spPr>
      </p:pic>
      <p:sp>
        <p:nvSpPr>
          <p:cNvPr id="11" name="object 11"/>
          <p:cNvSpPr txBox="1"/>
          <p:nvPr/>
        </p:nvSpPr>
        <p:spPr>
          <a:xfrm>
            <a:off x="5196585" y="4815149"/>
            <a:ext cx="938530" cy="441325"/>
          </a:xfrm>
          <a:prstGeom prst="rect">
            <a:avLst/>
          </a:prstGeom>
        </p:spPr>
        <p:txBody>
          <a:bodyPr vert="horz" wrap="square" lIns="0" tIns="901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710"/>
              </a:spcBef>
            </a:pPr>
            <a:r>
              <a:rPr sz="1000" spc="-10" dirty="0">
                <a:latin typeface="Arial"/>
                <a:cs typeface="Arial"/>
              </a:rPr>
              <a:t>AcMNPV-</a:t>
            </a:r>
            <a:r>
              <a:rPr sz="1000" spc="-25" dirty="0">
                <a:latin typeface="Arial"/>
                <a:cs typeface="Arial"/>
              </a:rPr>
              <a:t>Rep</a:t>
            </a:r>
            <a:endParaRPr sz="1000">
              <a:latin typeface="Arial"/>
              <a:cs typeface="Arial"/>
            </a:endParaRPr>
          </a:p>
          <a:p>
            <a:pPr marL="108585">
              <a:lnSpc>
                <a:spcPct val="100000"/>
              </a:lnSpc>
              <a:spcBef>
                <a:spcPts val="500"/>
              </a:spcBef>
            </a:pPr>
            <a:r>
              <a:rPr sz="800" dirty="0">
                <a:latin typeface="Arial Narrow"/>
                <a:cs typeface="Arial Narrow"/>
              </a:rPr>
              <a:t>8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16</a:t>
            </a:r>
            <a:r>
              <a:rPr sz="800" spc="35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24</a:t>
            </a:r>
            <a:r>
              <a:rPr sz="800" spc="17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32</a:t>
            </a:r>
            <a:r>
              <a:rPr sz="800" spc="1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40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spc="-25" dirty="0">
                <a:latin typeface="Arial Narrow"/>
                <a:cs typeface="Arial Narrow"/>
              </a:rPr>
              <a:t>48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12" name="object 12"/>
          <p:cNvSpPr txBox="1"/>
          <p:nvPr/>
        </p:nvSpPr>
        <p:spPr>
          <a:xfrm>
            <a:off x="6321614" y="4815149"/>
            <a:ext cx="934085" cy="441325"/>
          </a:xfrm>
          <a:prstGeom prst="rect">
            <a:avLst/>
          </a:prstGeom>
        </p:spPr>
        <p:txBody>
          <a:bodyPr vert="horz" wrap="square" lIns="0" tIns="90170" rIns="0" bIns="0" rtlCol="0">
            <a:spAutoFit/>
          </a:bodyPr>
          <a:lstStyle/>
          <a:p>
            <a:pPr marL="111760">
              <a:lnSpc>
                <a:spcPct val="100000"/>
              </a:lnSpc>
              <a:spcBef>
                <a:spcPts val="710"/>
              </a:spcBef>
            </a:pPr>
            <a:r>
              <a:rPr sz="1000" spc="-10" dirty="0">
                <a:latin typeface="Arial"/>
                <a:cs typeface="Arial"/>
              </a:rPr>
              <a:t>Acp6.9-</a:t>
            </a:r>
            <a:r>
              <a:rPr sz="1000" spc="-20" dirty="0">
                <a:latin typeface="Arial"/>
                <a:cs typeface="Arial"/>
              </a:rPr>
              <a:t>chiA</a:t>
            </a:r>
            <a:endParaRPr sz="100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500"/>
              </a:spcBef>
            </a:pPr>
            <a:r>
              <a:rPr sz="800" dirty="0">
                <a:latin typeface="Arial Narrow"/>
                <a:cs typeface="Arial Narrow"/>
              </a:rPr>
              <a:t>8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16</a:t>
            </a:r>
            <a:r>
              <a:rPr sz="800" spc="1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24</a:t>
            </a:r>
            <a:r>
              <a:rPr sz="800" spc="17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32</a:t>
            </a:r>
            <a:r>
              <a:rPr sz="800" spc="17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40</a:t>
            </a:r>
            <a:r>
              <a:rPr sz="800" spc="1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48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spc="-50" dirty="0">
                <a:latin typeface="Arial Narrow"/>
                <a:cs typeface="Arial Narrow"/>
              </a:rPr>
              <a:t>M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13" name="object 13"/>
          <p:cNvSpPr txBox="1"/>
          <p:nvPr/>
        </p:nvSpPr>
        <p:spPr>
          <a:xfrm>
            <a:off x="5287136" y="5970291"/>
            <a:ext cx="866775" cy="443865"/>
          </a:xfrm>
          <a:prstGeom prst="rect">
            <a:avLst/>
          </a:prstGeom>
        </p:spPr>
        <p:txBody>
          <a:bodyPr vert="horz" wrap="square" lIns="0" tIns="914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720"/>
              </a:spcBef>
            </a:pPr>
            <a:r>
              <a:rPr sz="1000" spc="-10" dirty="0">
                <a:latin typeface="Arial"/>
                <a:cs typeface="Arial"/>
              </a:rPr>
              <a:t>AcMNPV-</a:t>
            </a:r>
            <a:r>
              <a:rPr sz="1000" spc="-25" dirty="0">
                <a:latin typeface="Arial"/>
                <a:cs typeface="Arial"/>
              </a:rPr>
              <a:t>Rep</a:t>
            </a:r>
            <a:endParaRPr sz="1000">
              <a:latin typeface="Arial"/>
              <a:cs typeface="Arial"/>
            </a:endParaRPr>
          </a:p>
          <a:p>
            <a:pPr marL="36830">
              <a:lnSpc>
                <a:spcPct val="100000"/>
              </a:lnSpc>
              <a:spcBef>
                <a:spcPts val="509"/>
              </a:spcBef>
            </a:pPr>
            <a:r>
              <a:rPr sz="800" dirty="0">
                <a:latin typeface="Arial Narrow"/>
                <a:cs typeface="Arial Narrow"/>
              </a:rPr>
              <a:t>8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16</a:t>
            </a:r>
            <a:r>
              <a:rPr sz="800" spc="35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24</a:t>
            </a:r>
            <a:r>
              <a:rPr sz="800" spc="17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32</a:t>
            </a:r>
            <a:r>
              <a:rPr sz="800" spc="1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40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spc="-25" dirty="0">
                <a:latin typeface="Arial Narrow"/>
                <a:cs typeface="Arial Narrow"/>
              </a:rPr>
              <a:t>48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14" name="object 14"/>
          <p:cNvSpPr txBox="1"/>
          <p:nvPr/>
        </p:nvSpPr>
        <p:spPr>
          <a:xfrm>
            <a:off x="6265926" y="6014646"/>
            <a:ext cx="1262380" cy="400050"/>
          </a:xfrm>
          <a:prstGeom prst="rect">
            <a:avLst/>
          </a:prstGeom>
        </p:spPr>
        <p:txBody>
          <a:bodyPr vert="horz" wrap="square" lIns="0" tIns="6731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30"/>
              </a:spcBef>
            </a:pPr>
            <a:r>
              <a:rPr sz="1000" spc="-10" dirty="0">
                <a:latin typeface="Arial"/>
                <a:cs typeface="Arial"/>
              </a:rPr>
              <a:t>Acp6.9-chiA/polh-</a:t>
            </a:r>
            <a:r>
              <a:rPr sz="1000" spc="-20" dirty="0">
                <a:latin typeface="Arial"/>
                <a:cs typeface="Arial"/>
              </a:rPr>
              <a:t>cath</a:t>
            </a:r>
            <a:endParaRPr sz="1000">
              <a:latin typeface="Arial"/>
              <a:cs typeface="Arial"/>
            </a:endParaRPr>
          </a:p>
          <a:p>
            <a:pPr marL="86360">
              <a:lnSpc>
                <a:spcPct val="100000"/>
              </a:lnSpc>
              <a:spcBef>
                <a:spcPts val="355"/>
              </a:spcBef>
            </a:pPr>
            <a:r>
              <a:rPr sz="800" dirty="0">
                <a:latin typeface="Arial Narrow"/>
                <a:cs typeface="Arial Narrow"/>
              </a:rPr>
              <a:t>8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16</a:t>
            </a:r>
            <a:r>
              <a:rPr sz="800" spc="1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24</a:t>
            </a:r>
            <a:r>
              <a:rPr sz="800" spc="17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32</a:t>
            </a:r>
            <a:r>
              <a:rPr sz="800" spc="17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40</a:t>
            </a:r>
            <a:r>
              <a:rPr sz="800" spc="1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48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spc="-50" dirty="0">
                <a:latin typeface="Arial Narrow"/>
                <a:cs typeface="Arial Narrow"/>
              </a:rPr>
              <a:t>G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15" name="object 15"/>
          <p:cNvSpPr txBox="1"/>
          <p:nvPr/>
        </p:nvSpPr>
        <p:spPr>
          <a:xfrm>
            <a:off x="5846445" y="4538853"/>
            <a:ext cx="790575" cy="17780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1000" b="1" spc="-20" dirty="0">
                <a:latin typeface="Arial"/>
                <a:cs typeface="Arial"/>
              </a:rPr>
              <a:t>Anti-</a:t>
            </a:r>
            <a:r>
              <a:rPr sz="1000" b="1" spc="-10" dirty="0">
                <a:latin typeface="Arial"/>
                <a:cs typeface="Arial"/>
              </a:rPr>
              <a:t>V-</a:t>
            </a:r>
            <a:r>
              <a:rPr sz="1000" b="1" spc="-20" dirty="0">
                <a:latin typeface="Arial"/>
                <a:cs typeface="Arial"/>
              </a:rPr>
              <a:t>CATH</a:t>
            </a:r>
            <a:endParaRPr sz="1000">
              <a:latin typeface="Arial"/>
              <a:cs typeface="Arial"/>
            </a:endParaRPr>
          </a:p>
        </p:txBody>
      </p:sp>
      <p:grpSp>
        <p:nvGrpSpPr>
          <p:cNvPr id="16" name="object 16"/>
          <p:cNvGrpSpPr/>
          <p:nvPr/>
        </p:nvGrpSpPr>
        <p:grpSpPr>
          <a:xfrm>
            <a:off x="1338072" y="5017008"/>
            <a:ext cx="6337300" cy="2962910"/>
            <a:chOff x="1338072" y="5017008"/>
            <a:chExt cx="6337300" cy="2962910"/>
          </a:xfrm>
        </p:grpSpPr>
        <p:sp>
          <p:nvSpPr>
            <p:cNvPr id="17" name="object 17"/>
            <p:cNvSpPr/>
            <p:nvPr/>
          </p:nvSpPr>
          <p:spPr>
            <a:xfrm>
              <a:off x="4622292" y="5843016"/>
              <a:ext cx="470534" cy="1242060"/>
            </a:xfrm>
            <a:custGeom>
              <a:avLst/>
              <a:gdLst/>
              <a:ahLst/>
              <a:cxnLst/>
              <a:rect l="l" t="t" r="r" b="b"/>
              <a:pathLst>
                <a:path w="470535" h="1242059">
                  <a:moveTo>
                    <a:pt x="438150" y="1203960"/>
                  </a:moveTo>
                  <a:lnTo>
                    <a:pt x="425450" y="1197610"/>
                  </a:lnTo>
                  <a:lnTo>
                    <a:pt x="361950" y="1165860"/>
                  </a:lnTo>
                  <a:lnTo>
                    <a:pt x="361950" y="1197610"/>
                  </a:lnTo>
                  <a:lnTo>
                    <a:pt x="0" y="1197610"/>
                  </a:lnTo>
                  <a:lnTo>
                    <a:pt x="0" y="1210310"/>
                  </a:lnTo>
                  <a:lnTo>
                    <a:pt x="361950" y="1210310"/>
                  </a:lnTo>
                  <a:lnTo>
                    <a:pt x="361950" y="1242060"/>
                  </a:lnTo>
                  <a:lnTo>
                    <a:pt x="425450" y="1210310"/>
                  </a:lnTo>
                  <a:lnTo>
                    <a:pt x="438150" y="1203960"/>
                  </a:lnTo>
                  <a:close/>
                </a:path>
                <a:path w="470535" h="1242059">
                  <a:moveTo>
                    <a:pt x="470154" y="38100"/>
                  </a:moveTo>
                  <a:lnTo>
                    <a:pt x="457454" y="31750"/>
                  </a:lnTo>
                  <a:lnTo>
                    <a:pt x="393954" y="0"/>
                  </a:lnTo>
                  <a:lnTo>
                    <a:pt x="393954" y="31750"/>
                  </a:lnTo>
                  <a:lnTo>
                    <a:pt x="32004" y="31750"/>
                  </a:lnTo>
                  <a:lnTo>
                    <a:pt x="32004" y="44450"/>
                  </a:lnTo>
                  <a:lnTo>
                    <a:pt x="393954" y="44450"/>
                  </a:lnTo>
                  <a:lnTo>
                    <a:pt x="393954" y="76200"/>
                  </a:lnTo>
                  <a:lnTo>
                    <a:pt x="457454" y="44450"/>
                  </a:lnTo>
                  <a:lnTo>
                    <a:pt x="470154" y="38100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" name="object 18"/>
            <p:cNvSpPr/>
            <p:nvPr/>
          </p:nvSpPr>
          <p:spPr>
            <a:xfrm>
              <a:off x="3965448" y="6039612"/>
              <a:ext cx="2209800" cy="1934210"/>
            </a:xfrm>
            <a:custGeom>
              <a:avLst/>
              <a:gdLst/>
              <a:ahLst/>
              <a:cxnLst/>
              <a:rect l="l" t="t" r="r" b="b"/>
              <a:pathLst>
                <a:path w="2209800" h="1934209">
                  <a:moveTo>
                    <a:pt x="0" y="1933955"/>
                  </a:moveTo>
                  <a:lnTo>
                    <a:pt x="2209800" y="1933955"/>
                  </a:lnTo>
                  <a:lnTo>
                    <a:pt x="2209800" y="0"/>
                  </a:lnTo>
                  <a:lnTo>
                    <a:pt x="0" y="0"/>
                  </a:lnTo>
                  <a:lnTo>
                    <a:pt x="0" y="1933955"/>
                  </a:lnTo>
                  <a:close/>
                </a:path>
              </a:pathLst>
            </a:custGeom>
            <a:ln w="12192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" name="object 19"/>
            <p:cNvSpPr/>
            <p:nvPr/>
          </p:nvSpPr>
          <p:spPr>
            <a:xfrm>
              <a:off x="7439025" y="5516372"/>
              <a:ext cx="236220" cy="1314450"/>
            </a:xfrm>
            <a:custGeom>
              <a:avLst/>
              <a:gdLst/>
              <a:ahLst/>
              <a:cxnLst/>
              <a:rect l="l" t="t" r="r" b="b"/>
              <a:pathLst>
                <a:path w="236220" h="1314450">
                  <a:moveTo>
                    <a:pt x="187833" y="1314323"/>
                  </a:moveTo>
                  <a:lnTo>
                    <a:pt x="181991" y="1222629"/>
                  </a:lnTo>
                  <a:lnTo>
                    <a:pt x="0" y="1280287"/>
                  </a:lnTo>
                  <a:lnTo>
                    <a:pt x="187833" y="1314323"/>
                  </a:lnTo>
                  <a:close/>
                </a:path>
                <a:path w="236220" h="1314450">
                  <a:moveTo>
                    <a:pt x="236220" y="91821"/>
                  </a:moveTo>
                  <a:lnTo>
                    <a:pt x="230378" y="0"/>
                  </a:lnTo>
                  <a:lnTo>
                    <a:pt x="48387" y="57658"/>
                  </a:lnTo>
                  <a:lnTo>
                    <a:pt x="236220" y="91821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20" name="object 20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1338072" y="5017008"/>
              <a:ext cx="2529840" cy="2644140"/>
            </a:xfrm>
            <a:prstGeom prst="rect">
              <a:avLst/>
            </a:prstGeom>
          </p:spPr>
        </p:pic>
      </p:grpSp>
      <p:sp>
        <p:nvSpPr>
          <p:cNvPr id="21" name="object 21"/>
          <p:cNvSpPr txBox="1"/>
          <p:nvPr/>
        </p:nvSpPr>
        <p:spPr>
          <a:xfrm>
            <a:off x="2025142" y="4546219"/>
            <a:ext cx="621665" cy="17780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1000" b="1" spc="-20" dirty="0">
                <a:latin typeface="Arial"/>
                <a:cs typeface="Arial"/>
              </a:rPr>
              <a:t>Anti-CHIA</a:t>
            </a:r>
            <a:endParaRPr sz="1000">
              <a:latin typeface="Arial"/>
              <a:cs typeface="Arial"/>
            </a:endParaRPr>
          </a:p>
        </p:txBody>
      </p:sp>
      <p:sp>
        <p:nvSpPr>
          <p:cNvPr id="22" name="object 22"/>
          <p:cNvSpPr txBox="1"/>
          <p:nvPr/>
        </p:nvSpPr>
        <p:spPr>
          <a:xfrm>
            <a:off x="1604263" y="5305877"/>
            <a:ext cx="842010" cy="441325"/>
          </a:xfrm>
          <a:prstGeom prst="rect">
            <a:avLst/>
          </a:prstGeom>
        </p:spPr>
        <p:txBody>
          <a:bodyPr vert="horz" wrap="square" lIns="0" tIns="90170" rIns="0" bIns="0" rtlCol="0">
            <a:spAutoFit/>
          </a:bodyPr>
          <a:lstStyle/>
          <a:p>
            <a:pPr marL="13970">
              <a:lnSpc>
                <a:spcPct val="100000"/>
              </a:lnSpc>
              <a:spcBef>
                <a:spcPts val="710"/>
              </a:spcBef>
            </a:pPr>
            <a:r>
              <a:rPr sz="1000" spc="-10" dirty="0">
                <a:latin typeface="Arial"/>
                <a:cs typeface="Arial"/>
              </a:rPr>
              <a:t>AcMNPV-</a:t>
            </a:r>
            <a:r>
              <a:rPr sz="1000" spc="-25" dirty="0">
                <a:latin typeface="Arial"/>
                <a:cs typeface="Arial"/>
              </a:rPr>
              <a:t>Rep</a:t>
            </a:r>
            <a:endParaRPr sz="100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500"/>
              </a:spcBef>
            </a:pPr>
            <a:r>
              <a:rPr sz="800" dirty="0">
                <a:latin typeface="Arial Narrow"/>
                <a:cs typeface="Arial Narrow"/>
              </a:rPr>
              <a:t>8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16</a:t>
            </a:r>
            <a:r>
              <a:rPr sz="800" spc="35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24</a:t>
            </a:r>
            <a:r>
              <a:rPr sz="800" spc="17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32</a:t>
            </a:r>
            <a:r>
              <a:rPr sz="800" spc="1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40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spc="-25" dirty="0">
                <a:latin typeface="Arial Narrow"/>
                <a:cs typeface="Arial Narrow"/>
              </a:rPr>
              <a:t>48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23" name="object 23"/>
          <p:cNvSpPr txBox="1"/>
          <p:nvPr/>
        </p:nvSpPr>
        <p:spPr>
          <a:xfrm>
            <a:off x="2632899" y="5305877"/>
            <a:ext cx="934085" cy="441325"/>
          </a:xfrm>
          <a:prstGeom prst="rect">
            <a:avLst/>
          </a:prstGeom>
        </p:spPr>
        <p:txBody>
          <a:bodyPr vert="horz" wrap="square" lIns="0" tIns="90170" rIns="0" bIns="0" rtlCol="0">
            <a:spAutoFit/>
          </a:bodyPr>
          <a:lstStyle/>
          <a:p>
            <a:pPr marL="111760">
              <a:lnSpc>
                <a:spcPct val="100000"/>
              </a:lnSpc>
              <a:spcBef>
                <a:spcPts val="710"/>
              </a:spcBef>
            </a:pPr>
            <a:r>
              <a:rPr sz="1000" spc="-10" dirty="0">
                <a:latin typeface="Arial"/>
                <a:cs typeface="Arial"/>
              </a:rPr>
              <a:t>Acp6.9-</a:t>
            </a:r>
            <a:r>
              <a:rPr sz="1000" spc="-20" dirty="0">
                <a:latin typeface="Arial"/>
                <a:cs typeface="Arial"/>
              </a:rPr>
              <a:t>chiA</a:t>
            </a:r>
            <a:endParaRPr sz="100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500"/>
              </a:spcBef>
            </a:pPr>
            <a:r>
              <a:rPr sz="800" dirty="0">
                <a:latin typeface="Arial Narrow"/>
                <a:cs typeface="Arial Narrow"/>
              </a:rPr>
              <a:t>8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16</a:t>
            </a:r>
            <a:r>
              <a:rPr sz="800" spc="1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24</a:t>
            </a:r>
            <a:r>
              <a:rPr sz="800" spc="17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32</a:t>
            </a:r>
            <a:r>
              <a:rPr sz="800" spc="17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40</a:t>
            </a:r>
            <a:r>
              <a:rPr sz="800" spc="1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48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spc="-50" dirty="0">
                <a:latin typeface="Arial Narrow"/>
                <a:cs typeface="Arial Narrow"/>
              </a:rPr>
              <a:t>M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24" name="object 24"/>
          <p:cNvSpPr txBox="1"/>
          <p:nvPr/>
        </p:nvSpPr>
        <p:spPr>
          <a:xfrm>
            <a:off x="1338072" y="6510528"/>
            <a:ext cx="1160145" cy="1150620"/>
          </a:xfrm>
          <a:prstGeom prst="rect">
            <a:avLst/>
          </a:prstGeom>
          <a:ln w="12191">
            <a:solidFill>
              <a:srgbClr val="FFFFFF"/>
            </a:solidFill>
          </a:ln>
        </p:spPr>
        <p:txBody>
          <a:bodyPr vert="horz" wrap="square" lIns="0" tIns="42545" rIns="0" bIns="0" rtlCol="0">
            <a:spAutoFit/>
          </a:bodyPr>
          <a:lstStyle/>
          <a:p>
            <a:pPr marL="254000">
              <a:lnSpc>
                <a:spcPct val="100000"/>
              </a:lnSpc>
              <a:spcBef>
                <a:spcPts val="335"/>
              </a:spcBef>
            </a:pPr>
            <a:r>
              <a:rPr sz="1000" spc="-10" dirty="0">
                <a:latin typeface="Arial"/>
                <a:cs typeface="Arial"/>
              </a:rPr>
              <a:t>AcMNPV-</a:t>
            </a:r>
            <a:r>
              <a:rPr sz="1000" spc="-25" dirty="0">
                <a:latin typeface="Arial"/>
                <a:cs typeface="Arial"/>
              </a:rPr>
              <a:t>Rep</a:t>
            </a:r>
            <a:endParaRPr sz="1000">
              <a:latin typeface="Arial"/>
              <a:cs typeface="Arial"/>
            </a:endParaRPr>
          </a:p>
          <a:p>
            <a:pPr marL="297815">
              <a:lnSpc>
                <a:spcPct val="100000"/>
              </a:lnSpc>
              <a:spcBef>
                <a:spcPts val="505"/>
              </a:spcBef>
            </a:pPr>
            <a:r>
              <a:rPr sz="800" dirty="0">
                <a:latin typeface="Arial Narrow"/>
                <a:cs typeface="Arial Narrow"/>
              </a:rPr>
              <a:t>8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16</a:t>
            </a:r>
            <a:r>
              <a:rPr sz="800" spc="35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24</a:t>
            </a:r>
            <a:r>
              <a:rPr sz="800" spc="17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32</a:t>
            </a:r>
            <a:r>
              <a:rPr sz="800" spc="1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40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spc="-25" dirty="0">
                <a:latin typeface="Arial Narrow"/>
                <a:cs typeface="Arial Narrow"/>
              </a:rPr>
              <a:t>48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25" name="object 25"/>
          <p:cNvSpPr txBox="1"/>
          <p:nvPr/>
        </p:nvSpPr>
        <p:spPr>
          <a:xfrm>
            <a:off x="2577210" y="6505013"/>
            <a:ext cx="1262380" cy="400050"/>
          </a:xfrm>
          <a:prstGeom prst="rect">
            <a:avLst/>
          </a:prstGeom>
        </p:spPr>
        <p:txBody>
          <a:bodyPr vert="horz" wrap="square" lIns="0" tIns="6731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30"/>
              </a:spcBef>
            </a:pPr>
            <a:r>
              <a:rPr sz="1000" spc="-10" dirty="0">
                <a:latin typeface="Arial"/>
                <a:cs typeface="Arial"/>
              </a:rPr>
              <a:t>Acp6.9-chiA/polh-</a:t>
            </a:r>
            <a:r>
              <a:rPr sz="1000" spc="-20" dirty="0">
                <a:latin typeface="Arial"/>
                <a:cs typeface="Arial"/>
              </a:rPr>
              <a:t>cath</a:t>
            </a:r>
            <a:endParaRPr sz="1000">
              <a:latin typeface="Arial"/>
              <a:cs typeface="Arial"/>
            </a:endParaRPr>
          </a:p>
          <a:p>
            <a:pPr marL="86995">
              <a:lnSpc>
                <a:spcPct val="100000"/>
              </a:lnSpc>
              <a:spcBef>
                <a:spcPts val="355"/>
              </a:spcBef>
            </a:pPr>
            <a:r>
              <a:rPr sz="800" dirty="0">
                <a:latin typeface="Arial Narrow"/>
                <a:cs typeface="Arial Narrow"/>
              </a:rPr>
              <a:t>8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16</a:t>
            </a:r>
            <a:r>
              <a:rPr sz="800" spc="1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24</a:t>
            </a:r>
            <a:r>
              <a:rPr sz="800" spc="17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32</a:t>
            </a:r>
            <a:r>
              <a:rPr sz="800" spc="17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40</a:t>
            </a:r>
            <a:r>
              <a:rPr sz="800" spc="165" dirty="0">
                <a:latin typeface="Arial Narrow"/>
                <a:cs typeface="Arial Narrow"/>
              </a:rPr>
              <a:t> </a:t>
            </a:r>
            <a:r>
              <a:rPr sz="800" dirty="0">
                <a:latin typeface="Arial Narrow"/>
                <a:cs typeface="Arial Narrow"/>
              </a:rPr>
              <a:t>48</a:t>
            </a:r>
            <a:r>
              <a:rPr sz="800" spc="365" dirty="0">
                <a:latin typeface="Arial Narrow"/>
                <a:cs typeface="Arial Narrow"/>
              </a:rPr>
              <a:t> </a:t>
            </a:r>
            <a:r>
              <a:rPr sz="800" spc="-50" dirty="0">
                <a:latin typeface="Arial Narrow"/>
                <a:cs typeface="Arial Narrow"/>
              </a:rPr>
              <a:t>G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26" name="object 26"/>
          <p:cNvSpPr/>
          <p:nvPr/>
        </p:nvSpPr>
        <p:spPr>
          <a:xfrm>
            <a:off x="3911981" y="5813678"/>
            <a:ext cx="243840" cy="1231265"/>
          </a:xfrm>
          <a:custGeom>
            <a:avLst/>
            <a:gdLst/>
            <a:ahLst/>
            <a:cxnLst/>
            <a:rect l="l" t="t" r="r" b="b"/>
            <a:pathLst>
              <a:path w="243839" h="1231265">
                <a:moveTo>
                  <a:pt x="187833" y="91821"/>
                </a:moveTo>
                <a:lnTo>
                  <a:pt x="182118" y="0"/>
                </a:lnTo>
                <a:lnTo>
                  <a:pt x="0" y="57658"/>
                </a:lnTo>
                <a:lnTo>
                  <a:pt x="187833" y="91821"/>
                </a:lnTo>
                <a:close/>
              </a:path>
              <a:path w="243839" h="1231265">
                <a:moveTo>
                  <a:pt x="243459" y="1231265"/>
                </a:moveTo>
                <a:lnTo>
                  <a:pt x="237617" y="1139571"/>
                </a:lnTo>
                <a:lnTo>
                  <a:pt x="55626" y="1197102"/>
                </a:lnTo>
                <a:lnTo>
                  <a:pt x="243459" y="123126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" name="object 27"/>
          <p:cNvSpPr txBox="1"/>
          <p:nvPr/>
        </p:nvSpPr>
        <p:spPr>
          <a:xfrm>
            <a:off x="1214729" y="13013182"/>
            <a:ext cx="7934959" cy="112268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>
              <a:lnSpc>
                <a:spcPct val="100000"/>
              </a:lnSpc>
              <a:spcBef>
                <a:spcPts val="100"/>
              </a:spcBef>
            </a:pPr>
            <a:r>
              <a:rPr sz="1200" b="1" dirty="0">
                <a:latin typeface="Arial"/>
                <a:cs typeface="Arial"/>
              </a:rPr>
              <a:t>Figure</a:t>
            </a:r>
            <a:r>
              <a:rPr sz="1200" b="1" spc="-10" dirty="0">
                <a:latin typeface="Arial"/>
                <a:cs typeface="Arial"/>
              </a:rPr>
              <a:t> </a:t>
            </a:r>
            <a:r>
              <a:rPr sz="1200" b="1" dirty="0">
                <a:latin typeface="Arial"/>
                <a:cs typeface="Arial"/>
              </a:rPr>
              <a:t>S1:</a:t>
            </a:r>
            <a:r>
              <a:rPr sz="1200" b="1" spc="-10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Uncropped</a:t>
            </a:r>
            <a:r>
              <a:rPr sz="1200" spc="-5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blots</a:t>
            </a:r>
            <a:r>
              <a:rPr sz="1200" spc="-2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shown</a:t>
            </a:r>
            <a:r>
              <a:rPr sz="1200" spc="-3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in</a:t>
            </a:r>
            <a:r>
              <a:rPr sz="1200" spc="-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Figure</a:t>
            </a:r>
            <a:r>
              <a:rPr sz="1200" spc="-1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2.</a:t>
            </a:r>
            <a:r>
              <a:rPr sz="1200" spc="-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(a)</a:t>
            </a:r>
            <a:r>
              <a:rPr sz="1200" spc="-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immunoblots</a:t>
            </a:r>
            <a:r>
              <a:rPr sz="1200" spc="-4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of</a:t>
            </a:r>
            <a:r>
              <a:rPr sz="1200" spc="-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temporal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CHIA/proV-</a:t>
            </a:r>
            <a:r>
              <a:rPr sz="1200" spc="-25" dirty="0">
                <a:latin typeface="Arial"/>
                <a:cs typeface="Arial"/>
              </a:rPr>
              <a:t>CATH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protein</a:t>
            </a:r>
            <a:r>
              <a:rPr sz="1200" spc="-4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production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spc="-25" dirty="0">
                <a:latin typeface="Arial"/>
                <a:cs typeface="Arial"/>
              </a:rPr>
              <a:t>by </a:t>
            </a:r>
            <a:r>
              <a:rPr sz="1200" spc="-10" dirty="0">
                <a:latin typeface="Arial"/>
                <a:cs typeface="Arial"/>
              </a:rPr>
              <a:t>AcMNPV-</a:t>
            </a:r>
            <a:r>
              <a:rPr sz="1200" dirty="0">
                <a:latin typeface="Arial"/>
                <a:cs typeface="Arial"/>
              </a:rPr>
              <a:t>Rep,</a:t>
            </a:r>
            <a:r>
              <a:rPr sz="1200" spc="-95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Acp6.9-chiA</a:t>
            </a:r>
            <a:r>
              <a:rPr sz="1200" spc="-10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and</a:t>
            </a:r>
            <a:r>
              <a:rPr sz="1200" spc="-9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Acp6.9-</a:t>
            </a:r>
            <a:r>
              <a:rPr sz="1200" spc="-10" dirty="0">
                <a:latin typeface="Arial"/>
                <a:cs typeface="Arial"/>
              </a:rPr>
              <a:t>chiA/polh-</a:t>
            </a:r>
            <a:r>
              <a:rPr sz="1200" dirty="0">
                <a:latin typeface="Arial"/>
                <a:cs typeface="Arial"/>
              </a:rPr>
              <a:t>cath</a:t>
            </a:r>
            <a:r>
              <a:rPr sz="1200" spc="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infected</a:t>
            </a:r>
            <a:r>
              <a:rPr sz="1200" spc="-2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Sf21</a:t>
            </a:r>
            <a:r>
              <a:rPr sz="1200" spc="-2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cells.</a:t>
            </a:r>
            <a:r>
              <a:rPr sz="1200" spc="-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In</a:t>
            </a:r>
            <a:r>
              <a:rPr sz="1200" spc="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(a)</a:t>
            </a:r>
            <a:r>
              <a:rPr sz="1200" spc="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arrowheads</a:t>
            </a:r>
            <a:r>
              <a:rPr sz="1200" spc="-2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indicate</a:t>
            </a:r>
            <a:r>
              <a:rPr sz="1200" spc="-4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CHIA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bands</a:t>
            </a:r>
            <a:r>
              <a:rPr sz="1200" spc="-20" dirty="0">
                <a:latin typeface="Arial"/>
                <a:cs typeface="Arial"/>
              </a:rPr>
              <a:t> </a:t>
            </a:r>
            <a:r>
              <a:rPr sz="1200" spc="-25" dirty="0">
                <a:latin typeface="Arial"/>
                <a:cs typeface="Arial"/>
              </a:rPr>
              <a:t>and </a:t>
            </a:r>
            <a:r>
              <a:rPr sz="1200" dirty="0">
                <a:latin typeface="Arial"/>
                <a:cs typeface="Arial"/>
              </a:rPr>
              <a:t>arrows indicate</a:t>
            </a:r>
            <a:r>
              <a:rPr sz="1200" spc="-25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proV-</a:t>
            </a:r>
            <a:r>
              <a:rPr sz="1200" spc="-25" dirty="0">
                <a:latin typeface="Arial"/>
                <a:cs typeface="Arial"/>
              </a:rPr>
              <a:t>CATH</a:t>
            </a:r>
            <a:r>
              <a:rPr sz="1200" spc="-4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bands.</a:t>
            </a:r>
            <a:r>
              <a:rPr sz="1200" spc="-3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In</a:t>
            </a:r>
            <a:r>
              <a:rPr sz="1200" spc="-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(b)</a:t>
            </a:r>
            <a:r>
              <a:rPr sz="1200" spc="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CHIA,</a:t>
            </a:r>
            <a:r>
              <a:rPr sz="1200" spc="10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proV-CATH</a:t>
            </a:r>
            <a:r>
              <a:rPr sz="1200" spc="-3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and</a:t>
            </a:r>
            <a:r>
              <a:rPr sz="1200" spc="-2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GAPDH</a:t>
            </a:r>
            <a:r>
              <a:rPr sz="1200" spc="-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(loading</a:t>
            </a:r>
            <a:r>
              <a:rPr sz="1200" spc="-3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control)</a:t>
            </a:r>
            <a:r>
              <a:rPr sz="1200" spc="-2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proteins</a:t>
            </a:r>
            <a:r>
              <a:rPr sz="1200" spc="-3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were</a:t>
            </a:r>
            <a:r>
              <a:rPr sz="1200" spc="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detected</a:t>
            </a:r>
            <a:r>
              <a:rPr sz="1200" spc="-40" dirty="0">
                <a:latin typeface="Arial"/>
                <a:cs typeface="Arial"/>
              </a:rPr>
              <a:t> </a:t>
            </a:r>
            <a:r>
              <a:rPr sz="1200" spc="-25" dirty="0">
                <a:latin typeface="Arial"/>
                <a:cs typeface="Arial"/>
              </a:rPr>
              <a:t>on </a:t>
            </a:r>
            <a:r>
              <a:rPr sz="1200" dirty="0">
                <a:latin typeface="Arial"/>
                <a:cs typeface="Arial"/>
              </a:rPr>
              <a:t>two blots</a:t>
            </a:r>
            <a:r>
              <a:rPr sz="1200" spc="-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simultaneously:</a:t>
            </a:r>
            <a:r>
              <a:rPr sz="1200" spc="-1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each</a:t>
            </a:r>
            <a:r>
              <a:rPr sz="1200" spc="-2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blot</a:t>
            </a:r>
            <a:r>
              <a:rPr sz="1200" spc="-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had</a:t>
            </a:r>
            <a:r>
              <a:rPr sz="1200" spc="-65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AcMNPV-</a:t>
            </a:r>
            <a:r>
              <a:rPr sz="1200" dirty="0">
                <a:latin typeface="Arial"/>
                <a:cs typeface="Arial"/>
              </a:rPr>
              <a:t>Rep</a:t>
            </a:r>
            <a:r>
              <a:rPr sz="1200" spc="-3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samples</a:t>
            </a:r>
            <a:r>
              <a:rPr sz="1200" spc="-3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(leftmost</a:t>
            </a:r>
            <a:r>
              <a:rPr sz="1200" spc="-1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lanes)</a:t>
            </a:r>
            <a:r>
              <a:rPr sz="1200" spc="-2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and</a:t>
            </a:r>
            <a:r>
              <a:rPr sz="1200" spc="-20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either</a:t>
            </a:r>
            <a:r>
              <a:rPr sz="1200" spc="-9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Acp6.9-</a:t>
            </a:r>
            <a:r>
              <a:rPr sz="1200" spc="-10" dirty="0">
                <a:latin typeface="Arial"/>
                <a:cs typeface="Arial"/>
              </a:rPr>
              <a:t>chiA</a:t>
            </a:r>
            <a:r>
              <a:rPr sz="1200" spc="-10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or</a:t>
            </a:r>
            <a:r>
              <a:rPr sz="1200" spc="-75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Acp6.9- chiA/polh-</a:t>
            </a:r>
            <a:r>
              <a:rPr sz="1200" dirty="0">
                <a:latin typeface="Arial"/>
                <a:cs typeface="Arial"/>
              </a:rPr>
              <a:t>cath</a:t>
            </a:r>
            <a:r>
              <a:rPr sz="1200" spc="-3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samples</a:t>
            </a:r>
            <a:r>
              <a:rPr sz="1200" spc="-3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(rightmost</a:t>
            </a:r>
            <a:r>
              <a:rPr sz="1200" spc="-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lanes).</a:t>
            </a:r>
            <a:r>
              <a:rPr sz="1200" spc="-3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The</a:t>
            </a:r>
            <a:r>
              <a:rPr sz="1200" spc="-1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samples</a:t>
            </a:r>
            <a:r>
              <a:rPr sz="1200" spc="-3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in</a:t>
            </a:r>
            <a:r>
              <a:rPr sz="1200" spc="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portions</a:t>
            </a:r>
            <a:r>
              <a:rPr sz="1200" spc="-3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of</a:t>
            </a:r>
            <a:r>
              <a:rPr sz="1200" spc="-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blots</a:t>
            </a:r>
            <a:r>
              <a:rPr sz="1200" spc="-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demarcated</a:t>
            </a:r>
            <a:r>
              <a:rPr sz="1200" spc="-3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with</a:t>
            </a:r>
            <a:r>
              <a:rPr sz="1200" spc="1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a</a:t>
            </a:r>
            <a:r>
              <a:rPr sz="1200" spc="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white border</a:t>
            </a:r>
            <a:r>
              <a:rPr sz="1200" spc="-2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were </a:t>
            </a:r>
            <a:r>
              <a:rPr sz="1200" spc="-25" dirty="0">
                <a:latin typeface="Arial"/>
                <a:cs typeface="Arial"/>
              </a:rPr>
              <a:t>not </a:t>
            </a:r>
            <a:r>
              <a:rPr sz="1200" dirty="0">
                <a:latin typeface="Arial"/>
                <a:cs typeface="Arial"/>
              </a:rPr>
              <a:t>shown</a:t>
            </a:r>
            <a:r>
              <a:rPr sz="1200" spc="-2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in</a:t>
            </a:r>
            <a:r>
              <a:rPr sz="1200" spc="-2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Figure</a:t>
            </a:r>
            <a:r>
              <a:rPr sz="1200" spc="-20" dirty="0">
                <a:latin typeface="Arial"/>
                <a:cs typeface="Arial"/>
              </a:rPr>
              <a:t> </a:t>
            </a:r>
            <a:r>
              <a:rPr sz="1200" spc="-25" dirty="0">
                <a:latin typeface="Arial"/>
                <a:cs typeface="Arial"/>
              </a:rPr>
              <a:t>2.</a:t>
            </a:r>
            <a:endParaRPr sz="1200">
              <a:latin typeface="Arial"/>
              <a:cs typeface="Arial"/>
            </a:endParaRPr>
          </a:p>
        </p:txBody>
      </p:sp>
      <p:sp>
        <p:nvSpPr>
          <p:cNvPr id="28" name="object 28"/>
          <p:cNvSpPr txBox="1"/>
          <p:nvPr/>
        </p:nvSpPr>
        <p:spPr>
          <a:xfrm>
            <a:off x="1205890" y="8445754"/>
            <a:ext cx="2449830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dirty="0">
                <a:latin typeface="Arial"/>
                <a:cs typeface="Arial"/>
              </a:rPr>
              <a:t>b)</a:t>
            </a:r>
            <a:r>
              <a:rPr sz="1200" b="1" spc="-20" dirty="0">
                <a:latin typeface="Arial"/>
                <a:cs typeface="Arial"/>
              </a:rPr>
              <a:t> </a:t>
            </a:r>
            <a:r>
              <a:rPr sz="1200" b="1" dirty="0">
                <a:latin typeface="Arial"/>
                <a:cs typeface="Arial"/>
              </a:rPr>
              <a:t>CHIA</a:t>
            </a:r>
            <a:r>
              <a:rPr sz="1200" b="1" spc="-65" dirty="0">
                <a:latin typeface="Arial"/>
                <a:cs typeface="Arial"/>
              </a:rPr>
              <a:t> </a:t>
            </a:r>
            <a:r>
              <a:rPr sz="1200" b="1" dirty="0">
                <a:latin typeface="Arial"/>
                <a:cs typeface="Arial"/>
              </a:rPr>
              <a:t>and</a:t>
            </a:r>
            <a:r>
              <a:rPr sz="1200" b="1" spc="-20" dirty="0">
                <a:latin typeface="Arial"/>
                <a:cs typeface="Arial"/>
              </a:rPr>
              <a:t> proV-CATH</a:t>
            </a:r>
            <a:r>
              <a:rPr sz="1200" b="1" spc="5" dirty="0">
                <a:latin typeface="Arial"/>
                <a:cs typeface="Arial"/>
              </a:rPr>
              <a:t> </a:t>
            </a:r>
            <a:r>
              <a:rPr sz="1200" b="1" spc="-10" dirty="0">
                <a:latin typeface="Arial"/>
                <a:cs typeface="Arial"/>
              </a:rPr>
              <a:t>solubility</a:t>
            </a:r>
            <a:endParaRPr sz="1200">
              <a:latin typeface="Arial"/>
              <a:cs typeface="Arial"/>
            </a:endParaRPr>
          </a:p>
        </p:txBody>
      </p:sp>
      <p:grpSp>
        <p:nvGrpSpPr>
          <p:cNvPr id="29" name="object 29"/>
          <p:cNvGrpSpPr/>
          <p:nvPr/>
        </p:nvGrpSpPr>
        <p:grpSpPr>
          <a:xfrm>
            <a:off x="1166063" y="9911207"/>
            <a:ext cx="4138295" cy="1778635"/>
            <a:chOff x="1166063" y="9911207"/>
            <a:chExt cx="4138295" cy="1778635"/>
          </a:xfrm>
        </p:grpSpPr>
        <p:pic>
          <p:nvPicPr>
            <p:cNvPr id="30" name="object 30"/>
            <p:cNvPicPr/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1292987" y="9911207"/>
              <a:ext cx="3896105" cy="1778380"/>
            </a:xfrm>
            <a:prstGeom prst="rect">
              <a:avLst/>
            </a:prstGeom>
          </p:spPr>
        </p:pic>
        <p:sp>
          <p:nvSpPr>
            <p:cNvPr id="31" name="object 31"/>
            <p:cNvSpPr/>
            <p:nvPr/>
          </p:nvSpPr>
          <p:spPr>
            <a:xfrm>
              <a:off x="3140963" y="10053828"/>
              <a:ext cx="2156460" cy="1605280"/>
            </a:xfrm>
            <a:custGeom>
              <a:avLst/>
              <a:gdLst/>
              <a:ahLst/>
              <a:cxnLst/>
              <a:rect l="l" t="t" r="r" b="b"/>
              <a:pathLst>
                <a:path w="2156460" h="1605279">
                  <a:moveTo>
                    <a:pt x="0" y="1604772"/>
                  </a:moveTo>
                  <a:lnTo>
                    <a:pt x="2156460" y="1604772"/>
                  </a:lnTo>
                  <a:lnTo>
                    <a:pt x="2156460" y="0"/>
                  </a:lnTo>
                  <a:lnTo>
                    <a:pt x="0" y="0"/>
                  </a:lnTo>
                  <a:lnTo>
                    <a:pt x="0" y="1604772"/>
                  </a:lnTo>
                  <a:close/>
                </a:path>
              </a:pathLst>
            </a:custGeom>
            <a:ln w="12191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" name="object 32"/>
            <p:cNvSpPr/>
            <p:nvPr/>
          </p:nvSpPr>
          <p:spPr>
            <a:xfrm>
              <a:off x="1166063" y="10662920"/>
              <a:ext cx="188595" cy="92075"/>
            </a:xfrm>
            <a:custGeom>
              <a:avLst/>
              <a:gdLst/>
              <a:ahLst/>
              <a:cxnLst/>
              <a:rect l="l" t="t" r="r" b="b"/>
              <a:pathLst>
                <a:path w="188594" h="92075">
                  <a:moveTo>
                    <a:pt x="6845" y="0"/>
                  </a:moveTo>
                  <a:lnTo>
                    <a:pt x="0" y="91694"/>
                  </a:lnTo>
                  <a:lnTo>
                    <a:pt x="188137" y="59563"/>
                  </a:lnTo>
                  <a:lnTo>
                    <a:pt x="6845" y="0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33" name="object 33"/>
          <p:cNvGrpSpPr/>
          <p:nvPr/>
        </p:nvGrpSpPr>
        <p:grpSpPr>
          <a:xfrm>
            <a:off x="5797005" y="9687687"/>
            <a:ext cx="3742054" cy="2070735"/>
            <a:chOff x="5797005" y="9687687"/>
            <a:chExt cx="3742054" cy="2070735"/>
          </a:xfrm>
        </p:grpSpPr>
        <p:pic>
          <p:nvPicPr>
            <p:cNvPr id="34" name="object 34"/>
            <p:cNvPicPr/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5797005" y="9687687"/>
              <a:ext cx="3546004" cy="2031238"/>
            </a:xfrm>
            <a:prstGeom prst="rect">
              <a:avLst/>
            </a:prstGeom>
          </p:spPr>
        </p:pic>
        <p:sp>
          <p:nvSpPr>
            <p:cNvPr id="35" name="object 35"/>
            <p:cNvSpPr/>
            <p:nvPr/>
          </p:nvSpPr>
          <p:spPr>
            <a:xfrm>
              <a:off x="6292596" y="10396728"/>
              <a:ext cx="1638300" cy="1355090"/>
            </a:xfrm>
            <a:custGeom>
              <a:avLst/>
              <a:gdLst/>
              <a:ahLst/>
              <a:cxnLst/>
              <a:rect l="l" t="t" r="r" b="b"/>
              <a:pathLst>
                <a:path w="1638300" h="1355090">
                  <a:moveTo>
                    <a:pt x="0" y="1354836"/>
                  </a:moveTo>
                  <a:lnTo>
                    <a:pt x="1638300" y="1354836"/>
                  </a:lnTo>
                  <a:lnTo>
                    <a:pt x="1638300" y="0"/>
                  </a:lnTo>
                  <a:lnTo>
                    <a:pt x="0" y="0"/>
                  </a:lnTo>
                  <a:lnTo>
                    <a:pt x="0" y="1354836"/>
                  </a:lnTo>
                  <a:close/>
                </a:path>
              </a:pathLst>
            </a:custGeom>
            <a:ln w="12192">
              <a:solidFill>
                <a:srgbClr val="FFFF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" name="object 36"/>
            <p:cNvSpPr/>
            <p:nvPr/>
          </p:nvSpPr>
          <p:spPr>
            <a:xfrm>
              <a:off x="9265920" y="11198352"/>
              <a:ext cx="273050" cy="76200"/>
            </a:xfrm>
            <a:custGeom>
              <a:avLst/>
              <a:gdLst/>
              <a:ahLst/>
              <a:cxnLst/>
              <a:rect l="l" t="t" r="r" b="b"/>
              <a:pathLst>
                <a:path w="273050" h="76200">
                  <a:moveTo>
                    <a:pt x="76200" y="0"/>
                  </a:moveTo>
                  <a:lnTo>
                    <a:pt x="0" y="38100"/>
                  </a:lnTo>
                  <a:lnTo>
                    <a:pt x="76200" y="76200"/>
                  </a:lnTo>
                  <a:lnTo>
                    <a:pt x="76200" y="44450"/>
                  </a:lnTo>
                  <a:lnTo>
                    <a:pt x="63500" y="44450"/>
                  </a:lnTo>
                  <a:lnTo>
                    <a:pt x="63500" y="31750"/>
                  </a:lnTo>
                  <a:lnTo>
                    <a:pt x="76200" y="31750"/>
                  </a:lnTo>
                  <a:lnTo>
                    <a:pt x="76200" y="0"/>
                  </a:lnTo>
                  <a:close/>
                </a:path>
                <a:path w="273050" h="76200">
                  <a:moveTo>
                    <a:pt x="76200" y="31750"/>
                  </a:moveTo>
                  <a:lnTo>
                    <a:pt x="63500" y="31750"/>
                  </a:lnTo>
                  <a:lnTo>
                    <a:pt x="63500" y="44450"/>
                  </a:lnTo>
                  <a:lnTo>
                    <a:pt x="76200" y="44450"/>
                  </a:lnTo>
                  <a:lnTo>
                    <a:pt x="76200" y="31750"/>
                  </a:lnTo>
                  <a:close/>
                </a:path>
                <a:path w="273050" h="76200">
                  <a:moveTo>
                    <a:pt x="272669" y="31750"/>
                  </a:moveTo>
                  <a:lnTo>
                    <a:pt x="76200" y="31750"/>
                  </a:lnTo>
                  <a:lnTo>
                    <a:pt x="76200" y="44450"/>
                  </a:lnTo>
                  <a:lnTo>
                    <a:pt x="272669" y="44450"/>
                  </a:lnTo>
                  <a:lnTo>
                    <a:pt x="272669" y="31750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7" name="object 37"/>
          <p:cNvSpPr txBox="1"/>
          <p:nvPr/>
        </p:nvSpPr>
        <p:spPr>
          <a:xfrm>
            <a:off x="2309876" y="8877681"/>
            <a:ext cx="397510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spc="-20" dirty="0">
                <a:latin typeface="Arial"/>
                <a:cs typeface="Arial"/>
              </a:rPr>
              <a:t>CHIA</a:t>
            </a:r>
            <a:endParaRPr sz="1200">
              <a:latin typeface="Arial"/>
              <a:cs typeface="Arial"/>
            </a:endParaRPr>
          </a:p>
        </p:txBody>
      </p:sp>
      <p:sp>
        <p:nvSpPr>
          <p:cNvPr id="38" name="object 38"/>
          <p:cNvSpPr/>
          <p:nvPr/>
        </p:nvSpPr>
        <p:spPr>
          <a:xfrm>
            <a:off x="1770888" y="9323832"/>
            <a:ext cx="747395" cy="0"/>
          </a:xfrm>
          <a:custGeom>
            <a:avLst/>
            <a:gdLst/>
            <a:ahLst/>
            <a:cxnLst/>
            <a:rect l="l" t="t" r="r" b="b"/>
            <a:pathLst>
              <a:path w="747394">
                <a:moveTo>
                  <a:pt x="0" y="0"/>
                </a:moveTo>
                <a:lnTo>
                  <a:pt x="360044" y="0"/>
                </a:lnTo>
              </a:path>
              <a:path w="747394">
                <a:moveTo>
                  <a:pt x="387095" y="0"/>
                </a:moveTo>
                <a:lnTo>
                  <a:pt x="747141" y="0"/>
                </a:lnTo>
              </a:path>
            </a:pathLst>
          </a:custGeom>
          <a:ln w="1219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" name="object 39"/>
          <p:cNvSpPr txBox="1"/>
          <p:nvPr/>
        </p:nvSpPr>
        <p:spPr>
          <a:xfrm>
            <a:off x="2139442" y="9140190"/>
            <a:ext cx="238125" cy="17780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1000" b="1" spc="-25" dirty="0">
                <a:latin typeface="Arial Narrow"/>
                <a:cs typeface="Arial Narrow"/>
              </a:rPr>
              <a:t>SOL</a:t>
            </a:r>
            <a:endParaRPr sz="1000">
              <a:latin typeface="Arial Narrow"/>
              <a:cs typeface="Arial Narrow"/>
            </a:endParaRPr>
          </a:p>
        </p:txBody>
      </p:sp>
      <p:sp>
        <p:nvSpPr>
          <p:cNvPr id="40" name="object 40"/>
          <p:cNvSpPr/>
          <p:nvPr/>
        </p:nvSpPr>
        <p:spPr>
          <a:xfrm>
            <a:off x="2642616" y="9322308"/>
            <a:ext cx="747395" cy="0"/>
          </a:xfrm>
          <a:custGeom>
            <a:avLst/>
            <a:gdLst/>
            <a:ahLst/>
            <a:cxnLst/>
            <a:rect l="l" t="t" r="r" b="b"/>
            <a:pathLst>
              <a:path w="747395">
                <a:moveTo>
                  <a:pt x="0" y="0"/>
                </a:moveTo>
                <a:lnTo>
                  <a:pt x="360044" y="0"/>
                </a:lnTo>
              </a:path>
              <a:path w="747395">
                <a:moveTo>
                  <a:pt x="387095" y="0"/>
                </a:moveTo>
                <a:lnTo>
                  <a:pt x="747141" y="0"/>
                </a:lnTo>
              </a:path>
            </a:pathLst>
          </a:custGeom>
          <a:ln w="1219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1" name="object 41"/>
          <p:cNvSpPr txBox="1"/>
          <p:nvPr/>
        </p:nvSpPr>
        <p:spPr>
          <a:xfrm>
            <a:off x="2668016" y="9138666"/>
            <a:ext cx="341630" cy="17780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1000" b="1" spc="-10" dirty="0">
                <a:latin typeface="Arial Narrow"/>
                <a:cs typeface="Arial Narrow"/>
              </a:rPr>
              <a:t>INSOL</a:t>
            </a:r>
            <a:endParaRPr sz="1000">
              <a:latin typeface="Arial Narrow"/>
              <a:cs typeface="Arial Narrow"/>
            </a:endParaRPr>
          </a:p>
        </p:txBody>
      </p:sp>
      <p:sp>
        <p:nvSpPr>
          <p:cNvPr id="42" name="object 42"/>
          <p:cNvSpPr txBox="1"/>
          <p:nvPr/>
        </p:nvSpPr>
        <p:spPr>
          <a:xfrm>
            <a:off x="1945871" y="9338036"/>
            <a:ext cx="142875" cy="56324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dirty="0">
                <a:latin typeface="Arial Narrow"/>
                <a:cs typeface="Arial Narrow"/>
              </a:rPr>
              <a:t>AcMNPV-</a:t>
            </a:r>
            <a:r>
              <a:rPr sz="800" b="1" spc="-25" dirty="0">
                <a:latin typeface="Arial Narrow"/>
                <a:cs typeface="Arial Narrow"/>
              </a:rPr>
              <a:t>Rep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43" name="object 43"/>
          <p:cNvSpPr/>
          <p:nvPr/>
        </p:nvSpPr>
        <p:spPr>
          <a:xfrm>
            <a:off x="2145284" y="9398508"/>
            <a:ext cx="96520" cy="483870"/>
          </a:xfrm>
          <a:custGeom>
            <a:avLst/>
            <a:gdLst/>
            <a:ahLst/>
            <a:cxnLst/>
            <a:rect l="l" t="t" r="r" b="b"/>
            <a:pathLst>
              <a:path w="96519" h="483870">
                <a:moveTo>
                  <a:pt x="13462" y="77470"/>
                </a:moveTo>
                <a:lnTo>
                  <a:pt x="13335" y="66040"/>
                </a:lnTo>
                <a:lnTo>
                  <a:pt x="381" y="66167"/>
                </a:lnTo>
                <a:lnTo>
                  <a:pt x="508" y="77597"/>
                </a:lnTo>
                <a:lnTo>
                  <a:pt x="13462" y="77470"/>
                </a:lnTo>
                <a:close/>
              </a:path>
              <a:path w="96519" h="483870">
                <a:moveTo>
                  <a:pt x="55372" y="203962"/>
                </a:moveTo>
                <a:lnTo>
                  <a:pt x="55118" y="181356"/>
                </a:lnTo>
                <a:lnTo>
                  <a:pt x="41148" y="181483"/>
                </a:lnTo>
                <a:lnTo>
                  <a:pt x="41275" y="204101"/>
                </a:lnTo>
                <a:lnTo>
                  <a:pt x="55372" y="203962"/>
                </a:lnTo>
                <a:close/>
              </a:path>
              <a:path w="96519" h="483870">
                <a:moveTo>
                  <a:pt x="73406" y="60071"/>
                </a:moveTo>
                <a:lnTo>
                  <a:pt x="73279" y="47244"/>
                </a:lnTo>
                <a:lnTo>
                  <a:pt x="56769" y="42418"/>
                </a:lnTo>
                <a:lnTo>
                  <a:pt x="56730" y="38862"/>
                </a:lnTo>
                <a:lnTo>
                  <a:pt x="56553" y="22479"/>
                </a:lnTo>
                <a:lnTo>
                  <a:pt x="56515" y="18415"/>
                </a:lnTo>
                <a:lnTo>
                  <a:pt x="73025" y="13081"/>
                </a:lnTo>
                <a:lnTo>
                  <a:pt x="72898" y="0"/>
                </a:lnTo>
                <a:lnTo>
                  <a:pt x="44323" y="9664"/>
                </a:lnTo>
                <a:lnTo>
                  <a:pt x="44323" y="38862"/>
                </a:lnTo>
                <a:lnTo>
                  <a:pt x="17145" y="30988"/>
                </a:lnTo>
                <a:lnTo>
                  <a:pt x="44196" y="22479"/>
                </a:lnTo>
                <a:lnTo>
                  <a:pt x="44323" y="38862"/>
                </a:lnTo>
                <a:lnTo>
                  <a:pt x="44323" y="9664"/>
                </a:lnTo>
                <a:lnTo>
                  <a:pt x="0" y="24638"/>
                </a:lnTo>
                <a:lnTo>
                  <a:pt x="127" y="37465"/>
                </a:lnTo>
                <a:lnTo>
                  <a:pt x="73406" y="60071"/>
                </a:lnTo>
                <a:close/>
              </a:path>
              <a:path w="96519" h="483870">
                <a:moveTo>
                  <a:pt x="73660" y="76962"/>
                </a:moveTo>
                <a:lnTo>
                  <a:pt x="73533" y="65405"/>
                </a:lnTo>
                <a:lnTo>
                  <a:pt x="20574" y="65913"/>
                </a:lnTo>
                <a:lnTo>
                  <a:pt x="20701" y="77470"/>
                </a:lnTo>
                <a:lnTo>
                  <a:pt x="73660" y="76962"/>
                </a:lnTo>
                <a:close/>
              </a:path>
              <a:path w="96519" h="483870">
                <a:moveTo>
                  <a:pt x="74041" y="115824"/>
                </a:moveTo>
                <a:lnTo>
                  <a:pt x="47371" y="116078"/>
                </a:lnTo>
                <a:lnTo>
                  <a:pt x="40894" y="116078"/>
                </a:lnTo>
                <a:lnTo>
                  <a:pt x="36449" y="115316"/>
                </a:lnTo>
                <a:lnTo>
                  <a:pt x="34036" y="113665"/>
                </a:lnTo>
                <a:lnTo>
                  <a:pt x="31623" y="112141"/>
                </a:lnTo>
                <a:lnTo>
                  <a:pt x="30480" y="109855"/>
                </a:lnTo>
                <a:lnTo>
                  <a:pt x="30353" y="104013"/>
                </a:lnTo>
                <a:lnTo>
                  <a:pt x="31496" y="102108"/>
                </a:lnTo>
                <a:lnTo>
                  <a:pt x="33655" y="100838"/>
                </a:lnTo>
                <a:lnTo>
                  <a:pt x="35306" y="100076"/>
                </a:lnTo>
                <a:lnTo>
                  <a:pt x="39370" y="99568"/>
                </a:lnTo>
                <a:lnTo>
                  <a:pt x="45847" y="99568"/>
                </a:lnTo>
                <a:lnTo>
                  <a:pt x="73787" y="99314"/>
                </a:lnTo>
                <a:lnTo>
                  <a:pt x="73660" y="87757"/>
                </a:lnTo>
                <a:lnTo>
                  <a:pt x="42672" y="88011"/>
                </a:lnTo>
                <a:lnTo>
                  <a:pt x="36703" y="88138"/>
                </a:lnTo>
                <a:lnTo>
                  <a:pt x="32512" y="88519"/>
                </a:lnTo>
                <a:lnTo>
                  <a:pt x="30099" y="89281"/>
                </a:lnTo>
                <a:lnTo>
                  <a:pt x="26670" y="90297"/>
                </a:lnTo>
                <a:lnTo>
                  <a:pt x="24130" y="91948"/>
                </a:lnTo>
                <a:lnTo>
                  <a:pt x="22352" y="94361"/>
                </a:lnTo>
                <a:lnTo>
                  <a:pt x="20574" y="96647"/>
                </a:lnTo>
                <a:lnTo>
                  <a:pt x="19761" y="99314"/>
                </a:lnTo>
                <a:lnTo>
                  <a:pt x="19685" y="105664"/>
                </a:lnTo>
                <a:lnTo>
                  <a:pt x="20320" y="108077"/>
                </a:lnTo>
                <a:lnTo>
                  <a:pt x="21717" y="110236"/>
                </a:lnTo>
                <a:lnTo>
                  <a:pt x="22987" y="112395"/>
                </a:lnTo>
                <a:lnTo>
                  <a:pt x="25019" y="114427"/>
                </a:lnTo>
                <a:lnTo>
                  <a:pt x="27686" y="116205"/>
                </a:lnTo>
                <a:lnTo>
                  <a:pt x="889" y="116459"/>
                </a:lnTo>
                <a:lnTo>
                  <a:pt x="1016" y="128016"/>
                </a:lnTo>
                <a:lnTo>
                  <a:pt x="74041" y="127254"/>
                </a:lnTo>
                <a:lnTo>
                  <a:pt x="74041" y="116078"/>
                </a:lnTo>
                <a:lnTo>
                  <a:pt x="74041" y="115824"/>
                </a:lnTo>
                <a:close/>
              </a:path>
              <a:path w="96519" h="483870">
                <a:moveTo>
                  <a:pt x="75438" y="270510"/>
                </a:moveTo>
                <a:lnTo>
                  <a:pt x="75311" y="259080"/>
                </a:lnTo>
                <a:lnTo>
                  <a:pt x="61341" y="259207"/>
                </a:lnTo>
                <a:lnTo>
                  <a:pt x="61468" y="270637"/>
                </a:lnTo>
                <a:lnTo>
                  <a:pt x="75438" y="270510"/>
                </a:lnTo>
                <a:close/>
              </a:path>
              <a:path w="96519" h="483870">
                <a:moveTo>
                  <a:pt x="75692" y="161671"/>
                </a:moveTo>
                <a:lnTo>
                  <a:pt x="56261" y="134747"/>
                </a:lnTo>
                <a:lnTo>
                  <a:pt x="53975" y="146050"/>
                </a:lnTo>
                <a:lnTo>
                  <a:pt x="57785" y="146558"/>
                </a:lnTo>
                <a:lnTo>
                  <a:pt x="60452" y="147574"/>
                </a:lnTo>
                <a:lnTo>
                  <a:pt x="61849" y="148971"/>
                </a:lnTo>
                <a:lnTo>
                  <a:pt x="63373" y="150368"/>
                </a:lnTo>
                <a:lnTo>
                  <a:pt x="64135" y="152146"/>
                </a:lnTo>
                <a:lnTo>
                  <a:pt x="64262" y="157226"/>
                </a:lnTo>
                <a:lnTo>
                  <a:pt x="62865" y="159512"/>
                </a:lnTo>
                <a:lnTo>
                  <a:pt x="57785" y="163068"/>
                </a:lnTo>
                <a:lnTo>
                  <a:pt x="53340" y="163957"/>
                </a:lnTo>
                <a:lnTo>
                  <a:pt x="46990" y="163957"/>
                </a:lnTo>
                <a:lnTo>
                  <a:pt x="41275" y="164084"/>
                </a:lnTo>
                <a:lnTo>
                  <a:pt x="31115" y="150241"/>
                </a:lnTo>
                <a:lnTo>
                  <a:pt x="33909" y="147574"/>
                </a:lnTo>
                <a:lnTo>
                  <a:pt x="39370" y="146685"/>
                </a:lnTo>
                <a:lnTo>
                  <a:pt x="36830" y="135382"/>
                </a:lnTo>
                <a:lnTo>
                  <a:pt x="30988" y="136906"/>
                </a:lnTo>
                <a:lnTo>
                  <a:pt x="26797" y="139192"/>
                </a:lnTo>
                <a:lnTo>
                  <a:pt x="24130" y="142494"/>
                </a:lnTo>
                <a:lnTo>
                  <a:pt x="21463" y="145669"/>
                </a:lnTo>
                <a:lnTo>
                  <a:pt x="20066" y="149860"/>
                </a:lnTo>
                <a:lnTo>
                  <a:pt x="20193" y="154940"/>
                </a:lnTo>
                <a:lnTo>
                  <a:pt x="20307" y="161544"/>
                </a:lnTo>
                <a:lnTo>
                  <a:pt x="22606" y="166243"/>
                </a:lnTo>
                <a:lnTo>
                  <a:pt x="27432" y="170180"/>
                </a:lnTo>
                <a:lnTo>
                  <a:pt x="32258" y="173990"/>
                </a:lnTo>
                <a:lnTo>
                  <a:pt x="39116" y="175895"/>
                </a:lnTo>
                <a:lnTo>
                  <a:pt x="55753" y="175641"/>
                </a:lnTo>
                <a:lnTo>
                  <a:pt x="62230" y="173863"/>
                </a:lnTo>
                <a:lnTo>
                  <a:pt x="67691" y="170434"/>
                </a:lnTo>
                <a:lnTo>
                  <a:pt x="73025" y="167005"/>
                </a:lnTo>
                <a:lnTo>
                  <a:pt x="74485" y="164084"/>
                </a:lnTo>
                <a:lnTo>
                  <a:pt x="75692" y="161671"/>
                </a:lnTo>
                <a:close/>
              </a:path>
              <a:path w="96519" h="483870">
                <a:moveTo>
                  <a:pt x="76327" y="226453"/>
                </a:moveTo>
                <a:lnTo>
                  <a:pt x="74383" y="223151"/>
                </a:lnTo>
                <a:lnTo>
                  <a:pt x="73279" y="221234"/>
                </a:lnTo>
                <a:lnTo>
                  <a:pt x="67310" y="217170"/>
                </a:lnTo>
                <a:lnTo>
                  <a:pt x="62204" y="214528"/>
                </a:lnTo>
                <a:lnTo>
                  <a:pt x="55689" y="212686"/>
                </a:lnTo>
                <a:lnTo>
                  <a:pt x="47726" y="211620"/>
                </a:lnTo>
                <a:lnTo>
                  <a:pt x="40132" y="211391"/>
                </a:lnTo>
                <a:lnTo>
                  <a:pt x="40132" y="234327"/>
                </a:lnTo>
                <a:lnTo>
                  <a:pt x="39116" y="236220"/>
                </a:lnTo>
                <a:lnTo>
                  <a:pt x="36957" y="237744"/>
                </a:lnTo>
                <a:lnTo>
                  <a:pt x="34671" y="239395"/>
                </a:lnTo>
                <a:lnTo>
                  <a:pt x="31242" y="240157"/>
                </a:lnTo>
                <a:lnTo>
                  <a:pt x="26543" y="240157"/>
                </a:lnTo>
                <a:lnTo>
                  <a:pt x="21844" y="240284"/>
                </a:lnTo>
                <a:lnTo>
                  <a:pt x="18542" y="239649"/>
                </a:lnTo>
                <a:lnTo>
                  <a:pt x="16383" y="238252"/>
                </a:lnTo>
                <a:lnTo>
                  <a:pt x="14351" y="236855"/>
                </a:lnTo>
                <a:lnTo>
                  <a:pt x="13335" y="235077"/>
                </a:lnTo>
                <a:lnTo>
                  <a:pt x="13335" y="230759"/>
                </a:lnTo>
                <a:lnTo>
                  <a:pt x="27559" y="224282"/>
                </a:lnTo>
                <a:lnTo>
                  <a:pt x="31750" y="224282"/>
                </a:lnTo>
                <a:lnTo>
                  <a:pt x="40132" y="234327"/>
                </a:lnTo>
                <a:lnTo>
                  <a:pt x="40132" y="211391"/>
                </a:lnTo>
                <a:lnTo>
                  <a:pt x="1790" y="226187"/>
                </a:lnTo>
                <a:lnTo>
                  <a:pt x="1778" y="237998"/>
                </a:lnTo>
                <a:lnTo>
                  <a:pt x="4064" y="242455"/>
                </a:lnTo>
                <a:lnTo>
                  <a:pt x="12954" y="249809"/>
                </a:lnTo>
                <a:lnTo>
                  <a:pt x="19050" y="251587"/>
                </a:lnTo>
                <a:lnTo>
                  <a:pt x="26670" y="251460"/>
                </a:lnTo>
                <a:lnTo>
                  <a:pt x="33909" y="251460"/>
                </a:lnTo>
                <a:lnTo>
                  <a:pt x="39624" y="249555"/>
                </a:lnTo>
                <a:lnTo>
                  <a:pt x="43942" y="245999"/>
                </a:lnTo>
                <a:lnTo>
                  <a:pt x="48260" y="242570"/>
                </a:lnTo>
                <a:lnTo>
                  <a:pt x="49466" y="240284"/>
                </a:lnTo>
                <a:lnTo>
                  <a:pt x="50419" y="238506"/>
                </a:lnTo>
                <a:lnTo>
                  <a:pt x="50419" y="231775"/>
                </a:lnTo>
                <a:lnTo>
                  <a:pt x="49911" y="229755"/>
                </a:lnTo>
                <a:lnTo>
                  <a:pt x="48768" y="227977"/>
                </a:lnTo>
                <a:lnTo>
                  <a:pt x="47752" y="226187"/>
                </a:lnTo>
                <a:lnTo>
                  <a:pt x="46228" y="224536"/>
                </a:lnTo>
                <a:lnTo>
                  <a:pt x="45847" y="224282"/>
                </a:lnTo>
                <a:lnTo>
                  <a:pt x="44196" y="223151"/>
                </a:lnTo>
                <a:lnTo>
                  <a:pt x="52451" y="223520"/>
                </a:lnTo>
                <a:lnTo>
                  <a:pt x="57912" y="224536"/>
                </a:lnTo>
                <a:lnTo>
                  <a:pt x="60706" y="226187"/>
                </a:lnTo>
                <a:lnTo>
                  <a:pt x="63373" y="227711"/>
                </a:lnTo>
                <a:lnTo>
                  <a:pt x="64681" y="229755"/>
                </a:lnTo>
                <a:lnTo>
                  <a:pt x="64770" y="236220"/>
                </a:lnTo>
                <a:lnTo>
                  <a:pt x="62103" y="238379"/>
                </a:lnTo>
                <a:lnTo>
                  <a:pt x="56642" y="238887"/>
                </a:lnTo>
                <a:lnTo>
                  <a:pt x="58293" y="250075"/>
                </a:lnTo>
                <a:lnTo>
                  <a:pt x="64516" y="249174"/>
                </a:lnTo>
                <a:lnTo>
                  <a:pt x="69088" y="247269"/>
                </a:lnTo>
                <a:lnTo>
                  <a:pt x="72009" y="244221"/>
                </a:lnTo>
                <a:lnTo>
                  <a:pt x="74930" y="241300"/>
                </a:lnTo>
                <a:lnTo>
                  <a:pt x="76225" y="237744"/>
                </a:lnTo>
                <a:lnTo>
                  <a:pt x="76327" y="226453"/>
                </a:lnTo>
                <a:close/>
              </a:path>
              <a:path w="96519" h="483870">
                <a:moveTo>
                  <a:pt x="76962" y="294005"/>
                </a:moveTo>
                <a:lnTo>
                  <a:pt x="75755" y="291604"/>
                </a:lnTo>
                <a:lnTo>
                  <a:pt x="74676" y="289433"/>
                </a:lnTo>
                <a:lnTo>
                  <a:pt x="65786" y="282079"/>
                </a:lnTo>
                <a:lnTo>
                  <a:pt x="65405" y="281978"/>
                </a:lnTo>
                <a:lnTo>
                  <a:pt x="65405" y="301129"/>
                </a:lnTo>
                <a:lnTo>
                  <a:pt x="64135" y="303149"/>
                </a:lnTo>
                <a:lnTo>
                  <a:pt x="61722" y="304927"/>
                </a:lnTo>
                <a:lnTo>
                  <a:pt x="59309" y="306578"/>
                </a:lnTo>
                <a:lnTo>
                  <a:pt x="55753" y="307479"/>
                </a:lnTo>
                <a:lnTo>
                  <a:pt x="51181" y="307594"/>
                </a:lnTo>
                <a:lnTo>
                  <a:pt x="46990" y="307594"/>
                </a:lnTo>
                <a:lnTo>
                  <a:pt x="43942" y="306832"/>
                </a:lnTo>
                <a:lnTo>
                  <a:pt x="41783" y="305308"/>
                </a:lnTo>
                <a:lnTo>
                  <a:pt x="39751" y="303784"/>
                </a:lnTo>
                <a:lnTo>
                  <a:pt x="38608" y="302006"/>
                </a:lnTo>
                <a:lnTo>
                  <a:pt x="38608" y="297561"/>
                </a:lnTo>
                <a:lnTo>
                  <a:pt x="39624" y="295529"/>
                </a:lnTo>
                <a:lnTo>
                  <a:pt x="41910" y="294005"/>
                </a:lnTo>
                <a:lnTo>
                  <a:pt x="44069" y="292481"/>
                </a:lnTo>
                <a:lnTo>
                  <a:pt x="47498" y="291719"/>
                </a:lnTo>
                <a:lnTo>
                  <a:pt x="52324" y="291604"/>
                </a:lnTo>
                <a:lnTo>
                  <a:pt x="56896" y="291604"/>
                </a:lnTo>
                <a:lnTo>
                  <a:pt x="60198" y="292227"/>
                </a:lnTo>
                <a:lnTo>
                  <a:pt x="64262" y="295021"/>
                </a:lnTo>
                <a:lnTo>
                  <a:pt x="65278" y="296799"/>
                </a:lnTo>
                <a:lnTo>
                  <a:pt x="65405" y="301129"/>
                </a:lnTo>
                <a:lnTo>
                  <a:pt x="65405" y="281978"/>
                </a:lnTo>
                <a:lnTo>
                  <a:pt x="59817" y="280301"/>
                </a:lnTo>
                <a:lnTo>
                  <a:pt x="52070" y="280428"/>
                </a:lnTo>
                <a:lnTo>
                  <a:pt x="44831" y="280428"/>
                </a:lnTo>
                <a:lnTo>
                  <a:pt x="38989" y="282194"/>
                </a:lnTo>
                <a:lnTo>
                  <a:pt x="30353" y="289306"/>
                </a:lnTo>
                <a:lnTo>
                  <a:pt x="28194" y="293370"/>
                </a:lnTo>
                <a:lnTo>
                  <a:pt x="28321" y="300228"/>
                </a:lnTo>
                <a:lnTo>
                  <a:pt x="34544" y="308737"/>
                </a:lnTo>
                <a:lnTo>
                  <a:pt x="26289" y="308356"/>
                </a:lnTo>
                <a:lnTo>
                  <a:pt x="20828" y="307352"/>
                </a:lnTo>
                <a:lnTo>
                  <a:pt x="18034" y="305701"/>
                </a:lnTo>
                <a:lnTo>
                  <a:pt x="15240" y="304177"/>
                </a:lnTo>
                <a:lnTo>
                  <a:pt x="13970" y="302006"/>
                </a:lnTo>
                <a:lnTo>
                  <a:pt x="13868" y="300228"/>
                </a:lnTo>
                <a:lnTo>
                  <a:pt x="13843" y="295656"/>
                </a:lnTo>
                <a:lnTo>
                  <a:pt x="16510" y="293497"/>
                </a:lnTo>
                <a:lnTo>
                  <a:pt x="21971" y="292862"/>
                </a:lnTo>
                <a:lnTo>
                  <a:pt x="20320" y="281825"/>
                </a:lnTo>
                <a:lnTo>
                  <a:pt x="2286" y="294652"/>
                </a:lnTo>
                <a:lnTo>
                  <a:pt x="2413" y="305435"/>
                </a:lnTo>
                <a:lnTo>
                  <a:pt x="40259" y="320548"/>
                </a:lnTo>
                <a:lnTo>
                  <a:pt x="49441" y="320103"/>
                </a:lnTo>
                <a:lnTo>
                  <a:pt x="75095" y="308737"/>
                </a:lnTo>
                <a:lnTo>
                  <a:pt x="75742" y="307594"/>
                </a:lnTo>
                <a:lnTo>
                  <a:pt x="76962" y="305435"/>
                </a:lnTo>
                <a:lnTo>
                  <a:pt x="76962" y="294005"/>
                </a:lnTo>
                <a:close/>
              </a:path>
              <a:path w="96519" h="483870">
                <a:moveTo>
                  <a:pt x="77470" y="483743"/>
                </a:moveTo>
                <a:lnTo>
                  <a:pt x="77343" y="470916"/>
                </a:lnTo>
                <a:lnTo>
                  <a:pt x="60706" y="466090"/>
                </a:lnTo>
                <a:lnTo>
                  <a:pt x="60667" y="462534"/>
                </a:lnTo>
                <a:lnTo>
                  <a:pt x="60490" y="446151"/>
                </a:lnTo>
                <a:lnTo>
                  <a:pt x="60452" y="442087"/>
                </a:lnTo>
                <a:lnTo>
                  <a:pt x="76962" y="436753"/>
                </a:lnTo>
                <a:lnTo>
                  <a:pt x="76835" y="423672"/>
                </a:lnTo>
                <a:lnTo>
                  <a:pt x="48387" y="433311"/>
                </a:lnTo>
                <a:lnTo>
                  <a:pt x="48387" y="462534"/>
                </a:lnTo>
                <a:lnTo>
                  <a:pt x="21082" y="454660"/>
                </a:lnTo>
                <a:lnTo>
                  <a:pt x="48133" y="446151"/>
                </a:lnTo>
                <a:lnTo>
                  <a:pt x="48387" y="462534"/>
                </a:lnTo>
                <a:lnTo>
                  <a:pt x="48387" y="433311"/>
                </a:lnTo>
                <a:lnTo>
                  <a:pt x="4064" y="448310"/>
                </a:lnTo>
                <a:lnTo>
                  <a:pt x="4191" y="461137"/>
                </a:lnTo>
                <a:lnTo>
                  <a:pt x="77470" y="483743"/>
                </a:lnTo>
                <a:close/>
              </a:path>
              <a:path w="96519" h="483870">
                <a:moveTo>
                  <a:pt x="77978" y="405511"/>
                </a:moveTo>
                <a:lnTo>
                  <a:pt x="58547" y="378587"/>
                </a:lnTo>
                <a:lnTo>
                  <a:pt x="56261" y="389890"/>
                </a:lnTo>
                <a:lnTo>
                  <a:pt x="60071" y="390398"/>
                </a:lnTo>
                <a:lnTo>
                  <a:pt x="62738" y="391414"/>
                </a:lnTo>
                <a:lnTo>
                  <a:pt x="64135" y="392811"/>
                </a:lnTo>
                <a:lnTo>
                  <a:pt x="65659" y="394208"/>
                </a:lnTo>
                <a:lnTo>
                  <a:pt x="66421" y="395986"/>
                </a:lnTo>
                <a:lnTo>
                  <a:pt x="66548" y="401066"/>
                </a:lnTo>
                <a:lnTo>
                  <a:pt x="65278" y="403352"/>
                </a:lnTo>
                <a:lnTo>
                  <a:pt x="62611" y="405130"/>
                </a:lnTo>
                <a:lnTo>
                  <a:pt x="60071" y="406908"/>
                </a:lnTo>
                <a:lnTo>
                  <a:pt x="55626" y="407797"/>
                </a:lnTo>
                <a:lnTo>
                  <a:pt x="49276" y="407797"/>
                </a:lnTo>
                <a:lnTo>
                  <a:pt x="43561" y="407924"/>
                </a:lnTo>
                <a:lnTo>
                  <a:pt x="33401" y="394081"/>
                </a:lnTo>
                <a:lnTo>
                  <a:pt x="36195" y="391414"/>
                </a:lnTo>
                <a:lnTo>
                  <a:pt x="41656" y="390525"/>
                </a:lnTo>
                <a:lnTo>
                  <a:pt x="39116" y="379222"/>
                </a:lnTo>
                <a:lnTo>
                  <a:pt x="33274" y="380746"/>
                </a:lnTo>
                <a:lnTo>
                  <a:pt x="29083" y="383032"/>
                </a:lnTo>
                <a:lnTo>
                  <a:pt x="26416" y="386334"/>
                </a:lnTo>
                <a:lnTo>
                  <a:pt x="23749" y="389509"/>
                </a:lnTo>
                <a:lnTo>
                  <a:pt x="22352" y="393700"/>
                </a:lnTo>
                <a:lnTo>
                  <a:pt x="22479" y="398780"/>
                </a:lnTo>
                <a:lnTo>
                  <a:pt x="22593" y="405384"/>
                </a:lnTo>
                <a:lnTo>
                  <a:pt x="24892" y="410083"/>
                </a:lnTo>
                <a:lnTo>
                  <a:pt x="29718" y="414020"/>
                </a:lnTo>
                <a:lnTo>
                  <a:pt x="34544" y="417830"/>
                </a:lnTo>
                <a:lnTo>
                  <a:pt x="41402" y="419608"/>
                </a:lnTo>
                <a:lnTo>
                  <a:pt x="50546" y="419608"/>
                </a:lnTo>
                <a:lnTo>
                  <a:pt x="58166" y="419481"/>
                </a:lnTo>
                <a:lnTo>
                  <a:pt x="64643" y="417703"/>
                </a:lnTo>
                <a:lnTo>
                  <a:pt x="75311" y="410845"/>
                </a:lnTo>
                <a:lnTo>
                  <a:pt x="76771" y="407924"/>
                </a:lnTo>
                <a:lnTo>
                  <a:pt x="77978" y="405511"/>
                </a:lnTo>
                <a:close/>
              </a:path>
              <a:path w="96519" h="483870">
                <a:moveTo>
                  <a:pt x="96520" y="369697"/>
                </a:moveTo>
                <a:lnTo>
                  <a:pt x="96393" y="358902"/>
                </a:lnTo>
                <a:lnTo>
                  <a:pt x="96393" y="358394"/>
                </a:lnTo>
                <a:lnTo>
                  <a:pt x="96393" y="358140"/>
                </a:lnTo>
                <a:lnTo>
                  <a:pt x="69723" y="358394"/>
                </a:lnTo>
                <a:lnTo>
                  <a:pt x="72644" y="356235"/>
                </a:lnTo>
                <a:lnTo>
                  <a:pt x="74676" y="354076"/>
                </a:lnTo>
                <a:lnTo>
                  <a:pt x="75869" y="352044"/>
                </a:lnTo>
                <a:lnTo>
                  <a:pt x="76835" y="350151"/>
                </a:lnTo>
                <a:lnTo>
                  <a:pt x="77470" y="347980"/>
                </a:lnTo>
                <a:lnTo>
                  <a:pt x="77355" y="346075"/>
                </a:lnTo>
                <a:lnTo>
                  <a:pt x="77266" y="340626"/>
                </a:lnTo>
                <a:lnTo>
                  <a:pt x="76606" y="339471"/>
                </a:lnTo>
                <a:lnTo>
                  <a:pt x="74930" y="336550"/>
                </a:lnTo>
                <a:lnTo>
                  <a:pt x="69977" y="332994"/>
                </a:lnTo>
                <a:lnTo>
                  <a:pt x="66294" y="330301"/>
                </a:lnTo>
                <a:lnTo>
                  <a:pt x="66294" y="346075"/>
                </a:lnTo>
                <a:lnTo>
                  <a:pt x="66217" y="351536"/>
                </a:lnTo>
                <a:lnTo>
                  <a:pt x="64897" y="353822"/>
                </a:lnTo>
                <a:lnTo>
                  <a:pt x="62103" y="355727"/>
                </a:lnTo>
                <a:lnTo>
                  <a:pt x="59309" y="357759"/>
                </a:lnTo>
                <a:lnTo>
                  <a:pt x="54864" y="358775"/>
                </a:lnTo>
                <a:lnTo>
                  <a:pt x="48895" y="358775"/>
                </a:lnTo>
                <a:lnTo>
                  <a:pt x="43688" y="358902"/>
                </a:lnTo>
                <a:lnTo>
                  <a:pt x="39624" y="358013"/>
                </a:lnTo>
                <a:lnTo>
                  <a:pt x="37084" y="356108"/>
                </a:lnTo>
                <a:lnTo>
                  <a:pt x="34417" y="354330"/>
                </a:lnTo>
                <a:lnTo>
                  <a:pt x="33096" y="352171"/>
                </a:lnTo>
                <a:lnTo>
                  <a:pt x="33020" y="346583"/>
                </a:lnTo>
                <a:lnTo>
                  <a:pt x="34290" y="344297"/>
                </a:lnTo>
                <a:lnTo>
                  <a:pt x="36957" y="342404"/>
                </a:lnTo>
                <a:lnTo>
                  <a:pt x="39624" y="340626"/>
                </a:lnTo>
                <a:lnTo>
                  <a:pt x="43815" y="339598"/>
                </a:lnTo>
                <a:lnTo>
                  <a:pt x="49403" y="339598"/>
                </a:lnTo>
                <a:lnTo>
                  <a:pt x="55372" y="339471"/>
                </a:lnTo>
                <a:lnTo>
                  <a:pt x="59690" y="340360"/>
                </a:lnTo>
                <a:lnTo>
                  <a:pt x="62357" y="342150"/>
                </a:lnTo>
                <a:lnTo>
                  <a:pt x="64897" y="343928"/>
                </a:lnTo>
                <a:lnTo>
                  <a:pt x="66294" y="346075"/>
                </a:lnTo>
                <a:lnTo>
                  <a:pt x="66294" y="330301"/>
                </a:lnTo>
                <a:lnTo>
                  <a:pt x="65151" y="329450"/>
                </a:lnTo>
                <a:lnTo>
                  <a:pt x="58166" y="327660"/>
                </a:lnTo>
                <a:lnTo>
                  <a:pt x="40259" y="327926"/>
                </a:lnTo>
                <a:lnTo>
                  <a:pt x="33655" y="329704"/>
                </a:lnTo>
                <a:lnTo>
                  <a:pt x="28956" y="333375"/>
                </a:lnTo>
                <a:lnTo>
                  <a:pt x="24257" y="336931"/>
                </a:lnTo>
                <a:lnTo>
                  <a:pt x="21844" y="341249"/>
                </a:lnTo>
                <a:lnTo>
                  <a:pt x="21971" y="348996"/>
                </a:lnTo>
                <a:lnTo>
                  <a:pt x="22860" y="351536"/>
                </a:lnTo>
                <a:lnTo>
                  <a:pt x="24460" y="354076"/>
                </a:lnTo>
                <a:lnTo>
                  <a:pt x="26035" y="356362"/>
                </a:lnTo>
                <a:lnTo>
                  <a:pt x="28321" y="358267"/>
                </a:lnTo>
                <a:lnTo>
                  <a:pt x="31115" y="359664"/>
                </a:lnTo>
                <a:lnTo>
                  <a:pt x="23368" y="359791"/>
                </a:lnTo>
                <a:lnTo>
                  <a:pt x="23368" y="370459"/>
                </a:lnTo>
                <a:lnTo>
                  <a:pt x="96520" y="36969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4" name="object 44"/>
          <p:cNvSpPr txBox="1"/>
          <p:nvPr/>
        </p:nvSpPr>
        <p:spPr>
          <a:xfrm>
            <a:off x="2256482" y="9339305"/>
            <a:ext cx="429895" cy="567055"/>
          </a:xfrm>
          <a:prstGeom prst="rect">
            <a:avLst/>
          </a:prstGeom>
        </p:spPr>
        <p:txBody>
          <a:bodyPr vert="vert270" wrap="square" lIns="0" tIns="698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5"/>
              </a:spcBef>
            </a:pPr>
            <a:r>
              <a:rPr sz="800" b="1" spc="-10" dirty="0">
                <a:latin typeface="Arial Narrow"/>
                <a:cs typeface="Arial Narrow"/>
              </a:rPr>
              <a:t>Acp6.9-</a:t>
            </a:r>
            <a:r>
              <a:rPr sz="800" b="1" spc="-20" dirty="0">
                <a:latin typeface="Arial Narrow"/>
                <a:cs typeface="Arial Narrow"/>
              </a:rPr>
              <a:t>chiA</a:t>
            </a:r>
            <a:endParaRPr sz="800">
              <a:latin typeface="Arial Narrow"/>
              <a:cs typeface="Arial Narrow"/>
            </a:endParaRPr>
          </a:p>
          <a:p>
            <a:pPr marL="12700">
              <a:lnSpc>
                <a:spcPct val="100000"/>
              </a:lnSpc>
            </a:pPr>
            <a:r>
              <a:rPr sz="800" b="1" dirty="0">
                <a:latin typeface="Arial Narrow"/>
                <a:cs typeface="Arial Narrow"/>
              </a:rPr>
              <a:t>/</a:t>
            </a:r>
            <a:r>
              <a:rPr sz="800" b="1" spc="50" dirty="0">
                <a:latin typeface="Arial Narrow"/>
                <a:cs typeface="Arial Narrow"/>
              </a:rPr>
              <a:t> </a:t>
            </a:r>
            <a:r>
              <a:rPr sz="800" b="1" spc="-10" dirty="0">
                <a:latin typeface="Arial Narrow"/>
                <a:cs typeface="Arial Narrow"/>
              </a:rPr>
              <a:t>polh-</a:t>
            </a:r>
            <a:r>
              <a:rPr sz="800" b="1" spc="-20" dirty="0">
                <a:latin typeface="Arial Narrow"/>
                <a:cs typeface="Arial Narrow"/>
              </a:rPr>
              <a:t>cath</a:t>
            </a:r>
            <a:endParaRPr sz="800">
              <a:latin typeface="Arial Narrow"/>
              <a:cs typeface="Arial Narrow"/>
            </a:endParaRPr>
          </a:p>
          <a:p>
            <a:pPr marL="16510">
              <a:lnSpc>
                <a:spcPct val="100000"/>
              </a:lnSpc>
              <a:spcBef>
                <a:spcPts val="335"/>
              </a:spcBef>
            </a:pPr>
            <a:r>
              <a:rPr sz="800" b="1" dirty="0">
                <a:latin typeface="Arial Narrow"/>
                <a:cs typeface="Arial Narrow"/>
              </a:rPr>
              <a:t>AcMNPV-</a:t>
            </a:r>
            <a:r>
              <a:rPr sz="800" b="1" spc="-25" dirty="0">
                <a:latin typeface="Arial Narrow"/>
                <a:cs typeface="Arial Narrow"/>
              </a:rPr>
              <a:t>Rep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45" name="object 45"/>
          <p:cNvSpPr/>
          <p:nvPr/>
        </p:nvSpPr>
        <p:spPr>
          <a:xfrm>
            <a:off x="2752598" y="9399778"/>
            <a:ext cx="96520" cy="483870"/>
          </a:xfrm>
          <a:custGeom>
            <a:avLst/>
            <a:gdLst/>
            <a:ahLst/>
            <a:cxnLst/>
            <a:rect l="l" t="t" r="r" b="b"/>
            <a:pathLst>
              <a:path w="96519" h="483870">
                <a:moveTo>
                  <a:pt x="13462" y="77597"/>
                </a:moveTo>
                <a:lnTo>
                  <a:pt x="13335" y="66040"/>
                </a:lnTo>
                <a:lnTo>
                  <a:pt x="381" y="66167"/>
                </a:lnTo>
                <a:lnTo>
                  <a:pt x="508" y="77724"/>
                </a:lnTo>
                <a:lnTo>
                  <a:pt x="13462" y="77597"/>
                </a:lnTo>
                <a:close/>
              </a:path>
              <a:path w="96519" h="483870">
                <a:moveTo>
                  <a:pt x="55245" y="203962"/>
                </a:moveTo>
                <a:lnTo>
                  <a:pt x="54991" y="181483"/>
                </a:lnTo>
                <a:lnTo>
                  <a:pt x="41021" y="181610"/>
                </a:lnTo>
                <a:lnTo>
                  <a:pt x="41275" y="204089"/>
                </a:lnTo>
                <a:lnTo>
                  <a:pt x="55245" y="203962"/>
                </a:lnTo>
                <a:close/>
              </a:path>
              <a:path w="96519" h="483870">
                <a:moveTo>
                  <a:pt x="73406" y="60198"/>
                </a:moveTo>
                <a:lnTo>
                  <a:pt x="73279" y="47371"/>
                </a:lnTo>
                <a:lnTo>
                  <a:pt x="56642" y="42545"/>
                </a:lnTo>
                <a:lnTo>
                  <a:pt x="56616" y="38989"/>
                </a:lnTo>
                <a:lnTo>
                  <a:pt x="56527" y="22479"/>
                </a:lnTo>
                <a:lnTo>
                  <a:pt x="56515" y="18542"/>
                </a:lnTo>
                <a:lnTo>
                  <a:pt x="73025" y="13081"/>
                </a:lnTo>
                <a:lnTo>
                  <a:pt x="72898" y="0"/>
                </a:lnTo>
                <a:lnTo>
                  <a:pt x="44323" y="9715"/>
                </a:lnTo>
                <a:lnTo>
                  <a:pt x="44323" y="38989"/>
                </a:lnTo>
                <a:lnTo>
                  <a:pt x="17145" y="31115"/>
                </a:lnTo>
                <a:lnTo>
                  <a:pt x="44069" y="22479"/>
                </a:lnTo>
                <a:lnTo>
                  <a:pt x="44323" y="38989"/>
                </a:lnTo>
                <a:lnTo>
                  <a:pt x="44323" y="9715"/>
                </a:lnTo>
                <a:lnTo>
                  <a:pt x="0" y="24765"/>
                </a:lnTo>
                <a:lnTo>
                  <a:pt x="127" y="37592"/>
                </a:lnTo>
                <a:lnTo>
                  <a:pt x="73406" y="60198"/>
                </a:lnTo>
                <a:close/>
              </a:path>
              <a:path w="96519" h="483870">
                <a:moveTo>
                  <a:pt x="73533" y="76962"/>
                </a:moveTo>
                <a:lnTo>
                  <a:pt x="73406" y="65532"/>
                </a:lnTo>
                <a:lnTo>
                  <a:pt x="20447" y="66040"/>
                </a:lnTo>
                <a:lnTo>
                  <a:pt x="20574" y="77470"/>
                </a:lnTo>
                <a:lnTo>
                  <a:pt x="73533" y="76962"/>
                </a:lnTo>
                <a:close/>
              </a:path>
              <a:path w="96519" h="483870">
                <a:moveTo>
                  <a:pt x="74041" y="127381"/>
                </a:moveTo>
                <a:lnTo>
                  <a:pt x="73914" y="116205"/>
                </a:lnTo>
                <a:lnTo>
                  <a:pt x="73914" y="115824"/>
                </a:lnTo>
                <a:lnTo>
                  <a:pt x="47371" y="116078"/>
                </a:lnTo>
                <a:lnTo>
                  <a:pt x="30353" y="109855"/>
                </a:lnTo>
                <a:lnTo>
                  <a:pt x="30353" y="104140"/>
                </a:lnTo>
                <a:lnTo>
                  <a:pt x="31369" y="102108"/>
                </a:lnTo>
                <a:lnTo>
                  <a:pt x="33655" y="100965"/>
                </a:lnTo>
                <a:lnTo>
                  <a:pt x="35179" y="100076"/>
                </a:lnTo>
                <a:lnTo>
                  <a:pt x="39243" y="99695"/>
                </a:lnTo>
                <a:lnTo>
                  <a:pt x="45720" y="99568"/>
                </a:lnTo>
                <a:lnTo>
                  <a:pt x="73787" y="99314"/>
                </a:lnTo>
                <a:lnTo>
                  <a:pt x="73660" y="87757"/>
                </a:lnTo>
                <a:lnTo>
                  <a:pt x="42545" y="88138"/>
                </a:lnTo>
                <a:lnTo>
                  <a:pt x="36703" y="88138"/>
                </a:lnTo>
                <a:lnTo>
                  <a:pt x="32512" y="88519"/>
                </a:lnTo>
                <a:lnTo>
                  <a:pt x="19634" y="99314"/>
                </a:lnTo>
                <a:lnTo>
                  <a:pt x="19685" y="105664"/>
                </a:lnTo>
                <a:lnTo>
                  <a:pt x="27686" y="116205"/>
                </a:lnTo>
                <a:lnTo>
                  <a:pt x="889" y="116459"/>
                </a:lnTo>
                <a:lnTo>
                  <a:pt x="889" y="128016"/>
                </a:lnTo>
                <a:lnTo>
                  <a:pt x="74041" y="127381"/>
                </a:lnTo>
                <a:close/>
              </a:path>
              <a:path w="96519" h="483870">
                <a:moveTo>
                  <a:pt x="75438" y="270510"/>
                </a:moveTo>
                <a:lnTo>
                  <a:pt x="75311" y="259080"/>
                </a:lnTo>
                <a:lnTo>
                  <a:pt x="61214" y="259207"/>
                </a:lnTo>
                <a:lnTo>
                  <a:pt x="61341" y="270637"/>
                </a:lnTo>
                <a:lnTo>
                  <a:pt x="75438" y="270510"/>
                </a:lnTo>
                <a:close/>
              </a:path>
              <a:path w="96519" h="483870">
                <a:moveTo>
                  <a:pt x="75565" y="154686"/>
                </a:moveTo>
                <a:lnTo>
                  <a:pt x="74269" y="147218"/>
                </a:lnTo>
                <a:lnTo>
                  <a:pt x="70624" y="141389"/>
                </a:lnTo>
                <a:lnTo>
                  <a:pt x="64604" y="137223"/>
                </a:lnTo>
                <a:lnTo>
                  <a:pt x="56261" y="134747"/>
                </a:lnTo>
                <a:lnTo>
                  <a:pt x="53975" y="146050"/>
                </a:lnTo>
                <a:lnTo>
                  <a:pt x="57785" y="146685"/>
                </a:lnTo>
                <a:lnTo>
                  <a:pt x="60325" y="147574"/>
                </a:lnTo>
                <a:lnTo>
                  <a:pt x="63373" y="150368"/>
                </a:lnTo>
                <a:lnTo>
                  <a:pt x="64135" y="152146"/>
                </a:lnTo>
                <a:lnTo>
                  <a:pt x="64135" y="157226"/>
                </a:lnTo>
                <a:lnTo>
                  <a:pt x="46990" y="164084"/>
                </a:lnTo>
                <a:lnTo>
                  <a:pt x="41275" y="164084"/>
                </a:lnTo>
                <a:lnTo>
                  <a:pt x="37211" y="163322"/>
                </a:lnTo>
                <a:lnTo>
                  <a:pt x="34798" y="161544"/>
                </a:lnTo>
                <a:lnTo>
                  <a:pt x="32385" y="159893"/>
                </a:lnTo>
                <a:lnTo>
                  <a:pt x="31115" y="157607"/>
                </a:lnTo>
                <a:lnTo>
                  <a:pt x="31115" y="150368"/>
                </a:lnTo>
                <a:lnTo>
                  <a:pt x="33782" y="147701"/>
                </a:lnTo>
                <a:lnTo>
                  <a:pt x="39370" y="146812"/>
                </a:lnTo>
                <a:lnTo>
                  <a:pt x="36830" y="135509"/>
                </a:lnTo>
                <a:lnTo>
                  <a:pt x="20066" y="149860"/>
                </a:lnTo>
                <a:lnTo>
                  <a:pt x="20104" y="157226"/>
                </a:lnTo>
                <a:lnTo>
                  <a:pt x="39116" y="175895"/>
                </a:lnTo>
                <a:lnTo>
                  <a:pt x="48133" y="175768"/>
                </a:lnTo>
                <a:lnTo>
                  <a:pt x="55753" y="175768"/>
                </a:lnTo>
                <a:lnTo>
                  <a:pt x="62230" y="173990"/>
                </a:lnTo>
                <a:lnTo>
                  <a:pt x="67564" y="170434"/>
                </a:lnTo>
                <a:lnTo>
                  <a:pt x="72898" y="167005"/>
                </a:lnTo>
                <a:lnTo>
                  <a:pt x="74383" y="164084"/>
                </a:lnTo>
                <a:lnTo>
                  <a:pt x="75565" y="161798"/>
                </a:lnTo>
                <a:lnTo>
                  <a:pt x="75565" y="154686"/>
                </a:lnTo>
                <a:close/>
              </a:path>
              <a:path w="96519" h="483870">
                <a:moveTo>
                  <a:pt x="76327" y="237617"/>
                </a:moveTo>
                <a:lnTo>
                  <a:pt x="47663" y="211645"/>
                </a:lnTo>
                <a:lnTo>
                  <a:pt x="40132" y="211391"/>
                </a:lnTo>
                <a:lnTo>
                  <a:pt x="40132" y="234315"/>
                </a:lnTo>
                <a:lnTo>
                  <a:pt x="38989" y="236359"/>
                </a:lnTo>
                <a:lnTo>
                  <a:pt x="34671" y="239407"/>
                </a:lnTo>
                <a:lnTo>
                  <a:pt x="31242" y="240284"/>
                </a:lnTo>
                <a:lnTo>
                  <a:pt x="21844" y="240284"/>
                </a:lnTo>
                <a:lnTo>
                  <a:pt x="18415" y="239649"/>
                </a:lnTo>
                <a:lnTo>
                  <a:pt x="14351" y="236855"/>
                </a:lnTo>
                <a:lnTo>
                  <a:pt x="13335" y="235077"/>
                </a:lnTo>
                <a:lnTo>
                  <a:pt x="13335" y="230759"/>
                </a:lnTo>
                <a:lnTo>
                  <a:pt x="14478" y="228854"/>
                </a:lnTo>
                <a:lnTo>
                  <a:pt x="19304" y="225310"/>
                </a:lnTo>
                <a:lnTo>
                  <a:pt x="22860" y="224409"/>
                </a:lnTo>
                <a:lnTo>
                  <a:pt x="27432" y="224409"/>
                </a:lnTo>
                <a:lnTo>
                  <a:pt x="31623" y="224282"/>
                </a:lnTo>
                <a:lnTo>
                  <a:pt x="34798" y="225056"/>
                </a:lnTo>
                <a:lnTo>
                  <a:pt x="36830" y="226580"/>
                </a:lnTo>
                <a:lnTo>
                  <a:pt x="38989" y="228092"/>
                </a:lnTo>
                <a:lnTo>
                  <a:pt x="39928" y="229882"/>
                </a:lnTo>
                <a:lnTo>
                  <a:pt x="40017" y="232410"/>
                </a:lnTo>
                <a:lnTo>
                  <a:pt x="40132" y="234315"/>
                </a:lnTo>
                <a:lnTo>
                  <a:pt x="40132" y="211391"/>
                </a:lnTo>
                <a:lnTo>
                  <a:pt x="38354" y="211328"/>
                </a:lnTo>
                <a:lnTo>
                  <a:pt x="1854" y="226187"/>
                </a:lnTo>
                <a:lnTo>
                  <a:pt x="1778" y="238010"/>
                </a:lnTo>
                <a:lnTo>
                  <a:pt x="3937" y="242582"/>
                </a:lnTo>
                <a:lnTo>
                  <a:pt x="8382" y="246126"/>
                </a:lnTo>
                <a:lnTo>
                  <a:pt x="12827" y="249809"/>
                </a:lnTo>
                <a:lnTo>
                  <a:pt x="18923" y="251587"/>
                </a:lnTo>
                <a:lnTo>
                  <a:pt x="26670" y="251587"/>
                </a:lnTo>
                <a:lnTo>
                  <a:pt x="33909" y="251460"/>
                </a:lnTo>
                <a:lnTo>
                  <a:pt x="39624" y="249682"/>
                </a:lnTo>
                <a:lnTo>
                  <a:pt x="48260" y="242582"/>
                </a:lnTo>
                <a:lnTo>
                  <a:pt x="49466" y="240284"/>
                </a:lnTo>
                <a:lnTo>
                  <a:pt x="50419" y="238506"/>
                </a:lnTo>
                <a:lnTo>
                  <a:pt x="45593" y="224282"/>
                </a:lnTo>
                <a:lnTo>
                  <a:pt x="44069" y="223139"/>
                </a:lnTo>
                <a:lnTo>
                  <a:pt x="64770" y="236232"/>
                </a:lnTo>
                <a:lnTo>
                  <a:pt x="62103" y="238379"/>
                </a:lnTo>
                <a:lnTo>
                  <a:pt x="56642" y="239014"/>
                </a:lnTo>
                <a:lnTo>
                  <a:pt x="58293" y="250063"/>
                </a:lnTo>
                <a:lnTo>
                  <a:pt x="64389" y="249174"/>
                </a:lnTo>
                <a:lnTo>
                  <a:pt x="68961" y="247281"/>
                </a:lnTo>
                <a:lnTo>
                  <a:pt x="71882" y="244360"/>
                </a:lnTo>
                <a:lnTo>
                  <a:pt x="74803" y="241300"/>
                </a:lnTo>
                <a:lnTo>
                  <a:pt x="76327" y="237617"/>
                </a:lnTo>
                <a:close/>
              </a:path>
              <a:path w="96519" h="483870">
                <a:moveTo>
                  <a:pt x="76962" y="305435"/>
                </a:moveTo>
                <a:lnTo>
                  <a:pt x="76835" y="294005"/>
                </a:lnTo>
                <a:lnTo>
                  <a:pt x="75692" y="291592"/>
                </a:lnTo>
                <a:lnTo>
                  <a:pt x="74676" y="289433"/>
                </a:lnTo>
                <a:lnTo>
                  <a:pt x="70231" y="285750"/>
                </a:lnTo>
                <a:lnTo>
                  <a:pt x="65786" y="282206"/>
                </a:lnTo>
                <a:lnTo>
                  <a:pt x="65278" y="282054"/>
                </a:lnTo>
                <a:lnTo>
                  <a:pt x="65278" y="296926"/>
                </a:lnTo>
                <a:lnTo>
                  <a:pt x="65278" y="301256"/>
                </a:lnTo>
                <a:lnTo>
                  <a:pt x="64135" y="303149"/>
                </a:lnTo>
                <a:lnTo>
                  <a:pt x="59309" y="306705"/>
                </a:lnTo>
                <a:lnTo>
                  <a:pt x="55753" y="307606"/>
                </a:lnTo>
                <a:lnTo>
                  <a:pt x="46990" y="307606"/>
                </a:lnTo>
                <a:lnTo>
                  <a:pt x="43815" y="306959"/>
                </a:lnTo>
                <a:lnTo>
                  <a:pt x="41783" y="305435"/>
                </a:lnTo>
                <a:lnTo>
                  <a:pt x="39624" y="303911"/>
                </a:lnTo>
                <a:lnTo>
                  <a:pt x="38671" y="302133"/>
                </a:lnTo>
                <a:lnTo>
                  <a:pt x="38557" y="299085"/>
                </a:lnTo>
                <a:lnTo>
                  <a:pt x="38481" y="297561"/>
                </a:lnTo>
                <a:lnTo>
                  <a:pt x="39624" y="295656"/>
                </a:lnTo>
                <a:lnTo>
                  <a:pt x="41783" y="294132"/>
                </a:lnTo>
                <a:lnTo>
                  <a:pt x="43942" y="292481"/>
                </a:lnTo>
                <a:lnTo>
                  <a:pt x="47498" y="291731"/>
                </a:lnTo>
                <a:lnTo>
                  <a:pt x="52197" y="291731"/>
                </a:lnTo>
                <a:lnTo>
                  <a:pt x="56769" y="291592"/>
                </a:lnTo>
                <a:lnTo>
                  <a:pt x="60198" y="292354"/>
                </a:lnTo>
                <a:lnTo>
                  <a:pt x="64262" y="295160"/>
                </a:lnTo>
                <a:lnTo>
                  <a:pt x="65278" y="296926"/>
                </a:lnTo>
                <a:lnTo>
                  <a:pt x="65278" y="282054"/>
                </a:lnTo>
                <a:lnTo>
                  <a:pt x="59690" y="280289"/>
                </a:lnTo>
                <a:lnTo>
                  <a:pt x="44831" y="280555"/>
                </a:lnTo>
                <a:lnTo>
                  <a:pt x="38989" y="282333"/>
                </a:lnTo>
                <a:lnTo>
                  <a:pt x="34671" y="285877"/>
                </a:lnTo>
                <a:lnTo>
                  <a:pt x="30353" y="289306"/>
                </a:lnTo>
                <a:lnTo>
                  <a:pt x="28194" y="293509"/>
                </a:lnTo>
                <a:lnTo>
                  <a:pt x="28194" y="300355"/>
                </a:lnTo>
                <a:lnTo>
                  <a:pt x="28829" y="302260"/>
                </a:lnTo>
                <a:lnTo>
                  <a:pt x="30861" y="305816"/>
                </a:lnTo>
                <a:lnTo>
                  <a:pt x="32385" y="307340"/>
                </a:lnTo>
                <a:lnTo>
                  <a:pt x="34544" y="308737"/>
                </a:lnTo>
                <a:lnTo>
                  <a:pt x="26289" y="308356"/>
                </a:lnTo>
                <a:lnTo>
                  <a:pt x="20701" y="307467"/>
                </a:lnTo>
                <a:lnTo>
                  <a:pt x="18034" y="305816"/>
                </a:lnTo>
                <a:lnTo>
                  <a:pt x="15240" y="304165"/>
                </a:lnTo>
                <a:lnTo>
                  <a:pt x="13919" y="302260"/>
                </a:lnTo>
                <a:lnTo>
                  <a:pt x="13843" y="295783"/>
                </a:lnTo>
                <a:lnTo>
                  <a:pt x="16510" y="293509"/>
                </a:lnTo>
                <a:lnTo>
                  <a:pt x="21844" y="292989"/>
                </a:lnTo>
                <a:lnTo>
                  <a:pt x="20320" y="281813"/>
                </a:lnTo>
                <a:lnTo>
                  <a:pt x="14224" y="282702"/>
                </a:lnTo>
                <a:lnTo>
                  <a:pt x="9652" y="284734"/>
                </a:lnTo>
                <a:lnTo>
                  <a:pt x="6731" y="287782"/>
                </a:lnTo>
                <a:lnTo>
                  <a:pt x="3683" y="290830"/>
                </a:lnTo>
                <a:lnTo>
                  <a:pt x="2286" y="294640"/>
                </a:lnTo>
                <a:lnTo>
                  <a:pt x="2286" y="299466"/>
                </a:lnTo>
                <a:lnTo>
                  <a:pt x="40259" y="320675"/>
                </a:lnTo>
                <a:lnTo>
                  <a:pt x="49441" y="320205"/>
                </a:lnTo>
                <a:lnTo>
                  <a:pt x="75095" y="308737"/>
                </a:lnTo>
                <a:lnTo>
                  <a:pt x="75742" y="307606"/>
                </a:lnTo>
                <a:lnTo>
                  <a:pt x="76962" y="305435"/>
                </a:lnTo>
                <a:close/>
              </a:path>
              <a:path w="96519" h="483870">
                <a:moveTo>
                  <a:pt x="77343" y="483870"/>
                </a:moveTo>
                <a:lnTo>
                  <a:pt x="77216" y="470916"/>
                </a:lnTo>
                <a:lnTo>
                  <a:pt x="60706" y="466217"/>
                </a:lnTo>
                <a:lnTo>
                  <a:pt x="60655" y="462534"/>
                </a:lnTo>
                <a:lnTo>
                  <a:pt x="60490" y="446151"/>
                </a:lnTo>
                <a:lnTo>
                  <a:pt x="60452" y="442214"/>
                </a:lnTo>
                <a:lnTo>
                  <a:pt x="76962" y="436753"/>
                </a:lnTo>
                <a:lnTo>
                  <a:pt x="76835" y="423672"/>
                </a:lnTo>
                <a:lnTo>
                  <a:pt x="48260" y="433336"/>
                </a:lnTo>
                <a:lnTo>
                  <a:pt x="48260" y="462534"/>
                </a:lnTo>
                <a:lnTo>
                  <a:pt x="21082" y="454660"/>
                </a:lnTo>
                <a:lnTo>
                  <a:pt x="48133" y="446151"/>
                </a:lnTo>
                <a:lnTo>
                  <a:pt x="48260" y="462534"/>
                </a:lnTo>
                <a:lnTo>
                  <a:pt x="48260" y="433336"/>
                </a:lnTo>
                <a:lnTo>
                  <a:pt x="3937" y="448310"/>
                </a:lnTo>
                <a:lnTo>
                  <a:pt x="4064" y="461137"/>
                </a:lnTo>
                <a:lnTo>
                  <a:pt x="77343" y="483870"/>
                </a:lnTo>
                <a:close/>
              </a:path>
              <a:path w="96519" h="483870">
                <a:moveTo>
                  <a:pt x="77851" y="398526"/>
                </a:moveTo>
                <a:lnTo>
                  <a:pt x="76555" y="391058"/>
                </a:lnTo>
                <a:lnTo>
                  <a:pt x="72910" y="385229"/>
                </a:lnTo>
                <a:lnTo>
                  <a:pt x="66890" y="381063"/>
                </a:lnTo>
                <a:lnTo>
                  <a:pt x="58547" y="378587"/>
                </a:lnTo>
                <a:lnTo>
                  <a:pt x="56261" y="389890"/>
                </a:lnTo>
                <a:lnTo>
                  <a:pt x="60071" y="390525"/>
                </a:lnTo>
                <a:lnTo>
                  <a:pt x="62611" y="391414"/>
                </a:lnTo>
                <a:lnTo>
                  <a:pt x="65659" y="394208"/>
                </a:lnTo>
                <a:lnTo>
                  <a:pt x="66421" y="395986"/>
                </a:lnTo>
                <a:lnTo>
                  <a:pt x="66421" y="401066"/>
                </a:lnTo>
                <a:lnTo>
                  <a:pt x="49276" y="407924"/>
                </a:lnTo>
                <a:lnTo>
                  <a:pt x="43561" y="407924"/>
                </a:lnTo>
                <a:lnTo>
                  <a:pt x="39497" y="407162"/>
                </a:lnTo>
                <a:lnTo>
                  <a:pt x="37084" y="405384"/>
                </a:lnTo>
                <a:lnTo>
                  <a:pt x="34671" y="403733"/>
                </a:lnTo>
                <a:lnTo>
                  <a:pt x="33401" y="401447"/>
                </a:lnTo>
                <a:lnTo>
                  <a:pt x="33401" y="394081"/>
                </a:lnTo>
                <a:lnTo>
                  <a:pt x="36068" y="391541"/>
                </a:lnTo>
                <a:lnTo>
                  <a:pt x="41656" y="390652"/>
                </a:lnTo>
                <a:lnTo>
                  <a:pt x="39116" y="379349"/>
                </a:lnTo>
                <a:lnTo>
                  <a:pt x="22352" y="393700"/>
                </a:lnTo>
                <a:lnTo>
                  <a:pt x="22479" y="405130"/>
                </a:lnTo>
                <a:lnTo>
                  <a:pt x="24892" y="410210"/>
                </a:lnTo>
                <a:lnTo>
                  <a:pt x="29591" y="414020"/>
                </a:lnTo>
                <a:lnTo>
                  <a:pt x="34417" y="417830"/>
                </a:lnTo>
                <a:lnTo>
                  <a:pt x="41402" y="419735"/>
                </a:lnTo>
                <a:lnTo>
                  <a:pt x="50419" y="419608"/>
                </a:lnTo>
                <a:lnTo>
                  <a:pt x="58039" y="419608"/>
                </a:lnTo>
                <a:lnTo>
                  <a:pt x="64516" y="417830"/>
                </a:lnTo>
                <a:lnTo>
                  <a:pt x="69850" y="414274"/>
                </a:lnTo>
                <a:lnTo>
                  <a:pt x="75311" y="410845"/>
                </a:lnTo>
                <a:lnTo>
                  <a:pt x="76695" y="407924"/>
                </a:lnTo>
                <a:lnTo>
                  <a:pt x="77851" y="405511"/>
                </a:lnTo>
                <a:lnTo>
                  <a:pt x="77851" y="398526"/>
                </a:lnTo>
                <a:close/>
              </a:path>
              <a:path w="96519" h="483870">
                <a:moveTo>
                  <a:pt x="96520" y="369824"/>
                </a:moveTo>
                <a:lnTo>
                  <a:pt x="96393" y="358902"/>
                </a:lnTo>
                <a:lnTo>
                  <a:pt x="96393" y="358521"/>
                </a:lnTo>
                <a:lnTo>
                  <a:pt x="96393" y="358267"/>
                </a:lnTo>
                <a:lnTo>
                  <a:pt x="69723" y="358521"/>
                </a:lnTo>
                <a:lnTo>
                  <a:pt x="72644" y="356235"/>
                </a:lnTo>
                <a:lnTo>
                  <a:pt x="74676" y="354203"/>
                </a:lnTo>
                <a:lnTo>
                  <a:pt x="75755" y="352056"/>
                </a:lnTo>
                <a:lnTo>
                  <a:pt x="76835" y="350139"/>
                </a:lnTo>
                <a:lnTo>
                  <a:pt x="77343" y="348107"/>
                </a:lnTo>
                <a:lnTo>
                  <a:pt x="77343" y="340880"/>
                </a:lnTo>
                <a:lnTo>
                  <a:pt x="76593" y="339610"/>
                </a:lnTo>
                <a:lnTo>
                  <a:pt x="74803" y="336550"/>
                </a:lnTo>
                <a:lnTo>
                  <a:pt x="69977" y="333006"/>
                </a:lnTo>
                <a:lnTo>
                  <a:pt x="66294" y="330365"/>
                </a:lnTo>
                <a:lnTo>
                  <a:pt x="66294" y="351536"/>
                </a:lnTo>
                <a:lnTo>
                  <a:pt x="64897" y="353834"/>
                </a:lnTo>
                <a:lnTo>
                  <a:pt x="62103" y="355854"/>
                </a:lnTo>
                <a:lnTo>
                  <a:pt x="59182" y="357759"/>
                </a:lnTo>
                <a:lnTo>
                  <a:pt x="54864" y="358775"/>
                </a:lnTo>
                <a:lnTo>
                  <a:pt x="48895" y="358902"/>
                </a:lnTo>
                <a:lnTo>
                  <a:pt x="43561" y="358902"/>
                </a:lnTo>
                <a:lnTo>
                  <a:pt x="33020" y="346583"/>
                </a:lnTo>
                <a:lnTo>
                  <a:pt x="34290" y="344309"/>
                </a:lnTo>
                <a:lnTo>
                  <a:pt x="36957" y="342531"/>
                </a:lnTo>
                <a:lnTo>
                  <a:pt x="39624" y="340614"/>
                </a:lnTo>
                <a:lnTo>
                  <a:pt x="43815" y="339610"/>
                </a:lnTo>
                <a:lnTo>
                  <a:pt x="55372" y="339610"/>
                </a:lnTo>
                <a:lnTo>
                  <a:pt x="59563" y="340360"/>
                </a:lnTo>
                <a:lnTo>
                  <a:pt x="64897" y="343916"/>
                </a:lnTo>
                <a:lnTo>
                  <a:pt x="66167" y="346075"/>
                </a:lnTo>
                <a:lnTo>
                  <a:pt x="66294" y="351536"/>
                </a:lnTo>
                <a:lnTo>
                  <a:pt x="66294" y="330365"/>
                </a:lnTo>
                <a:lnTo>
                  <a:pt x="65024" y="329438"/>
                </a:lnTo>
                <a:lnTo>
                  <a:pt x="58039" y="327787"/>
                </a:lnTo>
                <a:lnTo>
                  <a:pt x="48895" y="327787"/>
                </a:lnTo>
                <a:lnTo>
                  <a:pt x="21971" y="349008"/>
                </a:lnTo>
                <a:lnTo>
                  <a:pt x="22733" y="351536"/>
                </a:lnTo>
                <a:lnTo>
                  <a:pt x="26035" y="356362"/>
                </a:lnTo>
                <a:lnTo>
                  <a:pt x="28194" y="358267"/>
                </a:lnTo>
                <a:lnTo>
                  <a:pt x="30988" y="359664"/>
                </a:lnTo>
                <a:lnTo>
                  <a:pt x="23241" y="359791"/>
                </a:lnTo>
                <a:lnTo>
                  <a:pt x="23368" y="370459"/>
                </a:lnTo>
                <a:lnTo>
                  <a:pt x="96520" y="36982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6" name="object 46"/>
          <p:cNvSpPr txBox="1"/>
          <p:nvPr/>
        </p:nvSpPr>
        <p:spPr>
          <a:xfrm>
            <a:off x="6886447" y="8844153"/>
            <a:ext cx="469265" cy="47370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83820">
              <a:lnSpc>
                <a:spcPct val="100000"/>
              </a:lnSpc>
              <a:spcBef>
                <a:spcPts val="100"/>
              </a:spcBef>
            </a:pPr>
            <a:r>
              <a:rPr sz="1200" b="1" spc="-20" dirty="0">
                <a:latin typeface="Arial"/>
                <a:cs typeface="Arial"/>
              </a:rPr>
              <a:t>CHIA</a:t>
            </a:r>
            <a:endParaRPr sz="120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885"/>
              </a:spcBef>
            </a:pPr>
            <a:r>
              <a:rPr sz="1000" b="1" spc="-25" dirty="0">
                <a:latin typeface="Arial Narrow"/>
                <a:cs typeface="Arial Narrow"/>
              </a:rPr>
              <a:t>SOL</a:t>
            </a:r>
            <a:endParaRPr sz="1000">
              <a:latin typeface="Arial Narrow"/>
              <a:cs typeface="Arial Narrow"/>
            </a:endParaRPr>
          </a:p>
        </p:txBody>
      </p:sp>
      <p:sp>
        <p:nvSpPr>
          <p:cNvPr id="47" name="object 47"/>
          <p:cNvSpPr/>
          <p:nvPr/>
        </p:nvSpPr>
        <p:spPr>
          <a:xfrm>
            <a:off x="3044951" y="9313164"/>
            <a:ext cx="747395" cy="0"/>
          </a:xfrm>
          <a:custGeom>
            <a:avLst/>
            <a:gdLst/>
            <a:ahLst/>
            <a:cxnLst/>
            <a:rect l="l" t="t" r="r" b="b"/>
            <a:pathLst>
              <a:path w="747395">
                <a:moveTo>
                  <a:pt x="0" y="0"/>
                </a:moveTo>
                <a:lnTo>
                  <a:pt x="360045" y="0"/>
                </a:lnTo>
              </a:path>
              <a:path w="747395">
                <a:moveTo>
                  <a:pt x="387096" y="0"/>
                </a:moveTo>
                <a:lnTo>
                  <a:pt x="747140" y="0"/>
                </a:lnTo>
              </a:path>
            </a:pathLst>
          </a:custGeom>
          <a:ln w="1219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8" name="object 48"/>
          <p:cNvSpPr txBox="1"/>
          <p:nvPr/>
        </p:nvSpPr>
        <p:spPr>
          <a:xfrm>
            <a:off x="2864208" y="9327114"/>
            <a:ext cx="443865" cy="58102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spc="-10" dirty="0">
                <a:latin typeface="Arial Narrow"/>
                <a:cs typeface="Arial Narrow"/>
              </a:rPr>
              <a:t>Acp6.9-</a:t>
            </a:r>
            <a:r>
              <a:rPr sz="800" b="1" spc="-20" dirty="0">
                <a:latin typeface="Arial Narrow"/>
                <a:cs typeface="Arial Narrow"/>
              </a:rPr>
              <a:t>chiA</a:t>
            </a:r>
            <a:endParaRPr sz="800">
              <a:latin typeface="Arial Narrow"/>
              <a:cs typeface="Arial Narrow"/>
            </a:endParaRPr>
          </a:p>
          <a:p>
            <a:pPr marL="12700">
              <a:lnSpc>
                <a:spcPct val="100000"/>
              </a:lnSpc>
            </a:pPr>
            <a:r>
              <a:rPr sz="800" b="1" dirty="0">
                <a:latin typeface="Arial Narrow"/>
                <a:cs typeface="Arial Narrow"/>
              </a:rPr>
              <a:t>/</a:t>
            </a:r>
            <a:r>
              <a:rPr sz="800" b="1" spc="50" dirty="0">
                <a:latin typeface="Arial Narrow"/>
                <a:cs typeface="Arial Narrow"/>
              </a:rPr>
              <a:t> </a:t>
            </a:r>
            <a:r>
              <a:rPr sz="800" b="1" spc="-10" dirty="0">
                <a:latin typeface="Arial Narrow"/>
                <a:cs typeface="Arial Narrow"/>
              </a:rPr>
              <a:t>polh-</a:t>
            </a:r>
            <a:r>
              <a:rPr sz="800" b="1" spc="-20" dirty="0">
                <a:latin typeface="Arial Narrow"/>
                <a:cs typeface="Arial Narrow"/>
              </a:rPr>
              <a:t>cath</a:t>
            </a:r>
            <a:endParaRPr sz="800">
              <a:latin typeface="Arial Narrow"/>
              <a:cs typeface="Arial Narrow"/>
            </a:endParaRPr>
          </a:p>
          <a:p>
            <a:pPr marL="30480">
              <a:lnSpc>
                <a:spcPct val="100000"/>
              </a:lnSpc>
              <a:spcBef>
                <a:spcPts val="450"/>
              </a:spcBef>
            </a:pPr>
            <a:r>
              <a:rPr sz="800" b="1" dirty="0">
                <a:latin typeface="Arial Narrow"/>
                <a:cs typeface="Arial Narrow"/>
              </a:rPr>
              <a:t>AcMNPV-</a:t>
            </a:r>
            <a:r>
              <a:rPr sz="800" b="1" spc="-25" dirty="0">
                <a:latin typeface="Arial Narrow"/>
                <a:cs typeface="Arial Narrow"/>
              </a:rPr>
              <a:t>Rep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49" name="object 49"/>
          <p:cNvSpPr/>
          <p:nvPr/>
        </p:nvSpPr>
        <p:spPr>
          <a:xfrm>
            <a:off x="3915155" y="9311640"/>
            <a:ext cx="748665" cy="0"/>
          </a:xfrm>
          <a:custGeom>
            <a:avLst/>
            <a:gdLst/>
            <a:ahLst/>
            <a:cxnLst/>
            <a:rect l="l" t="t" r="r" b="b"/>
            <a:pathLst>
              <a:path w="748664">
                <a:moveTo>
                  <a:pt x="0" y="0"/>
                </a:moveTo>
                <a:lnTo>
                  <a:pt x="360045" y="0"/>
                </a:lnTo>
              </a:path>
              <a:path w="748664">
                <a:moveTo>
                  <a:pt x="388620" y="0"/>
                </a:moveTo>
                <a:lnTo>
                  <a:pt x="748665" y="0"/>
                </a:lnTo>
              </a:path>
            </a:pathLst>
          </a:custGeom>
          <a:ln w="1219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0" name="object 50"/>
          <p:cNvSpPr txBox="1"/>
          <p:nvPr/>
        </p:nvSpPr>
        <p:spPr>
          <a:xfrm>
            <a:off x="3413505" y="8844438"/>
            <a:ext cx="869950" cy="462280"/>
          </a:xfrm>
          <a:prstGeom prst="rect">
            <a:avLst/>
          </a:prstGeom>
        </p:spPr>
        <p:txBody>
          <a:bodyPr vert="horz" wrap="square" lIns="0" tIns="68580" rIns="0" bIns="0" rtlCol="0">
            <a:spAutoFit/>
          </a:bodyPr>
          <a:lstStyle/>
          <a:p>
            <a:pPr marL="36830">
              <a:lnSpc>
                <a:spcPct val="100000"/>
              </a:lnSpc>
              <a:spcBef>
                <a:spcPts val="540"/>
              </a:spcBef>
            </a:pPr>
            <a:r>
              <a:rPr sz="1200" b="1" spc="-20" dirty="0">
                <a:latin typeface="Arial"/>
                <a:cs typeface="Arial"/>
              </a:rPr>
              <a:t>proV-CATH</a:t>
            </a:r>
            <a:endParaRPr sz="120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360"/>
              </a:spcBef>
              <a:tabLst>
                <a:tab pos="540385" algn="l"/>
              </a:tabLst>
            </a:pPr>
            <a:r>
              <a:rPr sz="1000" b="1" spc="-25" dirty="0">
                <a:latin typeface="Arial Narrow"/>
                <a:cs typeface="Arial Narrow"/>
              </a:rPr>
              <a:t>SOL</a:t>
            </a:r>
            <a:r>
              <a:rPr sz="1000" b="1" dirty="0">
                <a:latin typeface="Arial Narrow"/>
                <a:cs typeface="Arial Narrow"/>
              </a:rPr>
              <a:t>	</a:t>
            </a:r>
            <a:r>
              <a:rPr sz="1000" b="1" spc="-10" dirty="0">
                <a:latin typeface="Arial Narrow"/>
                <a:cs typeface="Arial Narrow"/>
              </a:rPr>
              <a:t>INSOL</a:t>
            </a:r>
            <a:endParaRPr sz="1000">
              <a:latin typeface="Arial Narrow"/>
              <a:cs typeface="Arial Narrow"/>
            </a:endParaRPr>
          </a:p>
        </p:txBody>
      </p:sp>
      <p:sp>
        <p:nvSpPr>
          <p:cNvPr id="51" name="object 51"/>
          <p:cNvSpPr/>
          <p:nvPr/>
        </p:nvSpPr>
        <p:spPr>
          <a:xfrm>
            <a:off x="3364484" y="9387585"/>
            <a:ext cx="96520" cy="483870"/>
          </a:xfrm>
          <a:custGeom>
            <a:avLst/>
            <a:gdLst/>
            <a:ahLst/>
            <a:cxnLst/>
            <a:rect l="l" t="t" r="r" b="b"/>
            <a:pathLst>
              <a:path w="96520" h="483870">
                <a:moveTo>
                  <a:pt x="13462" y="77597"/>
                </a:moveTo>
                <a:lnTo>
                  <a:pt x="13335" y="66040"/>
                </a:lnTo>
                <a:lnTo>
                  <a:pt x="381" y="66167"/>
                </a:lnTo>
                <a:lnTo>
                  <a:pt x="508" y="77724"/>
                </a:lnTo>
                <a:lnTo>
                  <a:pt x="13462" y="77597"/>
                </a:lnTo>
                <a:close/>
              </a:path>
              <a:path w="96520" h="483870">
                <a:moveTo>
                  <a:pt x="55372" y="203962"/>
                </a:moveTo>
                <a:lnTo>
                  <a:pt x="55118" y="181356"/>
                </a:lnTo>
                <a:lnTo>
                  <a:pt x="41148" y="181610"/>
                </a:lnTo>
                <a:lnTo>
                  <a:pt x="41275" y="204089"/>
                </a:lnTo>
                <a:lnTo>
                  <a:pt x="55372" y="203962"/>
                </a:lnTo>
                <a:close/>
              </a:path>
              <a:path w="96520" h="483870">
                <a:moveTo>
                  <a:pt x="73406" y="60198"/>
                </a:moveTo>
                <a:lnTo>
                  <a:pt x="73279" y="47244"/>
                </a:lnTo>
                <a:lnTo>
                  <a:pt x="56769" y="42545"/>
                </a:lnTo>
                <a:lnTo>
                  <a:pt x="56718" y="38862"/>
                </a:lnTo>
                <a:lnTo>
                  <a:pt x="56553" y="22479"/>
                </a:lnTo>
                <a:lnTo>
                  <a:pt x="56515" y="18542"/>
                </a:lnTo>
                <a:lnTo>
                  <a:pt x="73025" y="13081"/>
                </a:lnTo>
                <a:lnTo>
                  <a:pt x="72898" y="0"/>
                </a:lnTo>
                <a:lnTo>
                  <a:pt x="44323" y="9664"/>
                </a:lnTo>
                <a:lnTo>
                  <a:pt x="44323" y="38862"/>
                </a:lnTo>
                <a:lnTo>
                  <a:pt x="17145" y="30988"/>
                </a:lnTo>
                <a:lnTo>
                  <a:pt x="44196" y="22479"/>
                </a:lnTo>
                <a:lnTo>
                  <a:pt x="44323" y="38862"/>
                </a:lnTo>
                <a:lnTo>
                  <a:pt x="44323" y="9664"/>
                </a:lnTo>
                <a:lnTo>
                  <a:pt x="0" y="24638"/>
                </a:lnTo>
                <a:lnTo>
                  <a:pt x="127" y="37465"/>
                </a:lnTo>
                <a:lnTo>
                  <a:pt x="73406" y="60198"/>
                </a:lnTo>
                <a:close/>
              </a:path>
              <a:path w="96520" h="483870">
                <a:moveTo>
                  <a:pt x="73660" y="76962"/>
                </a:moveTo>
                <a:lnTo>
                  <a:pt x="73533" y="65532"/>
                </a:lnTo>
                <a:lnTo>
                  <a:pt x="20574" y="65913"/>
                </a:lnTo>
                <a:lnTo>
                  <a:pt x="20701" y="77470"/>
                </a:lnTo>
                <a:lnTo>
                  <a:pt x="73660" y="76962"/>
                </a:lnTo>
                <a:close/>
              </a:path>
              <a:path w="96520" h="483870">
                <a:moveTo>
                  <a:pt x="74041" y="115824"/>
                </a:moveTo>
                <a:lnTo>
                  <a:pt x="47371" y="116078"/>
                </a:lnTo>
                <a:lnTo>
                  <a:pt x="40894" y="116078"/>
                </a:lnTo>
                <a:lnTo>
                  <a:pt x="36449" y="115316"/>
                </a:lnTo>
                <a:lnTo>
                  <a:pt x="34036" y="113665"/>
                </a:lnTo>
                <a:lnTo>
                  <a:pt x="31623" y="112141"/>
                </a:lnTo>
                <a:lnTo>
                  <a:pt x="30480" y="109855"/>
                </a:lnTo>
                <a:lnTo>
                  <a:pt x="30353" y="104140"/>
                </a:lnTo>
                <a:lnTo>
                  <a:pt x="31496" y="102108"/>
                </a:lnTo>
                <a:lnTo>
                  <a:pt x="35306" y="100076"/>
                </a:lnTo>
                <a:lnTo>
                  <a:pt x="39370" y="99695"/>
                </a:lnTo>
                <a:lnTo>
                  <a:pt x="45847" y="99568"/>
                </a:lnTo>
                <a:lnTo>
                  <a:pt x="73787" y="99314"/>
                </a:lnTo>
                <a:lnTo>
                  <a:pt x="73660" y="87757"/>
                </a:lnTo>
                <a:lnTo>
                  <a:pt x="42672" y="88138"/>
                </a:lnTo>
                <a:lnTo>
                  <a:pt x="36703" y="88138"/>
                </a:lnTo>
                <a:lnTo>
                  <a:pt x="32512" y="88519"/>
                </a:lnTo>
                <a:lnTo>
                  <a:pt x="30099" y="89281"/>
                </a:lnTo>
                <a:lnTo>
                  <a:pt x="26670" y="90297"/>
                </a:lnTo>
                <a:lnTo>
                  <a:pt x="24130" y="92075"/>
                </a:lnTo>
                <a:lnTo>
                  <a:pt x="20574" y="96647"/>
                </a:lnTo>
                <a:lnTo>
                  <a:pt x="19761" y="99314"/>
                </a:lnTo>
                <a:lnTo>
                  <a:pt x="19685" y="105664"/>
                </a:lnTo>
                <a:lnTo>
                  <a:pt x="20320" y="108077"/>
                </a:lnTo>
                <a:lnTo>
                  <a:pt x="21717" y="110236"/>
                </a:lnTo>
                <a:lnTo>
                  <a:pt x="22987" y="112395"/>
                </a:lnTo>
                <a:lnTo>
                  <a:pt x="25019" y="114427"/>
                </a:lnTo>
                <a:lnTo>
                  <a:pt x="27686" y="116205"/>
                </a:lnTo>
                <a:lnTo>
                  <a:pt x="889" y="116459"/>
                </a:lnTo>
                <a:lnTo>
                  <a:pt x="1016" y="128016"/>
                </a:lnTo>
                <a:lnTo>
                  <a:pt x="74041" y="127381"/>
                </a:lnTo>
                <a:lnTo>
                  <a:pt x="74041" y="116078"/>
                </a:lnTo>
                <a:lnTo>
                  <a:pt x="74041" y="115824"/>
                </a:lnTo>
                <a:close/>
              </a:path>
              <a:path w="96520" h="483870">
                <a:moveTo>
                  <a:pt x="75438" y="270522"/>
                </a:moveTo>
                <a:lnTo>
                  <a:pt x="75311" y="259080"/>
                </a:lnTo>
                <a:lnTo>
                  <a:pt x="61341" y="259207"/>
                </a:lnTo>
                <a:lnTo>
                  <a:pt x="61468" y="270649"/>
                </a:lnTo>
                <a:lnTo>
                  <a:pt x="75438" y="270522"/>
                </a:lnTo>
                <a:close/>
              </a:path>
              <a:path w="96520" h="483870">
                <a:moveTo>
                  <a:pt x="75692" y="161671"/>
                </a:moveTo>
                <a:lnTo>
                  <a:pt x="56261" y="134747"/>
                </a:lnTo>
                <a:lnTo>
                  <a:pt x="53975" y="146050"/>
                </a:lnTo>
                <a:lnTo>
                  <a:pt x="57785" y="146685"/>
                </a:lnTo>
                <a:lnTo>
                  <a:pt x="60452" y="147574"/>
                </a:lnTo>
                <a:lnTo>
                  <a:pt x="61849" y="148971"/>
                </a:lnTo>
                <a:lnTo>
                  <a:pt x="63373" y="150368"/>
                </a:lnTo>
                <a:lnTo>
                  <a:pt x="64135" y="152146"/>
                </a:lnTo>
                <a:lnTo>
                  <a:pt x="46990" y="164084"/>
                </a:lnTo>
                <a:lnTo>
                  <a:pt x="41275" y="164084"/>
                </a:lnTo>
                <a:lnTo>
                  <a:pt x="31115" y="150241"/>
                </a:lnTo>
                <a:lnTo>
                  <a:pt x="33909" y="147701"/>
                </a:lnTo>
                <a:lnTo>
                  <a:pt x="39370" y="146812"/>
                </a:lnTo>
                <a:lnTo>
                  <a:pt x="36830" y="135509"/>
                </a:lnTo>
                <a:lnTo>
                  <a:pt x="30988" y="136906"/>
                </a:lnTo>
                <a:lnTo>
                  <a:pt x="26797" y="139319"/>
                </a:lnTo>
                <a:lnTo>
                  <a:pt x="21463" y="145669"/>
                </a:lnTo>
                <a:lnTo>
                  <a:pt x="20066" y="149860"/>
                </a:lnTo>
                <a:lnTo>
                  <a:pt x="20180" y="154686"/>
                </a:lnTo>
                <a:lnTo>
                  <a:pt x="20307" y="161544"/>
                </a:lnTo>
                <a:lnTo>
                  <a:pt x="22606" y="166370"/>
                </a:lnTo>
                <a:lnTo>
                  <a:pt x="32258" y="173990"/>
                </a:lnTo>
                <a:lnTo>
                  <a:pt x="39116" y="175895"/>
                </a:lnTo>
                <a:lnTo>
                  <a:pt x="48260" y="175768"/>
                </a:lnTo>
                <a:lnTo>
                  <a:pt x="55753" y="175768"/>
                </a:lnTo>
                <a:lnTo>
                  <a:pt x="62230" y="173990"/>
                </a:lnTo>
                <a:lnTo>
                  <a:pt x="73025" y="167005"/>
                </a:lnTo>
                <a:lnTo>
                  <a:pt x="74485" y="164084"/>
                </a:lnTo>
                <a:lnTo>
                  <a:pt x="75692" y="161671"/>
                </a:lnTo>
                <a:close/>
              </a:path>
              <a:path w="96520" h="483870">
                <a:moveTo>
                  <a:pt x="76327" y="226568"/>
                </a:moveTo>
                <a:lnTo>
                  <a:pt x="74358" y="223151"/>
                </a:lnTo>
                <a:lnTo>
                  <a:pt x="73279" y="221234"/>
                </a:lnTo>
                <a:lnTo>
                  <a:pt x="67310" y="217170"/>
                </a:lnTo>
                <a:lnTo>
                  <a:pt x="62204" y="214579"/>
                </a:lnTo>
                <a:lnTo>
                  <a:pt x="55689" y="212725"/>
                </a:lnTo>
                <a:lnTo>
                  <a:pt x="47726" y="211645"/>
                </a:lnTo>
                <a:lnTo>
                  <a:pt x="40132" y="211391"/>
                </a:lnTo>
                <a:lnTo>
                  <a:pt x="40132" y="234327"/>
                </a:lnTo>
                <a:lnTo>
                  <a:pt x="39116" y="236220"/>
                </a:lnTo>
                <a:lnTo>
                  <a:pt x="36957" y="237871"/>
                </a:lnTo>
                <a:lnTo>
                  <a:pt x="34671" y="239395"/>
                </a:lnTo>
                <a:lnTo>
                  <a:pt x="31242" y="240157"/>
                </a:lnTo>
                <a:lnTo>
                  <a:pt x="26543" y="240284"/>
                </a:lnTo>
                <a:lnTo>
                  <a:pt x="21844" y="240284"/>
                </a:lnTo>
                <a:lnTo>
                  <a:pt x="18542" y="239649"/>
                </a:lnTo>
                <a:lnTo>
                  <a:pt x="16383" y="238252"/>
                </a:lnTo>
                <a:lnTo>
                  <a:pt x="14351" y="236855"/>
                </a:lnTo>
                <a:lnTo>
                  <a:pt x="13335" y="235077"/>
                </a:lnTo>
                <a:lnTo>
                  <a:pt x="13335" y="230759"/>
                </a:lnTo>
                <a:lnTo>
                  <a:pt x="14605" y="228727"/>
                </a:lnTo>
                <a:lnTo>
                  <a:pt x="17018" y="227076"/>
                </a:lnTo>
                <a:lnTo>
                  <a:pt x="19431" y="225298"/>
                </a:lnTo>
                <a:lnTo>
                  <a:pt x="22987" y="224409"/>
                </a:lnTo>
                <a:lnTo>
                  <a:pt x="27559" y="224282"/>
                </a:lnTo>
                <a:lnTo>
                  <a:pt x="31750" y="224282"/>
                </a:lnTo>
                <a:lnTo>
                  <a:pt x="40132" y="234327"/>
                </a:lnTo>
                <a:lnTo>
                  <a:pt x="40132" y="211391"/>
                </a:lnTo>
                <a:lnTo>
                  <a:pt x="1854" y="226199"/>
                </a:lnTo>
                <a:lnTo>
                  <a:pt x="1778" y="237998"/>
                </a:lnTo>
                <a:lnTo>
                  <a:pt x="4064" y="242443"/>
                </a:lnTo>
                <a:lnTo>
                  <a:pt x="12954" y="249809"/>
                </a:lnTo>
                <a:lnTo>
                  <a:pt x="19050" y="251599"/>
                </a:lnTo>
                <a:lnTo>
                  <a:pt x="26670" y="251472"/>
                </a:lnTo>
                <a:lnTo>
                  <a:pt x="33909" y="251472"/>
                </a:lnTo>
                <a:lnTo>
                  <a:pt x="39624" y="249682"/>
                </a:lnTo>
                <a:lnTo>
                  <a:pt x="48260" y="242570"/>
                </a:lnTo>
                <a:lnTo>
                  <a:pt x="49466" y="240284"/>
                </a:lnTo>
                <a:lnTo>
                  <a:pt x="50419" y="238506"/>
                </a:lnTo>
                <a:lnTo>
                  <a:pt x="50419" y="231775"/>
                </a:lnTo>
                <a:lnTo>
                  <a:pt x="49911" y="229743"/>
                </a:lnTo>
                <a:lnTo>
                  <a:pt x="48768" y="227977"/>
                </a:lnTo>
                <a:lnTo>
                  <a:pt x="47752" y="226199"/>
                </a:lnTo>
                <a:lnTo>
                  <a:pt x="46228" y="224548"/>
                </a:lnTo>
                <a:lnTo>
                  <a:pt x="45847" y="224282"/>
                </a:lnTo>
                <a:lnTo>
                  <a:pt x="44196" y="223151"/>
                </a:lnTo>
                <a:lnTo>
                  <a:pt x="52451" y="223520"/>
                </a:lnTo>
                <a:lnTo>
                  <a:pt x="57912" y="224548"/>
                </a:lnTo>
                <a:lnTo>
                  <a:pt x="60706" y="226199"/>
                </a:lnTo>
                <a:lnTo>
                  <a:pt x="63373" y="227723"/>
                </a:lnTo>
                <a:lnTo>
                  <a:pt x="64681" y="229743"/>
                </a:lnTo>
                <a:lnTo>
                  <a:pt x="64770" y="236220"/>
                </a:lnTo>
                <a:lnTo>
                  <a:pt x="62103" y="238379"/>
                </a:lnTo>
                <a:lnTo>
                  <a:pt x="56642" y="239026"/>
                </a:lnTo>
                <a:lnTo>
                  <a:pt x="58293" y="250075"/>
                </a:lnTo>
                <a:lnTo>
                  <a:pt x="76225" y="237871"/>
                </a:lnTo>
                <a:lnTo>
                  <a:pt x="76327" y="226568"/>
                </a:lnTo>
                <a:close/>
              </a:path>
              <a:path w="96520" h="483870">
                <a:moveTo>
                  <a:pt x="76962" y="294005"/>
                </a:moveTo>
                <a:lnTo>
                  <a:pt x="75755" y="291592"/>
                </a:lnTo>
                <a:lnTo>
                  <a:pt x="74676" y="289433"/>
                </a:lnTo>
                <a:lnTo>
                  <a:pt x="65786" y="282067"/>
                </a:lnTo>
                <a:lnTo>
                  <a:pt x="65405" y="281965"/>
                </a:lnTo>
                <a:lnTo>
                  <a:pt x="65405" y="301244"/>
                </a:lnTo>
                <a:lnTo>
                  <a:pt x="64135" y="303149"/>
                </a:lnTo>
                <a:lnTo>
                  <a:pt x="59309" y="306705"/>
                </a:lnTo>
                <a:lnTo>
                  <a:pt x="55753" y="307594"/>
                </a:lnTo>
                <a:lnTo>
                  <a:pt x="46990" y="307594"/>
                </a:lnTo>
                <a:lnTo>
                  <a:pt x="43942" y="306832"/>
                </a:lnTo>
                <a:lnTo>
                  <a:pt x="41783" y="305308"/>
                </a:lnTo>
                <a:lnTo>
                  <a:pt x="39751" y="303923"/>
                </a:lnTo>
                <a:lnTo>
                  <a:pt x="38671" y="302133"/>
                </a:lnTo>
                <a:lnTo>
                  <a:pt x="38608" y="297573"/>
                </a:lnTo>
                <a:lnTo>
                  <a:pt x="39624" y="295656"/>
                </a:lnTo>
                <a:lnTo>
                  <a:pt x="41910" y="294005"/>
                </a:lnTo>
                <a:lnTo>
                  <a:pt x="44069" y="292481"/>
                </a:lnTo>
                <a:lnTo>
                  <a:pt x="47498" y="291719"/>
                </a:lnTo>
                <a:lnTo>
                  <a:pt x="52324" y="291719"/>
                </a:lnTo>
                <a:lnTo>
                  <a:pt x="56896" y="291592"/>
                </a:lnTo>
                <a:lnTo>
                  <a:pt x="60198" y="292354"/>
                </a:lnTo>
                <a:lnTo>
                  <a:pt x="64262" y="295148"/>
                </a:lnTo>
                <a:lnTo>
                  <a:pt x="65278" y="296926"/>
                </a:lnTo>
                <a:lnTo>
                  <a:pt x="65405" y="301244"/>
                </a:lnTo>
                <a:lnTo>
                  <a:pt x="65405" y="281965"/>
                </a:lnTo>
                <a:lnTo>
                  <a:pt x="59817" y="280301"/>
                </a:lnTo>
                <a:lnTo>
                  <a:pt x="52070" y="280416"/>
                </a:lnTo>
                <a:lnTo>
                  <a:pt x="44831" y="280416"/>
                </a:lnTo>
                <a:lnTo>
                  <a:pt x="38989" y="282321"/>
                </a:lnTo>
                <a:lnTo>
                  <a:pt x="34671" y="285750"/>
                </a:lnTo>
                <a:lnTo>
                  <a:pt x="30353" y="289306"/>
                </a:lnTo>
                <a:lnTo>
                  <a:pt x="28194" y="293497"/>
                </a:lnTo>
                <a:lnTo>
                  <a:pt x="28321" y="300228"/>
                </a:lnTo>
                <a:lnTo>
                  <a:pt x="34544" y="308749"/>
                </a:lnTo>
                <a:lnTo>
                  <a:pt x="26289" y="308356"/>
                </a:lnTo>
                <a:lnTo>
                  <a:pt x="13843" y="295783"/>
                </a:lnTo>
                <a:lnTo>
                  <a:pt x="16510" y="293497"/>
                </a:lnTo>
                <a:lnTo>
                  <a:pt x="21971" y="293001"/>
                </a:lnTo>
                <a:lnTo>
                  <a:pt x="20320" y="281825"/>
                </a:lnTo>
                <a:lnTo>
                  <a:pt x="2286" y="294652"/>
                </a:lnTo>
                <a:lnTo>
                  <a:pt x="2413" y="305447"/>
                </a:lnTo>
                <a:lnTo>
                  <a:pt x="40259" y="320548"/>
                </a:lnTo>
                <a:lnTo>
                  <a:pt x="49441" y="320103"/>
                </a:lnTo>
                <a:lnTo>
                  <a:pt x="75742" y="307594"/>
                </a:lnTo>
                <a:lnTo>
                  <a:pt x="76962" y="305447"/>
                </a:lnTo>
                <a:lnTo>
                  <a:pt x="76962" y="294005"/>
                </a:lnTo>
                <a:close/>
              </a:path>
              <a:path w="96520" h="483870">
                <a:moveTo>
                  <a:pt x="77470" y="483870"/>
                </a:moveTo>
                <a:lnTo>
                  <a:pt x="77343" y="470916"/>
                </a:lnTo>
                <a:lnTo>
                  <a:pt x="60706" y="466217"/>
                </a:lnTo>
                <a:lnTo>
                  <a:pt x="60655" y="462534"/>
                </a:lnTo>
                <a:lnTo>
                  <a:pt x="60490" y="446151"/>
                </a:lnTo>
                <a:lnTo>
                  <a:pt x="60452" y="442214"/>
                </a:lnTo>
                <a:lnTo>
                  <a:pt x="76962" y="436753"/>
                </a:lnTo>
                <a:lnTo>
                  <a:pt x="76835" y="423672"/>
                </a:lnTo>
                <a:lnTo>
                  <a:pt x="48387" y="433311"/>
                </a:lnTo>
                <a:lnTo>
                  <a:pt x="48387" y="462534"/>
                </a:lnTo>
                <a:lnTo>
                  <a:pt x="21082" y="454660"/>
                </a:lnTo>
                <a:lnTo>
                  <a:pt x="48133" y="446151"/>
                </a:lnTo>
                <a:lnTo>
                  <a:pt x="48387" y="462534"/>
                </a:lnTo>
                <a:lnTo>
                  <a:pt x="48387" y="433311"/>
                </a:lnTo>
                <a:lnTo>
                  <a:pt x="4064" y="448310"/>
                </a:lnTo>
                <a:lnTo>
                  <a:pt x="4191" y="461137"/>
                </a:lnTo>
                <a:lnTo>
                  <a:pt x="77470" y="483870"/>
                </a:lnTo>
                <a:close/>
              </a:path>
              <a:path w="96520" h="483870">
                <a:moveTo>
                  <a:pt x="77978" y="405511"/>
                </a:moveTo>
                <a:lnTo>
                  <a:pt x="58547" y="378587"/>
                </a:lnTo>
                <a:lnTo>
                  <a:pt x="56261" y="389890"/>
                </a:lnTo>
                <a:lnTo>
                  <a:pt x="60071" y="390398"/>
                </a:lnTo>
                <a:lnTo>
                  <a:pt x="62738" y="391414"/>
                </a:lnTo>
                <a:lnTo>
                  <a:pt x="64135" y="392811"/>
                </a:lnTo>
                <a:lnTo>
                  <a:pt x="65659" y="394208"/>
                </a:lnTo>
                <a:lnTo>
                  <a:pt x="66421" y="395986"/>
                </a:lnTo>
                <a:lnTo>
                  <a:pt x="66433" y="398526"/>
                </a:lnTo>
                <a:lnTo>
                  <a:pt x="66548" y="401066"/>
                </a:lnTo>
                <a:lnTo>
                  <a:pt x="65278" y="403352"/>
                </a:lnTo>
                <a:lnTo>
                  <a:pt x="62611" y="405130"/>
                </a:lnTo>
                <a:lnTo>
                  <a:pt x="60071" y="406908"/>
                </a:lnTo>
                <a:lnTo>
                  <a:pt x="55626" y="407797"/>
                </a:lnTo>
                <a:lnTo>
                  <a:pt x="49276" y="407924"/>
                </a:lnTo>
                <a:lnTo>
                  <a:pt x="43561" y="407924"/>
                </a:lnTo>
                <a:lnTo>
                  <a:pt x="33401" y="394081"/>
                </a:lnTo>
                <a:lnTo>
                  <a:pt x="36195" y="391414"/>
                </a:lnTo>
                <a:lnTo>
                  <a:pt x="41656" y="390525"/>
                </a:lnTo>
                <a:lnTo>
                  <a:pt x="39116" y="379349"/>
                </a:lnTo>
                <a:lnTo>
                  <a:pt x="33274" y="380746"/>
                </a:lnTo>
                <a:lnTo>
                  <a:pt x="29083" y="383032"/>
                </a:lnTo>
                <a:lnTo>
                  <a:pt x="26416" y="386334"/>
                </a:lnTo>
                <a:lnTo>
                  <a:pt x="23749" y="389509"/>
                </a:lnTo>
                <a:lnTo>
                  <a:pt x="22352" y="393700"/>
                </a:lnTo>
                <a:lnTo>
                  <a:pt x="22466" y="398526"/>
                </a:lnTo>
                <a:lnTo>
                  <a:pt x="22593" y="405384"/>
                </a:lnTo>
                <a:lnTo>
                  <a:pt x="24892" y="410210"/>
                </a:lnTo>
                <a:lnTo>
                  <a:pt x="34544" y="417830"/>
                </a:lnTo>
                <a:lnTo>
                  <a:pt x="41402" y="419735"/>
                </a:lnTo>
                <a:lnTo>
                  <a:pt x="50546" y="419608"/>
                </a:lnTo>
                <a:lnTo>
                  <a:pt x="58166" y="419608"/>
                </a:lnTo>
                <a:lnTo>
                  <a:pt x="64643" y="417830"/>
                </a:lnTo>
                <a:lnTo>
                  <a:pt x="69977" y="414274"/>
                </a:lnTo>
                <a:lnTo>
                  <a:pt x="75311" y="410845"/>
                </a:lnTo>
                <a:lnTo>
                  <a:pt x="76771" y="407924"/>
                </a:lnTo>
                <a:lnTo>
                  <a:pt x="77978" y="405511"/>
                </a:lnTo>
                <a:close/>
              </a:path>
              <a:path w="96520" h="483870">
                <a:moveTo>
                  <a:pt x="96520" y="369697"/>
                </a:moveTo>
                <a:lnTo>
                  <a:pt x="96393" y="358902"/>
                </a:lnTo>
                <a:lnTo>
                  <a:pt x="96393" y="358521"/>
                </a:lnTo>
                <a:lnTo>
                  <a:pt x="96393" y="358267"/>
                </a:lnTo>
                <a:lnTo>
                  <a:pt x="69723" y="358521"/>
                </a:lnTo>
                <a:lnTo>
                  <a:pt x="72644" y="356247"/>
                </a:lnTo>
                <a:lnTo>
                  <a:pt x="74676" y="354203"/>
                </a:lnTo>
                <a:lnTo>
                  <a:pt x="75882" y="352044"/>
                </a:lnTo>
                <a:lnTo>
                  <a:pt x="76835" y="350151"/>
                </a:lnTo>
                <a:lnTo>
                  <a:pt x="77470" y="347980"/>
                </a:lnTo>
                <a:lnTo>
                  <a:pt x="77343" y="340741"/>
                </a:lnTo>
                <a:lnTo>
                  <a:pt x="76606" y="339471"/>
                </a:lnTo>
                <a:lnTo>
                  <a:pt x="74930" y="336550"/>
                </a:lnTo>
                <a:lnTo>
                  <a:pt x="69977" y="332994"/>
                </a:lnTo>
                <a:lnTo>
                  <a:pt x="66294" y="330301"/>
                </a:lnTo>
                <a:lnTo>
                  <a:pt x="66294" y="346075"/>
                </a:lnTo>
                <a:lnTo>
                  <a:pt x="54864" y="358775"/>
                </a:lnTo>
                <a:lnTo>
                  <a:pt x="48895" y="358775"/>
                </a:lnTo>
                <a:lnTo>
                  <a:pt x="43688" y="358902"/>
                </a:lnTo>
                <a:lnTo>
                  <a:pt x="39624" y="358025"/>
                </a:lnTo>
                <a:lnTo>
                  <a:pt x="37084" y="356108"/>
                </a:lnTo>
                <a:lnTo>
                  <a:pt x="34417" y="354330"/>
                </a:lnTo>
                <a:lnTo>
                  <a:pt x="33096" y="352171"/>
                </a:lnTo>
                <a:lnTo>
                  <a:pt x="33020" y="346583"/>
                </a:lnTo>
                <a:lnTo>
                  <a:pt x="34290" y="344297"/>
                </a:lnTo>
                <a:lnTo>
                  <a:pt x="36957" y="342392"/>
                </a:lnTo>
                <a:lnTo>
                  <a:pt x="39624" y="340626"/>
                </a:lnTo>
                <a:lnTo>
                  <a:pt x="43815" y="339598"/>
                </a:lnTo>
                <a:lnTo>
                  <a:pt x="49403" y="339598"/>
                </a:lnTo>
                <a:lnTo>
                  <a:pt x="55372" y="339471"/>
                </a:lnTo>
                <a:lnTo>
                  <a:pt x="59690" y="340372"/>
                </a:lnTo>
                <a:lnTo>
                  <a:pt x="62357" y="342150"/>
                </a:lnTo>
                <a:lnTo>
                  <a:pt x="64897" y="343916"/>
                </a:lnTo>
                <a:lnTo>
                  <a:pt x="66294" y="346075"/>
                </a:lnTo>
                <a:lnTo>
                  <a:pt x="66294" y="330301"/>
                </a:lnTo>
                <a:lnTo>
                  <a:pt x="65151" y="329450"/>
                </a:lnTo>
                <a:lnTo>
                  <a:pt x="58166" y="327799"/>
                </a:lnTo>
                <a:lnTo>
                  <a:pt x="49022" y="327799"/>
                </a:lnTo>
                <a:lnTo>
                  <a:pt x="40259" y="327926"/>
                </a:lnTo>
                <a:lnTo>
                  <a:pt x="33655" y="329692"/>
                </a:lnTo>
                <a:lnTo>
                  <a:pt x="28956" y="333375"/>
                </a:lnTo>
                <a:lnTo>
                  <a:pt x="24257" y="336931"/>
                </a:lnTo>
                <a:lnTo>
                  <a:pt x="21844" y="341249"/>
                </a:lnTo>
                <a:lnTo>
                  <a:pt x="21971" y="348996"/>
                </a:lnTo>
                <a:lnTo>
                  <a:pt x="22860" y="351548"/>
                </a:lnTo>
                <a:lnTo>
                  <a:pt x="24638" y="354330"/>
                </a:lnTo>
                <a:lnTo>
                  <a:pt x="26035" y="356374"/>
                </a:lnTo>
                <a:lnTo>
                  <a:pt x="28321" y="358267"/>
                </a:lnTo>
                <a:lnTo>
                  <a:pt x="31115" y="359676"/>
                </a:lnTo>
                <a:lnTo>
                  <a:pt x="23368" y="359791"/>
                </a:lnTo>
                <a:lnTo>
                  <a:pt x="23368" y="370459"/>
                </a:lnTo>
                <a:lnTo>
                  <a:pt x="96520" y="36969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2" name="object 52"/>
          <p:cNvSpPr txBox="1"/>
          <p:nvPr/>
        </p:nvSpPr>
        <p:spPr>
          <a:xfrm>
            <a:off x="3476221" y="9328638"/>
            <a:ext cx="418465" cy="56705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dirty="0">
                <a:latin typeface="Arial Narrow"/>
                <a:cs typeface="Arial Narrow"/>
              </a:rPr>
              <a:t>Acp6.9-</a:t>
            </a:r>
            <a:r>
              <a:rPr sz="800" b="1" spc="-20" dirty="0">
                <a:latin typeface="Arial Narrow"/>
                <a:cs typeface="Arial Narrow"/>
              </a:rPr>
              <a:t>chiA</a:t>
            </a:r>
            <a:endParaRPr sz="800">
              <a:latin typeface="Arial Narrow"/>
              <a:cs typeface="Arial Narrow"/>
            </a:endParaRPr>
          </a:p>
          <a:p>
            <a:pPr marL="12700">
              <a:lnSpc>
                <a:spcPct val="100000"/>
              </a:lnSpc>
            </a:pPr>
            <a:r>
              <a:rPr sz="800" b="1" dirty="0">
                <a:latin typeface="Arial Narrow"/>
                <a:cs typeface="Arial Narrow"/>
              </a:rPr>
              <a:t>/</a:t>
            </a:r>
            <a:r>
              <a:rPr sz="800" b="1" spc="5" dirty="0">
                <a:latin typeface="Arial Narrow"/>
                <a:cs typeface="Arial Narrow"/>
              </a:rPr>
              <a:t> </a:t>
            </a:r>
            <a:r>
              <a:rPr sz="800" b="1" dirty="0">
                <a:latin typeface="Arial Narrow"/>
                <a:cs typeface="Arial Narrow"/>
              </a:rPr>
              <a:t>polh-</a:t>
            </a:r>
            <a:r>
              <a:rPr sz="800" b="1" spc="-20" dirty="0">
                <a:latin typeface="Arial Narrow"/>
                <a:cs typeface="Arial Narrow"/>
              </a:rPr>
              <a:t>cath</a:t>
            </a:r>
            <a:endParaRPr sz="800">
              <a:latin typeface="Arial Narrow"/>
              <a:cs typeface="Arial Narrow"/>
            </a:endParaRPr>
          </a:p>
          <a:p>
            <a:pPr marL="16510">
              <a:lnSpc>
                <a:spcPct val="100000"/>
              </a:lnSpc>
              <a:spcBef>
                <a:spcPts val="254"/>
              </a:spcBef>
            </a:pPr>
            <a:r>
              <a:rPr sz="800" b="1" dirty="0">
                <a:latin typeface="Arial Narrow"/>
                <a:cs typeface="Arial Narrow"/>
              </a:rPr>
              <a:t>AcMNPV-</a:t>
            </a:r>
            <a:r>
              <a:rPr sz="800" b="1" spc="-25" dirty="0">
                <a:latin typeface="Arial Narrow"/>
                <a:cs typeface="Arial Narrow"/>
              </a:rPr>
              <a:t>Rep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53" name="object 53"/>
          <p:cNvSpPr/>
          <p:nvPr/>
        </p:nvSpPr>
        <p:spPr>
          <a:xfrm>
            <a:off x="3960876" y="9388856"/>
            <a:ext cx="96520" cy="483870"/>
          </a:xfrm>
          <a:custGeom>
            <a:avLst/>
            <a:gdLst/>
            <a:ahLst/>
            <a:cxnLst/>
            <a:rect l="l" t="t" r="r" b="b"/>
            <a:pathLst>
              <a:path w="96520" h="483870">
                <a:moveTo>
                  <a:pt x="13462" y="77597"/>
                </a:moveTo>
                <a:lnTo>
                  <a:pt x="13335" y="66040"/>
                </a:lnTo>
                <a:lnTo>
                  <a:pt x="381" y="66167"/>
                </a:lnTo>
                <a:lnTo>
                  <a:pt x="508" y="77724"/>
                </a:lnTo>
                <a:lnTo>
                  <a:pt x="13462" y="77597"/>
                </a:lnTo>
                <a:close/>
              </a:path>
              <a:path w="96520" h="483870">
                <a:moveTo>
                  <a:pt x="55245" y="204089"/>
                </a:moveTo>
                <a:lnTo>
                  <a:pt x="55118" y="181483"/>
                </a:lnTo>
                <a:lnTo>
                  <a:pt x="41021" y="181610"/>
                </a:lnTo>
                <a:lnTo>
                  <a:pt x="41275" y="204216"/>
                </a:lnTo>
                <a:lnTo>
                  <a:pt x="55245" y="204089"/>
                </a:lnTo>
                <a:close/>
              </a:path>
              <a:path w="96520" h="483870">
                <a:moveTo>
                  <a:pt x="73406" y="60198"/>
                </a:moveTo>
                <a:lnTo>
                  <a:pt x="73279" y="47371"/>
                </a:lnTo>
                <a:lnTo>
                  <a:pt x="56769" y="42545"/>
                </a:lnTo>
                <a:lnTo>
                  <a:pt x="56730" y="38989"/>
                </a:lnTo>
                <a:lnTo>
                  <a:pt x="56553" y="22606"/>
                </a:lnTo>
                <a:lnTo>
                  <a:pt x="56515" y="18542"/>
                </a:lnTo>
                <a:lnTo>
                  <a:pt x="73025" y="13208"/>
                </a:lnTo>
                <a:lnTo>
                  <a:pt x="72898" y="0"/>
                </a:lnTo>
                <a:lnTo>
                  <a:pt x="44323" y="9715"/>
                </a:lnTo>
                <a:lnTo>
                  <a:pt x="44323" y="38989"/>
                </a:lnTo>
                <a:lnTo>
                  <a:pt x="17145" y="31115"/>
                </a:lnTo>
                <a:lnTo>
                  <a:pt x="44196" y="22606"/>
                </a:lnTo>
                <a:lnTo>
                  <a:pt x="44323" y="38989"/>
                </a:lnTo>
                <a:lnTo>
                  <a:pt x="44323" y="9715"/>
                </a:lnTo>
                <a:lnTo>
                  <a:pt x="0" y="24765"/>
                </a:lnTo>
                <a:lnTo>
                  <a:pt x="127" y="37592"/>
                </a:lnTo>
                <a:lnTo>
                  <a:pt x="73406" y="60198"/>
                </a:lnTo>
                <a:close/>
              </a:path>
              <a:path w="96520" h="483870">
                <a:moveTo>
                  <a:pt x="73660" y="77089"/>
                </a:moveTo>
                <a:lnTo>
                  <a:pt x="73533" y="65532"/>
                </a:lnTo>
                <a:lnTo>
                  <a:pt x="20574" y="66040"/>
                </a:lnTo>
                <a:lnTo>
                  <a:pt x="20701" y="77597"/>
                </a:lnTo>
                <a:lnTo>
                  <a:pt x="73660" y="77089"/>
                </a:lnTo>
                <a:close/>
              </a:path>
              <a:path w="96520" h="483870">
                <a:moveTo>
                  <a:pt x="74041" y="127381"/>
                </a:moveTo>
                <a:lnTo>
                  <a:pt x="73914" y="116205"/>
                </a:lnTo>
                <a:lnTo>
                  <a:pt x="73914" y="115824"/>
                </a:lnTo>
                <a:lnTo>
                  <a:pt x="47371" y="116078"/>
                </a:lnTo>
                <a:lnTo>
                  <a:pt x="30353" y="104140"/>
                </a:lnTo>
                <a:lnTo>
                  <a:pt x="31496" y="102108"/>
                </a:lnTo>
                <a:lnTo>
                  <a:pt x="35306" y="100076"/>
                </a:lnTo>
                <a:lnTo>
                  <a:pt x="39370" y="99695"/>
                </a:lnTo>
                <a:lnTo>
                  <a:pt x="45847" y="99568"/>
                </a:lnTo>
                <a:lnTo>
                  <a:pt x="73787" y="99314"/>
                </a:lnTo>
                <a:lnTo>
                  <a:pt x="73660" y="87884"/>
                </a:lnTo>
                <a:lnTo>
                  <a:pt x="42672" y="88138"/>
                </a:lnTo>
                <a:lnTo>
                  <a:pt x="36703" y="88138"/>
                </a:lnTo>
                <a:lnTo>
                  <a:pt x="32512" y="88646"/>
                </a:lnTo>
                <a:lnTo>
                  <a:pt x="30099" y="89408"/>
                </a:lnTo>
                <a:lnTo>
                  <a:pt x="26670" y="90424"/>
                </a:lnTo>
                <a:lnTo>
                  <a:pt x="24130" y="92075"/>
                </a:lnTo>
                <a:lnTo>
                  <a:pt x="20447" y="96774"/>
                </a:lnTo>
                <a:lnTo>
                  <a:pt x="19672" y="99314"/>
                </a:lnTo>
                <a:lnTo>
                  <a:pt x="19685" y="105664"/>
                </a:lnTo>
                <a:lnTo>
                  <a:pt x="20320" y="108077"/>
                </a:lnTo>
                <a:lnTo>
                  <a:pt x="21717" y="110236"/>
                </a:lnTo>
                <a:lnTo>
                  <a:pt x="22987" y="112522"/>
                </a:lnTo>
                <a:lnTo>
                  <a:pt x="25019" y="114554"/>
                </a:lnTo>
                <a:lnTo>
                  <a:pt x="27686" y="116332"/>
                </a:lnTo>
                <a:lnTo>
                  <a:pt x="889" y="116586"/>
                </a:lnTo>
                <a:lnTo>
                  <a:pt x="1016" y="128016"/>
                </a:lnTo>
                <a:lnTo>
                  <a:pt x="74041" y="127381"/>
                </a:lnTo>
                <a:close/>
              </a:path>
              <a:path w="96520" h="483870">
                <a:moveTo>
                  <a:pt x="75438" y="270637"/>
                </a:moveTo>
                <a:lnTo>
                  <a:pt x="75311" y="259080"/>
                </a:lnTo>
                <a:lnTo>
                  <a:pt x="61341" y="259207"/>
                </a:lnTo>
                <a:lnTo>
                  <a:pt x="61468" y="270764"/>
                </a:lnTo>
                <a:lnTo>
                  <a:pt x="75438" y="270637"/>
                </a:lnTo>
                <a:close/>
              </a:path>
              <a:path w="96520" h="483870">
                <a:moveTo>
                  <a:pt x="75692" y="161798"/>
                </a:moveTo>
                <a:lnTo>
                  <a:pt x="56261" y="134747"/>
                </a:lnTo>
                <a:lnTo>
                  <a:pt x="53975" y="146177"/>
                </a:lnTo>
                <a:lnTo>
                  <a:pt x="57785" y="146685"/>
                </a:lnTo>
                <a:lnTo>
                  <a:pt x="60452" y="147701"/>
                </a:lnTo>
                <a:lnTo>
                  <a:pt x="61849" y="149098"/>
                </a:lnTo>
                <a:lnTo>
                  <a:pt x="63373" y="150368"/>
                </a:lnTo>
                <a:lnTo>
                  <a:pt x="64135" y="152146"/>
                </a:lnTo>
                <a:lnTo>
                  <a:pt x="64135" y="157226"/>
                </a:lnTo>
                <a:lnTo>
                  <a:pt x="62865" y="159639"/>
                </a:lnTo>
                <a:lnTo>
                  <a:pt x="60325" y="161417"/>
                </a:lnTo>
                <a:lnTo>
                  <a:pt x="57785" y="163068"/>
                </a:lnTo>
                <a:lnTo>
                  <a:pt x="53340" y="164084"/>
                </a:lnTo>
                <a:lnTo>
                  <a:pt x="41275" y="164084"/>
                </a:lnTo>
                <a:lnTo>
                  <a:pt x="37211" y="163322"/>
                </a:lnTo>
                <a:lnTo>
                  <a:pt x="34798" y="161544"/>
                </a:lnTo>
                <a:lnTo>
                  <a:pt x="32385" y="159893"/>
                </a:lnTo>
                <a:lnTo>
                  <a:pt x="31115" y="157607"/>
                </a:lnTo>
                <a:lnTo>
                  <a:pt x="31115" y="150368"/>
                </a:lnTo>
                <a:lnTo>
                  <a:pt x="33909" y="147701"/>
                </a:lnTo>
                <a:lnTo>
                  <a:pt x="39370" y="146812"/>
                </a:lnTo>
                <a:lnTo>
                  <a:pt x="36830" y="135509"/>
                </a:lnTo>
                <a:lnTo>
                  <a:pt x="20066" y="149987"/>
                </a:lnTo>
                <a:lnTo>
                  <a:pt x="20193" y="155067"/>
                </a:lnTo>
                <a:lnTo>
                  <a:pt x="20307" y="161544"/>
                </a:lnTo>
                <a:lnTo>
                  <a:pt x="22606" y="166370"/>
                </a:lnTo>
                <a:lnTo>
                  <a:pt x="27432" y="170180"/>
                </a:lnTo>
                <a:lnTo>
                  <a:pt x="32131" y="173990"/>
                </a:lnTo>
                <a:lnTo>
                  <a:pt x="39116" y="175895"/>
                </a:lnTo>
                <a:lnTo>
                  <a:pt x="48260" y="175895"/>
                </a:lnTo>
                <a:lnTo>
                  <a:pt x="74510" y="164084"/>
                </a:lnTo>
                <a:lnTo>
                  <a:pt x="75692" y="161798"/>
                </a:lnTo>
                <a:close/>
              </a:path>
              <a:path w="96520" h="483870">
                <a:moveTo>
                  <a:pt x="76327" y="237629"/>
                </a:moveTo>
                <a:lnTo>
                  <a:pt x="76200" y="226580"/>
                </a:lnTo>
                <a:lnTo>
                  <a:pt x="74345" y="223278"/>
                </a:lnTo>
                <a:lnTo>
                  <a:pt x="73279" y="221361"/>
                </a:lnTo>
                <a:lnTo>
                  <a:pt x="40132" y="211518"/>
                </a:lnTo>
                <a:lnTo>
                  <a:pt x="40132" y="234454"/>
                </a:lnTo>
                <a:lnTo>
                  <a:pt x="38989" y="236347"/>
                </a:lnTo>
                <a:lnTo>
                  <a:pt x="34671" y="239407"/>
                </a:lnTo>
                <a:lnTo>
                  <a:pt x="31242" y="240284"/>
                </a:lnTo>
                <a:lnTo>
                  <a:pt x="21844" y="240284"/>
                </a:lnTo>
                <a:lnTo>
                  <a:pt x="18415" y="239649"/>
                </a:lnTo>
                <a:lnTo>
                  <a:pt x="14351" y="236855"/>
                </a:lnTo>
                <a:lnTo>
                  <a:pt x="13335" y="235077"/>
                </a:lnTo>
                <a:lnTo>
                  <a:pt x="13335" y="230759"/>
                </a:lnTo>
                <a:lnTo>
                  <a:pt x="14478" y="228854"/>
                </a:lnTo>
                <a:lnTo>
                  <a:pt x="17018" y="227076"/>
                </a:lnTo>
                <a:lnTo>
                  <a:pt x="19431" y="225298"/>
                </a:lnTo>
                <a:lnTo>
                  <a:pt x="22860" y="224409"/>
                </a:lnTo>
                <a:lnTo>
                  <a:pt x="31623" y="224409"/>
                </a:lnTo>
                <a:lnTo>
                  <a:pt x="40132" y="234454"/>
                </a:lnTo>
                <a:lnTo>
                  <a:pt x="40132" y="211518"/>
                </a:lnTo>
                <a:lnTo>
                  <a:pt x="1854" y="226187"/>
                </a:lnTo>
                <a:lnTo>
                  <a:pt x="1778" y="237998"/>
                </a:lnTo>
                <a:lnTo>
                  <a:pt x="4064" y="242582"/>
                </a:lnTo>
                <a:lnTo>
                  <a:pt x="8509" y="246253"/>
                </a:lnTo>
                <a:lnTo>
                  <a:pt x="12954" y="249809"/>
                </a:lnTo>
                <a:lnTo>
                  <a:pt x="19050" y="251587"/>
                </a:lnTo>
                <a:lnTo>
                  <a:pt x="26670" y="251587"/>
                </a:lnTo>
                <a:lnTo>
                  <a:pt x="33909" y="251460"/>
                </a:lnTo>
                <a:lnTo>
                  <a:pt x="39624" y="249682"/>
                </a:lnTo>
                <a:lnTo>
                  <a:pt x="48260" y="242582"/>
                </a:lnTo>
                <a:lnTo>
                  <a:pt x="49466" y="240284"/>
                </a:lnTo>
                <a:lnTo>
                  <a:pt x="50419" y="238506"/>
                </a:lnTo>
                <a:lnTo>
                  <a:pt x="50419" y="231775"/>
                </a:lnTo>
                <a:lnTo>
                  <a:pt x="49784" y="229882"/>
                </a:lnTo>
                <a:lnTo>
                  <a:pt x="48691" y="227838"/>
                </a:lnTo>
                <a:lnTo>
                  <a:pt x="47752" y="226187"/>
                </a:lnTo>
                <a:lnTo>
                  <a:pt x="46228" y="224663"/>
                </a:lnTo>
                <a:lnTo>
                  <a:pt x="45847" y="224409"/>
                </a:lnTo>
                <a:lnTo>
                  <a:pt x="44196" y="223278"/>
                </a:lnTo>
                <a:lnTo>
                  <a:pt x="64770" y="229882"/>
                </a:lnTo>
                <a:lnTo>
                  <a:pt x="64770" y="236232"/>
                </a:lnTo>
                <a:lnTo>
                  <a:pt x="62103" y="238379"/>
                </a:lnTo>
                <a:lnTo>
                  <a:pt x="56642" y="239014"/>
                </a:lnTo>
                <a:lnTo>
                  <a:pt x="58293" y="250063"/>
                </a:lnTo>
                <a:lnTo>
                  <a:pt x="64389" y="249174"/>
                </a:lnTo>
                <a:lnTo>
                  <a:pt x="68961" y="247281"/>
                </a:lnTo>
                <a:lnTo>
                  <a:pt x="72009" y="244348"/>
                </a:lnTo>
                <a:lnTo>
                  <a:pt x="74930" y="241427"/>
                </a:lnTo>
                <a:lnTo>
                  <a:pt x="76327" y="237629"/>
                </a:lnTo>
                <a:close/>
              </a:path>
              <a:path w="96520" h="483870">
                <a:moveTo>
                  <a:pt x="76885" y="305562"/>
                </a:moveTo>
                <a:lnTo>
                  <a:pt x="76835" y="294005"/>
                </a:lnTo>
                <a:lnTo>
                  <a:pt x="75755" y="291731"/>
                </a:lnTo>
                <a:lnTo>
                  <a:pt x="74676" y="289433"/>
                </a:lnTo>
                <a:lnTo>
                  <a:pt x="70231" y="285877"/>
                </a:lnTo>
                <a:lnTo>
                  <a:pt x="65786" y="282206"/>
                </a:lnTo>
                <a:lnTo>
                  <a:pt x="65278" y="282067"/>
                </a:lnTo>
                <a:lnTo>
                  <a:pt x="65278" y="296926"/>
                </a:lnTo>
                <a:lnTo>
                  <a:pt x="65278" y="301256"/>
                </a:lnTo>
                <a:lnTo>
                  <a:pt x="64135" y="303276"/>
                </a:lnTo>
                <a:lnTo>
                  <a:pt x="61722" y="304927"/>
                </a:lnTo>
                <a:lnTo>
                  <a:pt x="59309" y="306705"/>
                </a:lnTo>
                <a:lnTo>
                  <a:pt x="55753" y="307606"/>
                </a:lnTo>
                <a:lnTo>
                  <a:pt x="51181" y="307606"/>
                </a:lnTo>
                <a:lnTo>
                  <a:pt x="46990" y="307721"/>
                </a:lnTo>
                <a:lnTo>
                  <a:pt x="43942" y="306959"/>
                </a:lnTo>
                <a:lnTo>
                  <a:pt x="39624" y="303911"/>
                </a:lnTo>
                <a:lnTo>
                  <a:pt x="38671" y="302133"/>
                </a:lnTo>
                <a:lnTo>
                  <a:pt x="38608" y="297561"/>
                </a:lnTo>
                <a:lnTo>
                  <a:pt x="39624" y="295656"/>
                </a:lnTo>
                <a:lnTo>
                  <a:pt x="43942" y="292608"/>
                </a:lnTo>
                <a:lnTo>
                  <a:pt x="47498" y="291731"/>
                </a:lnTo>
                <a:lnTo>
                  <a:pt x="56896" y="291731"/>
                </a:lnTo>
                <a:lnTo>
                  <a:pt x="60198" y="292354"/>
                </a:lnTo>
                <a:lnTo>
                  <a:pt x="64262" y="295148"/>
                </a:lnTo>
                <a:lnTo>
                  <a:pt x="65278" y="296926"/>
                </a:lnTo>
                <a:lnTo>
                  <a:pt x="65278" y="282067"/>
                </a:lnTo>
                <a:lnTo>
                  <a:pt x="59817" y="280428"/>
                </a:lnTo>
                <a:lnTo>
                  <a:pt x="52070" y="280428"/>
                </a:lnTo>
                <a:lnTo>
                  <a:pt x="44831" y="280555"/>
                </a:lnTo>
                <a:lnTo>
                  <a:pt x="38989" y="282321"/>
                </a:lnTo>
                <a:lnTo>
                  <a:pt x="30353" y="289433"/>
                </a:lnTo>
                <a:lnTo>
                  <a:pt x="28194" y="293497"/>
                </a:lnTo>
                <a:lnTo>
                  <a:pt x="28321" y="300355"/>
                </a:lnTo>
                <a:lnTo>
                  <a:pt x="28829" y="302260"/>
                </a:lnTo>
                <a:lnTo>
                  <a:pt x="30861" y="305828"/>
                </a:lnTo>
                <a:lnTo>
                  <a:pt x="32512" y="307352"/>
                </a:lnTo>
                <a:lnTo>
                  <a:pt x="34544" y="308737"/>
                </a:lnTo>
                <a:lnTo>
                  <a:pt x="26289" y="308483"/>
                </a:lnTo>
                <a:lnTo>
                  <a:pt x="20701" y="307479"/>
                </a:lnTo>
                <a:lnTo>
                  <a:pt x="18034" y="305828"/>
                </a:lnTo>
                <a:lnTo>
                  <a:pt x="15240" y="304177"/>
                </a:lnTo>
                <a:lnTo>
                  <a:pt x="13919" y="302260"/>
                </a:lnTo>
                <a:lnTo>
                  <a:pt x="13843" y="295783"/>
                </a:lnTo>
                <a:lnTo>
                  <a:pt x="16510" y="293624"/>
                </a:lnTo>
                <a:lnTo>
                  <a:pt x="21971" y="292989"/>
                </a:lnTo>
                <a:lnTo>
                  <a:pt x="20320" y="281952"/>
                </a:lnTo>
                <a:lnTo>
                  <a:pt x="2286" y="294652"/>
                </a:lnTo>
                <a:lnTo>
                  <a:pt x="2413" y="305562"/>
                </a:lnTo>
                <a:lnTo>
                  <a:pt x="40259" y="320675"/>
                </a:lnTo>
                <a:lnTo>
                  <a:pt x="49441" y="320230"/>
                </a:lnTo>
                <a:lnTo>
                  <a:pt x="75145" y="308737"/>
                </a:lnTo>
                <a:lnTo>
                  <a:pt x="75704" y="307721"/>
                </a:lnTo>
                <a:lnTo>
                  <a:pt x="76885" y="305562"/>
                </a:lnTo>
                <a:close/>
              </a:path>
              <a:path w="96520" h="483870">
                <a:moveTo>
                  <a:pt x="77470" y="483870"/>
                </a:moveTo>
                <a:lnTo>
                  <a:pt x="77343" y="471043"/>
                </a:lnTo>
                <a:lnTo>
                  <a:pt x="60706" y="466217"/>
                </a:lnTo>
                <a:lnTo>
                  <a:pt x="60667" y="462661"/>
                </a:lnTo>
                <a:lnTo>
                  <a:pt x="60490" y="446278"/>
                </a:lnTo>
                <a:lnTo>
                  <a:pt x="60452" y="442214"/>
                </a:lnTo>
                <a:lnTo>
                  <a:pt x="76962" y="436753"/>
                </a:lnTo>
                <a:lnTo>
                  <a:pt x="76835" y="423672"/>
                </a:lnTo>
                <a:lnTo>
                  <a:pt x="48260" y="433387"/>
                </a:lnTo>
                <a:lnTo>
                  <a:pt x="48260" y="462661"/>
                </a:lnTo>
                <a:lnTo>
                  <a:pt x="21082" y="454787"/>
                </a:lnTo>
                <a:lnTo>
                  <a:pt x="48133" y="446278"/>
                </a:lnTo>
                <a:lnTo>
                  <a:pt x="48260" y="462661"/>
                </a:lnTo>
                <a:lnTo>
                  <a:pt x="48260" y="433387"/>
                </a:lnTo>
                <a:lnTo>
                  <a:pt x="3937" y="448437"/>
                </a:lnTo>
                <a:lnTo>
                  <a:pt x="4064" y="461264"/>
                </a:lnTo>
                <a:lnTo>
                  <a:pt x="77470" y="483870"/>
                </a:lnTo>
                <a:close/>
              </a:path>
              <a:path w="96520" h="483870">
                <a:moveTo>
                  <a:pt x="77978" y="405638"/>
                </a:moveTo>
                <a:lnTo>
                  <a:pt x="58547" y="378587"/>
                </a:lnTo>
                <a:lnTo>
                  <a:pt x="56261" y="389890"/>
                </a:lnTo>
                <a:lnTo>
                  <a:pt x="60071" y="390525"/>
                </a:lnTo>
                <a:lnTo>
                  <a:pt x="62738" y="391541"/>
                </a:lnTo>
                <a:lnTo>
                  <a:pt x="65659" y="394208"/>
                </a:lnTo>
                <a:lnTo>
                  <a:pt x="66421" y="395986"/>
                </a:lnTo>
                <a:lnTo>
                  <a:pt x="66421" y="401066"/>
                </a:lnTo>
                <a:lnTo>
                  <a:pt x="65151" y="403479"/>
                </a:lnTo>
                <a:lnTo>
                  <a:pt x="62611" y="405130"/>
                </a:lnTo>
                <a:lnTo>
                  <a:pt x="60071" y="406908"/>
                </a:lnTo>
                <a:lnTo>
                  <a:pt x="55626" y="407797"/>
                </a:lnTo>
                <a:lnTo>
                  <a:pt x="49276" y="407924"/>
                </a:lnTo>
                <a:lnTo>
                  <a:pt x="43561" y="407924"/>
                </a:lnTo>
                <a:lnTo>
                  <a:pt x="39497" y="407162"/>
                </a:lnTo>
                <a:lnTo>
                  <a:pt x="37084" y="405384"/>
                </a:lnTo>
                <a:lnTo>
                  <a:pt x="34671" y="403733"/>
                </a:lnTo>
                <a:lnTo>
                  <a:pt x="33528" y="401447"/>
                </a:lnTo>
                <a:lnTo>
                  <a:pt x="33401" y="394208"/>
                </a:lnTo>
                <a:lnTo>
                  <a:pt x="36195" y="391541"/>
                </a:lnTo>
                <a:lnTo>
                  <a:pt x="41656" y="390652"/>
                </a:lnTo>
                <a:lnTo>
                  <a:pt x="39116" y="379349"/>
                </a:lnTo>
                <a:lnTo>
                  <a:pt x="22352" y="393827"/>
                </a:lnTo>
                <a:lnTo>
                  <a:pt x="22479" y="398907"/>
                </a:lnTo>
                <a:lnTo>
                  <a:pt x="22593" y="405384"/>
                </a:lnTo>
                <a:lnTo>
                  <a:pt x="24892" y="410210"/>
                </a:lnTo>
                <a:lnTo>
                  <a:pt x="29718" y="414020"/>
                </a:lnTo>
                <a:lnTo>
                  <a:pt x="34417" y="417830"/>
                </a:lnTo>
                <a:lnTo>
                  <a:pt x="41402" y="419735"/>
                </a:lnTo>
                <a:lnTo>
                  <a:pt x="50546" y="419608"/>
                </a:lnTo>
                <a:lnTo>
                  <a:pt x="58039" y="419608"/>
                </a:lnTo>
                <a:lnTo>
                  <a:pt x="64516" y="417830"/>
                </a:lnTo>
                <a:lnTo>
                  <a:pt x="69977" y="414401"/>
                </a:lnTo>
                <a:lnTo>
                  <a:pt x="75311" y="410845"/>
                </a:lnTo>
                <a:lnTo>
                  <a:pt x="76796" y="407924"/>
                </a:lnTo>
                <a:lnTo>
                  <a:pt x="77978" y="405638"/>
                </a:lnTo>
                <a:close/>
              </a:path>
              <a:path w="96520" h="483870">
                <a:moveTo>
                  <a:pt x="96520" y="369824"/>
                </a:moveTo>
                <a:lnTo>
                  <a:pt x="96393" y="358902"/>
                </a:lnTo>
                <a:lnTo>
                  <a:pt x="96393" y="358521"/>
                </a:lnTo>
                <a:lnTo>
                  <a:pt x="96393" y="358279"/>
                </a:lnTo>
                <a:lnTo>
                  <a:pt x="69723" y="358521"/>
                </a:lnTo>
                <a:lnTo>
                  <a:pt x="72644" y="356362"/>
                </a:lnTo>
                <a:lnTo>
                  <a:pt x="74676" y="354203"/>
                </a:lnTo>
                <a:lnTo>
                  <a:pt x="76149" y="351536"/>
                </a:lnTo>
                <a:lnTo>
                  <a:pt x="76835" y="350278"/>
                </a:lnTo>
                <a:lnTo>
                  <a:pt x="77343" y="348107"/>
                </a:lnTo>
                <a:lnTo>
                  <a:pt x="77343" y="340880"/>
                </a:lnTo>
                <a:lnTo>
                  <a:pt x="76593" y="339598"/>
                </a:lnTo>
                <a:lnTo>
                  <a:pt x="74803" y="336550"/>
                </a:lnTo>
                <a:lnTo>
                  <a:pt x="69977" y="333006"/>
                </a:lnTo>
                <a:lnTo>
                  <a:pt x="66294" y="330390"/>
                </a:lnTo>
                <a:lnTo>
                  <a:pt x="66294" y="346202"/>
                </a:lnTo>
                <a:lnTo>
                  <a:pt x="66205" y="351663"/>
                </a:lnTo>
                <a:lnTo>
                  <a:pt x="48895" y="358902"/>
                </a:lnTo>
                <a:lnTo>
                  <a:pt x="43561" y="358902"/>
                </a:lnTo>
                <a:lnTo>
                  <a:pt x="33020" y="346583"/>
                </a:lnTo>
                <a:lnTo>
                  <a:pt x="34290" y="344424"/>
                </a:lnTo>
                <a:lnTo>
                  <a:pt x="39624" y="340614"/>
                </a:lnTo>
                <a:lnTo>
                  <a:pt x="43815" y="339725"/>
                </a:lnTo>
                <a:lnTo>
                  <a:pt x="49403" y="339598"/>
                </a:lnTo>
                <a:lnTo>
                  <a:pt x="55372" y="339598"/>
                </a:lnTo>
                <a:lnTo>
                  <a:pt x="59690" y="340487"/>
                </a:lnTo>
                <a:lnTo>
                  <a:pt x="62230" y="342138"/>
                </a:lnTo>
                <a:lnTo>
                  <a:pt x="64897" y="343928"/>
                </a:lnTo>
                <a:lnTo>
                  <a:pt x="66294" y="346202"/>
                </a:lnTo>
                <a:lnTo>
                  <a:pt x="66294" y="330390"/>
                </a:lnTo>
                <a:lnTo>
                  <a:pt x="65151" y="329577"/>
                </a:lnTo>
                <a:lnTo>
                  <a:pt x="58166" y="327787"/>
                </a:lnTo>
                <a:lnTo>
                  <a:pt x="49022" y="327914"/>
                </a:lnTo>
                <a:lnTo>
                  <a:pt x="40259" y="327914"/>
                </a:lnTo>
                <a:lnTo>
                  <a:pt x="33655" y="329831"/>
                </a:lnTo>
                <a:lnTo>
                  <a:pt x="28956" y="333375"/>
                </a:lnTo>
                <a:lnTo>
                  <a:pt x="24257" y="337058"/>
                </a:lnTo>
                <a:lnTo>
                  <a:pt x="21844" y="341376"/>
                </a:lnTo>
                <a:lnTo>
                  <a:pt x="21971" y="348996"/>
                </a:lnTo>
                <a:lnTo>
                  <a:pt x="22733" y="351663"/>
                </a:lnTo>
                <a:lnTo>
                  <a:pt x="24638" y="354330"/>
                </a:lnTo>
                <a:lnTo>
                  <a:pt x="26035" y="356362"/>
                </a:lnTo>
                <a:lnTo>
                  <a:pt x="28321" y="358279"/>
                </a:lnTo>
                <a:lnTo>
                  <a:pt x="31115" y="359803"/>
                </a:lnTo>
                <a:lnTo>
                  <a:pt x="23368" y="359803"/>
                </a:lnTo>
                <a:lnTo>
                  <a:pt x="23368" y="370459"/>
                </a:lnTo>
                <a:lnTo>
                  <a:pt x="96520" y="36982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4" name="object 54"/>
          <p:cNvSpPr txBox="1"/>
          <p:nvPr/>
        </p:nvSpPr>
        <p:spPr>
          <a:xfrm>
            <a:off x="4072740" y="9387146"/>
            <a:ext cx="264795" cy="50990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spc="-10" dirty="0">
                <a:latin typeface="Arial Narrow"/>
                <a:cs typeface="Arial Narrow"/>
              </a:rPr>
              <a:t>Acp6.9-</a:t>
            </a:r>
            <a:r>
              <a:rPr sz="800" b="1" spc="-20" dirty="0">
                <a:latin typeface="Arial Narrow"/>
                <a:cs typeface="Arial Narrow"/>
              </a:rPr>
              <a:t>chiA</a:t>
            </a:r>
            <a:endParaRPr sz="800">
              <a:latin typeface="Arial Narrow"/>
              <a:cs typeface="Arial Narrow"/>
            </a:endParaRPr>
          </a:p>
          <a:p>
            <a:pPr marL="12700">
              <a:lnSpc>
                <a:spcPct val="100000"/>
              </a:lnSpc>
            </a:pPr>
            <a:r>
              <a:rPr sz="800" b="1" dirty="0">
                <a:latin typeface="Arial Narrow"/>
                <a:cs typeface="Arial Narrow"/>
              </a:rPr>
              <a:t>/</a:t>
            </a:r>
            <a:r>
              <a:rPr sz="800" b="1" spc="50" dirty="0">
                <a:latin typeface="Arial Narrow"/>
                <a:cs typeface="Arial Narrow"/>
              </a:rPr>
              <a:t> </a:t>
            </a:r>
            <a:r>
              <a:rPr sz="800" b="1" spc="-10" dirty="0">
                <a:latin typeface="Arial Narrow"/>
                <a:cs typeface="Arial Narrow"/>
              </a:rPr>
              <a:t>polh-</a:t>
            </a:r>
            <a:r>
              <a:rPr sz="800" b="1" spc="-20" dirty="0">
                <a:latin typeface="Arial Narrow"/>
                <a:cs typeface="Arial Narrow"/>
              </a:rPr>
              <a:t>cath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55" name="object 55"/>
          <p:cNvSpPr/>
          <p:nvPr/>
        </p:nvSpPr>
        <p:spPr>
          <a:xfrm>
            <a:off x="6516623" y="9323832"/>
            <a:ext cx="748665" cy="0"/>
          </a:xfrm>
          <a:custGeom>
            <a:avLst/>
            <a:gdLst/>
            <a:ahLst/>
            <a:cxnLst/>
            <a:rect l="l" t="t" r="r" b="b"/>
            <a:pathLst>
              <a:path w="748665">
                <a:moveTo>
                  <a:pt x="0" y="0"/>
                </a:moveTo>
                <a:lnTo>
                  <a:pt x="360045" y="0"/>
                </a:lnTo>
              </a:path>
              <a:path w="748665">
                <a:moveTo>
                  <a:pt x="388620" y="0"/>
                </a:moveTo>
                <a:lnTo>
                  <a:pt x="748665" y="0"/>
                </a:lnTo>
              </a:path>
            </a:pathLst>
          </a:custGeom>
          <a:ln w="1219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6" name="object 56"/>
          <p:cNvSpPr/>
          <p:nvPr/>
        </p:nvSpPr>
        <p:spPr>
          <a:xfrm>
            <a:off x="7388352" y="9322308"/>
            <a:ext cx="747395" cy="0"/>
          </a:xfrm>
          <a:custGeom>
            <a:avLst/>
            <a:gdLst/>
            <a:ahLst/>
            <a:cxnLst/>
            <a:rect l="l" t="t" r="r" b="b"/>
            <a:pathLst>
              <a:path w="747395">
                <a:moveTo>
                  <a:pt x="0" y="0"/>
                </a:moveTo>
                <a:lnTo>
                  <a:pt x="360045" y="0"/>
                </a:lnTo>
              </a:path>
              <a:path w="747395">
                <a:moveTo>
                  <a:pt x="387096" y="0"/>
                </a:moveTo>
                <a:lnTo>
                  <a:pt x="747141" y="0"/>
                </a:lnTo>
              </a:path>
            </a:pathLst>
          </a:custGeom>
          <a:ln w="1219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7" name="object 57"/>
          <p:cNvSpPr txBox="1"/>
          <p:nvPr/>
        </p:nvSpPr>
        <p:spPr>
          <a:xfrm>
            <a:off x="7414641" y="9138666"/>
            <a:ext cx="341630" cy="17780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sz="1000" b="1" spc="-10" dirty="0">
                <a:latin typeface="Arial Narrow"/>
                <a:cs typeface="Arial Narrow"/>
              </a:rPr>
              <a:t>INSOL</a:t>
            </a:r>
            <a:endParaRPr sz="1000">
              <a:latin typeface="Arial Narrow"/>
              <a:cs typeface="Arial Narrow"/>
            </a:endParaRPr>
          </a:p>
        </p:txBody>
      </p:sp>
      <p:sp>
        <p:nvSpPr>
          <p:cNvPr id="58" name="object 58"/>
          <p:cNvSpPr txBox="1"/>
          <p:nvPr/>
        </p:nvSpPr>
        <p:spPr>
          <a:xfrm>
            <a:off x="6692496" y="9338036"/>
            <a:ext cx="142875" cy="56324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dirty="0">
                <a:latin typeface="Arial Narrow"/>
                <a:cs typeface="Arial Narrow"/>
              </a:rPr>
              <a:t>AcMNPV-</a:t>
            </a:r>
            <a:r>
              <a:rPr sz="800" b="1" spc="-25" dirty="0">
                <a:latin typeface="Arial Narrow"/>
                <a:cs typeface="Arial Narrow"/>
              </a:rPr>
              <a:t>Rep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59" name="object 59"/>
          <p:cNvSpPr/>
          <p:nvPr/>
        </p:nvSpPr>
        <p:spPr>
          <a:xfrm>
            <a:off x="6891528" y="9398508"/>
            <a:ext cx="96520" cy="483870"/>
          </a:xfrm>
          <a:custGeom>
            <a:avLst/>
            <a:gdLst/>
            <a:ahLst/>
            <a:cxnLst/>
            <a:rect l="l" t="t" r="r" b="b"/>
            <a:pathLst>
              <a:path w="96520" h="483870">
                <a:moveTo>
                  <a:pt x="13462" y="77470"/>
                </a:moveTo>
                <a:lnTo>
                  <a:pt x="13335" y="66040"/>
                </a:lnTo>
                <a:lnTo>
                  <a:pt x="381" y="66167"/>
                </a:lnTo>
                <a:lnTo>
                  <a:pt x="508" y="77597"/>
                </a:lnTo>
                <a:lnTo>
                  <a:pt x="13462" y="77470"/>
                </a:lnTo>
                <a:close/>
              </a:path>
              <a:path w="96520" h="483870">
                <a:moveTo>
                  <a:pt x="55245" y="203962"/>
                </a:moveTo>
                <a:lnTo>
                  <a:pt x="54991" y="181356"/>
                </a:lnTo>
                <a:lnTo>
                  <a:pt x="41021" y="181483"/>
                </a:lnTo>
                <a:lnTo>
                  <a:pt x="41275" y="204101"/>
                </a:lnTo>
                <a:lnTo>
                  <a:pt x="55245" y="203962"/>
                </a:lnTo>
                <a:close/>
              </a:path>
              <a:path w="96520" h="483870">
                <a:moveTo>
                  <a:pt x="73406" y="60071"/>
                </a:moveTo>
                <a:lnTo>
                  <a:pt x="73279" y="47244"/>
                </a:lnTo>
                <a:lnTo>
                  <a:pt x="56642" y="42418"/>
                </a:lnTo>
                <a:lnTo>
                  <a:pt x="56603" y="38862"/>
                </a:lnTo>
                <a:lnTo>
                  <a:pt x="56426" y="22479"/>
                </a:lnTo>
                <a:lnTo>
                  <a:pt x="56388" y="18415"/>
                </a:lnTo>
                <a:lnTo>
                  <a:pt x="72898" y="13081"/>
                </a:lnTo>
                <a:lnTo>
                  <a:pt x="72771" y="0"/>
                </a:lnTo>
                <a:lnTo>
                  <a:pt x="44323" y="9639"/>
                </a:lnTo>
                <a:lnTo>
                  <a:pt x="44323" y="38862"/>
                </a:lnTo>
                <a:lnTo>
                  <a:pt x="17018" y="30988"/>
                </a:lnTo>
                <a:lnTo>
                  <a:pt x="44069" y="22479"/>
                </a:lnTo>
                <a:lnTo>
                  <a:pt x="44323" y="38862"/>
                </a:lnTo>
                <a:lnTo>
                  <a:pt x="44323" y="9639"/>
                </a:lnTo>
                <a:lnTo>
                  <a:pt x="0" y="24638"/>
                </a:lnTo>
                <a:lnTo>
                  <a:pt x="127" y="37465"/>
                </a:lnTo>
                <a:lnTo>
                  <a:pt x="73406" y="60071"/>
                </a:lnTo>
                <a:close/>
              </a:path>
              <a:path w="96520" h="483870">
                <a:moveTo>
                  <a:pt x="73533" y="76962"/>
                </a:moveTo>
                <a:lnTo>
                  <a:pt x="73406" y="65405"/>
                </a:lnTo>
                <a:lnTo>
                  <a:pt x="20447" y="65913"/>
                </a:lnTo>
                <a:lnTo>
                  <a:pt x="20574" y="77470"/>
                </a:lnTo>
                <a:lnTo>
                  <a:pt x="73533" y="76962"/>
                </a:lnTo>
                <a:close/>
              </a:path>
              <a:path w="96520" h="483870">
                <a:moveTo>
                  <a:pt x="74041" y="127254"/>
                </a:moveTo>
                <a:lnTo>
                  <a:pt x="73914" y="116078"/>
                </a:lnTo>
                <a:lnTo>
                  <a:pt x="73914" y="115824"/>
                </a:lnTo>
                <a:lnTo>
                  <a:pt x="47371" y="116078"/>
                </a:lnTo>
                <a:lnTo>
                  <a:pt x="40894" y="116078"/>
                </a:lnTo>
                <a:lnTo>
                  <a:pt x="36322" y="115316"/>
                </a:lnTo>
                <a:lnTo>
                  <a:pt x="34036" y="113665"/>
                </a:lnTo>
                <a:lnTo>
                  <a:pt x="31623" y="112014"/>
                </a:lnTo>
                <a:lnTo>
                  <a:pt x="30353" y="109728"/>
                </a:lnTo>
                <a:lnTo>
                  <a:pt x="30353" y="104013"/>
                </a:lnTo>
                <a:lnTo>
                  <a:pt x="31369" y="102108"/>
                </a:lnTo>
                <a:lnTo>
                  <a:pt x="33528" y="100838"/>
                </a:lnTo>
                <a:lnTo>
                  <a:pt x="35179" y="100076"/>
                </a:lnTo>
                <a:lnTo>
                  <a:pt x="39243" y="99568"/>
                </a:lnTo>
                <a:lnTo>
                  <a:pt x="45720" y="99568"/>
                </a:lnTo>
                <a:lnTo>
                  <a:pt x="73787" y="99314"/>
                </a:lnTo>
                <a:lnTo>
                  <a:pt x="73660" y="87757"/>
                </a:lnTo>
                <a:lnTo>
                  <a:pt x="42545" y="88011"/>
                </a:lnTo>
                <a:lnTo>
                  <a:pt x="36576" y="88138"/>
                </a:lnTo>
                <a:lnTo>
                  <a:pt x="32512" y="88519"/>
                </a:lnTo>
                <a:lnTo>
                  <a:pt x="26670" y="90297"/>
                </a:lnTo>
                <a:lnTo>
                  <a:pt x="24003" y="91948"/>
                </a:lnTo>
                <a:lnTo>
                  <a:pt x="22225" y="94361"/>
                </a:lnTo>
                <a:lnTo>
                  <a:pt x="20447" y="96647"/>
                </a:lnTo>
                <a:lnTo>
                  <a:pt x="19634" y="99314"/>
                </a:lnTo>
                <a:lnTo>
                  <a:pt x="19558" y="105664"/>
                </a:lnTo>
                <a:lnTo>
                  <a:pt x="20320" y="107950"/>
                </a:lnTo>
                <a:lnTo>
                  <a:pt x="21590" y="110236"/>
                </a:lnTo>
                <a:lnTo>
                  <a:pt x="22987" y="112395"/>
                </a:lnTo>
                <a:lnTo>
                  <a:pt x="25019" y="114427"/>
                </a:lnTo>
                <a:lnTo>
                  <a:pt x="27686" y="116205"/>
                </a:lnTo>
                <a:lnTo>
                  <a:pt x="762" y="116459"/>
                </a:lnTo>
                <a:lnTo>
                  <a:pt x="889" y="128016"/>
                </a:lnTo>
                <a:lnTo>
                  <a:pt x="74041" y="127254"/>
                </a:lnTo>
                <a:close/>
              </a:path>
              <a:path w="96520" h="483870">
                <a:moveTo>
                  <a:pt x="75311" y="259080"/>
                </a:moveTo>
                <a:lnTo>
                  <a:pt x="61214" y="259207"/>
                </a:lnTo>
                <a:lnTo>
                  <a:pt x="61341" y="270637"/>
                </a:lnTo>
                <a:lnTo>
                  <a:pt x="75311" y="270510"/>
                </a:lnTo>
                <a:lnTo>
                  <a:pt x="75311" y="259080"/>
                </a:lnTo>
                <a:close/>
              </a:path>
              <a:path w="96520" h="483870">
                <a:moveTo>
                  <a:pt x="75565" y="154559"/>
                </a:moveTo>
                <a:lnTo>
                  <a:pt x="74269" y="147116"/>
                </a:lnTo>
                <a:lnTo>
                  <a:pt x="70612" y="141325"/>
                </a:lnTo>
                <a:lnTo>
                  <a:pt x="64554" y="137210"/>
                </a:lnTo>
                <a:lnTo>
                  <a:pt x="56134" y="134747"/>
                </a:lnTo>
                <a:lnTo>
                  <a:pt x="53975" y="146050"/>
                </a:lnTo>
                <a:lnTo>
                  <a:pt x="57658" y="146558"/>
                </a:lnTo>
                <a:lnTo>
                  <a:pt x="60325" y="147574"/>
                </a:lnTo>
                <a:lnTo>
                  <a:pt x="63373" y="150368"/>
                </a:lnTo>
                <a:lnTo>
                  <a:pt x="64135" y="152146"/>
                </a:lnTo>
                <a:lnTo>
                  <a:pt x="64135" y="157226"/>
                </a:lnTo>
                <a:lnTo>
                  <a:pt x="62865" y="159512"/>
                </a:lnTo>
                <a:lnTo>
                  <a:pt x="60325" y="161290"/>
                </a:lnTo>
                <a:lnTo>
                  <a:pt x="57658" y="163068"/>
                </a:lnTo>
                <a:lnTo>
                  <a:pt x="53213" y="163957"/>
                </a:lnTo>
                <a:lnTo>
                  <a:pt x="46990" y="163957"/>
                </a:lnTo>
                <a:lnTo>
                  <a:pt x="41275" y="164084"/>
                </a:lnTo>
                <a:lnTo>
                  <a:pt x="37211" y="163195"/>
                </a:lnTo>
                <a:lnTo>
                  <a:pt x="34798" y="161544"/>
                </a:lnTo>
                <a:lnTo>
                  <a:pt x="32385" y="159766"/>
                </a:lnTo>
                <a:lnTo>
                  <a:pt x="31115" y="157480"/>
                </a:lnTo>
                <a:lnTo>
                  <a:pt x="31115" y="150241"/>
                </a:lnTo>
                <a:lnTo>
                  <a:pt x="33782" y="147574"/>
                </a:lnTo>
                <a:lnTo>
                  <a:pt x="39370" y="146685"/>
                </a:lnTo>
                <a:lnTo>
                  <a:pt x="36703" y="135382"/>
                </a:lnTo>
                <a:lnTo>
                  <a:pt x="30861" y="136906"/>
                </a:lnTo>
                <a:lnTo>
                  <a:pt x="26670" y="139192"/>
                </a:lnTo>
                <a:lnTo>
                  <a:pt x="24003" y="142494"/>
                </a:lnTo>
                <a:lnTo>
                  <a:pt x="21336" y="145669"/>
                </a:lnTo>
                <a:lnTo>
                  <a:pt x="20066" y="149860"/>
                </a:lnTo>
                <a:lnTo>
                  <a:pt x="20193" y="161290"/>
                </a:lnTo>
                <a:lnTo>
                  <a:pt x="22606" y="166243"/>
                </a:lnTo>
                <a:lnTo>
                  <a:pt x="27305" y="170180"/>
                </a:lnTo>
                <a:lnTo>
                  <a:pt x="32131" y="173990"/>
                </a:lnTo>
                <a:lnTo>
                  <a:pt x="39116" y="175895"/>
                </a:lnTo>
                <a:lnTo>
                  <a:pt x="55753" y="175641"/>
                </a:lnTo>
                <a:lnTo>
                  <a:pt x="62230" y="173863"/>
                </a:lnTo>
                <a:lnTo>
                  <a:pt x="72898" y="167005"/>
                </a:lnTo>
                <a:lnTo>
                  <a:pt x="74358" y="164084"/>
                </a:lnTo>
                <a:lnTo>
                  <a:pt x="75565" y="161671"/>
                </a:lnTo>
                <a:lnTo>
                  <a:pt x="75565" y="154559"/>
                </a:lnTo>
                <a:close/>
              </a:path>
              <a:path w="96520" h="483870">
                <a:moveTo>
                  <a:pt x="76212" y="237744"/>
                </a:moveTo>
                <a:lnTo>
                  <a:pt x="76200" y="226453"/>
                </a:lnTo>
                <a:lnTo>
                  <a:pt x="74256" y="223151"/>
                </a:lnTo>
                <a:lnTo>
                  <a:pt x="73152" y="221234"/>
                </a:lnTo>
                <a:lnTo>
                  <a:pt x="40132" y="211391"/>
                </a:lnTo>
                <a:lnTo>
                  <a:pt x="40132" y="234327"/>
                </a:lnTo>
                <a:lnTo>
                  <a:pt x="38989" y="236220"/>
                </a:lnTo>
                <a:lnTo>
                  <a:pt x="36830" y="237744"/>
                </a:lnTo>
                <a:lnTo>
                  <a:pt x="34671" y="239395"/>
                </a:lnTo>
                <a:lnTo>
                  <a:pt x="31242" y="240157"/>
                </a:lnTo>
                <a:lnTo>
                  <a:pt x="26543" y="240157"/>
                </a:lnTo>
                <a:lnTo>
                  <a:pt x="21844" y="240284"/>
                </a:lnTo>
                <a:lnTo>
                  <a:pt x="18415" y="239522"/>
                </a:lnTo>
                <a:lnTo>
                  <a:pt x="16383" y="238252"/>
                </a:lnTo>
                <a:lnTo>
                  <a:pt x="14351" y="236855"/>
                </a:lnTo>
                <a:lnTo>
                  <a:pt x="13335" y="235077"/>
                </a:lnTo>
                <a:lnTo>
                  <a:pt x="13258" y="231775"/>
                </a:lnTo>
                <a:lnTo>
                  <a:pt x="13208" y="230759"/>
                </a:lnTo>
                <a:lnTo>
                  <a:pt x="14478" y="228727"/>
                </a:lnTo>
                <a:lnTo>
                  <a:pt x="16891" y="226949"/>
                </a:lnTo>
                <a:lnTo>
                  <a:pt x="19304" y="225298"/>
                </a:lnTo>
                <a:lnTo>
                  <a:pt x="22860" y="224282"/>
                </a:lnTo>
                <a:lnTo>
                  <a:pt x="31623" y="224282"/>
                </a:lnTo>
                <a:lnTo>
                  <a:pt x="34798" y="225044"/>
                </a:lnTo>
                <a:lnTo>
                  <a:pt x="36830" y="226580"/>
                </a:lnTo>
                <a:lnTo>
                  <a:pt x="38989" y="228104"/>
                </a:lnTo>
                <a:lnTo>
                  <a:pt x="40005" y="229870"/>
                </a:lnTo>
                <a:lnTo>
                  <a:pt x="40132" y="234327"/>
                </a:lnTo>
                <a:lnTo>
                  <a:pt x="40132" y="211391"/>
                </a:lnTo>
                <a:lnTo>
                  <a:pt x="1790" y="226187"/>
                </a:lnTo>
                <a:lnTo>
                  <a:pt x="1778" y="237998"/>
                </a:lnTo>
                <a:lnTo>
                  <a:pt x="3937" y="242455"/>
                </a:lnTo>
                <a:lnTo>
                  <a:pt x="12827" y="249809"/>
                </a:lnTo>
                <a:lnTo>
                  <a:pt x="18923" y="251587"/>
                </a:lnTo>
                <a:lnTo>
                  <a:pt x="26670" y="251460"/>
                </a:lnTo>
                <a:lnTo>
                  <a:pt x="33909" y="251460"/>
                </a:lnTo>
                <a:lnTo>
                  <a:pt x="39624" y="249555"/>
                </a:lnTo>
                <a:lnTo>
                  <a:pt x="43942" y="245999"/>
                </a:lnTo>
                <a:lnTo>
                  <a:pt x="48260" y="242570"/>
                </a:lnTo>
                <a:lnTo>
                  <a:pt x="49466" y="240284"/>
                </a:lnTo>
                <a:lnTo>
                  <a:pt x="50419" y="238506"/>
                </a:lnTo>
                <a:lnTo>
                  <a:pt x="50292" y="231775"/>
                </a:lnTo>
                <a:lnTo>
                  <a:pt x="49784" y="229755"/>
                </a:lnTo>
                <a:lnTo>
                  <a:pt x="47752" y="226187"/>
                </a:lnTo>
                <a:lnTo>
                  <a:pt x="46101" y="224536"/>
                </a:lnTo>
                <a:lnTo>
                  <a:pt x="45720" y="224282"/>
                </a:lnTo>
                <a:lnTo>
                  <a:pt x="44069" y="223151"/>
                </a:lnTo>
                <a:lnTo>
                  <a:pt x="52324" y="223520"/>
                </a:lnTo>
                <a:lnTo>
                  <a:pt x="57912" y="224536"/>
                </a:lnTo>
                <a:lnTo>
                  <a:pt x="60579" y="226187"/>
                </a:lnTo>
                <a:lnTo>
                  <a:pt x="63246" y="227711"/>
                </a:lnTo>
                <a:lnTo>
                  <a:pt x="64643" y="229870"/>
                </a:lnTo>
                <a:lnTo>
                  <a:pt x="64770" y="236220"/>
                </a:lnTo>
                <a:lnTo>
                  <a:pt x="61976" y="238379"/>
                </a:lnTo>
                <a:lnTo>
                  <a:pt x="56642" y="238887"/>
                </a:lnTo>
                <a:lnTo>
                  <a:pt x="58166" y="250075"/>
                </a:lnTo>
                <a:lnTo>
                  <a:pt x="64389" y="249174"/>
                </a:lnTo>
                <a:lnTo>
                  <a:pt x="68961" y="247269"/>
                </a:lnTo>
                <a:lnTo>
                  <a:pt x="71882" y="244221"/>
                </a:lnTo>
                <a:lnTo>
                  <a:pt x="74803" y="241300"/>
                </a:lnTo>
                <a:lnTo>
                  <a:pt x="76212" y="237744"/>
                </a:lnTo>
                <a:close/>
              </a:path>
              <a:path w="96520" h="483870">
                <a:moveTo>
                  <a:pt x="76962" y="305435"/>
                </a:moveTo>
                <a:lnTo>
                  <a:pt x="76835" y="294005"/>
                </a:lnTo>
                <a:lnTo>
                  <a:pt x="75628" y="291604"/>
                </a:lnTo>
                <a:lnTo>
                  <a:pt x="74549" y="289433"/>
                </a:lnTo>
                <a:lnTo>
                  <a:pt x="70231" y="285750"/>
                </a:lnTo>
                <a:lnTo>
                  <a:pt x="65786" y="282079"/>
                </a:lnTo>
                <a:lnTo>
                  <a:pt x="65278" y="281940"/>
                </a:lnTo>
                <a:lnTo>
                  <a:pt x="65278" y="296799"/>
                </a:lnTo>
                <a:lnTo>
                  <a:pt x="65278" y="301129"/>
                </a:lnTo>
                <a:lnTo>
                  <a:pt x="51054" y="307594"/>
                </a:lnTo>
                <a:lnTo>
                  <a:pt x="46990" y="307594"/>
                </a:lnTo>
                <a:lnTo>
                  <a:pt x="43815" y="306832"/>
                </a:lnTo>
                <a:lnTo>
                  <a:pt x="41783" y="305308"/>
                </a:lnTo>
                <a:lnTo>
                  <a:pt x="39624" y="303784"/>
                </a:lnTo>
                <a:lnTo>
                  <a:pt x="38671" y="302133"/>
                </a:lnTo>
                <a:lnTo>
                  <a:pt x="38557" y="298958"/>
                </a:lnTo>
                <a:lnTo>
                  <a:pt x="38481" y="297434"/>
                </a:lnTo>
                <a:lnTo>
                  <a:pt x="39624" y="295529"/>
                </a:lnTo>
                <a:lnTo>
                  <a:pt x="43942" y="292481"/>
                </a:lnTo>
                <a:lnTo>
                  <a:pt x="47371" y="291719"/>
                </a:lnTo>
                <a:lnTo>
                  <a:pt x="52197" y="291604"/>
                </a:lnTo>
                <a:lnTo>
                  <a:pt x="56769" y="291604"/>
                </a:lnTo>
                <a:lnTo>
                  <a:pt x="60198" y="292227"/>
                </a:lnTo>
                <a:lnTo>
                  <a:pt x="64262" y="295021"/>
                </a:lnTo>
                <a:lnTo>
                  <a:pt x="65278" y="296799"/>
                </a:lnTo>
                <a:lnTo>
                  <a:pt x="65278" y="281940"/>
                </a:lnTo>
                <a:lnTo>
                  <a:pt x="59690" y="280301"/>
                </a:lnTo>
                <a:lnTo>
                  <a:pt x="51943" y="280428"/>
                </a:lnTo>
                <a:lnTo>
                  <a:pt x="44704" y="280428"/>
                </a:lnTo>
                <a:lnTo>
                  <a:pt x="38989" y="282194"/>
                </a:lnTo>
                <a:lnTo>
                  <a:pt x="30353" y="289306"/>
                </a:lnTo>
                <a:lnTo>
                  <a:pt x="28194" y="293370"/>
                </a:lnTo>
                <a:lnTo>
                  <a:pt x="28194" y="300228"/>
                </a:lnTo>
                <a:lnTo>
                  <a:pt x="28702" y="302133"/>
                </a:lnTo>
                <a:lnTo>
                  <a:pt x="29845" y="303911"/>
                </a:lnTo>
                <a:lnTo>
                  <a:pt x="30861" y="305701"/>
                </a:lnTo>
                <a:lnTo>
                  <a:pt x="32385" y="307352"/>
                </a:lnTo>
                <a:lnTo>
                  <a:pt x="34544" y="308737"/>
                </a:lnTo>
                <a:lnTo>
                  <a:pt x="26162" y="308356"/>
                </a:lnTo>
                <a:lnTo>
                  <a:pt x="20701" y="307352"/>
                </a:lnTo>
                <a:lnTo>
                  <a:pt x="17907" y="305701"/>
                </a:lnTo>
                <a:lnTo>
                  <a:pt x="15240" y="304177"/>
                </a:lnTo>
                <a:lnTo>
                  <a:pt x="13919" y="302133"/>
                </a:lnTo>
                <a:lnTo>
                  <a:pt x="13716" y="295656"/>
                </a:lnTo>
                <a:lnTo>
                  <a:pt x="16510" y="293497"/>
                </a:lnTo>
                <a:lnTo>
                  <a:pt x="21844" y="292862"/>
                </a:lnTo>
                <a:lnTo>
                  <a:pt x="20320" y="281825"/>
                </a:lnTo>
                <a:lnTo>
                  <a:pt x="14224" y="282702"/>
                </a:lnTo>
                <a:lnTo>
                  <a:pt x="9652" y="284734"/>
                </a:lnTo>
                <a:lnTo>
                  <a:pt x="6731" y="287782"/>
                </a:lnTo>
                <a:lnTo>
                  <a:pt x="3683" y="290830"/>
                </a:lnTo>
                <a:lnTo>
                  <a:pt x="2514" y="294005"/>
                </a:lnTo>
                <a:lnTo>
                  <a:pt x="2413" y="305435"/>
                </a:lnTo>
                <a:lnTo>
                  <a:pt x="5334" y="310654"/>
                </a:lnTo>
                <a:lnTo>
                  <a:pt x="40259" y="320548"/>
                </a:lnTo>
                <a:lnTo>
                  <a:pt x="49390" y="320103"/>
                </a:lnTo>
                <a:lnTo>
                  <a:pt x="75095" y="308737"/>
                </a:lnTo>
                <a:lnTo>
                  <a:pt x="75742" y="307594"/>
                </a:lnTo>
                <a:lnTo>
                  <a:pt x="76962" y="305435"/>
                </a:lnTo>
                <a:close/>
              </a:path>
              <a:path w="96520" h="483870">
                <a:moveTo>
                  <a:pt x="77343" y="483743"/>
                </a:moveTo>
                <a:lnTo>
                  <a:pt x="77216" y="470916"/>
                </a:lnTo>
                <a:lnTo>
                  <a:pt x="60706" y="466090"/>
                </a:lnTo>
                <a:lnTo>
                  <a:pt x="60667" y="462534"/>
                </a:lnTo>
                <a:lnTo>
                  <a:pt x="60490" y="446151"/>
                </a:lnTo>
                <a:lnTo>
                  <a:pt x="60452" y="442087"/>
                </a:lnTo>
                <a:lnTo>
                  <a:pt x="76962" y="436753"/>
                </a:lnTo>
                <a:lnTo>
                  <a:pt x="76835" y="423545"/>
                </a:lnTo>
                <a:lnTo>
                  <a:pt x="48260" y="433260"/>
                </a:lnTo>
                <a:lnTo>
                  <a:pt x="48260" y="462534"/>
                </a:lnTo>
                <a:lnTo>
                  <a:pt x="21082" y="454660"/>
                </a:lnTo>
                <a:lnTo>
                  <a:pt x="48133" y="446151"/>
                </a:lnTo>
                <a:lnTo>
                  <a:pt x="48260" y="462534"/>
                </a:lnTo>
                <a:lnTo>
                  <a:pt x="48260" y="433260"/>
                </a:lnTo>
                <a:lnTo>
                  <a:pt x="3937" y="448310"/>
                </a:lnTo>
                <a:lnTo>
                  <a:pt x="4064" y="461137"/>
                </a:lnTo>
                <a:lnTo>
                  <a:pt x="77343" y="483743"/>
                </a:lnTo>
                <a:close/>
              </a:path>
              <a:path w="96520" h="483870">
                <a:moveTo>
                  <a:pt x="77851" y="398399"/>
                </a:moveTo>
                <a:lnTo>
                  <a:pt x="76555" y="390944"/>
                </a:lnTo>
                <a:lnTo>
                  <a:pt x="72885" y="385152"/>
                </a:lnTo>
                <a:lnTo>
                  <a:pt x="66840" y="380987"/>
                </a:lnTo>
                <a:lnTo>
                  <a:pt x="58420" y="378460"/>
                </a:lnTo>
                <a:lnTo>
                  <a:pt x="56261" y="389890"/>
                </a:lnTo>
                <a:lnTo>
                  <a:pt x="59944" y="390398"/>
                </a:lnTo>
                <a:lnTo>
                  <a:pt x="62611" y="391414"/>
                </a:lnTo>
                <a:lnTo>
                  <a:pt x="65659" y="394208"/>
                </a:lnTo>
                <a:lnTo>
                  <a:pt x="66421" y="395986"/>
                </a:lnTo>
                <a:lnTo>
                  <a:pt x="66421" y="401066"/>
                </a:lnTo>
                <a:lnTo>
                  <a:pt x="65151" y="403352"/>
                </a:lnTo>
                <a:lnTo>
                  <a:pt x="62611" y="405130"/>
                </a:lnTo>
                <a:lnTo>
                  <a:pt x="59944" y="406908"/>
                </a:lnTo>
                <a:lnTo>
                  <a:pt x="55499" y="407797"/>
                </a:lnTo>
                <a:lnTo>
                  <a:pt x="49276" y="407797"/>
                </a:lnTo>
                <a:lnTo>
                  <a:pt x="43561" y="407924"/>
                </a:lnTo>
                <a:lnTo>
                  <a:pt x="39497" y="407035"/>
                </a:lnTo>
                <a:lnTo>
                  <a:pt x="37084" y="405384"/>
                </a:lnTo>
                <a:lnTo>
                  <a:pt x="34671" y="403606"/>
                </a:lnTo>
                <a:lnTo>
                  <a:pt x="33401" y="401320"/>
                </a:lnTo>
                <a:lnTo>
                  <a:pt x="33401" y="394081"/>
                </a:lnTo>
                <a:lnTo>
                  <a:pt x="36068" y="391414"/>
                </a:lnTo>
                <a:lnTo>
                  <a:pt x="41656" y="390525"/>
                </a:lnTo>
                <a:lnTo>
                  <a:pt x="38989" y="379222"/>
                </a:lnTo>
                <a:lnTo>
                  <a:pt x="33147" y="380746"/>
                </a:lnTo>
                <a:lnTo>
                  <a:pt x="28956" y="383032"/>
                </a:lnTo>
                <a:lnTo>
                  <a:pt x="26289" y="386334"/>
                </a:lnTo>
                <a:lnTo>
                  <a:pt x="23622" y="389509"/>
                </a:lnTo>
                <a:lnTo>
                  <a:pt x="22352" y="393700"/>
                </a:lnTo>
                <a:lnTo>
                  <a:pt x="22479" y="405130"/>
                </a:lnTo>
                <a:lnTo>
                  <a:pt x="24892" y="410083"/>
                </a:lnTo>
                <a:lnTo>
                  <a:pt x="29591" y="414020"/>
                </a:lnTo>
                <a:lnTo>
                  <a:pt x="34417" y="417830"/>
                </a:lnTo>
                <a:lnTo>
                  <a:pt x="41402" y="419608"/>
                </a:lnTo>
                <a:lnTo>
                  <a:pt x="50419" y="419608"/>
                </a:lnTo>
                <a:lnTo>
                  <a:pt x="58039" y="419481"/>
                </a:lnTo>
                <a:lnTo>
                  <a:pt x="64516" y="417703"/>
                </a:lnTo>
                <a:lnTo>
                  <a:pt x="75184" y="410845"/>
                </a:lnTo>
                <a:lnTo>
                  <a:pt x="76644" y="407924"/>
                </a:lnTo>
                <a:lnTo>
                  <a:pt x="77851" y="405511"/>
                </a:lnTo>
                <a:lnTo>
                  <a:pt x="77851" y="398399"/>
                </a:lnTo>
                <a:close/>
              </a:path>
              <a:path w="96520" h="483870">
                <a:moveTo>
                  <a:pt x="96393" y="358140"/>
                </a:moveTo>
                <a:lnTo>
                  <a:pt x="69723" y="358394"/>
                </a:lnTo>
                <a:lnTo>
                  <a:pt x="72644" y="356235"/>
                </a:lnTo>
                <a:lnTo>
                  <a:pt x="74676" y="354076"/>
                </a:lnTo>
                <a:lnTo>
                  <a:pt x="76111" y="351409"/>
                </a:lnTo>
                <a:lnTo>
                  <a:pt x="76835" y="350151"/>
                </a:lnTo>
                <a:lnTo>
                  <a:pt x="77343" y="347980"/>
                </a:lnTo>
                <a:lnTo>
                  <a:pt x="77216" y="340753"/>
                </a:lnTo>
                <a:lnTo>
                  <a:pt x="76479" y="339471"/>
                </a:lnTo>
                <a:lnTo>
                  <a:pt x="74803" y="336550"/>
                </a:lnTo>
                <a:lnTo>
                  <a:pt x="69977" y="332994"/>
                </a:lnTo>
                <a:lnTo>
                  <a:pt x="66217" y="330314"/>
                </a:lnTo>
                <a:lnTo>
                  <a:pt x="66217" y="351536"/>
                </a:lnTo>
                <a:lnTo>
                  <a:pt x="64897" y="353822"/>
                </a:lnTo>
                <a:lnTo>
                  <a:pt x="62103" y="355727"/>
                </a:lnTo>
                <a:lnTo>
                  <a:pt x="59182" y="357759"/>
                </a:lnTo>
                <a:lnTo>
                  <a:pt x="54864" y="358775"/>
                </a:lnTo>
                <a:lnTo>
                  <a:pt x="48768" y="358775"/>
                </a:lnTo>
                <a:lnTo>
                  <a:pt x="43561" y="358902"/>
                </a:lnTo>
                <a:lnTo>
                  <a:pt x="39624" y="358013"/>
                </a:lnTo>
                <a:lnTo>
                  <a:pt x="36957" y="356108"/>
                </a:lnTo>
                <a:lnTo>
                  <a:pt x="34290" y="354330"/>
                </a:lnTo>
                <a:lnTo>
                  <a:pt x="33083" y="352171"/>
                </a:lnTo>
                <a:lnTo>
                  <a:pt x="32994" y="348754"/>
                </a:lnTo>
                <a:lnTo>
                  <a:pt x="32893" y="346583"/>
                </a:lnTo>
                <a:lnTo>
                  <a:pt x="34290" y="344297"/>
                </a:lnTo>
                <a:lnTo>
                  <a:pt x="39624" y="340487"/>
                </a:lnTo>
                <a:lnTo>
                  <a:pt x="43815" y="339598"/>
                </a:lnTo>
                <a:lnTo>
                  <a:pt x="49403" y="339598"/>
                </a:lnTo>
                <a:lnTo>
                  <a:pt x="55372" y="339471"/>
                </a:lnTo>
                <a:lnTo>
                  <a:pt x="59563" y="340360"/>
                </a:lnTo>
                <a:lnTo>
                  <a:pt x="64897" y="343928"/>
                </a:lnTo>
                <a:lnTo>
                  <a:pt x="66167" y="346075"/>
                </a:lnTo>
                <a:lnTo>
                  <a:pt x="66217" y="351536"/>
                </a:lnTo>
                <a:lnTo>
                  <a:pt x="66217" y="330314"/>
                </a:lnTo>
                <a:lnTo>
                  <a:pt x="65024" y="329450"/>
                </a:lnTo>
                <a:lnTo>
                  <a:pt x="58039" y="327660"/>
                </a:lnTo>
                <a:lnTo>
                  <a:pt x="40259" y="327926"/>
                </a:lnTo>
                <a:lnTo>
                  <a:pt x="33528" y="329704"/>
                </a:lnTo>
                <a:lnTo>
                  <a:pt x="28829" y="333375"/>
                </a:lnTo>
                <a:lnTo>
                  <a:pt x="24130" y="336931"/>
                </a:lnTo>
                <a:lnTo>
                  <a:pt x="21844" y="341249"/>
                </a:lnTo>
                <a:lnTo>
                  <a:pt x="21932" y="349250"/>
                </a:lnTo>
                <a:lnTo>
                  <a:pt x="22733" y="351536"/>
                </a:lnTo>
                <a:lnTo>
                  <a:pt x="26035" y="356362"/>
                </a:lnTo>
                <a:lnTo>
                  <a:pt x="28194" y="358267"/>
                </a:lnTo>
                <a:lnTo>
                  <a:pt x="30988" y="359664"/>
                </a:lnTo>
                <a:lnTo>
                  <a:pt x="23241" y="359791"/>
                </a:lnTo>
                <a:lnTo>
                  <a:pt x="23368" y="370459"/>
                </a:lnTo>
                <a:lnTo>
                  <a:pt x="96393" y="369697"/>
                </a:lnTo>
                <a:lnTo>
                  <a:pt x="96393" y="358902"/>
                </a:lnTo>
                <a:lnTo>
                  <a:pt x="96393" y="358394"/>
                </a:lnTo>
                <a:lnTo>
                  <a:pt x="96393" y="35814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0" name="object 60"/>
          <p:cNvSpPr txBox="1"/>
          <p:nvPr/>
        </p:nvSpPr>
        <p:spPr>
          <a:xfrm>
            <a:off x="7003646" y="9339305"/>
            <a:ext cx="429259" cy="56705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spc="-10" dirty="0">
                <a:latin typeface="Arial Narrow"/>
                <a:cs typeface="Arial Narrow"/>
              </a:rPr>
              <a:t>Acp6.9-</a:t>
            </a:r>
            <a:r>
              <a:rPr sz="800" b="1" spc="-20" dirty="0">
                <a:latin typeface="Arial Narrow"/>
                <a:cs typeface="Arial Narrow"/>
              </a:rPr>
              <a:t>chiA</a:t>
            </a:r>
            <a:endParaRPr sz="800">
              <a:latin typeface="Arial Narrow"/>
              <a:cs typeface="Arial Narrow"/>
            </a:endParaRPr>
          </a:p>
          <a:p>
            <a:pPr marL="12700">
              <a:lnSpc>
                <a:spcPct val="100000"/>
              </a:lnSpc>
            </a:pPr>
            <a:r>
              <a:rPr sz="800" b="1" dirty="0">
                <a:latin typeface="Arial Narrow"/>
                <a:cs typeface="Arial Narrow"/>
              </a:rPr>
              <a:t>/</a:t>
            </a:r>
            <a:r>
              <a:rPr sz="800" b="1" spc="50" dirty="0">
                <a:latin typeface="Arial Narrow"/>
                <a:cs typeface="Arial Narrow"/>
              </a:rPr>
              <a:t> </a:t>
            </a:r>
            <a:r>
              <a:rPr sz="800" b="1" spc="-10" dirty="0">
                <a:latin typeface="Arial Narrow"/>
                <a:cs typeface="Arial Narrow"/>
              </a:rPr>
              <a:t>polh-</a:t>
            </a:r>
            <a:r>
              <a:rPr sz="800" b="1" spc="-20" dirty="0">
                <a:latin typeface="Arial Narrow"/>
                <a:cs typeface="Arial Narrow"/>
              </a:rPr>
              <a:t>cath</a:t>
            </a:r>
            <a:endParaRPr sz="800">
              <a:latin typeface="Arial Narrow"/>
              <a:cs typeface="Arial Narrow"/>
            </a:endParaRPr>
          </a:p>
          <a:p>
            <a:pPr marL="16510">
              <a:lnSpc>
                <a:spcPct val="100000"/>
              </a:lnSpc>
              <a:spcBef>
                <a:spcPts val="335"/>
              </a:spcBef>
            </a:pPr>
            <a:r>
              <a:rPr sz="800" b="1" dirty="0">
                <a:latin typeface="Arial Narrow"/>
                <a:cs typeface="Arial Narrow"/>
              </a:rPr>
              <a:t>AcMNPV-</a:t>
            </a:r>
            <a:r>
              <a:rPr sz="800" b="1" spc="-25" dirty="0">
                <a:latin typeface="Arial Narrow"/>
                <a:cs typeface="Arial Narrow"/>
              </a:rPr>
              <a:t>Rep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61" name="object 61"/>
          <p:cNvSpPr/>
          <p:nvPr/>
        </p:nvSpPr>
        <p:spPr>
          <a:xfrm>
            <a:off x="7498715" y="9399778"/>
            <a:ext cx="96520" cy="483870"/>
          </a:xfrm>
          <a:custGeom>
            <a:avLst/>
            <a:gdLst/>
            <a:ahLst/>
            <a:cxnLst/>
            <a:rect l="l" t="t" r="r" b="b"/>
            <a:pathLst>
              <a:path w="96520" h="483870">
                <a:moveTo>
                  <a:pt x="13462" y="77597"/>
                </a:moveTo>
                <a:lnTo>
                  <a:pt x="13335" y="66040"/>
                </a:lnTo>
                <a:lnTo>
                  <a:pt x="381" y="66167"/>
                </a:lnTo>
                <a:lnTo>
                  <a:pt x="508" y="77724"/>
                </a:lnTo>
                <a:lnTo>
                  <a:pt x="13462" y="77597"/>
                </a:lnTo>
                <a:close/>
              </a:path>
              <a:path w="96520" h="483870">
                <a:moveTo>
                  <a:pt x="55372" y="203962"/>
                </a:moveTo>
                <a:lnTo>
                  <a:pt x="55118" y="181483"/>
                </a:lnTo>
                <a:lnTo>
                  <a:pt x="41148" y="181610"/>
                </a:lnTo>
                <a:lnTo>
                  <a:pt x="41275" y="204089"/>
                </a:lnTo>
                <a:lnTo>
                  <a:pt x="55372" y="203962"/>
                </a:lnTo>
                <a:close/>
              </a:path>
              <a:path w="96520" h="483870">
                <a:moveTo>
                  <a:pt x="73406" y="60198"/>
                </a:moveTo>
                <a:lnTo>
                  <a:pt x="73279" y="47371"/>
                </a:lnTo>
                <a:lnTo>
                  <a:pt x="56769" y="42545"/>
                </a:lnTo>
                <a:lnTo>
                  <a:pt x="56730" y="38989"/>
                </a:lnTo>
                <a:lnTo>
                  <a:pt x="56553" y="22479"/>
                </a:lnTo>
                <a:lnTo>
                  <a:pt x="56515" y="18542"/>
                </a:lnTo>
                <a:lnTo>
                  <a:pt x="73025" y="13081"/>
                </a:lnTo>
                <a:lnTo>
                  <a:pt x="72898" y="0"/>
                </a:lnTo>
                <a:lnTo>
                  <a:pt x="44323" y="9715"/>
                </a:lnTo>
                <a:lnTo>
                  <a:pt x="44323" y="38989"/>
                </a:lnTo>
                <a:lnTo>
                  <a:pt x="17145" y="31115"/>
                </a:lnTo>
                <a:lnTo>
                  <a:pt x="44196" y="22479"/>
                </a:lnTo>
                <a:lnTo>
                  <a:pt x="44323" y="38989"/>
                </a:lnTo>
                <a:lnTo>
                  <a:pt x="44323" y="9715"/>
                </a:lnTo>
                <a:lnTo>
                  <a:pt x="0" y="24765"/>
                </a:lnTo>
                <a:lnTo>
                  <a:pt x="127" y="37465"/>
                </a:lnTo>
                <a:lnTo>
                  <a:pt x="73406" y="60198"/>
                </a:lnTo>
                <a:close/>
              </a:path>
              <a:path w="96520" h="483870">
                <a:moveTo>
                  <a:pt x="73660" y="76962"/>
                </a:moveTo>
                <a:lnTo>
                  <a:pt x="73533" y="65532"/>
                </a:lnTo>
                <a:lnTo>
                  <a:pt x="20574" y="66040"/>
                </a:lnTo>
                <a:lnTo>
                  <a:pt x="20701" y="77470"/>
                </a:lnTo>
                <a:lnTo>
                  <a:pt x="73660" y="76962"/>
                </a:lnTo>
                <a:close/>
              </a:path>
              <a:path w="96520" h="483870">
                <a:moveTo>
                  <a:pt x="74041" y="115824"/>
                </a:moveTo>
                <a:lnTo>
                  <a:pt x="47371" y="116078"/>
                </a:lnTo>
                <a:lnTo>
                  <a:pt x="40894" y="116078"/>
                </a:lnTo>
                <a:lnTo>
                  <a:pt x="30353" y="104140"/>
                </a:lnTo>
                <a:lnTo>
                  <a:pt x="31496" y="102108"/>
                </a:lnTo>
                <a:lnTo>
                  <a:pt x="35306" y="100076"/>
                </a:lnTo>
                <a:lnTo>
                  <a:pt x="39370" y="99695"/>
                </a:lnTo>
                <a:lnTo>
                  <a:pt x="45847" y="99568"/>
                </a:lnTo>
                <a:lnTo>
                  <a:pt x="73787" y="99314"/>
                </a:lnTo>
                <a:lnTo>
                  <a:pt x="73660" y="87757"/>
                </a:lnTo>
                <a:lnTo>
                  <a:pt x="42672" y="88138"/>
                </a:lnTo>
                <a:lnTo>
                  <a:pt x="36703" y="88138"/>
                </a:lnTo>
                <a:lnTo>
                  <a:pt x="32512" y="88519"/>
                </a:lnTo>
                <a:lnTo>
                  <a:pt x="30099" y="89281"/>
                </a:lnTo>
                <a:lnTo>
                  <a:pt x="26670" y="90297"/>
                </a:lnTo>
                <a:lnTo>
                  <a:pt x="24130" y="92075"/>
                </a:lnTo>
                <a:lnTo>
                  <a:pt x="22352" y="94361"/>
                </a:lnTo>
                <a:lnTo>
                  <a:pt x="20574" y="96774"/>
                </a:lnTo>
                <a:lnTo>
                  <a:pt x="19761" y="99314"/>
                </a:lnTo>
                <a:lnTo>
                  <a:pt x="19685" y="105664"/>
                </a:lnTo>
                <a:lnTo>
                  <a:pt x="20320" y="108077"/>
                </a:lnTo>
                <a:lnTo>
                  <a:pt x="21717" y="110236"/>
                </a:lnTo>
                <a:lnTo>
                  <a:pt x="22987" y="112522"/>
                </a:lnTo>
                <a:lnTo>
                  <a:pt x="25019" y="114427"/>
                </a:lnTo>
                <a:lnTo>
                  <a:pt x="27686" y="116205"/>
                </a:lnTo>
                <a:lnTo>
                  <a:pt x="889" y="116459"/>
                </a:lnTo>
                <a:lnTo>
                  <a:pt x="1016" y="128016"/>
                </a:lnTo>
                <a:lnTo>
                  <a:pt x="74041" y="127381"/>
                </a:lnTo>
                <a:lnTo>
                  <a:pt x="74041" y="116078"/>
                </a:lnTo>
                <a:lnTo>
                  <a:pt x="74041" y="115824"/>
                </a:lnTo>
                <a:close/>
              </a:path>
              <a:path w="96520" h="483870">
                <a:moveTo>
                  <a:pt x="75438" y="270510"/>
                </a:moveTo>
                <a:lnTo>
                  <a:pt x="75311" y="259080"/>
                </a:lnTo>
                <a:lnTo>
                  <a:pt x="61341" y="259207"/>
                </a:lnTo>
                <a:lnTo>
                  <a:pt x="61468" y="270637"/>
                </a:lnTo>
                <a:lnTo>
                  <a:pt x="75438" y="270510"/>
                </a:lnTo>
                <a:close/>
              </a:path>
              <a:path w="96520" h="483870">
                <a:moveTo>
                  <a:pt x="75692" y="161798"/>
                </a:moveTo>
                <a:lnTo>
                  <a:pt x="56261" y="134747"/>
                </a:lnTo>
                <a:lnTo>
                  <a:pt x="53975" y="146050"/>
                </a:lnTo>
                <a:lnTo>
                  <a:pt x="57785" y="146685"/>
                </a:lnTo>
                <a:lnTo>
                  <a:pt x="60452" y="147574"/>
                </a:lnTo>
                <a:lnTo>
                  <a:pt x="61849" y="148971"/>
                </a:lnTo>
                <a:lnTo>
                  <a:pt x="63373" y="150368"/>
                </a:lnTo>
                <a:lnTo>
                  <a:pt x="64135" y="152146"/>
                </a:lnTo>
                <a:lnTo>
                  <a:pt x="46990" y="164084"/>
                </a:lnTo>
                <a:lnTo>
                  <a:pt x="41275" y="164084"/>
                </a:lnTo>
                <a:lnTo>
                  <a:pt x="37211" y="163322"/>
                </a:lnTo>
                <a:lnTo>
                  <a:pt x="34798" y="161544"/>
                </a:lnTo>
                <a:lnTo>
                  <a:pt x="32385" y="159893"/>
                </a:lnTo>
                <a:lnTo>
                  <a:pt x="31242" y="157607"/>
                </a:lnTo>
                <a:lnTo>
                  <a:pt x="31115" y="150368"/>
                </a:lnTo>
                <a:lnTo>
                  <a:pt x="33909" y="147701"/>
                </a:lnTo>
                <a:lnTo>
                  <a:pt x="39370" y="146812"/>
                </a:lnTo>
                <a:lnTo>
                  <a:pt x="36830" y="135509"/>
                </a:lnTo>
                <a:lnTo>
                  <a:pt x="20066" y="149860"/>
                </a:lnTo>
                <a:lnTo>
                  <a:pt x="20180" y="154686"/>
                </a:lnTo>
                <a:lnTo>
                  <a:pt x="20307" y="161544"/>
                </a:lnTo>
                <a:lnTo>
                  <a:pt x="22606" y="166370"/>
                </a:lnTo>
                <a:lnTo>
                  <a:pt x="27432" y="170180"/>
                </a:lnTo>
                <a:lnTo>
                  <a:pt x="32131" y="173990"/>
                </a:lnTo>
                <a:lnTo>
                  <a:pt x="39116" y="175895"/>
                </a:lnTo>
                <a:lnTo>
                  <a:pt x="48260" y="175768"/>
                </a:lnTo>
                <a:lnTo>
                  <a:pt x="55753" y="175768"/>
                </a:lnTo>
                <a:lnTo>
                  <a:pt x="62230" y="173990"/>
                </a:lnTo>
                <a:lnTo>
                  <a:pt x="73025" y="167005"/>
                </a:lnTo>
                <a:lnTo>
                  <a:pt x="74510" y="164084"/>
                </a:lnTo>
                <a:lnTo>
                  <a:pt x="75692" y="161798"/>
                </a:lnTo>
                <a:close/>
              </a:path>
              <a:path w="96520" h="483870">
                <a:moveTo>
                  <a:pt x="76327" y="226580"/>
                </a:moveTo>
                <a:lnTo>
                  <a:pt x="74358" y="223139"/>
                </a:lnTo>
                <a:lnTo>
                  <a:pt x="73279" y="221234"/>
                </a:lnTo>
                <a:lnTo>
                  <a:pt x="67310" y="217309"/>
                </a:lnTo>
                <a:lnTo>
                  <a:pt x="62204" y="214642"/>
                </a:lnTo>
                <a:lnTo>
                  <a:pt x="55689" y="212750"/>
                </a:lnTo>
                <a:lnTo>
                  <a:pt x="47726" y="211645"/>
                </a:lnTo>
                <a:lnTo>
                  <a:pt x="40132" y="211391"/>
                </a:lnTo>
                <a:lnTo>
                  <a:pt x="40132" y="234315"/>
                </a:lnTo>
                <a:lnTo>
                  <a:pt x="39116" y="236359"/>
                </a:lnTo>
                <a:lnTo>
                  <a:pt x="36830" y="237883"/>
                </a:lnTo>
                <a:lnTo>
                  <a:pt x="34671" y="239407"/>
                </a:lnTo>
                <a:lnTo>
                  <a:pt x="31242" y="240284"/>
                </a:lnTo>
                <a:lnTo>
                  <a:pt x="21844" y="240284"/>
                </a:lnTo>
                <a:lnTo>
                  <a:pt x="18415" y="239649"/>
                </a:lnTo>
                <a:lnTo>
                  <a:pt x="14351" y="236855"/>
                </a:lnTo>
                <a:lnTo>
                  <a:pt x="13335" y="235077"/>
                </a:lnTo>
                <a:lnTo>
                  <a:pt x="13335" y="230759"/>
                </a:lnTo>
                <a:lnTo>
                  <a:pt x="14605" y="228854"/>
                </a:lnTo>
                <a:lnTo>
                  <a:pt x="19431" y="225310"/>
                </a:lnTo>
                <a:lnTo>
                  <a:pt x="22987" y="224409"/>
                </a:lnTo>
                <a:lnTo>
                  <a:pt x="27559" y="224409"/>
                </a:lnTo>
                <a:lnTo>
                  <a:pt x="31750" y="224282"/>
                </a:lnTo>
                <a:lnTo>
                  <a:pt x="40132" y="234315"/>
                </a:lnTo>
                <a:lnTo>
                  <a:pt x="40132" y="211391"/>
                </a:lnTo>
                <a:lnTo>
                  <a:pt x="1854" y="226187"/>
                </a:lnTo>
                <a:lnTo>
                  <a:pt x="1778" y="238010"/>
                </a:lnTo>
                <a:lnTo>
                  <a:pt x="4064" y="242582"/>
                </a:lnTo>
                <a:lnTo>
                  <a:pt x="8509" y="246126"/>
                </a:lnTo>
                <a:lnTo>
                  <a:pt x="12954" y="249809"/>
                </a:lnTo>
                <a:lnTo>
                  <a:pt x="19050" y="251587"/>
                </a:lnTo>
                <a:lnTo>
                  <a:pt x="26670" y="251587"/>
                </a:lnTo>
                <a:lnTo>
                  <a:pt x="33909" y="251460"/>
                </a:lnTo>
                <a:lnTo>
                  <a:pt x="39624" y="249682"/>
                </a:lnTo>
                <a:lnTo>
                  <a:pt x="48260" y="242582"/>
                </a:lnTo>
                <a:lnTo>
                  <a:pt x="49466" y="240284"/>
                </a:lnTo>
                <a:lnTo>
                  <a:pt x="50419" y="238506"/>
                </a:lnTo>
                <a:lnTo>
                  <a:pt x="50419" y="231775"/>
                </a:lnTo>
                <a:lnTo>
                  <a:pt x="49911" y="229755"/>
                </a:lnTo>
                <a:lnTo>
                  <a:pt x="48691" y="227838"/>
                </a:lnTo>
                <a:lnTo>
                  <a:pt x="47752" y="226187"/>
                </a:lnTo>
                <a:lnTo>
                  <a:pt x="46228" y="224663"/>
                </a:lnTo>
                <a:lnTo>
                  <a:pt x="45720" y="224282"/>
                </a:lnTo>
                <a:lnTo>
                  <a:pt x="44196" y="223139"/>
                </a:lnTo>
                <a:lnTo>
                  <a:pt x="64770" y="236232"/>
                </a:lnTo>
                <a:lnTo>
                  <a:pt x="62103" y="238379"/>
                </a:lnTo>
                <a:lnTo>
                  <a:pt x="56642" y="239014"/>
                </a:lnTo>
                <a:lnTo>
                  <a:pt x="58293" y="250063"/>
                </a:lnTo>
                <a:lnTo>
                  <a:pt x="76225" y="237883"/>
                </a:lnTo>
                <a:lnTo>
                  <a:pt x="76327" y="226580"/>
                </a:lnTo>
                <a:close/>
              </a:path>
              <a:path w="96520" h="483870">
                <a:moveTo>
                  <a:pt x="76962" y="294005"/>
                </a:moveTo>
                <a:lnTo>
                  <a:pt x="75755" y="291592"/>
                </a:lnTo>
                <a:lnTo>
                  <a:pt x="74676" y="289433"/>
                </a:lnTo>
                <a:lnTo>
                  <a:pt x="70231" y="285750"/>
                </a:lnTo>
                <a:lnTo>
                  <a:pt x="65786" y="282206"/>
                </a:lnTo>
                <a:lnTo>
                  <a:pt x="65405" y="282092"/>
                </a:lnTo>
                <a:lnTo>
                  <a:pt x="65405" y="301256"/>
                </a:lnTo>
                <a:lnTo>
                  <a:pt x="64135" y="303149"/>
                </a:lnTo>
                <a:lnTo>
                  <a:pt x="59309" y="306705"/>
                </a:lnTo>
                <a:lnTo>
                  <a:pt x="55753" y="307606"/>
                </a:lnTo>
                <a:lnTo>
                  <a:pt x="46990" y="307606"/>
                </a:lnTo>
                <a:lnTo>
                  <a:pt x="38608" y="297561"/>
                </a:lnTo>
                <a:lnTo>
                  <a:pt x="39624" y="295656"/>
                </a:lnTo>
                <a:lnTo>
                  <a:pt x="41783" y="294132"/>
                </a:lnTo>
                <a:lnTo>
                  <a:pt x="44069" y="292481"/>
                </a:lnTo>
                <a:lnTo>
                  <a:pt x="47498" y="291731"/>
                </a:lnTo>
                <a:lnTo>
                  <a:pt x="52324" y="291731"/>
                </a:lnTo>
                <a:lnTo>
                  <a:pt x="56896" y="291592"/>
                </a:lnTo>
                <a:lnTo>
                  <a:pt x="60198" y="292354"/>
                </a:lnTo>
                <a:lnTo>
                  <a:pt x="64262" y="295160"/>
                </a:lnTo>
                <a:lnTo>
                  <a:pt x="65278" y="296926"/>
                </a:lnTo>
                <a:lnTo>
                  <a:pt x="65405" y="301256"/>
                </a:lnTo>
                <a:lnTo>
                  <a:pt x="65405" y="282092"/>
                </a:lnTo>
                <a:lnTo>
                  <a:pt x="59817" y="280289"/>
                </a:lnTo>
                <a:lnTo>
                  <a:pt x="44831" y="280555"/>
                </a:lnTo>
                <a:lnTo>
                  <a:pt x="38989" y="282333"/>
                </a:lnTo>
                <a:lnTo>
                  <a:pt x="34671" y="285877"/>
                </a:lnTo>
                <a:lnTo>
                  <a:pt x="30353" y="289306"/>
                </a:lnTo>
                <a:lnTo>
                  <a:pt x="28194" y="293509"/>
                </a:lnTo>
                <a:lnTo>
                  <a:pt x="28321" y="300355"/>
                </a:lnTo>
                <a:lnTo>
                  <a:pt x="28829" y="302260"/>
                </a:lnTo>
                <a:lnTo>
                  <a:pt x="29921" y="304165"/>
                </a:lnTo>
                <a:lnTo>
                  <a:pt x="30988" y="305816"/>
                </a:lnTo>
                <a:lnTo>
                  <a:pt x="32512" y="307340"/>
                </a:lnTo>
                <a:lnTo>
                  <a:pt x="34544" y="308737"/>
                </a:lnTo>
                <a:lnTo>
                  <a:pt x="26289" y="308356"/>
                </a:lnTo>
                <a:lnTo>
                  <a:pt x="20828" y="307467"/>
                </a:lnTo>
                <a:lnTo>
                  <a:pt x="15240" y="304165"/>
                </a:lnTo>
                <a:lnTo>
                  <a:pt x="13919" y="302260"/>
                </a:lnTo>
                <a:lnTo>
                  <a:pt x="13843" y="295783"/>
                </a:lnTo>
                <a:lnTo>
                  <a:pt x="16510" y="293509"/>
                </a:lnTo>
                <a:lnTo>
                  <a:pt x="21971" y="292989"/>
                </a:lnTo>
                <a:lnTo>
                  <a:pt x="20320" y="281813"/>
                </a:lnTo>
                <a:lnTo>
                  <a:pt x="2413" y="305435"/>
                </a:lnTo>
                <a:lnTo>
                  <a:pt x="5461" y="310781"/>
                </a:lnTo>
                <a:lnTo>
                  <a:pt x="40259" y="320675"/>
                </a:lnTo>
                <a:lnTo>
                  <a:pt x="49441" y="320205"/>
                </a:lnTo>
                <a:lnTo>
                  <a:pt x="75095" y="308737"/>
                </a:lnTo>
                <a:lnTo>
                  <a:pt x="75742" y="307606"/>
                </a:lnTo>
                <a:lnTo>
                  <a:pt x="76962" y="305435"/>
                </a:lnTo>
                <a:lnTo>
                  <a:pt x="76962" y="294005"/>
                </a:lnTo>
                <a:close/>
              </a:path>
              <a:path w="96520" h="483870">
                <a:moveTo>
                  <a:pt x="77470" y="483870"/>
                </a:moveTo>
                <a:lnTo>
                  <a:pt x="77343" y="470916"/>
                </a:lnTo>
                <a:lnTo>
                  <a:pt x="60706" y="466217"/>
                </a:lnTo>
                <a:lnTo>
                  <a:pt x="60655" y="462534"/>
                </a:lnTo>
                <a:lnTo>
                  <a:pt x="60490" y="446151"/>
                </a:lnTo>
                <a:lnTo>
                  <a:pt x="60452" y="442214"/>
                </a:lnTo>
                <a:lnTo>
                  <a:pt x="76962" y="436753"/>
                </a:lnTo>
                <a:lnTo>
                  <a:pt x="76835" y="423672"/>
                </a:lnTo>
                <a:lnTo>
                  <a:pt x="48260" y="433349"/>
                </a:lnTo>
                <a:lnTo>
                  <a:pt x="48260" y="462534"/>
                </a:lnTo>
                <a:lnTo>
                  <a:pt x="21082" y="454660"/>
                </a:lnTo>
                <a:lnTo>
                  <a:pt x="48133" y="446151"/>
                </a:lnTo>
                <a:lnTo>
                  <a:pt x="48260" y="462534"/>
                </a:lnTo>
                <a:lnTo>
                  <a:pt x="48260" y="433349"/>
                </a:lnTo>
                <a:lnTo>
                  <a:pt x="4064" y="448310"/>
                </a:lnTo>
                <a:lnTo>
                  <a:pt x="4191" y="461137"/>
                </a:lnTo>
                <a:lnTo>
                  <a:pt x="77470" y="483870"/>
                </a:lnTo>
                <a:close/>
              </a:path>
              <a:path w="96520" h="483870">
                <a:moveTo>
                  <a:pt x="77978" y="405511"/>
                </a:moveTo>
                <a:lnTo>
                  <a:pt x="58547" y="378587"/>
                </a:lnTo>
                <a:lnTo>
                  <a:pt x="56261" y="389890"/>
                </a:lnTo>
                <a:lnTo>
                  <a:pt x="60071" y="390525"/>
                </a:lnTo>
                <a:lnTo>
                  <a:pt x="62738" y="391414"/>
                </a:lnTo>
                <a:lnTo>
                  <a:pt x="64135" y="392811"/>
                </a:lnTo>
                <a:lnTo>
                  <a:pt x="65659" y="394208"/>
                </a:lnTo>
                <a:lnTo>
                  <a:pt x="66421" y="395986"/>
                </a:lnTo>
                <a:lnTo>
                  <a:pt x="66433" y="398526"/>
                </a:lnTo>
                <a:lnTo>
                  <a:pt x="66548" y="401066"/>
                </a:lnTo>
                <a:lnTo>
                  <a:pt x="65151" y="403352"/>
                </a:lnTo>
                <a:lnTo>
                  <a:pt x="60071" y="406908"/>
                </a:lnTo>
                <a:lnTo>
                  <a:pt x="55626" y="407797"/>
                </a:lnTo>
                <a:lnTo>
                  <a:pt x="49276" y="407924"/>
                </a:lnTo>
                <a:lnTo>
                  <a:pt x="43561" y="407924"/>
                </a:lnTo>
                <a:lnTo>
                  <a:pt x="39497" y="407162"/>
                </a:lnTo>
                <a:lnTo>
                  <a:pt x="34671" y="403606"/>
                </a:lnTo>
                <a:lnTo>
                  <a:pt x="33528" y="401447"/>
                </a:lnTo>
                <a:lnTo>
                  <a:pt x="33401" y="394081"/>
                </a:lnTo>
                <a:lnTo>
                  <a:pt x="36195" y="391541"/>
                </a:lnTo>
                <a:lnTo>
                  <a:pt x="41656" y="390652"/>
                </a:lnTo>
                <a:lnTo>
                  <a:pt x="39116" y="379349"/>
                </a:lnTo>
                <a:lnTo>
                  <a:pt x="22352" y="393700"/>
                </a:lnTo>
                <a:lnTo>
                  <a:pt x="22479" y="405130"/>
                </a:lnTo>
                <a:lnTo>
                  <a:pt x="24892" y="410210"/>
                </a:lnTo>
                <a:lnTo>
                  <a:pt x="34544" y="417830"/>
                </a:lnTo>
                <a:lnTo>
                  <a:pt x="41402" y="419735"/>
                </a:lnTo>
                <a:lnTo>
                  <a:pt x="50546" y="419608"/>
                </a:lnTo>
                <a:lnTo>
                  <a:pt x="58039" y="419608"/>
                </a:lnTo>
                <a:lnTo>
                  <a:pt x="64516" y="417830"/>
                </a:lnTo>
                <a:lnTo>
                  <a:pt x="75311" y="410845"/>
                </a:lnTo>
                <a:lnTo>
                  <a:pt x="76771" y="407924"/>
                </a:lnTo>
                <a:lnTo>
                  <a:pt x="77978" y="405511"/>
                </a:lnTo>
                <a:close/>
              </a:path>
              <a:path w="96520" h="483870">
                <a:moveTo>
                  <a:pt x="96520" y="369824"/>
                </a:moveTo>
                <a:lnTo>
                  <a:pt x="96393" y="358902"/>
                </a:lnTo>
                <a:lnTo>
                  <a:pt x="96393" y="358521"/>
                </a:lnTo>
                <a:lnTo>
                  <a:pt x="96393" y="358267"/>
                </a:lnTo>
                <a:lnTo>
                  <a:pt x="69723" y="358521"/>
                </a:lnTo>
                <a:lnTo>
                  <a:pt x="72644" y="356235"/>
                </a:lnTo>
                <a:lnTo>
                  <a:pt x="74676" y="354203"/>
                </a:lnTo>
                <a:lnTo>
                  <a:pt x="75882" y="352056"/>
                </a:lnTo>
                <a:lnTo>
                  <a:pt x="76835" y="350139"/>
                </a:lnTo>
                <a:lnTo>
                  <a:pt x="77470" y="348107"/>
                </a:lnTo>
                <a:lnTo>
                  <a:pt x="77343" y="340880"/>
                </a:lnTo>
                <a:lnTo>
                  <a:pt x="76555" y="339483"/>
                </a:lnTo>
                <a:lnTo>
                  <a:pt x="74930" y="336550"/>
                </a:lnTo>
                <a:lnTo>
                  <a:pt x="69977" y="333006"/>
                </a:lnTo>
                <a:lnTo>
                  <a:pt x="66294" y="330288"/>
                </a:lnTo>
                <a:lnTo>
                  <a:pt x="66294" y="346075"/>
                </a:lnTo>
                <a:lnTo>
                  <a:pt x="66294" y="351536"/>
                </a:lnTo>
                <a:lnTo>
                  <a:pt x="64897" y="353834"/>
                </a:lnTo>
                <a:lnTo>
                  <a:pt x="62103" y="355854"/>
                </a:lnTo>
                <a:lnTo>
                  <a:pt x="59309" y="357759"/>
                </a:lnTo>
                <a:lnTo>
                  <a:pt x="54864" y="358775"/>
                </a:lnTo>
                <a:lnTo>
                  <a:pt x="48895" y="358902"/>
                </a:lnTo>
                <a:lnTo>
                  <a:pt x="43561" y="358902"/>
                </a:lnTo>
                <a:lnTo>
                  <a:pt x="33020" y="346583"/>
                </a:lnTo>
                <a:lnTo>
                  <a:pt x="34290" y="344309"/>
                </a:lnTo>
                <a:lnTo>
                  <a:pt x="36957" y="342531"/>
                </a:lnTo>
                <a:lnTo>
                  <a:pt x="39624" y="340614"/>
                </a:lnTo>
                <a:lnTo>
                  <a:pt x="43815" y="339610"/>
                </a:lnTo>
                <a:lnTo>
                  <a:pt x="49403" y="339610"/>
                </a:lnTo>
                <a:lnTo>
                  <a:pt x="55372" y="339483"/>
                </a:lnTo>
                <a:lnTo>
                  <a:pt x="59690" y="340360"/>
                </a:lnTo>
                <a:lnTo>
                  <a:pt x="62357" y="342138"/>
                </a:lnTo>
                <a:lnTo>
                  <a:pt x="64897" y="343916"/>
                </a:lnTo>
                <a:lnTo>
                  <a:pt x="66294" y="346075"/>
                </a:lnTo>
                <a:lnTo>
                  <a:pt x="66294" y="330288"/>
                </a:lnTo>
                <a:lnTo>
                  <a:pt x="65151" y="329438"/>
                </a:lnTo>
                <a:lnTo>
                  <a:pt x="58166" y="327787"/>
                </a:lnTo>
                <a:lnTo>
                  <a:pt x="49022" y="327787"/>
                </a:lnTo>
                <a:lnTo>
                  <a:pt x="21971" y="349008"/>
                </a:lnTo>
                <a:lnTo>
                  <a:pt x="22860" y="351536"/>
                </a:lnTo>
                <a:lnTo>
                  <a:pt x="24638" y="354330"/>
                </a:lnTo>
                <a:lnTo>
                  <a:pt x="26035" y="356362"/>
                </a:lnTo>
                <a:lnTo>
                  <a:pt x="28321" y="358267"/>
                </a:lnTo>
                <a:lnTo>
                  <a:pt x="31115" y="359664"/>
                </a:lnTo>
                <a:lnTo>
                  <a:pt x="23368" y="359791"/>
                </a:lnTo>
                <a:lnTo>
                  <a:pt x="23368" y="370459"/>
                </a:lnTo>
                <a:lnTo>
                  <a:pt x="96520" y="36982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2" name="object 62"/>
          <p:cNvSpPr/>
          <p:nvPr/>
        </p:nvSpPr>
        <p:spPr>
          <a:xfrm>
            <a:off x="7790688" y="9313164"/>
            <a:ext cx="747395" cy="0"/>
          </a:xfrm>
          <a:custGeom>
            <a:avLst/>
            <a:gdLst/>
            <a:ahLst/>
            <a:cxnLst/>
            <a:rect l="l" t="t" r="r" b="b"/>
            <a:pathLst>
              <a:path w="747395">
                <a:moveTo>
                  <a:pt x="0" y="0"/>
                </a:moveTo>
                <a:lnTo>
                  <a:pt x="360044" y="0"/>
                </a:lnTo>
              </a:path>
              <a:path w="747395">
                <a:moveTo>
                  <a:pt x="387095" y="0"/>
                </a:moveTo>
                <a:lnTo>
                  <a:pt x="747140" y="0"/>
                </a:lnTo>
              </a:path>
            </a:pathLst>
          </a:custGeom>
          <a:ln w="1219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3" name="object 63"/>
          <p:cNvSpPr txBox="1"/>
          <p:nvPr/>
        </p:nvSpPr>
        <p:spPr>
          <a:xfrm>
            <a:off x="7610833" y="9327114"/>
            <a:ext cx="443865" cy="58102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spc="-10" dirty="0">
                <a:latin typeface="Arial Narrow"/>
                <a:cs typeface="Arial Narrow"/>
              </a:rPr>
              <a:t>Acp6.9-</a:t>
            </a:r>
            <a:r>
              <a:rPr sz="800" b="1" spc="-20" dirty="0">
                <a:latin typeface="Arial Narrow"/>
                <a:cs typeface="Arial Narrow"/>
              </a:rPr>
              <a:t>chiA</a:t>
            </a:r>
            <a:endParaRPr sz="800">
              <a:latin typeface="Arial Narrow"/>
              <a:cs typeface="Arial Narrow"/>
            </a:endParaRPr>
          </a:p>
          <a:p>
            <a:pPr marL="12700">
              <a:lnSpc>
                <a:spcPct val="100000"/>
              </a:lnSpc>
            </a:pPr>
            <a:r>
              <a:rPr sz="800" b="1" dirty="0">
                <a:latin typeface="Arial Narrow"/>
                <a:cs typeface="Arial Narrow"/>
              </a:rPr>
              <a:t>/</a:t>
            </a:r>
            <a:r>
              <a:rPr sz="800" b="1" spc="50" dirty="0">
                <a:latin typeface="Arial Narrow"/>
                <a:cs typeface="Arial Narrow"/>
              </a:rPr>
              <a:t> </a:t>
            </a:r>
            <a:r>
              <a:rPr sz="800" b="1" spc="-10" dirty="0">
                <a:latin typeface="Arial Narrow"/>
                <a:cs typeface="Arial Narrow"/>
              </a:rPr>
              <a:t>polh-</a:t>
            </a:r>
            <a:r>
              <a:rPr sz="800" b="1" spc="-20" dirty="0">
                <a:latin typeface="Arial Narrow"/>
                <a:cs typeface="Arial Narrow"/>
              </a:rPr>
              <a:t>cath</a:t>
            </a:r>
            <a:endParaRPr sz="800">
              <a:latin typeface="Arial Narrow"/>
              <a:cs typeface="Arial Narrow"/>
            </a:endParaRPr>
          </a:p>
          <a:p>
            <a:pPr marL="30480">
              <a:lnSpc>
                <a:spcPct val="100000"/>
              </a:lnSpc>
              <a:spcBef>
                <a:spcPts val="450"/>
              </a:spcBef>
            </a:pPr>
            <a:r>
              <a:rPr sz="800" b="1" dirty="0">
                <a:latin typeface="Arial Narrow"/>
                <a:cs typeface="Arial Narrow"/>
              </a:rPr>
              <a:t>AcMNPV-</a:t>
            </a:r>
            <a:r>
              <a:rPr sz="800" b="1" spc="-25" dirty="0">
                <a:latin typeface="Arial Narrow"/>
                <a:cs typeface="Arial Narrow"/>
              </a:rPr>
              <a:t>Rep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64" name="object 64"/>
          <p:cNvSpPr/>
          <p:nvPr/>
        </p:nvSpPr>
        <p:spPr>
          <a:xfrm>
            <a:off x="8662416" y="9311640"/>
            <a:ext cx="747395" cy="0"/>
          </a:xfrm>
          <a:custGeom>
            <a:avLst/>
            <a:gdLst/>
            <a:ahLst/>
            <a:cxnLst/>
            <a:rect l="l" t="t" r="r" b="b"/>
            <a:pathLst>
              <a:path w="747395">
                <a:moveTo>
                  <a:pt x="0" y="0"/>
                </a:moveTo>
                <a:lnTo>
                  <a:pt x="360044" y="0"/>
                </a:lnTo>
              </a:path>
              <a:path w="747395">
                <a:moveTo>
                  <a:pt x="387095" y="0"/>
                </a:moveTo>
                <a:lnTo>
                  <a:pt x="747140" y="0"/>
                </a:lnTo>
              </a:path>
            </a:pathLst>
          </a:custGeom>
          <a:ln w="1219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5" name="object 65"/>
          <p:cNvSpPr txBox="1"/>
          <p:nvPr/>
        </p:nvSpPr>
        <p:spPr>
          <a:xfrm>
            <a:off x="8160257" y="8844153"/>
            <a:ext cx="869950" cy="46291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57785">
              <a:lnSpc>
                <a:spcPct val="100000"/>
              </a:lnSpc>
              <a:spcBef>
                <a:spcPts val="100"/>
              </a:spcBef>
            </a:pPr>
            <a:r>
              <a:rPr sz="1200" b="1" spc="-20" dirty="0">
                <a:latin typeface="Arial"/>
                <a:cs typeface="Arial"/>
              </a:rPr>
              <a:t>proV-CATH</a:t>
            </a:r>
            <a:endParaRPr sz="120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800"/>
              </a:spcBef>
              <a:tabLst>
                <a:tab pos="540385" algn="l"/>
              </a:tabLst>
            </a:pPr>
            <a:r>
              <a:rPr sz="1000" b="1" spc="-25" dirty="0">
                <a:latin typeface="Arial Narrow"/>
                <a:cs typeface="Arial Narrow"/>
              </a:rPr>
              <a:t>SOL</a:t>
            </a:r>
            <a:r>
              <a:rPr sz="1000" b="1" dirty="0">
                <a:latin typeface="Arial Narrow"/>
                <a:cs typeface="Arial Narrow"/>
              </a:rPr>
              <a:t>	</a:t>
            </a:r>
            <a:r>
              <a:rPr sz="1000" b="1" spc="-10" dirty="0">
                <a:latin typeface="Arial Narrow"/>
                <a:cs typeface="Arial Narrow"/>
              </a:rPr>
              <a:t>INSOL</a:t>
            </a:r>
            <a:endParaRPr sz="1000">
              <a:latin typeface="Arial Narrow"/>
              <a:cs typeface="Arial Narrow"/>
            </a:endParaRPr>
          </a:p>
        </p:txBody>
      </p:sp>
      <p:sp>
        <p:nvSpPr>
          <p:cNvPr id="66" name="object 66"/>
          <p:cNvSpPr/>
          <p:nvPr/>
        </p:nvSpPr>
        <p:spPr>
          <a:xfrm>
            <a:off x="8110728" y="9387585"/>
            <a:ext cx="96520" cy="483870"/>
          </a:xfrm>
          <a:custGeom>
            <a:avLst/>
            <a:gdLst/>
            <a:ahLst/>
            <a:cxnLst/>
            <a:rect l="l" t="t" r="r" b="b"/>
            <a:pathLst>
              <a:path w="96520" h="483870">
                <a:moveTo>
                  <a:pt x="13462" y="77597"/>
                </a:moveTo>
                <a:lnTo>
                  <a:pt x="13335" y="66040"/>
                </a:lnTo>
                <a:lnTo>
                  <a:pt x="381" y="66167"/>
                </a:lnTo>
                <a:lnTo>
                  <a:pt x="508" y="77724"/>
                </a:lnTo>
                <a:lnTo>
                  <a:pt x="13462" y="77597"/>
                </a:lnTo>
                <a:close/>
              </a:path>
              <a:path w="96520" h="483870">
                <a:moveTo>
                  <a:pt x="55245" y="203962"/>
                </a:moveTo>
                <a:lnTo>
                  <a:pt x="54991" y="181356"/>
                </a:lnTo>
                <a:lnTo>
                  <a:pt x="41021" y="181483"/>
                </a:lnTo>
                <a:lnTo>
                  <a:pt x="41275" y="204089"/>
                </a:lnTo>
                <a:lnTo>
                  <a:pt x="55245" y="203962"/>
                </a:lnTo>
                <a:close/>
              </a:path>
              <a:path w="96520" h="483870">
                <a:moveTo>
                  <a:pt x="73406" y="60198"/>
                </a:moveTo>
                <a:lnTo>
                  <a:pt x="73279" y="47244"/>
                </a:lnTo>
                <a:lnTo>
                  <a:pt x="56642" y="42545"/>
                </a:lnTo>
                <a:lnTo>
                  <a:pt x="56591" y="38862"/>
                </a:lnTo>
                <a:lnTo>
                  <a:pt x="56426" y="22479"/>
                </a:lnTo>
                <a:lnTo>
                  <a:pt x="56388" y="18542"/>
                </a:lnTo>
                <a:lnTo>
                  <a:pt x="72898" y="13081"/>
                </a:lnTo>
                <a:lnTo>
                  <a:pt x="72771" y="0"/>
                </a:lnTo>
                <a:lnTo>
                  <a:pt x="44323" y="9639"/>
                </a:lnTo>
                <a:lnTo>
                  <a:pt x="44323" y="38862"/>
                </a:lnTo>
                <a:lnTo>
                  <a:pt x="17018" y="30988"/>
                </a:lnTo>
                <a:lnTo>
                  <a:pt x="44069" y="22479"/>
                </a:lnTo>
                <a:lnTo>
                  <a:pt x="44323" y="38862"/>
                </a:lnTo>
                <a:lnTo>
                  <a:pt x="44323" y="9639"/>
                </a:lnTo>
                <a:lnTo>
                  <a:pt x="0" y="24638"/>
                </a:lnTo>
                <a:lnTo>
                  <a:pt x="127" y="37465"/>
                </a:lnTo>
                <a:lnTo>
                  <a:pt x="73406" y="60198"/>
                </a:lnTo>
                <a:close/>
              </a:path>
              <a:path w="96520" h="483870">
                <a:moveTo>
                  <a:pt x="73533" y="76962"/>
                </a:moveTo>
                <a:lnTo>
                  <a:pt x="73406" y="65532"/>
                </a:lnTo>
                <a:lnTo>
                  <a:pt x="20447" y="65913"/>
                </a:lnTo>
                <a:lnTo>
                  <a:pt x="20574" y="77470"/>
                </a:lnTo>
                <a:lnTo>
                  <a:pt x="73533" y="76962"/>
                </a:lnTo>
                <a:close/>
              </a:path>
              <a:path w="96520" h="483870">
                <a:moveTo>
                  <a:pt x="74041" y="127381"/>
                </a:moveTo>
                <a:lnTo>
                  <a:pt x="73914" y="116078"/>
                </a:lnTo>
                <a:lnTo>
                  <a:pt x="73914" y="115824"/>
                </a:lnTo>
                <a:lnTo>
                  <a:pt x="47371" y="116078"/>
                </a:lnTo>
                <a:lnTo>
                  <a:pt x="40894" y="116078"/>
                </a:lnTo>
                <a:lnTo>
                  <a:pt x="36322" y="115316"/>
                </a:lnTo>
                <a:lnTo>
                  <a:pt x="34036" y="113665"/>
                </a:lnTo>
                <a:lnTo>
                  <a:pt x="31623" y="112141"/>
                </a:lnTo>
                <a:lnTo>
                  <a:pt x="30353" y="109855"/>
                </a:lnTo>
                <a:lnTo>
                  <a:pt x="30353" y="104140"/>
                </a:lnTo>
                <a:lnTo>
                  <a:pt x="73787" y="99314"/>
                </a:lnTo>
                <a:lnTo>
                  <a:pt x="73660" y="87757"/>
                </a:lnTo>
                <a:lnTo>
                  <a:pt x="42545" y="88138"/>
                </a:lnTo>
                <a:lnTo>
                  <a:pt x="36576" y="88138"/>
                </a:lnTo>
                <a:lnTo>
                  <a:pt x="32512" y="88519"/>
                </a:lnTo>
                <a:lnTo>
                  <a:pt x="19558" y="105664"/>
                </a:lnTo>
                <a:lnTo>
                  <a:pt x="20320" y="108077"/>
                </a:lnTo>
                <a:lnTo>
                  <a:pt x="21590" y="110236"/>
                </a:lnTo>
                <a:lnTo>
                  <a:pt x="22987" y="112395"/>
                </a:lnTo>
                <a:lnTo>
                  <a:pt x="25019" y="114427"/>
                </a:lnTo>
                <a:lnTo>
                  <a:pt x="27686" y="116205"/>
                </a:lnTo>
                <a:lnTo>
                  <a:pt x="762" y="116459"/>
                </a:lnTo>
                <a:lnTo>
                  <a:pt x="889" y="128016"/>
                </a:lnTo>
                <a:lnTo>
                  <a:pt x="74041" y="127381"/>
                </a:lnTo>
                <a:close/>
              </a:path>
              <a:path w="96520" h="483870">
                <a:moveTo>
                  <a:pt x="75311" y="259080"/>
                </a:moveTo>
                <a:lnTo>
                  <a:pt x="61214" y="259207"/>
                </a:lnTo>
                <a:lnTo>
                  <a:pt x="61341" y="270649"/>
                </a:lnTo>
                <a:lnTo>
                  <a:pt x="75311" y="270522"/>
                </a:lnTo>
                <a:lnTo>
                  <a:pt x="75311" y="259080"/>
                </a:lnTo>
                <a:close/>
              </a:path>
              <a:path w="96520" h="483870">
                <a:moveTo>
                  <a:pt x="75565" y="154686"/>
                </a:moveTo>
                <a:lnTo>
                  <a:pt x="74269" y="147167"/>
                </a:lnTo>
                <a:lnTo>
                  <a:pt x="70612" y="141338"/>
                </a:lnTo>
                <a:lnTo>
                  <a:pt x="64554" y="137210"/>
                </a:lnTo>
                <a:lnTo>
                  <a:pt x="56134" y="134747"/>
                </a:lnTo>
                <a:lnTo>
                  <a:pt x="53975" y="146050"/>
                </a:lnTo>
                <a:lnTo>
                  <a:pt x="57658" y="146685"/>
                </a:lnTo>
                <a:lnTo>
                  <a:pt x="60325" y="147574"/>
                </a:lnTo>
                <a:lnTo>
                  <a:pt x="63373" y="150368"/>
                </a:lnTo>
                <a:lnTo>
                  <a:pt x="64135" y="152146"/>
                </a:lnTo>
                <a:lnTo>
                  <a:pt x="64135" y="157226"/>
                </a:lnTo>
                <a:lnTo>
                  <a:pt x="46990" y="164084"/>
                </a:lnTo>
                <a:lnTo>
                  <a:pt x="41275" y="164084"/>
                </a:lnTo>
                <a:lnTo>
                  <a:pt x="37211" y="163195"/>
                </a:lnTo>
                <a:lnTo>
                  <a:pt x="34798" y="161544"/>
                </a:lnTo>
                <a:lnTo>
                  <a:pt x="32385" y="159766"/>
                </a:lnTo>
                <a:lnTo>
                  <a:pt x="31115" y="157480"/>
                </a:lnTo>
                <a:lnTo>
                  <a:pt x="31115" y="150241"/>
                </a:lnTo>
                <a:lnTo>
                  <a:pt x="33782" y="147574"/>
                </a:lnTo>
                <a:lnTo>
                  <a:pt x="39370" y="146812"/>
                </a:lnTo>
                <a:lnTo>
                  <a:pt x="36703" y="135509"/>
                </a:lnTo>
                <a:lnTo>
                  <a:pt x="30861" y="136906"/>
                </a:lnTo>
                <a:lnTo>
                  <a:pt x="26670" y="139192"/>
                </a:lnTo>
                <a:lnTo>
                  <a:pt x="24003" y="142494"/>
                </a:lnTo>
                <a:lnTo>
                  <a:pt x="21336" y="145669"/>
                </a:lnTo>
                <a:lnTo>
                  <a:pt x="20066" y="149860"/>
                </a:lnTo>
                <a:lnTo>
                  <a:pt x="20193" y="161290"/>
                </a:lnTo>
                <a:lnTo>
                  <a:pt x="22606" y="166370"/>
                </a:lnTo>
                <a:lnTo>
                  <a:pt x="27305" y="170180"/>
                </a:lnTo>
                <a:lnTo>
                  <a:pt x="32131" y="173990"/>
                </a:lnTo>
                <a:lnTo>
                  <a:pt x="39116" y="175895"/>
                </a:lnTo>
                <a:lnTo>
                  <a:pt x="48133" y="175768"/>
                </a:lnTo>
                <a:lnTo>
                  <a:pt x="55753" y="175768"/>
                </a:lnTo>
                <a:lnTo>
                  <a:pt x="62230" y="173990"/>
                </a:lnTo>
                <a:lnTo>
                  <a:pt x="67564" y="170434"/>
                </a:lnTo>
                <a:lnTo>
                  <a:pt x="72898" y="167005"/>
                </a:lnTo>
                <a:lnTo>
                  <a:pt x="74358" y="164084"/>
                </a:lnTo>
                <a:lnTo>
                  <a:pt x="75565" y="161671"/>
                </a:lnTo>
                <a:lnTo>
                  <a:pt x="75565" y="154686"/>
                </a:lnTo>
                <a:close/>
              </a:path>
              <a:path w="96520" h="483870">
                <a:moveTo>
                  <a:pt x="76212" y="237871"/>
                </a:moveTo>
                <a:lnTo>
                  <a:pt x="76123" y="226441"/>
                </a:lnTo>
                <a:lnTo>
                  <a:pt x="74231" y="223151"/>
                </a:lnTo>
                <a:lnTo>
                  <a:pt x="73152" y="221234"/>
                </a:lnTo>
                <a:lnTo>
                  <a:pt x="40132" y="211391"/>
                </a:lnTo>
                <a:lnTo>
                  <a:pt x="40132" y="234327"/>
                </a:lnTo>
                <a:lnTo>
                  <a:pt x="38989" y="236220"/>
                </a:lnTo>
                <a:lnTo>
                  <a:pt x="36830" y="237871"/>
                </a:lnTo>
                <a:lnTo>
                  <a:pt x="34671" y="239395"/>
                </a:lnTo>
                <a:lnTo>
                  <a:pt x="31242" y="240157"/>
                </a:lnTo>
                <a:lnTo>
                  <a:pt x="26543" y="240284"/>
                </a:lnTo>
                <a:lnTo>
                  <a:pt x="21844" y="240284"/>
                </a:lnTo>
                <a:lnTo>
                  <a:pt x="18415" y="239649"/>
                </a:lnTo>
                <a:lnTo>
                  <a:pt x="14351" y="236855"/>
                </a:lnTo>
                <a:lnTo>
                  <a:pt x="13335" y="235077"/>
                </a:lnTo>
                <a:lnTo>
                  <a:pt x="13258" y="231775"/>
                </a:lnTo>
                <a:lnTo>
                  <a:pt x="13208" y="230759"/>
                </a:lnTo>
                <a:lnTo>
                  <a:pt x="14478" y="228727"/>
                </a:lnTo>
                <a:lnTo>
                  <a:pt x="16891" y="227076"/>
                </a:lnTo>
                <a:lnTo>
                  <a:pt x="19304" y="225298"/>
                </a:lnTo>
                <a:lnTo>
                  <a:pt x="22860" y="224409"/>
                </a:lnTo>
                <a:lnTo>
                  <a:pt x="27432" y="224282"/>
                </a:lnTo>
                <a:lnTo>
                  <a:pt x="31623" y="224282"/>
                </a:lnTo>
                <a:lnTo>
                  <a:pt x="34798" y="225044"/>
                </a:lnTo>
                <a:lnTo>
                  <a:pt x="36830" y="226568"/>
                </a:lnTo>
                <a:lnTo>
                  <a:pt x="38989" y="228092"/>
                </a:lnTo>
                <a:lnTo>
                  <a:pt x="40005" y="229870"/>
                </a:lnTo>
                <a:lnTo>
                  <a:pt x="40132" y="234327"/>
                </a:lnTo>
                <a:lnTo>
                  <a:pt x="40132" y="211391"/>
                </a:lnTo>
                <a:lnTo>
                  <a:pt x="1790" y="226199"/>
                </a:lnTo>
                <a:lnTo>
                  <a:pt x="1778" y="237998"/>
                </a:lnTo>
                <a:lnTo>
                  <a:pt x="3937" y="242443"/>
                </a:lnTo>
                <a:lnTo>
                  <a:pt x="12827" y="249809"/>
                </a:lnTo>
                <a:lnTo>
                  <a:pt x="18923" y="251599"/>
                </a:lnTo>
                <a:lnTo>
                  <a:pt x="26670" y="251472"/>
                </a:lnTo>
                <a:lnTo>
                  <a:pt x="33909" y="251472"/>
                </a:lnTo>
                <a:lnTo>
                  <a:pt x="39624" y="249682"/>
                </a:lnTo>
                <a:lnTo>
                  <a:pt x="48260" y="242570"/>
                </a:lnTo>
                <a:lnTo>
                  <a:pt x="49466" y="240284"/>
                </a:lnTo>
                <a:lnTo>
                  <a:pt x="50419" y="238506"/>
                </a:lnTo>
                <a:lnTo>
                  <a:pt x="44069" y="223151"/>
                </a:lnTo>
                <a:lnTo>
                  <a:pt x="52324" y="223520"/>
                </a:lnTo>
                <a:lnTo>
                  <a:pt x="57912" y="224548"/>
                </a:lnTo>
                <a:lnTo>
                  <a:pt x="60579" y="226199"/>
                </a:lnTo>
                <a:lnTo>
                  <a:pt x="63246" y="227723"/>
                </a:lnTo>
                <a:lnTo>
                  <a:pt x="64643" y="229870"/>
                </a:lnTo>
                <a:lnTo>
                  <a:pt x="64770" y="236220"/>
                </a:lnTo>
                <a:lnTo>
                  <a:pt x="61976" y="238379"/>
                </a:lnTo>
                <a:lnTo>
                  <a:pt x="56642" y="239026"/>
                </a:lnTo>
                <a:lnTo>
                  <a:pt x="58166" y="250075"/>
                </a:lnTo>
                <a:lnTo>
                  <a:pt x="64389" y="249174"/>
                </a:lnTo>
                <a:lnTo>
                  <a:pt x="68961" y="247269"/>
                </a:lnTo>
                <a:lnTo>
                  <a:pt x="71882" y="244221"/>
                </a:lnTo>
                <a:lnTo>
                  <a:pt x="74803" y="241300"/>
                </a:lnTo>
                <a:lnTo>
                  <a:pt x="76212" y="237871"/>
                </a:lnTo>
                <a:close/>
              </a:path>
              <a:path w="96520" h="483870">
                <a:moveTo>
                  <a:pt x="76962" y="305447"/>
                </a:moveTo>
                <a:lnTo>
                  <a:pt x="76835" y="294005"/>
                </a:lnTo>
                <a:lnTo>
                  <a:pt x="75628" y="291592"/>
                </a:lnTo>
                <a:lnTo>
                  <a:pt x="74549" y="289433"/>
                </a:lnTo>
                <a:lnTo>
                  <a:pt x="70231" y="285750"/>
                </a:lnTo>
                <a:lnTo>
                  <a:pt x="65786" y="282067"/>
                </a:lnTo>
                <a:lnTo>
                  <a:pt x="65278" y="281927"/>
                </a:lnTo>
                <a:lnTo>
                  <a:pt x="65278" y="296799"/>
                </a:lnTo>
                <a:lnTo>
                  <a:pt x="65278" y="301244"/>
                </a:lnTo>
                <a:lnTo>
                  <a:pt x="64135" y="303149"/>
                </a:lnTo>
                <a:lnTo>
                  <a:pt x="61722" y="304927"/>
                </a:lnTo>
                <a:lnTo>
                  <a:pt x="59182" y="306705"/>
                </a:lnTo>
                <a:lnTo>
                  <a:pt x="55753" y="307594"/>
                </a:lnTo>
                <a:lnTo>
                  <a:pt x="46990" y="307594"/>
                </a:lnTo>
                <a:lnTo>
                  <a:pt x="43815" y="306832"/>
                </a:lnTo>
                <a:lnTo>
                  <a:pt x="41783" y="305308"/>
                </a:lnTo>
                <a:lnTo>
                  <a:pt x="39624" y="303923"/>
                </a:lnTo>
                <a:lnTo>
                  <a:pt x="38671" y="302133"/>
                </a:lnTo>
                <a:lnTo>
                  <a:pt x="38557" y="299097"/>
                </a:lnTo>
                <a:lnTo>
                  <a:pt x="38481" y="297573"/>
                </a:lnTo>
                <a:lnTo>
                  <a:pt x="39624" y="295656"/>
                </a:lnTo>
                <a:lnTo>
                  <a:pt x="41783" y="294005"/>
                </a:lnTo>
                <a:lnTo>
                  <a:pt x="43942" y="292481"/>
                </a:lnTo>
                <a:lnTo>
                  <a:pt x="47371" y="291719"/>
                </a:lnTo>
                <a:lnTo>
                  <a:pt x="52197" y="291719"/>
                </a:lnTo>
                <a:lnTo>
                  <a:pt x="56769" y="291592"/>
                </a:lnTo>
                <a:lnTo>
                  <a:pt x="60198" y="292354"/>
                </a:lnTo>
                <a:lnTo>
                  <a:pt x="64262" y="295148"/>
                </a:lnTo>
                <a:lnTo>
                  <a:pt x="65278" y="296799"/>
                </a:lnTo>
                <a:lnTo>
                  <a:pt x="65278" y="281927"/>
                </a:lnTo>
                <a:lnTo>
                  <a:pt x="59690" y="280301"/>
                </a:lnTo>
                <a:lnTo>
                  <a:pt x="51943" y="280416"/>
                </a:lnTo>
                <a:lnTo>
                  <a:pt x="44704" y="280416"/>
                </a:lnTo>
                <a:lnTo>
                  <a:pt x="38989" y="282321"/>
                </a:lnTo>
                <a:lnTo>
                  <a:pt x="34671" y="285750"/>
                </a:lnTo>
                <a:lnTo>
                  <a:pt x="30353" y="289306"/>
                </a:lnTo>
                <a:lnTo>
                  <a:pt x="28194" y="293497"/>
                </a:lnTo>
                <a:lnTo>
                  <a:pt x="28194" y="300228"/>
                </a:lnTo>
                <a:lnTo>
                  <a:pt x="28702" y="302272"/>
                </a:lnTo>
                <a:lnTo>
                  <a:pt x="29921" y="304177"/>
                </a:lnTo>
                <a:lnTo>
                  <a:pt x="30861" y="305701"/>
                </a:lnTo>
                <a:lnTo>
                  <a:pt x="32385" y="307352"/>
                </a:lnTo>
                <a:lnTo>
                  <a:pt x="34544" y="308749"/>
                </a:lnTo>
                <a:lnTo>
                  <a:pt x="26162" y="308356"/>
                </a:lnTo>
                <a:lnTo>
                  <a:pt x="13716" y="295783"/>
                </a:lnTo>
                <a:lnTo>
                  <a:pt x="16510" y="293497"/>
                </a:lnTo>
                <a:lnTo>
                  <a:pt x="21844" y="293001"/>
                </a:lnTo>
                <a:lnTo>
                  <a:pt x="20320" y="281825"/>
                </a:lnTo>
                <a:lnTo>
                  <a:pt x="14224" y="282702"/>
                </a:lnTo>
                <a:lnTo>
                  <a:pt x="9652" y="284734"/>
                </a:lnTo>
                <a:lnTo>
                  <a:pt x="6731" y="287782"/>
                </a:lnTo>
                <a:lnTo>
                  <a:pt x="3683" y="290830"/>
                </a:lnTo>
                <a:lnTo>
                  <a:pt x="2514" y="294005"/>
                </a:lnTo>
                <a:lnTo>
                  <a:pt x="2413" y="305447"/>
                </a:lnTo>
                <a:lnTo>
                  <a:pt x="5334" y="310642"/>
                </a:lnTo>
                <a:lnTo>
                  <a:pt x="40259" y="320548"/>
                </a:lnTo>
                <a:lnTo>
                  <a:pt x="49390" y="320103"/>
                </a:lnTo>
                <a:lnTo>
                  <a:pt x="75742" y="307594"/>
                </a:lnTo>
                <a:lnTo>
                  <a:pt x="76962" y="305447"/>
                </a:lnTo>
                <a:close/>
              </a:path>
              <a:path w="96520" h="483870">
                <a:moveTo>
                  <a:pt x="77343" y="483870"/>
                </a:moveTo>
                <a:lnTo>
                  <a:pt x="77216" y="470916"/>
                </a:lnTo>
                <a:lnTo>
                  <a:pt x="60706" y="466090"/>
                </a:lnTo>
                <a:lnTo>
                  <a:pt x="60667" y="462534"/>
                </a:lnTo>
                <a:lnTo>
                  <a:pt x="60490" y="446151"/>
                </a:lnTo>
                <a:lnTo>
                  <a:pt x="60452" y="442214"/>
                </a:lnTo>
                <a:lnTo>
                  <a:pt x="76962" y="436753"/>
                </a:lnTo>
                <a:lnTo>
                  <a:pt x="76835" y="423672"/>
                </a:lnTo>
                <a:lnTo>
                  <a:pt x="48260" y="433336"/>
                </a:lnTo>
                <a:lnTo>
                  <a:pt x="48260" y="462534"/>
                </a:lnTo>
                <a:lnTo>
                  <a:pt x="21082" y="454660"/>
                </a:lnTo>
                <a:lnTo>
                  <a:pt x="48133" y="446151"/>
                </a:lnTo>
                <a:lnTo>
                  <a:pt x="48260" y="462534"/>
                </a:lnTo>
                <a:lnTo>
                  <a:pt x="48260" y="433336"/>
                </a:lnTo>
                <a:lnTo>
                  <a:pt x="3937" y="448310"/>
                </a:lnTo>
                <a:lnTo>
                  <a:pt x="4064" y="461137"/>
                </a:lnTo>
                <a:lnTo>
                  <a:pt x="77343" y="483870"/>
                </a:lnTo>
                <a:close/>
              </a:path>
              <a:path w="96520" h="483870">
                <a:moveTo>
                  <a:pt x="77851" y="398526"/>
                </a:moveTo>
                <a:lnTo>
                  <a:pt x="76555" y="391007"/>
                </a:lnTo>
                <a:lnTo>
                  <a:pt x="72885" y="385178"/>
                </a:lnTo>
                <a:lnTo>
                  <a:pt x="66840" y="381050"/>
                </a:lnTo>
                <a:lnTo>
                  <a:pt x="58420" y="378587"/>
                </a:lnTo>
                <a:lnTo>
                  <a:pt x="56261" y="389890"/>
                </a:lnTo>
                <a:lnTo>
                  <a:pt x="59944" y="390398"/>
                </a:lnTo>
                <a:lnTo>
                  <a:pt x="62611" y="391414"/>
                </a:lnTo>
                <a:lnTo>
                  <a:pt x="65659" y="394208"/>
                </a:lnTo>
                <a:lnTo>
                  <a:pt x="66421" y="395986"/>
                </a:lnTo>
                <a:lnTo>
                  <a:pt x="66421" y="401066"/>
                </a:lnTo>
                <a:lnTo>
                  <a:pt x="65151" y="403352"/>
                </a:lnTo>
                <a:lnTo>
                  <a:pt x="62611" y="405130"/>
                </a:lnTo>
                <a:lnTo>
                  <a:pt x="59944" y="406908"/>
                </a:lnTo>
                <a:lnTo>
                  <a:pt x="55499" y="407797"/>
                </a:lnTo>
                <a:lnTo>
                  <a:pt x="49276" y="407797"/>
                </a:lnTo>
                <a:lnTo>
                  <a:pt x="43561" y="407924"/>
                </a:lnTo>
                <a:lnTo>
                  <a:pt x="39497" y="407035"/>
                </a:lnTo>
                <a:lnTo>
                  <a:pt x="37084" y="405384"/>
                </a:lnTo>
                <a:lnTo>
                  <a:pt x="34671" y="403606"/>
                </a:lnTo>
                <a:lnTo>
                  <a:pt x="33401" y="401320"/>
                </a:lnTo>
                <a:lnTo>
                  <a:pt x="33401" y="394081"/>
                </a:lnTo>
                <a:lnTo>
                  <a:pt x="36068" y="391414"/>
                </a:lnTo>
                <a:lnTo>
                  <a:pt x="41656" y="390525"/>
                </a:lnTo>
                <a:lnTo>
                  <a:pt x="38989" y="379222"/>
                </a:lnTo>
                <a:lnTo>
                  <a:pt x="33147" y="380746"/>
                </a:lnTo>
                <a:lnTo>
                  <a:pt x="28956" y="383032"/>
                </a:lnTo>
                <a:lnTo>
                  <a:pt x="26289" y="386334"/>
                </a:lnTo>
                <a:lnTo>
                  <a:pt x="23622" y="389509"/>
                </a:lnTo>
                <a:lnTo>
                  <a:pt x="22352" y="393700"/>
                </a:lnTo>
                <a:lnTo>
                  <a:pt x="22479" y="405130"/>
                </a:lnTo>
                <a:lnTo>
                  <a:pt x="24892" y="410210"/>
                </a:lnTo>
                <a:lnTo>
                  <a:pt x="29591" y="414020"/>
                </a:lnTo>
                <a:lnTo>
                  <a:pt x="34417" y="417830"/>
                </a:lnTo>
                <a:lnTo>
                  <a:pt x="41402" y="419735"/>
                </a:lnTo>
                <a:lnTo>
                  <a:pt x="58039" y="419481"/>
                </a:lnTo>
                <a:lnTo>
                  <a:pt x="64516" y="417830"/>
                </a:lnTo>
                <a:lnTo>
                  <a:pt x="69850" y="414274"/>
                </a:lnTo>
                <a:lnTo>
                  <a:pt x="75184" y="410845"/>
                </a:lnTo>
                <a:lnTo>
                  <a:pt x="76644" y="407924"/>
                </a:lnTo>
                <a:lnTo>
                  <a:pt x="77851" y="405511"/>
                </a:lnTo>
                <a:lnTo>
                  <a:pt x="77851" y="398526"/>
                </a:lnTo>
                <a:close/>
              </a:path>
              <a:path w="96520" h="483870">
                <a:moveTo>
                  <a:pt x="96393" y="358267"/>
                </a:moveTo>
                <a:lnTo>
                  <a:pt x="69723" y="358521"/>
                </a:lnTo>
                <a:lnTo>
                  <a:pt x="72644" y="356247"/>
                </a:lnTo>
                <a:lnTo>
                  <a:pt x="74676" y="354203"/>
                </a:lnTo>
                <a:lnTo>
                  <a:pt x="75755" y="352044"/>
                </a:lnTo>
                <a:lnTo>
                  <a:pt x="76835" y="350151"/>
                </a:lnTo>
                <a:lnTo>
                  <a:pt x="77343" y="347980"/>
                </a:lnTo>
                <a:lnTo>
                  <a:pt x="77216" y="340741"/>
                </a:lnTo>
                <a:lnTo>
                  <a:pt x="76479" y="339471"/>
                </a:lnTo>
                <a:lnTo>
                  <a:pt x="74803" y="336550"/>
                </a:lnTo>
                <a:lnTo>
                  <a:pt x="69977" y="332994"/>
                </a:lnTo>
                <a:lnTo>
                  <a:pt x="66217" y="330314"/>
                </a:lnTo>
                <a:lnTo>
                  <a:pt x="66217" y="351548"/>
                </a:lnTo>
                <a:lnTo>
                  <a:pt x="64897" y="353822"/>
                </a:lnTo>
                <a:lnTo>
                  <a:pt x="62103" y="355854"/>
                </a:lnTo>
                <a:lnTo>
                  <a:pt x="59182" y="357759"/>
                </a:lnTo>
                <a:lnTo>
                  <a:pt x="54864" y="358775"/>
                </a:lnTo>
                <a:lnTo>
                  <a:pt x="48768" y="358775"/>
                </a:lnTo>
                <a:lnTo>
                  <a:pt x="43561" y="358902"/>
                </a:lnTo>
                <a:lnTo>
                  <a:pt x="39624" y="358025"/>
                </a:lnTo>
                <a:lnTo>
                  <a:pt x="36957" y="356108"/>
                </a:lnTo>
                <a:lnTo>
                  <a:pt x="34290" y="354330"/>
                </a:lnTo>
                <a:lnTo>
                  <a:pt x="33083" y="352171"/>
                </a:lnTo>
                <a:lnTo>
                  <a:pt x="32994" y="348742"/>
                </a:lnTo>
                <a:lnTo>
                  <a:pt x="32893" y="346583"/>
                </a:lnTo>
                <a:lnTo>
                  <a:pt x="34290" y="344297"/>
                </a:lnTo>
                <a:lnTo>
                  <a:pt x="36957" y="342392"/>
                </a:lnTo>
                <a:lnTo>
                  <a:pt x="39624" y="340626"/>
                </a:lnTo>
                <a:lnTo>
                  <a:pt x="43815" y="339598"/>
                </a:lnTo>
                <a:lnTo>
                  <a:pt x="49403" y="339598"/>
                </a:lnTo>
                <a:lnTo>
                  <a:pt x="55372" y="339471"/>
                </a:lnTo>
                <a:lnTo>
                  <a:pt x="59563" y="340372"/>
                </a:lnTo>
                <a:lnTo>
                  <a:pt x="64897" y="343916"/>
                </a:lnTo>
                <a:lnTo>
                  <a:pt x="66167" y="346075"/>
                </a:lnTo>
                <a:lnTo>
                  <a:pt x="66217" y="351548"/>
                </a:lnTo>
                <a:lnTo>
                  <a:pt x="66217" y="330314"/>
                </a:lnTo>
                <a:lnTo>
                  <a:pt x="65024" y="329450"/>
                </a:lnTo>
                <a:lnTo>
                  <a:pt x="58039" y="327672"/>
                </a:lnTo>
                <a:lnTo>
                  <a:pt x="40259" y="327926"/>
                </a:lnTo>
                <a:lnTo>
                  <a:pt x="33528" y="329692"/>
                </a:lnTo>
                <a:lnTo>
                  <a:pt x="28829" y="333375"/>
                </a:lnTo>
                <a:lnTo>
                  <a:pt x="24130" y="336931"/>
                </a:lnTo>
                <a:lnTo>
                  <a:pt x="21844" y="341249"/>
                </a:lnTo>
                <a:lnTo>
                  <a:pt x="21932" y="349250"/>
                </a:lnTo>
                <a:lnTo>
                  <a:pt x="22733" y="351548"/>
                </a:lnTo>
                <a:lnTo>
                  <a:pt x="26035" y="356374"/>
                </a:lnTo>
                <a:lnTo>
                  <a:pt x="28194" y="358267"/>
                </a:lnTo>
                <a:lnTo>
                  <a:pt x="30988" y="359676"/>
                </a:lnTo>
                <a:lnTo>
                  <a:pt x="23241" y="359791"/>
                </a:lnTo>
                <a:lnTo>
                  <a:pt x="23368" y="370459"/>
                </a:lnTo>
                <a:lnTo>
                  <a:pt x="96393" y="369697"/>
                </a:lnTo>
                <a:lnTo>
                  <a:pt x="96393" y="358902"/>
                </a:lnTo>
                <a:lnTo>
                  <a:pt x="96393" y="358521"/>
                </a:lnTo>
                <a:lnTo>
                  <a:pt x="96393" y="3582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7" name="object 67"/>
          <p:cNvSpPr txBox="1"/>
          <p:nvPr/>
        </p:nvSpPr>
        <p:spPr>
          <a:xfrm>
            <a:off x="8222846" y="9328638"/>
            <a:ext cx="418465" cy="56705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dirty="0">
                <a:latin typeface="Arial Narrow"/>
                <a:cs typeface="Arial Narrow"/>
              </a:rPr>
              <a:t>Acp6.9-</a:t>
            </a:r>
            <a:r>
              <a:rPr sz="800" b="1" spc="-20" dirty="0">
                <a:latin typeface="Arial Narrow"/>
                <a:cs typeface="Arial Narrow"/>
              </a:rPr>
              <a:t>chiA</a:t>
            </a:r>
            <a:endParaRPr sz="800">
              <a:latin typeface="Arial Narrow"/>
              <a:cs typeface="Arial Narrow"/>
            </a:endParaRPr>
          </a:p>
          <a:p>
            <a:pPr marL="12700">
              <a:lnSpc>
                <a:spcPct val="100000"/>
              </a:lnSpc>
            </a:pPr>
            <a:r>
              <a:rPr sz="800" b="1" dirty="0">
                <a:latin typeface="Arial Narrow"/>
                <a:cs typeface="Arial Narrow"/>
              </a:rPr>
              <a:t>/</a:t>
            </a:r>
            <a:r>
              <a:rPr sz="800" b="1" spc="5" dirty="0">
                <a:latin typeface="Arial Narrow"/>
                <a:cs typeface="Arial Narrow"/>
              </a:rPr>
              <a:t> </a:t>
            </a:r>
            <a:r>
              <a:rPr sz="800" b="1" dirty="0">
                <a:latin typeface="Arial Narrow"/>
                <a:cs typeface="Arial Narrow"/>
              </a:rPr>
              <a:t>polh-</a:t>
            </a:r>
            <a:r>
              <a:rPr sz="800" b="1" spc="-20" dirty="0">
                <a:latin typeface="Arial Narrow"/>
                <a:cs typeface="Arial Narrow"/>
              </a:rPr>
              <a:t>cath</a:t>
            </a:r>
            <a:endParaRPr sz="800">
              <a:latin typeface="Arial Narrow"/>
              <a:cs typeface="Arial Narrow"/>
            </a:endParaRPr>
          </a:p>
          <a:p>
            <a:pPr marL="16510">
              <a:lnSpc>
                <a:spcPct val="100000"/>
              </a:lnSpc>
              <a:spcBef>
                <a:spcPts val="254"/>
              </a:spcBef>
            </a:pPr>
            <a:r>
              <a:rPr sz="800" b="1" dirty="0">
                <a:latin typeface="Arial Narrow"/>
                <a:cs typeface="Arial Narrow"/>
              </a:rPr>
              <a:t>AcMNPV-</a:t>
            </a:r>
            <a:r>
              <a:rPr sz="800" b="1" spc="-25" dirty="0">
                <a:latin typeface="Arial Narrow"/>
                <a:cs typeface="Arial Narrow"/>
              </a:rPr>
              <a:t>Rep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68" name="object 68"/>
          <p:cNvSpPr/>
          <p:nvPr/>
        </p:nvSpPr>
        <p:spPr>
          <a:xfrm>
            <a:off x="8707120" y="9388856"/>
            <a:ext cx="96520" cy="483870"/>
          </a:xfrm>
          <a:custGeom>
            <a:avLst/>
            <a:gdLst/>
            <a:ahLst/>
            <a:cxnLst/>
            <a:rect l="l" t="t" r="r" b="b"/>
            <a:pathLst>
              <a:path w="96520" h="483870">
                <a:moveTo>
                  <a:pt x="13462" y="77597"/>
                </a:moveTo>
                <a:lnTo>
                  <a:pt x="13335" y="66040"/>
                </a:lnTo>
                <a:lnTo>
                  <a:pt x="381" y="66167"/>
                </a:lnTo>
                <a:lnTo>
                  <a:pt x="381" y="77724"/>
                </a:lnTo>
                <a:lnTo>
                  <a:pt x="13462" y="77597"/>
                </a:lnTo>
                <a:close/>
              </a:path>
              <a:path w="96520" h="483870">
                <a:moveTo>
                  <a:pt x="55245" y="204089"/>
                </a:moveTo>
                <a:lnTo>
                  <a:pt x="54991" y="181483"/>
                </a:lnTo>
                <a:lnTo>
                  <a:pt x="41021" y="181610"/>
                </a:lnTo>
                <a:lnTo>
                  <a:pt x="41275" y="204216"/>
                </a:lnTo>
                <a:lnTo>
                  <a:pt x="55245" y="204089"/>
                </a:lnTo>
                <a:close/>
              </a:path>
              <a:path w="96520" h="483870">
                <a:moveTo>
                  <a:pt x="73406" y="60198"/>
                </a:moveTo>
                <a:lnTo>
                  <a:pt x="73279" y="47371"/>
                </a:lnTo>
                <a:lnTo>
                  <a:pt x="56642" y="42545"/>
                </a:lnTo>
                <a:lnTo>
                  <a:pt x="56603" y="38989"/>
                </a:lnTo>
                <a:lnTo>
                  <a:pt x="56426" y="22606"/>
                </a:lnTo>
                <a:lnTo>
                  <a:pt x="56388" y="18542"/>
                </a:lnTo>
                <a:lnTo>
                  <a:pt x="72898" y="13208"/>
                </a:lnTo>
                <a:lnTo>
                  <a:pt x="72771" y="0"/>
                </a:lnTo>
                <a:lnTo>
                  <a:pt x="44196" y="9728"/>
                </a:lnTo>
                <a:lnTo>
                  <a:pt x="44196" y="38989"/>
                </a:lnTo>
                <a:lnTo>
                  <a:pt x="17018" y="31115"/>
                </a:lnTo>
                <a:lnTo>
                  <a:pt x="44069" y="22606"/>
                </a:lnTo>
                <a:lnTo>
                  <a:pt x="44196" y="38989"/>
                </a:lnTo>
                <a:lnTo>
                  <a:pt x="44196" y="9728"/>
                </a:lnTo>
                <a:lnTo>
                  <a:pt x="0" y="24765"/>
                </a:lnTo>
                <a:lnTo>
                  <a:pt x="0" y="37592"/>
                </a:lnTo>
                <a:lnTo>
                  <a:pt x="73406" y="60198"/>
                </a:lnTo>
                <a:close/>
              </a:path>
              <a:path w="96520" h="483870">
                <a:moveTo>
                  <a:pt x="73533" y="77089"/>
                </a:moveTo>
                <a:lnTo>
                  <a:pt x="73406" y="65532"/>
                </a:lnTo>
                <a:lnTo>
                  <a:pt x="20447" y="66040"/>
                </a:lnTo>
                <a:lnTo>
                  <a:pt x="20574" y="77597"/>
                </a:lnTo>
                <a:lnTo>
                  <a:pt x="73533" y="77089"/>
                </a:lnTo>
                <a:close/>
              </a:path>
              <a:path w="96520" h="483870">
                <a:moveTo>
                  <a:pt x="74041" y="127381"/>
                </a:moveTo>
                <a:lnTo>
                  <a:pt x="73914" y="116205"/>
                </a:lnTo>
                <a:lnTo>
                  <a:pt x="73914" y="115824"/>
                </a:lnTo>
                <a:lnTo>
                  <a:pt x="40767" y="116205"/>
                </a:lnTo>
                <a:lnTo>
                  <a:pt x="36322" y="115443"/>
                </a:lnTo>
                <a:lnTo>
                  <a:pt x="33909" y="113792"/>
                </a:lnTo>
                <a:lnTo>
                  <a:pt x="31623" y="112141"/>
                </a:lnTo>
                <a:lnTo>
                  <a:pt x="30353" y="109855"/>
                </a:lnTo>
                <a:lnTo>
                  <a:pt x="30353" y="104140"/>
                </a:lnTo>
                <a:lnTo>
                  <a:pt x="73787" y="99314"/>
                </a:lnTo>
                <a:lnTo>
                  <a:pt x="73660" y="87884"/>
                </a:lnTo>
                <a:lnTo>
                  <a:pt x="42545" y="88138"/>
                </a:lnTo>
                <a:lnTo>
                  <a:pt x="36576" y="88138"/>
                </a:lnTo>
                <a:lnTo>
                  <a:pt x="32385" y="88646"/>
                </a:lnTo>
                <a:lnTo>
                  <a:pt x="19558" y="105664"/>
                </a:lnTo>
                <a:lnTo>
                  <a:pt x="20320" y="108077"/>
                </a:lnTo>
                <a:lnTo>
                  <a:pt x="21590" y="110236"/>
                </a:lnTo>
                <a:lnTo>
                  <a:pt x="22987" y="112522"/>
                </a:lnTo>
                <a:lnTo>
                  <a:pt x="24892" y="114554"/>
                </a:lnTo>
                <a:lnTo>
                  <a:pt x="27686" y="116332"/>
                </a:lnTo>
                <a:lnTo>
                  <a:pt x="762" y="116586"/>
                </a:lnTo>
                <a:lnTo>
                  <a:pt x="889" y="128016"/>
                </a:lnTo>
                <a:lnTo>
                  <a:pt x="74041" y="127381"/>
                </a:lnTo>
                <a:close/>
              </a:path>
              <a:path w="96520" h="483870">
                <a:moveTo>
                  <a:pt x="75311" y="270637"/>
                </a:moveTo>
                <a:lnTo>
                  <a:pt x="75184" y="259080"/>
                </a:lnTo>
                <a:lnTo>
                  <a:pt x="61214" y="259207"/>
                </a:lnTo>
                <a:lnTo>
                  <a:pt x="61341" y="270764"/>
                </a:lnTo>
                <a:lnTo>
                  <a:pt x="75311" y="270637"/>
                </a:lnTo>
                <a:close/>
              </a:path>
              <a:path w="96520" h="483870">
                <a:moveTo>
                  <a:pt x="75565" y="161798"/>
                </a:moveTo>
                <a:lnTo>
                  <a:pt x="56134" y="134747"/>
                </a:lnTo>
                <a:lnTo>
                  <a:pt x="53975" y="146177"/>
                </a:lnTo>
                <a:lnTo>
                  <a:pt x="57658" y="146685"/>
                </a:lnTo>
                <a:lnTo>
                  <a:pt x="60325" y="147701"/>
                </a:lnTo>
                <a:lnTo>
                  <a:pt x="63246" y="150368"/>
                </a:lnTo>
                <a:lnTo>
                  <a:pt x="64008" y="152146"/>
                </a:lnTo>
                <a:lnTo>
                  <a:pt x="64135" y="157226"/>
                </a:lnTo>
                <a:lnTo>
                  <a:pt x="62865" y="159639"/>
                </a:lnTo>
                <a:lnTo>
                  <a:pt x="60198" y="161417"/>
                </a:lnTo>
                <a:lnTo>
                  <a:pt x="57658" y="163068"/>
                </a:lnTo>
                <a:lnTo>
                  <a:pt x="53213" y="164084"/>
                </a:lnTo>
                <a:lnTo>
                  <a:pt x="41275" y="164084"/>
                </a:lnTo>
                <a:lnTo>
                  <a:pt x="37211" y="163322"/>
                </a:lnTo>
                <a:lnTo>
                  <a:pt x="34798" y="161544"/>
                </a:lnTo>
                <a:lnTo>
                  <a:pt x="32385" y="159893"/>
                </a:lnTo>
                <a:lnTo>
                  <a:pt x="31115" y="157607"/>
                </a:lnTo>
                <a:lnTo>
                  <a:pt x="30988" y="150368"/>
                </a:lnTo>
                <a:lnTo>
                  <a:pt x="33782" y="147701"/>
                </a:lnTo>
                <a:lnTo>
                  <a:pt x="39370" y="146812"/>
                </a:lnTo>
                <a:lnTo>
                  <a:pt x="36703" y="135509"/>
                </a:lnTo>
                <a:lnTo>
                  <a:pt x="20066" y="149987"/>
                </a:lnTo>
                <a:lnTo>
                  <a:pt x="20180" y="161544"/>
                </a:lnTo>
                <a:lnTo>
                  <a:pt x="22479" y="166370"/>
                </a:lnTo>
                <a:lnTo>
                  <a:pt x="32131" y="173990"/>
                </a:lnTo>
                <a:lnTo>
                  <a:pt x="38989" y="175895"/>
                </a:lnTo>
                <a:lnTo>
                  <a:pt x="48133" y="175895"/>
                </a:lnTo>
                <a:lnTo>
                  <a:pt x="74383" y="164084"/>
                </a:lnTo>
                <a:lnTo>
                  <a:pt x="75565" y="161798"/>
                </a:lnTo>
                <a:close/>
              </a:path>
              <a:path w="96520" h="483870">
                <a:moveTo>
                  <a:pt x="76327" y="237629"/>
                </a:moveTo>
                <a:lnTo>
                  <a:pt x="76200" y="226580"/>
                </a:lnTo>
                <a:lnTo>
                  <a:pt x="74256" y="223278"/>
                </a:lnTo>
                <a:lnTo>
                  <a:pt x="73152" y="221361"/>
                </a:lnTo>
                <a:lnTo>
                  <a:pt x="40005" y="211518"/>
                </a:lnTo>
                <a:lnTo>
                  <a:pt x="40005" y="234454"/>
                </a:lnTo>
                <a:lnTo>
                  <a:pt x="38989" y="236347"/>
                </a:lnTo>
                <a:lnTo>
                  <a:pt x="34671" y="239407"/>
                </a:lnTo>
                <a:lnTo>
                  <a:pt x="31242" y="240284"/>
                </a:lnTo>
                <a:lnTo>
                  <a:pt x="21717" y="240284"/>
                </a:lnTo>
                <a:lnTo>
                  <a:pt x="18415" y="239649"/>
                </a:lnTo>
                <a:lnTo>
                  <a:pt x="14351" y="236855"/>
                </a:lnTo>
                <a:lnTo>
                  <a:pt x="13335" y="235077"/>
                </a:lnTo>
                <a:lnTo>
                  <a:pt x="13208" y="230759"/>
                </a:lnTo>
                <a:lnTo>
                  <a:pt x="14478" y="228854"/>
                </a:lnTo>
                <a:lnTo>
                  <a:pt x="19304" y="225298"/>
                </a:lnTo>
                <a:lnTo>
                  <a:pt x="22860" y="224409"/>
                </a:lnTo>
                <a:lnTo>
                  <a:pt x="27432" y="224409"/>
                </a:lnTo>
                <a:lnTo>
                  <a:pt x="31623" y="224282"/>
                </a:lnTo>
                <a:lnTo>
                  <a:pt x="34798" y="225056"/>
                </a:lnTo>
                <a:lnTo>
                  <a:pt x="36830" y="226580"/>
                </a:lnTo>
                <a:lnTo>
                  <a:pt x="38989" y="228104"/>
                </a:lnTo>
                <a:lnTo>
                  <a:pt x="39928" y="229882"/>
                </a:lnTo>
                <a:lnTo>
                  <a:pt x="40005" y="234454"/>
                </a:lnTo>
                <a:lnTo>
                  <a:pt x="40005" y="211518"/>
                </a:lnTo>
                <a:lnTo>
                  <a:pt x="1739" y="226187"/>
                </a:lnTo>
                <a:lnTo>
                  <a:pt x="1651" y="237998"/>
                </a:lnTo>
                <a:lnTo>
                  <a:pt x="3937" y="242582"/>
                </a:lnTo>
                <a:lnTo>
                  <a:pt x="8382" y="246253"/>
                </a:lnTo>
                <a:lnTo>
                  <a:pt x="12827" y="249809"/>
                </a:lnTo>
                <a:lnTo>
                  <a:pt x="18923" y="251587"/>
                </a:lnTo>
                <a:lnTo>
                  <a:pt x="26670" y="251587"/>
                </a:lnTo>
                <a:lnTo>
                  <a:pt x="33782" y="251460"/>
                </a:lnTo>
                <a:lnTo>
                  <a:pt x="39624" y="249682"/>
                </a:lnTo>
                <a:lnTo>
                  <a:pt x="48260" y="242582"/>
                </a:lnTo>
                <a:lnTo>
                  <a:pt x="49466" y="240284"/>
                </a:lnTo>
                <a:lnTo>
                  <a:pt x="50419" y="238506"/>
                </a:lnTo>
                <a:lnTo>
                  <a:pt x="50304" y="234454"/>
                </a:lnTo>
                <a:lnTo>
                  <a:pt x="50292" y="231775"/>
                </a:lnTo>
                <a:lnTo>
                  <a:pt x="49784" y="229882"/>
                </a:lnTo>
                <a:lnTo>
                  <a:pt x="44069" y="223278"/>
                </a:lnTo>
                <a:lnTo>
                  <a:pt x="52324" y="223647"/>
                </a:lnTo>
                <a:lnTo>
                  <a:pt x="57785" y="224663"/>
                </a:lnTo>
                <a:lnTo>
                  <a:pt x="60579" y="226187"/>
                </a:lnTo>
                <a:lnTo>
                  <a:pt x="63246" y="227838"/>
                </a:lnTo>
                <a:lnTo>
                  <a:pt x="64643" y="229882"/>
                </a:lnTo>
                <a:lnTo>
                  <a:pt x="64643" y="236232"/>
                </a:lnTo>
                <a:lnTo>
                  <a:pt x="61976" y="238379"/>
                </a:lnTo>
                <a:lnTo>
                  <a:pt x="56642" y="239014"/>
                </a:lnTo>
                <a:lnTo>
                  <a:pt x="58166" y="250063"/>
                </a:lnTo>
                <a:lnTo>
                  <a:pt x="64389" y="249174"/>
                </a:lnTo>
                <a:lnTo>
                  <a:pt x="68961" y="247281"/>
                </a:lnTo>
                <a:lnTo>
                  <a:pt x="74803" y="241427"/>
                </a:lnTo>
                <a:lnTo>
                  <a:pt x="76327" y="237629"/>
                </a:lnTo>
                <a:close/>
              </a:path>
              <a:path w="96520" h="483870">
                <a:moveTo>
                  <a:pt x="76885" y="305562"/>
                </a:moveTo>
                <a:lnTo>
                  <a:pt x="76835" y="294005"/>
                </a:lnTo>
                <a:lnTo>
                  <a:pt x="75692" y="291731"/>
                </a:lnTo>
                <a:lnTo>
                  <a:pt x="74549" y="289433"/>
                </a:lnTo>
                <a:lnTo>
                  <a:pt x="70104" y="285877"/>
                </a:lnTo>
                <a:lnTo>
                  <a:pt x="65786" y="282206"/>
                </a:lnTo>
                <a:lnTo>
                  <a:pt x="65278" y="282067"/>
                </a:lnTo>
                <a:lnTo>
                  <a:pt x="65278" y="296926"/>
                </a:lnTo>
                <a:lnTo>
                  <a:pt x="65278" y="301256"/>
                </a:lnTo>
                <a:lnTo>
                  <a:pt x="64008" y="303276"/>
                </a:lnTo>
                <a:lnTo>
                  <a:pt x="61595" y="304927"/>
                </a:lnTo>
                <a:lnTo>
                  <a:pt x="59182" y="306705"/>
                </a:lnTo>
                <a:lnTo>
                  <a:pt x="55753" y="307606"/>
                </a:lnTo>
                <a:lnTo>
                  <a:pt x="51054" y="307606"/>
                </a:lnTo>
                <a:lnTo>
                  <a:pt x="46990" y="307721"/>
                </a:lnTo>
                <a:lnTo>
                  <a:pt x="43815" y="306959"/>
                </a:lnTo>
                <a:lnTo>
                  <a:pt x="41656" y="305435"/>
                </a:lnTo>
                <a:lnTo>
                  <a:pt x="39624" y="303911"/>
                </a:lnTo>
                <a:lnTo>
                  <a:pt x="38557" y="302133"/>
                </a:lnTo>
                <a:lnTo>
                  <a:pt x="38481" y="297561"/>
                </a:lnTo>
                <a:lnTo>
                  <a:pt x="39624" y="295656"/>
                </a:lnTo>
                <a:lnTo>
                  <a:pt x="43942" y="292608"/>
                </a:lnTo>
                <a:lnTo>
                  <a:pt x="47371" y="291731"/>
                </a:lnTo>
                <a:lnTo>
                  <a:pt x="56769" y="291731"/>
                </a:lnTo>
                <a:lnTo>
                  <a:pt x="60071" y="292354"/>
                </a:lnTo>
                <a:lnTo>
                  <a:pt x="64135" y="295148"/>
                </a:lnTo>
                <a:lnTo>
                  <a:pt x="65278" y="296926"/>
                </a:lnTo>
                <a:lnTo>
                  <a:pt x="65278" y="282067"/>
                </a:lnTo>
                <a:lnTo>
                  <a:pt x="59690" y="280428"/>
                </a:lnTo>
                <a:lnTo>
                  <a:pt x="51943" y="280428"/>
                </a:lnTo>
                <a:lnTo>
                  <a:pt x="44704" y="280555"/>
                </a:lnTo>
                <a:lnTo>
                  <a:pt x="38989" y="282321"/>
                </a:lnTo>
                <a:lnTo>
                  <a:pt x="34671" y="285877"/>
                </a:lnTo>
                <a:lnTo>
                  <a:pt x="30226" y="289433"/>
                </a:lnTo>
                <a:lnTo>
                  <a:pt x="28194" y="293497"/>
                </a:lnTo>
                <a:lnTo>
                  <a:pt x="28194" y="300355"/>
                </a:lnTo>
                <a:lnTo>
                  <a:pt x="28702" y="302260"/>
                </a:lnTo>
                <a:lnTo>
                  <a:pt x="29908" y="304177"/>
                </a:lnTo>
                <a:lnTo>
                  <a:pt x="30861" y="305828"/>
                </a:lnTo>
                <a:lnTo>
                  <a:pt x="32385" y="307352"/>
                </a:lnTo>
                <a:lnTo>
                  <a:pt x="34417" y="308737"/>
                </a:lnTo>
                <a:lnTo>
                  <a:pt x="26162" y="308483"/>
                </a:lnTo>
                <a:lnTo>
                  <a:pt x="13716" y="295783"/>
                </a:lnTo>
                <a:lnTo>
                  <a:pt x="16383" y="293624"/>
                </a:lnTo>
                <a:lnTo>
                  <a:pt x="21844" y="292989"/>
                </a:lnTo>
                <a:lnTo>
                  <a:pt x="20193" y="281952"/>
                </a:lnTo>
                <a:lnTo>
                  <a:pt x="2286" y="294652"/>
                </a:lnTo>
                <a:lnTo>
                  <a:pt x="2286" y="305562"/>
                </a:lnTo>
                <a:lnTo>
                  <a:pt x="40132" y="320675"/>
                </a:lnTo>
                <a:lnTo>
                  <a:pt x="49314" y="320230"/>
                </a:lnTo>
                <a:lnTo>
                  <a:pt x="75145" y="308737"/>
                </a:lnTo>
                <a:lnTo>
                  <a:pt x="75704" y="307721"/>
                </a:lnTo>
                <a:lnTo>
                  <a:pt x="76885" y="305562"/>
                </a:lnTo>
                <a:close/>
              </a:path>
              <a:path w="96520" h="483870">
                <a:moveTo>
                  <a:pt x="77343" y="483870"/>
                </a:moveTo>
                <a:lnTo>
                  <a:pt x="77216" y="471043"/>
                </a:lnTo>
                <a:lnTo>
                  <a:pt x="60579" y="466217"/>
                </a:lnTo>
                <a:lnTo>
                  <a:pt x="60553" y="462661"/>
                </a:lnTo>
                <a:lnTo>
                  <a:pt x="60464" y="446278"/>
                </a:lnTo>
                <a:lnTo>
                  <a:pt x="60452" y="442214"/>
                </a:lnTo>
                <a:lnTo>
                  <a:pt x="76962" y="436753"/>
                </a:lnTo>
                <a:lnTo>
                  <a:pt x="76835" y="423672"/>
                </a:lnTo>
                <a:lnTo>
                  <a:pt x="48260" y="433387"/>
                </a:lnTo>
                <a:lnTo>
                  <a:pt x="48260" y="462661"/>
                </a:lnTo>
                <a:lnTo>
                  <a:pt x="21082" y="454787"/>
                </a:lnTo>
                <a:lnTo>
                  <a:pt x="48133" y="446278"/>
                </a:lnTo>
                <a:lnTo>
                  <a:pt x="48260" y="462661"/>
                </a:lnTo>
                <a:lnTo>
                  <a:pt x="48260" y="433387"/>
                </a:lnTo>
                <a:lnTo>
                  <a:pt x="3937" y="448437"/>
                </a:lnTo>
                <a:lnTo>
                  <a:pt x="4064" y="461264"/>
                </a:lnTo>
                <a:lnTo>
                  <a:pt x="77343" y="483870"/>
                </a:lnTo>
                <a:close/>
              </a:path>
              <a:path w="96520" h="483870">
                <a:moveTo>
                  <a:pt x="77851" y="405638"/>
                </a:moveTo>
                <a:lnTo>
                  <a:pt x="58420" y="378587"/>
                </a:lnTo>
                <a:lnTo>
                  <a:pt x="56261" y="389890"/>
                </a:lnTo>
                <a:lnTo>
                  <a:pt x="59944" y="390525"/>
                </a:lnTo>
                <a:lnTo>
                  <a:pt x="62611" y="391541"/>
                </a:lnTo>
                <a:lnTo>
                  <a:pt x="64135" y="392811"/>
                </a:lnTo>
                <a:lnTo>
                  <a:pt x="65532" y="394208"/>
                </a:lnTo>
                <a:lnTo>
                  <a:pt x="66294" y="395986"/>
                </a:lnTo>
                <a:lnTo>
                  <a:pt x="66421" y="401066"/>
                </a:lnTo>
                <a:lnTo>
                  <a:pt x="65151" y="403479"/>
                </a:lnTo>
                <a:lnTo>
                  <a:pt x="62484" y="405130"/>
                </a:lnTo>
                <a:lnTo>
                  <a:pt x="59944" y="406908"/>
                </a:lnTo>
                <a:lnTo>
                  <a:pt x="55499" y="407797"/>
                </a:lnTo>
                <a:lnTo>
                  <a:pt x="49149" y="407924"/>
                </a:lnTo>
                <a:lnTo>
                  <a:pt x="43561" y="407924"/>
                </a:lnTo>
                <a:lnTo>
                  <a:pt x="39497" y="407162"/>
                </a:lnTo>
                <a:lnTo>
                  <a:pt x="37084" y="405384"/>
                </a:lnTo>
                <a:lnTo>
                  <a:pt x="34671" y="403733"/>
                </a:lnTo>
                <a:lnTo>
                  <a:pt x="33401" y="401447"/>
                </a:lnTo>
                <a:lnTo>
                  <a:pt x="33274" y="394208"/>
                </a:lnTo>
                <a:lnTo>
                  <a:pt x="36068" y="391541"/>
                </a:lnTo>
                <a:lnTo>
                  <a:pt x="41656" y="390652"/>
                </a:lnTo>
                <a:lnTo>
                  <a:pt x="38989" y="379349"/>
                </a:lnTo>
                <a:lnTo>
                  <a:pt x="22352" y="393827"/>
                </a:lnTo>
                <a:lnTo>
                  <a:pt x="22479" y="405384"/>
                </a:lnTo>
                <a:lnTo>
                  <a:pt x="24892" y="410210"/>
                </a:lnTo>
                <a:lnTo>
                  <a:pt x="29591" y="414020"/>
                </a:lnTo>
                <a:lnTo>
                  <a:pt x="34417" y="417830"/>
                </a:lnTo>
                <a:lnTo>
                  <a:pt x="41275" y="419735"/>
                </a:lnTo>
                <a:lnTo>
                  <a:pt x="50419" y="419608"/>
                </a:lnTo>
                <a:lnTo>
                  <a:pt x="58039" y="419608"/>
                </a:lnTo>
                <a:lnTo>
                  <a:pt x="64516" y="417830"/>
                </a:lnTo>
                <a:lnTo>
                  <a:pt x="69850" y="414401"/>
                </a:lnTo>
                <a:lnTo>
                  <a:pt x="75184" y="410845"/>
                </a:lnTo>
                <a:lnTo>
                  <a:pt x="76669" y="407924"/>
                </a:lnTo>
                <a:lnTo>
                  <a:pt x="77851" y="405638"/>
                </a:lnTo>
                <a:close/>
              </a:path>
              <a:path w="96520" h="483870">
                <a:moveTo>
                  <a:pt x="96393" y="369824"/>
                </a:moveTo>
                <a:lnTo>
                  <a:pt x="96266" y="358902"/>
                </a:lnTo>
                <a:lnTo>
                  <a:pt x="96266" y="358521"/>
                </a:lnTo>
                <a:lnTo>
                  <a:pt x="96266" y="358279"/>
                </a:lnTo>
                <a:lnTo>
                  <a:pt x="69723" y="358521"/>
                </a:lnTo>
                <a:lnTo>
                  <a:pt x="72644" y="356362"/>
                </a:lnTo>
                <a:lnTo>
                  <a:pt x="74549" y="354203"/>
                </a:lnTo>
                <a:lnTo>
                  <a:pt x="76073" y="351536"/>
                </a:lnTo>
                <a:lnTo>
                  <a:pt x="76835" y="350278"/>
                </a:lnTo>
                <a:lnTo>
                  <a:pt x="77343" y="348107"/>
                </a:lnTo>
                <a:lnTo>
                  <a:pt x="77216" y="340880"/>
                </a:lnTo>
                <a:lnTo>
                  <a:pt x="76504" y="339598"/>
                </a:lnTo>
                <a:lnTo>
                  <a:pt x="74803" y="336550"/>
                </a:lnTo>
                <a:lnTo>
                  <a:pt x="66205" y="330428"/>
                </a:lnTo>
                <a:lnTo>
                  <a:pt x="66205" y="351663"/>
                </a:lnTo>
                <a:lnTo>
                  <a:pt x="64897" y="353822"/>
                </a:lnTo>
                <a:lnTo>
                  <a:pt x="61976" y="355854"/>
                </a:lnTo>
                <a:lnTo>
                  <a:pt x="59182" y="357759"/>
                </a:lnTo>
                <a:lnTo>
                  <a:pt x="54737" y="358775"/>
                </a:lnTo>
                <a:lnTo>
                  <a:pt x="48768" y="358902"/>
                </a:lnTo>
                <a:lnTo>
                  <a:pt x="43561" y="358902"/>
                </a:lnTo>
                <a:lnTo>
                  <a:pt x="32893" y="346583"/>
                </a:lnTo>
                <a:lnTo>
                  <a:pt x="34290" y="344424"/>
                </a:lnTo>
                <a:lnTo>
                  <a:pt x="39624" y="340614"/>
                </a:lnTo>
                <a:lnTo>
                  <a:pt x="43688" y="339725"/>
                </a:lnTo>
                <a:lnTo>
                  <a:pt x="49403" y="339598"/>
                </a:lnTo>
                <a:lnTo>
                  <a:pt x="55245" y="339598"/>
                </a:lnTo>
                <a:lnTo>
                  <a:pt x="59563" y="340360"/>
                </a:lnTo>
                <a:lnTo>
                  <a:pt x="64897" y="343928"/>
                </a:lnTo>
                <a:lnTo>
                  <a:pt x="66167" y="346202"/>
                </a:lnTo>
                <a:lnTo>
                  <a:pt x="66205" y="351663"/>
                </a:lnTo>
                <a:lnTo>
                  <a:pt x="66205" y="330428"/>
                </a:lnTo>
                <a:lnTo>
                  <a:pt x="65024" y="329577"/>
                </a:lnTo>
                <a:lnTo>
                  <a:pt x="58039" y="327787"/>
                </a:lnTo>
                <a:lnTo>
                  <a:pt x="48895" y="327914"/>
                </a:lnTo>
                <a:lnTo>
                  <a:pt x="40259" y="327914"/>
                </a:lnTo>
                <a:lnTo>
                  <a:pt x="33528" y="329831"/>
                </a:lnTo>
                <a:lnTo>
                  <a:pt x="28829" y="333375"/>
                </a:lnTo>
                <a:lnTo>
                  <a:pt x="24130" y="337058"/>
                </a:lnTo>
                <a:lnTo>
                  <a:pt x="21844" y="341376"/>
                </a:lnTo>
                <a:lnTo>
                  <a:pt x="21920" y="349250"/>
                </a:lnTo>
                <a:lnTo>
                  <a:pt x="22733" y="351663"/>
                </a:lnTo>
                <a:lnTo>
                  <a:pt x="24638" y="354330"/>
                </a:lnTo>
                <a:lnTo>
                  <a:pt x="26035" y="356362"/>
                </a:lnTo>
                <a:lnTo>
                  <a:pt x="28194" y="358279"/>
                </a:lnTo>
                <a:lnTo>
                  <a:pt x="30988" y="359803"/>
                </a:lnTo>
                <a:lnTo>
                  <a:pt x="23241" y="359803"/>
                </a:lnTo>
                <a:lnTo>
                  <a:pt x="23368" y="370459"/>
                </a:lnTo>
                <a:lnTo>
                  <a:pt x="96393" y="36982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9" name="object 69"/>
          <p:cNvSpPr txBox="1"/>
          <p:nvPr/>
        </p:nvSpPr>
        <p:spPr>
          <a:xfrm>
            <a:off x="8819365" y="9387146"/>
            <a:ext cx="264795" cy="50990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spc="-10" dirty="0">
                <a:latin typeface="Arial Narrow"/>
                <a:cs typeface="Arial Narrow"/>
              </a:rPr>
              <a:t>Acp6.9-</a:t>
            </a:r>
            <a:r>
              <a:rPr sz="800" b="1" spc="-20" dirty="0">
                <a:latin typeface="Arial Narrow"/>
                <a:cs typeface="Arial Narrow"/>
              </a:rPr>
              <a:t>chiA</a:t>
            </a:r>
            <a:endParaRPr sz="800">
              <a:latin typeface="Arial Narrow"/>
              <a:cs typeface="Arial Narrow"/>
            </a:endParaRPr>
          </a:p>
          <a:p>
            <a:pPr marL="12700">
              <a:lnSpc>
                <a:spcPct val="100000"/>
              </a:lnSpc>
            </a:pPr>
            <a:r>
              <a:rPr sz="800" b="1" dirty="0">
                <a:latin typeface="Arial Narrow"/>
                <a:cs typeface="Arial Narrow"/>
              </a:rPr>
              <a:t>/</a:t>
            </a:r>
            <a:r>
              <a:rPr sz="800" b="1" spc="50" dirty="0">
                <a:latin typeface="Arial Narrow"/>
                <a:cs typeface="Arial Narrow"/>
              </a:rPr>
              <a:t> </a:t>
            </a:r>
            <a:r>
              <a:rPr sz="800" b="1" spc="-10" dirty="0">
                <a:latin typeface="Arial Narrow"/>
                <a:cs typeface="Arial Narrow"/>
              </a:rPr>
              <a:t>polh-</a:t>
            </a:r>
            <a:r>
              <a:rPr sz="800" b="1" spc="-20" dirty="0">
                <a:latin typeface="Arial Narrow"/>
                <a:cs typeface="Arial Narrow"/>
              </a:rPr>
              <a:t>cath</a:t>
            </a:r>
            <a:endParaRPr sz="800">
              <a:latin typeface="Arial Narrow"/>
              <a:cs typeface="Arial Narrow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2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987552" y="2996184"/>
            <a:ext cx="1944624" cy="1255775"/>
          </a:xfrm>
          <a:prstGeom prst="rect">
            <a:avLst/>
          </a:prstGeom>
        </p:spPr>
      </p:pic>
      <p:pic>
        <p:nvPicPr>
          <p:cNvPr id="3" name="object 3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929639" y="5204460"/>
            <a:ext cx="2164080" cy="1716024"/>
          </a:xfrm>
          <a:prstGeom prst="rect">
            <a:avLst/>
          </a:prstGeom>
        </p:spPr>
      </p:pic>
      <p:pic>
        <p:nvPicPr>
          <p:cNvPr id="4" name="object 4"/>
          <p:cNvPicPr/>
          <p:nvPr/>
        </p:nvPicPr>
        <p:blipFill>
          <a:blip r:embed="rId4" cstate="print"/>
          <a:stretch>
            <a:fillRect/>
          </a:stretch>
        </p:blipFill>
        <p:spPr>
          <a:xfrm>
            <a:off x="4137659" y="5285232"/>
            <a:ext cx="2159508" cy="1525524"/>
          </a:xfrm>
          <a:prstGeom prst="rect">
            <a:avLst/>
          </a:prstGeom>
        </p:spPr>
      </p:pic>
      <p:pic>
        <p:nvPicPr>
          <p:cNvPr id="5" name="object 5"/>
          <p:cNvPicPr/>
          <p:nvPr/>
        </p:nvPicPr>
        <p:blipFill>
          <a:blip r:embed="rId5" cstate="print"/>
          <a:stretch>
            <a:fillRect/>
          </a:stretch>
        </p:blipFill>
        <p:spPr>
          <a:xfrm>
            <a:off x="8354568" y="5184648"/>
            <a:ext cx="3022092" cy="1633727"/>
          </a:xfrm>
          <a:prstGeom prst="rect">
            <a:avLst/>
          </a:prstGeom>
        </p:spPr>
      </p:pic>
      <p:pic>
        <p:nvPicPr>
          <p:cNvPr id="6" name="object 6"/>
          <p:cNvPicPr/>
          <p:nvPr/>
        </p:nvPicPr>
        <p:blipFill>
          <a:blip r:embed="rId6" cstate="print"/>
          <a:stretch>
            <a:fillRect/>
          </a:stretch>
        </p:blipFill>
        <p:spPr>
          <a:xfrm>
            <a:off x="3895344" y="2961132"/>
            <a:ext cx="2401824" cy="1484376"/>
          </a:xfrm>
          <a:prstGeom prst="rect">
            <a:avLst/>
          </a:prstGeom>
        </p:spPr>
      </p:pic>
      <p:pic>
        <p:nvPicPr>
          <p:cNvPr id="7" name="object 7"/>
          <p:cNvPicPr/>
          <p:nvPr/>
        </p:nvPicPr>
        <p:blipFill>
          <a:blip r:embed="rId7" cstate="print"/>
          <a:stretch>
            <a:fillRect/>
          </a:stretch>
        </p:blipFill>
        <p:spPr>
          <a:xfrm>
            <a:off x="8354568" y="2994660"/>
            <a:ext cx="1441703" cy="1450848"/>
          </a:xfrm>
          <a:prstGeom prst="rect">
            <a:avLst/>
          </a:prstGeom>
        </p:spPr>
      </p:pic>
      <p:sp>
        <p:nvSpPr>
          <p:cNvPr id="8" name="object 8"/>
          <p:cNvSpPr txBox="1"/>
          <p:nvPr/>
        </p:nvSpPr>
        <p:spPr>
          <a:xfrm>
            <a:off x="618956" y="3557143"/>
            <a:ext cx="196215" cy="39751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b="1" spc="-20" dirty="0">
                <a:latin typeface="Arial"/>
                <a:cs typeface="Arial"/>
              </a:rPr>
              <a:t>CHIA</a:t>
            </a:r>
            <a:endParaRPr sz="1200">
              <a:latin typeface="Arial"/>
              <a:cs typeface="Arial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3616664" y="3676904"/>
            <a:ext cx="196215" cy="39751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b="1" spc="-20" dirty="0">
                <a:latin typeface="Arial"/>
                <a:cs typeface="Arial"/>
              </a:rPr>
              <a:t>CHIA</a:t>
            </a:r>
            <a:endParaRPr sz="1200">
              <a:latin typeface="Arial"/>
              <a:cs typeface="Arial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8087191" y="3743071"/>
            <a:ext cx="196215" cy="39751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b="1" spc="-20" dirty="0">
                <a:latin typeface="Arial"/>
                <a:cs typeface="Arial"/>
              </a:rPr>
              <a:t>CHIA</a:t>
            </a:r>
            <a:endParaRPr sz="1200">
              <a:latin typeface="Arial"/>
              <a:cs typeface="Arial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638768" y="6016676"/>
            <a:ext cx="196215" cy="57785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b="1" spc="-40" dirty="0">
                <a:latin typeface="Arial"/>
                <a:cs typeface="Arial"/>
              </a:rPr>
              <a:t>V-</a:t>
            </a:r>
            <a:r>
              <a:rPr sz="1200" b="1" spc="-25" dirty="0">
                <a:latin typeface="Arial"/>
                <a:cs typeface="Arial"/>
              </a:rPr>
              <a:t>CATH</a:t>
            </a:r>
            <a:endParaRPr sz="1200">
              <a:latin typeface="Arial"/>
              <a:cs typeface="Arial"/>
            </a:endParaRPr>
          </a:p>
        </p:txBody>
      </p:sp>
      <p:sp>
        <p:nvSpPr>
          <p:cNvPr id="12" name="object 12"/>
          <p:cNvSpPr txBox="1"/>
          <p:nvPr/>
        </p:nvSpPr>
        <p:spPr>
          <a:xfrm>
            <a:off x="3644731" y="6047156"/>
            <a:ext cx="196215" cy="57785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b="1" spc="-40" dirty="0">
                <a:latin typeface="Arial"/>
                <a:cs typeface="Arial"/>
              </a:rPr>
              <a:t>V-</a:t>
            </a:r>
            <a:r>
              <a:rPr sz="1200" b="1" spc="-25" dirty="0">
                <a:latin typeface="Arial"/>
                <a:cs typeface="Arial"/>
              </a:rPr>
              <a:t>CATH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" name="object 13"/>
          <p:cNvSpPr txBox="1"/>
          <p:nvPr/>
        </p:nvSpPr>
        <p:spPr>
          <a:xfrm>
            <a:off x="8071570" y="5988609"/>
            <a:ext cx="196215" cy="57785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b="1" spc="-40" dirty="0">
                <a:latin typeface="Arial"/>
                <a:cs typeface="Arial"/>
              </a:rPr>
              <a:t>V-</a:t>
            </a:r>
            <a:r>
              <a:rPr sz="1200" b="1" spc="-25" dirty="0">
                <a:latin typeface="Arial"/>
                <a:cs typeface="Arial"/>
              </a:rPr>
              <a:t>CATH</a:t>
            </a:r>
            <a:endParaRPr sz="1200">
              <a:latin typeface="Arial"/>
              <a:cs typeface="Arial"/>
            </a:endParaRPr>
          </a:p>
        </p:txBody>
      </p:sp>
      <p:sp>
        <p:nvSpPr>
          <p:cNvPr id="14" name="object 14"/>
          <p:cNvSpPr txBox="1"/>
          <p:nvPr/>
        </p:nvSpPr>
        <p:spPr>
          <a:xfrm>
            <a:off x="8434196" y="1516761"/>
            <a:ext cx="894080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u="sng" spc="-10" dirty="0">
                <a:uFill>
                  <a:solidFill>
                    <a:srgbClr val="000000"/>
                  </a:solidFill>
                </a:uFill>
                <a:latin typeface="Arial"/>
                <a:cs typeface="Arial"/>
              </a:rPr>
              <a:t>Hemolymph</a:t>
            </a:r>
            <a:endParaRPr sz="1200">
              <a:latin typeface="Arial"/>
              <a:cs typeface="Arial"/>
            </a:endParaRPr>
          </a:p>
        </p:txBody>
      </p:sp>
      <p:sp>
        <p:nvSpPr>
          <p:cNvPr id="15" name="object 15"/>
          <p:cNvSpPr txBox="1"/>
          <p:nvPr/>
        </p:nvSpPr>
        <p:spPr>
          <a:xfrm>
            <a:off x="4505959" y="2062098"/>
            <a:ext cx="77787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dirty="0">
                <a:latin typeface="Arial"/>
                <a:cs typeface="Arial"/>
              </a:rPr>
              <a:t>4</a:t>
            </a:r>
            <a:r>
              <a:rPr sz="1200" b="1" spc="-30" dirty="0">
                <a:latin typeface="Arial"/>
                <a:cs typeface="Arial"/>
              </a:rPr>
              <a:t> </a:t>
            </a:r>
            <a:r>
              <a:rPr sz="1200" b="1" dirty="0">
                <a:latin typeface="Arial"/>
                <a:cs typeface="Arial"/>
              </a:rPr>
              <a:t>Days </a:t>
            </a:r>
            <a:r>
              <a:rPr sz="1200" b="1" spc="-20" dirty="0">
                <a:latin typeface="Arial"/>
                <a:cs typeface="Arial"/>
              </a:rPr>
              <a:t>p.i.</a:t>
            </a:r>
            <a:endParaRPr sz="1200">
              <a:latin typeface="Arial"/>
              <a:cs typeface="Arial"/>
            </a:endParaRPr>
          </a:p>
        </p:txBody>
      </p:sp>
      <p:sp>
        <p:nvSpPr>
          <p:cNvPr id="16" name="object 16"/>
          <p:cNvSpPr txBox="1"/>
          <p:nvPr/>
        </p:nvSpPr>
        <p:spPr>
          <a:xfrm>
            <a:off x="1092504" y="1624076"/>
            <a:ext cx="969010" cy="20827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ts val="1580"/>
              </a:lnSpc>
              <a:tabLst>
                <a:tab pos="362585" algn="l"/>
              </a:tabLst>
            </a:pPr>
            <a:r>
              <a:rPr sz="1400" b="1" spc="-25" dirty="0">
                <a:latin typeface="Calibri"/>
                <a:cs typeface="Calibri"/>
              </a:rPr>
              <a:t>a)</a:t>
            </a:r>
            <a:r>
              <a:rPr sz="1400" b="1" dirty="0">
                <a:latin typeface="Calibri"/>
                <a:cs typeface="Calibri"/>
              </a:rPr>
              <a:t>	</a:t>
            </a:r>
            <a:r>
              <a:rPr sz="1200" b="1" u="sng" spc="-10" dirty="0">
                <a:uFill>
                  <a:solidFill>
                    <a:srgbClr val="000000"/>
                  </a:solidFill>
                </a:uFill>
                <a:latin typeface="Arial"/>
                <a:cs typeface="Arial"/>
              </a:rPr>
              <a:t>Carcass</a:t>
            </a:r>
            <a:endParaRPr sz="1200">
              <a:latin typeface="Arial"/>
              <a:cs typeface="Arial"/>
            </a:endParaRPr>
          </a:p>
        </p:txBody>
      </p:sp>
      <p:sp>
        <p:nvSpPr>
          <p:cNvPr id="17" name="object 17"/>
          <p:cNvSpPr txBox="1"/>
          <p:nvPr/>
        </p:nvSpPr>
        <p:spPr>
          <a:xfrm>
            <a:off x="8164830" y="1508888"/>
            <a:ext cx="178435" cy="2393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spc="-25" dirty="0">
                <a:latin typeface="Calibri"/>
                <a:cs typeface="Calibri"/>
              </a:rPr>
              <a:t>b)</a:t>
            </a:r>
            <a:endParaRPr sz="1400">
              <a:latin typeface="Calibri"/>
              <a:cs typeface="Calibri"/>
            </a:endParaRPr>
          </a:p>
        </p:txBody>
      </p:sp>
      <p:sp>
        <p:nvSpPr>
          <p:cNvPr id="18" name="object 18"/>
          <p:cNvSpPr/>
          <p:nvPr/>
        </p:nvSpPr>
        <p:spPr>
          <a:xfrm>
            <a:off x="10020300" y="5184648"/>
            <a:ext cx="1356360" cy="1256030"/>
          </a:xfrm>
          <a:custGeom>
            <a:avLst/>
            <a:gdLst/>
            <a:ahLst/>
            <a:cxnLst/>
            <a:rect l="l" t="t" r="r" b="b"/>
            <a:pathLst>
              <a:path w="1356359" h="1256029">
                <a:moveTo>
                  <a:pt x="0" y="1255776"/>
                </a:moveTo>
                <a:lnTo>
                  <a:pt x="1356359" y="1255776"/>
                </a:lnTo>
                <a:lnTo>
                  <a:pt x="1356359" y="0"/>
                </a:lnTo>
                <a:lnTo>
                  <a:pt x="0" y="0"/>
                </a:lnTo>
                <a:lnTo>
                  <a:pt x="0" y="1255776"/>
                </a:lnTo>
                <a:close/>
              </a:path>
            </a:pathLst>
          </a:custGeom>
          <a:ln w="12192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object 19"/>
          <p:cNvSpPr txBox="1"/>
          <p:nvPr/>
        </p:nvSpPr>
        <p:spPr>
          <a:xfrm>
            <a:off x="1922564" y="7944968"/>
            <a:ext cx="7881620" cy="1305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>
              <a:lnSpc>
                <a:spcPct val="100000"/>
              </a:lnSpc>
              <a:spcBef>
                <a:spcPts val="100"/>
              </a:spcBef>
            </a:pPr>
            <a:r>
              <a:rPr sz="1200" b="1" dirty="0">
                <a:latin typeface="Arial"/>
                <a:cs typeface="Arial"/>
              </a:rPr>
              <a:t>Figure</a:t>
            </a:r>
            <a:r>
              <a:rPr sz="1200" b="1" spc="-5" dirty="0">
                <a:latin typeface="Arial"/>
                <a:cs typeface="Arial"/>
              </a:rPr>
              <a:t> </a:t>
            </a:r>
            <a:r>
              <a:rPr sz="1200" b="1" dirty="0">
                <a:latin typeface="Arial"/>
                <a:cs typeface="Arial"/>
              </a:rPr>
              <a:t>S2:</a:t>
            </a:r>
            <a:r>
              <a:rPr sz="1200" b="1" spc="-10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Uncropped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blots</a:t>
            </a:r>
            <a:r>
              <a:rPr sz="1200" spc="-2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shown</a:t>
            </a:r>
            <a:r>
              <a:rPr sz="1200" spc="-2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in</a:t>
            </a:r>
            <a:r>
              <a:rPr sz="1200" spc="-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Figure</a:t>
            </a:r>
            <a:r>
              <a:rPr sz="1200" spc="-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5.</a:t>
            </a:r>
            <a:r>
              <a:rPr sz="1200" spc="-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(a) </a:t>
            </a:r>
            <a:r>
              <a:rPr sz="1200" spc="-20" dirty="0">
                <a:latin typeface="Arial"/>
                <a:cs typeface="Arial"/>
              </a:rPr>
              <a:t>CHIA/V-</a:t>
            </a:r>
            <a:r>
              <a:rPr sz="1200" spc="-25" dirty="0">
                <a:latin typeface="Arial"/>
                <a:cs typeface="Arial"/>
              </a:rPr>
              <a:t>CATH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immunoblots</a:t>
            </a:r>
            <a:r>
              <a:rPr sz="1200" spc="-3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of</a:t>
            </a:r>
            <a:r>
              <a:rPr sz="1200" spc="265" dirty="0">
                <a:latin typeface="Arial"/>
                <a:cs typeface="Arial"/>
              </a:rPr>
              <a:t> </a:t>
            </a:r>
            <a:r>
              <a:rPr sz="1200" spc="-25" dirty="0">
                <a:latin typeface="Arial"/>
                <a:cs typeface="Arial"/>
              </a:rPr>
              <a:t>AcEGFP,</a:t>
            </a:r>
            <a:r>
              <a:rPr sz="1200" spc="-55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AcMNPV-</a:t>
            </a:r>
            <a:r>
              <a:rPr sz="1200" dirty="0">
                <a:latin typeface="Arial"/>
                <a:cs typeface="Arial"/>
              </a:rPr>
              <a:t>Rep,</a:t>
            </a:r>
            <a:r>
              <a:rPr sz="1200" spc="-95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Acp6.9- chiA</a:t>
            </a:r>
            <a:r>
              <a:rPr sz="1200" spc="-8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and</a:t>
            </a:r>
            <a:r>
              <a:rPr sz="1200" spc="-7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Acp6.9-</a:t>
            </a:r>
            <a:r>
              <a:rPr sz="1200" spc="-10" dirty="0">
                <a:latin typeface="Arial"/>
                <a:cs typeface="Arial"/>
              </a:rPr>
              <a:t>chiA/polh-</a:t>
            </a:r>
            <a:r>
              <a:rPr sz="1200" dirty="0">
                <a:latin typeface="Arial"/>
                <a:cs typeface="Arial"/>
              </a:rPr>
              <a:t>cath</a:t>
            </a:r>
            <a:r>
              <a:rPr sz="1200" spc="-2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infected</a:t>
            </a:r>
            <a:r>
              <a:rPr sz="1200" spc="-35" dirty="0">
                <a:latin typeface="Arial"/>
                <a:cs typeface="Arial"/>
              </a:rPr>
              <a:t> </a:t>
            </a:r>
            <a:r>
              <a:rPr sz="1200" i="1" dirty="0">
                <a:latin typeface="Arial"/>
                <a:cs typeface="Arial"/>
              </a:rPr>
              <a:t>T</a:t>
            </a:r>
            <a:r>
              <a:rPr sz="1200" i="1" spc="10" dirty="0">
                <a:latin typeface="Arial"/>
                <a:cs typeface="Arial"/>
              </a:rPr>
              <a:t> </a:t>
            </a:r>
            <a:r>
              <a:rPr sz="1200" i="1" dirty="0">
                <a:latin typeface="Arial"/>
                <a:cs typeface="Arial"/>
              </a:rPr>
              <a:t>ni</a:t>
            </a:r>
            <a:r>
              <a:rPr sz="1200" i="1" spc="10" dirty="0">
                <a:latin typeface="Arial"/>
                <a:cs typeface="Arial"/>
              </a:rPr>
              <a:t> </a:t>
            </a:r>
            <a:r>
              <a:rPr sz="1200" i="1" dirty="0">
                <a:latin typeface="Arial"/>
                <a:cs typeface="Arial"/>
              </a:rPr>
              <a:t>carcass </a:t>
            </a:r>
            <a:r>
              <a:rPr sz="1200" dirty="0">
                <a:latin typeface="Arial"/>
                <a:cs typeface="Arial"/>
              </a:rPr>
              <a:t>proteins.</a:t>
            </a:r>
            <a:r>
              <a:rPr sz="1200" spc="-2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(b)</a:t>
            </a:r>
            <a:r>
              <a:rPr sz="1200" spc="10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CHIA/V-CATH</a:t>
            </a:r>
            <a:r>
              <a:rPr sz="1200" spc="-1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immunoblots</a:t>
            </a:r>
            <a:r>
              <a:rPr sz="1200" spc="-3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of</a:t>
            </a:r>
            <a:r>
              <a:rPr sz="1200" spc="300" dirty="0">
                <a:latin typeface="Arial"/>
                <a:cs typeface="Arial"/>
              </a:rPr>
              <a:t> </a:t>
            </a:r>
            <a:r>
              <a:rPr sz="1200" spc="-25" dirty="0">
                <a:latin typeface="Arial"/>
                <a:cs typeface="Arial"/>
              </a:rPr>
              <a:t>AcEGFP,</a:t>
            </a:r>
            <a:r>
              <a:rPr sz="1200" spc="-60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AcMNPV- </a:t>
            </a:r>
            <a:r>
              <a:rPr sz="1200" dirty="0">
                <a:latin typeface="Arial"/>
                <a:cs typeface="Arial"/>
              </a:rPr>
              <a:t>Rep,</a:t>
            </a:r>
            <a:r>
              <a:rPr sz="1200" spc="-75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Acp6.9-chiA</a:t>
            </a:r>
            <a:r>
              <a:rPr sz="1200" spc="-10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(p6.9)</a:t>
            </a:r>
            <a:r>
              <a:rPr sz="1200" spc="-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and</a:t>
            </a:r>
            <a:r>
              <a:rPr sz="1200" spc="-8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Acp6.9-</a:t>
            </a:r>
            <a:r>
              <a:rPr sz="1200" spc="-10" dirty="0">
                <a:latin typeface="Arial"/>
                <a:cs typeface="Arial"/>
              </a:rPr>
              <a:t>chiA/polh-</a:t>
            </a:r>
            <a:r>
              <a:rPr sz="1200" dirty="0">
                <a:latin typeface="Arial"/>
                <a:cs typeface="Arial"/>
              </a:rPr>
              <a:t>cath</a:t>
            </a:r>
            <a:r>
              <a:rPr sz="1200" spc="-3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(p6.9/ph)</a:t>
            </a:r>
            <a:r>
              <a:rPr sz="1200" spc="-3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infected</a:t>
            </a:r>
            <a:r>
              <a:rPr sz="1200" spc="-35" dirty="0">
                <a:latin typeface="Arial"/>
                <a:cs typeface="Arial"/>
              </a:rPr>
              <a:t> </a:t>
            </a:r>
            <a:r>
              <a:rPr sz="1200" i="1" dirty="0">
                <a:latin typeface="Arial"/>
                <a:cs typeface="Arial"/>
              </a:rPr>
              <a:t>T</a:t>
            </a:r>
            <a:r>
              <a:rPr sz="1200" i="1" spc="15" dirty="0">
                <a:latin typeface="Arial"/>
                <a:cs typeface="Arial"/>
              </a:rPr>
              <a:t> </a:t>
            </a:r>
            <a:r>
              <a:rPr sz="1200" i="1" dirty="0">
                <a:latin typeface="Arial"/>
                <a:cs typeface="Arial"/>
              </a:rPr>
              <a:t>ni</a:t>
            </a:r>
            <a:r>
              <a:rPr sz="1200" i="1" spc="-5" dirty="0">
                <a:latin typeface="Arial"/>
                <a:cs typeface="Arial"/>
              </a:rPr>
              <a:t> </a:t>
            </a:r>
            <a:r>
              <a:rPr sz="1200" i="1" dirty="0">
                <a:latin typeface="Arial"/>
                <a:cs typeface="Arial"/>
              </a:rPr>
              <a:t>hemolymph</a:t>
            </a:r>
            <a:r>
              <a:rPr sz="1200" i="1" spc="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proteins.</a:t>
            </a:r>
            <a:r>
              <a:rPr sz="1200" spc="-2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In</a:t>
            </a:r>
            <a:r>
              <a:rPr sz="1200" spc="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(b)</a:t>
            </a:r>
            <a:r>
              <a:rPr sz="1200" spc="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the</a:t>
            </a:r>
            <a:r>
              <a:rPr sz="1200" spc="-15" dirty="0">
                <a:latin typeface="Arial"/>
                <a:cs typeface="Arial"/>
              </a:rPr>
              <a:t> </a:t>
            </a:r>
            <a:r>
              <a:rPr sz="1200" spc="-20" dirty="0">
                <a:latin typeface="Arial"/>
                <a:cs typeface="Arial"/>
              </a:rPr>
              <a:t>blot </a:t>
            </a:r>
            <a:r>
              <a:rPr sz="1200" dirty="0">
                <a:latin typeface="Arial"/>
                <a:cs typeface="Arial"/>
              </a:rPr>
              <a:t>contained</a:t>
            </a:r>
            <a:r>
              <a:rPr sz="1200" spc="-20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duplicate</a:t>
            </a:r>
            <a:r>
              <a:rPr sz="1200" spc="-70" dirty="0">
                <a:latin typeface="Arial"/>
                <a:cs typeface="Arial"/>
              </a:rPr>
              <a:t> </a:t>
            </a:r>
            <a:r>
              <a:rPr sz="1200" spc="-25" dirty="0">
                <a:latin typeface="Arial"/>
                <a:cs typeface="Arial"/>
              </a:rPr>
              <a:t>AcEGFP,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AcMNPV-</a:t>
            </a:r>
            <a:r>
              <a:rPr sz="1200" dirty="0">
                <a:latin typeface="Arial"/>
                <a:cs typeface="Arial"/>
              </a:rPr>
              <a:t>Rep,</a:t>
            </a:r>
            <a:r>
              <a:rPr sz="1200" spc="-75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Acp6.9-</a:t>
            </a:r>
            <a:r>
              <a:rPr sz="1200" dirty="0">
                <a:latin typeface="Arial"/>
                <a:cs typeface="Arial"/>
              </a:rPr>
              <a:t>chiA</a:t>
            </a:r>
            <a:r>
              <a:rPr sz="1200" spc="-50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and</a:t>
            </a:r>
            <a:r>
              <a:rPr sz="1200" spc="-85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Acp6.9-chiA/polh-</a:t>
            </a:r>
            <a:r>
              <a:rPr sz="1200" dirty="0">
                <a:latin typeface="Arial"/>
                <a:cs typeface="Arial"/>
              </a:rPr>
              <a:t>cath</a:t>
            </a:r>
            <a:r>
              <a:rPr sz="1200" spc="-1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infected</a:t>
            </a:r>
            <a:r>
              <a:rPr sz="1200" spc="-10" dirty="0">
                <a:latin typeface="Arial"/>
                <a:cs typeface="Arial"/>
              </a:rPr>
              <a:t> </a:t>
            </a:r>
            <a:r>
              <a:rPr sz="1200" i="1" spc="-20" dirty="0">
                <a:latin typeface="Arial"/>
                <a:cs typeface="Arial"/>
              </a:rPr>
              <a:t>T.</a:t>
            </a:r>
            <a:r>
              <a:rPr sz="1200" i="1" spc="45" dirty="0">
                <a:latin typeface="Arial"/>
                <a:cs typeface="Arial"/>
              </a:rPr>
              <a:t> </a:t>
            </a:r>
            <a:r>
              <a:rPr sz="1200" i="1" dirty="0">
                <a:latin typeface="Arial"/>
                <a:cs typeface="Arial"/>
              </a:rPr>
              <a:t>ni</a:t>
            </a:r>
            <a:r>
              <a:rPr sz="1200" i="1" spc="15" dirty="0">
                <a:latin typeface="Arial"/>
                <a:cs typeface="Arial"/>
              </a:rPr>
              <a:t> </a:t>
            </a:r>
            <a:r>
              <a:rPr sz="1200" i="1" spc="-10" dirty="0">
                <a:latin typeface="Arial"/>
                <a:cs typeface="Arial"/>
              </a:rPr>
              <a:t>hemolymph </a:t>
            </a:r>
            <a:r>
              <a:rPr sz="1200" dirty="0">
                <a:latin typeface="Arial"/>
                <a:cs typeface="Arial"/>
              </a:rPr>
              <a:t>samples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to</a:t>
            </a:r>
            <a:r>
              <a:rPr sz="1200" spc="-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the</a:t>
            </a:r>
            <a:r>
              <a:rPr sz="1200" spc="-1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right</a:t>
            </a:r>
            <a:r>
              <a:rPr sz="1200" spc="-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(in</a:t>
            </a:r>
            <a:r>
              <a:rPr sz="1200" spc="-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the</a:t>
            </a:r>
            <a:r>
              <a:rPr sz="1200" spc="-2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white</a:t>
            </a:r>
            <a:r>
              <a:rPr sz="1200" spc="-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box)</a:t>
            </a:r>
            <a:r>
              <a:rPr sz="1200" spc="-2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that</a:t>
            </a:r>
            <a:r>
              <a:rPr sz="1200" spc="-1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were</a:t>
            </a:r>
            <a:r>
              <a:rPr sz="1200" spc="-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not</a:t>
            </a:r>
            <a:r>
              <a:rPr sz="1200" spc="-1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shown</a:t>
            </a:r>
            <a:r>
              <a:rPr sz="1200" spc="-2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in</a:t>
            </a:r>
            <a:r>
              <a:rPr sz="1200" spc="-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Figure</a:t>
            </a:r>
            <a:r>
              <a:rPr sz="1200" spc="-1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5,</a:t>
            </a:r>
            <a:r>
              <a:rPr sz="1200" spc="-1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but</a:t>
            </a:r>
            <a:r>
              <a:rPr sz="1200" spc="-1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are</a:t>
            </a:r>
            <a:r>
              <a:rPr sz="1200" spc="-1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shown</a:t>
            </a:r>
            <a:r>
              <a:rPr sz="1200" spc="-1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here</a:t>
            </a:r>
            <a:r>
              <a:rPr sz="1200" spc="-3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to</a:t>
            </a:r>
            <a:r>
              <a:rPr sz="1200" spc="-1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show</a:t>
            </a:r>
            <a:r>
              <a:rPr sz="1200" spc="-2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there</a:t>
            </a:r>
            <a:r>
              <a:rPr sz="1200" spc="-3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is</a:t>
            </a:r>
            <a:r>
              <a:rPr sz="1200" spc="-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not</a:t>
            </a:r>
            <a:r>
              <a:rPr sz="1200" spc="-25" dirty="0">
                <a:latin typeface="Arial"/>
                <a:cs typeface="Arial"/>
              </a:rPr>
              <a:t> any </a:t>
            </a:r>
            <a:r>
              <a:rPr sz="1200" spc="-20" dirty="0">
                <a:latin typeface="Arial"/>
                <a:cs typeface="Arial"/>
              </a:rPr>
              <a:t>proV-</a:t>
            </a:r>
            <a:r>
              <a:rPr sz="1200" spc="-35" dirty="0">
                <a:latin typeface="Arial"/>
                <a:cs typeface="Arial"/>
              </a:rPr>
              <a:t>CAT/V-CATH</a:t>
            </a:r>
            <a:r>
              <a:rPr sz="1200" spc="-4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bands</a:t>
            </a:r>
            <a:r>
              <a:rPr sz="1200" spc="-4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in</a:t>
            </a:r>
            <a:r>
              <a:rPr sz="1200" spc="-15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the</a:t>
            </a:r>
            <a:r>
              <a:rPr sz="1200" spc="-80" dirty="0">
                <a:latin typeface="Arial"/>
                <a:cs typeface="Arial"/>
              </a:rPr>
              <a:t> </a:t>
            </a:r>
            <a:r>
              <a:rPr sz="1200" spc="-25" dirty="0">
                <a:latin typeface="Arial"/>
                <a:cs typeface="Arial"/>
              </a:rPr>
              <a:t>AcMNPV-</a:t>
            </a:r>
            <a:r>
              <a:rPr sz="1200" dirty="0">
                <a:latin typeface="Arial"/>
                <a:cs typeface="Arial"/>
              </a:rPr>
              <a:t>Rep</a:t>
            </a:r>
            <a:r>
              <a:rPr sz="1200" spc="-2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sample</a:t>
            </a:r>
            <a:r>
              <a:rPr sz="1200" spc="-3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(i.e. in</a:t>
            </a:r>
            <a:r>
              <a:rPr sz="1200" spc="-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Figure</a:t>
            </a:r>
            <a:r>
              <a:rPr sz="1200" spc="-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5b,</a:t>
            </a:r>
            <a:r>
              <a:rPr sz="1200" spc="-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there</a:t>
            </a:r>
            <a:r>
              <a:rPr sz="1200" spc="-2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is a</a:t>
            </a:r>
            <a:r>
              <a:rPr sz="1200" spc="-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spurious</a:t>
            </a:r>
            <a:r>
              <a:rPr sz="1200" spc="-2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black</a:t>
            </a:r>
            <a:r>
              <a:rPr sz="1200" spc="-2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dot</a:t>
            </a:r>
            <a:r>
              <a:rPr sz="1200" spc="-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in</a:t>
            </a:r>
            <a:r>
              <a:rPr sz="1200" spc="-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the</a:t>
            </a:r>
            <a:r>
              <a:rPr sz="1200" spc="-10" dirty="0">
                <a:latin typeface="Arial"/>
                <a:cs typeface="Arial"/>
              </a:rPr>
              <a:t> position where</a:t>
            </a:r>
            <a:r>
              <a:rPr sz="1200" spc="-80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AcMNPV-</a:t>
            </a:r>
            <a:r>
              <a:rPr sz="1200" dirty="0">
                <a:latin typeface="Arial"/>
                <a:cs typeface="Arial"/>
              </a:rPr>
              <a:t>rep</a:t>
            </a:r>
            <a:r>
              <a:rPr sz="1200" spc="-25" dirty="0">
                <a:latin typeface="Arial"/>
                <a:cs typeface="Arial"/>
              </a:rPr>
              <a:t> </a:t>
            </a:r>
            <a:r>
              <a:rPr sz="1200" spc="-40" dirty="0">
                <a:latin typeface="Arial"/>
                <a:cs typeface="Arial"/>
              </a:rPr>
              <a:t>V-</a:t>
            </a:r>
            <a:r>
              <a:rPr sz="1200" spc="-20" dirty="0">
                <a:latin typeface="Arial"/>
                <a:cs typeface="Arial"/>
              </a:rPr>
              <a:t>CATH</a:t>
            </a:r>
            <a:r>
              <a:rPr sz="1200" spc="-2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would</a:t>
            </a:r>
            <a:r>
              <a:rPr sz="1200" spc="-1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have</a:t>
            </a:r>
            <a:r>
              <a:rPr sz="1200" spc="-10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been</a:t>
            </a:r>
            <a:r>
              <a:rPr sz="1200" spc="-35" dirty="0">
                <a:latin typeface="Arial"/>
                <a:cs typeface="Arial"/>
              </a:rPr>
              <a:t> </a:t>
            </a:r>
            <a:r>
              <a:rPr sz="1200" spc="-10" dirty="0">
                <a:latin typeface="Arial"/>
                <a:cs typeface="Arial"/>
              </a:rPr>
              <a:t>immunodetected).</a:t>
            </a:r>
            <a:endParaRPr sz="1200" dirty="0">
              <a:latin typeface="Arial"/>
              <a:cs typeface="Arial"/>
            </a:endParaRPr>
          </a:p>
        </p:txBody>
      </p:sp>
      <p:sp>
        <p:nvSpPr>
          <p:cNvPr id="20" name="object 20"/>
          <p:cNvSpPr txBox="1"/>
          <p:nvPr/>
        </p:nvSpPr>
        <p:spPr>
          <a:xfrm>
            <a:off x="8535669" y="2049526"/>
            <a:ext cx="77787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dirty="0">
                <a:latin typeface="Arial"/>
                <a:cs typeface="Arial"/>
              </a:rPr>
              <a:t>3</a:t>
            </a:r>
            <a:r>
              <a:rPr sz="1200" b="1" spc="-30" dirty="0">
                <a:latin typeface="Arial"/>
                <a:cs typeface="Arial"/>
              </a:rPr>
              <a:t> </a:t>
            </a:r>
            <a:r>
              <a:rPr sz="1200" b="1" dirty="0">
                <a:latin typeface="Arial"/>
                <a:cs typeface="Arial"/>
              </a:rPr>
              <a:t>Days </a:t>
            </a:r>
            <a:r>
              <a:rPr sz="1200" b="1" spc="-20" dirty="0">
                <a:latin typeface="Arial"/>
                <a:cs typeface="Arial"/>
              </a:rPr>
              <a:t>p.i.</a:t>
            </a:r>
            <a:endParaRPr sz="1200">
              <a:latin typeface="Arial"/>
              <a:cs typeface="Arial"/>
            </a:endParaRPr>
          </a:p>
        </p:txBody>
      </p:sp>
      <p:sp>
        <p:nvSpPr>
          <p:cNvPr id="21" name="object 21"/>
          <p:cNvSpPr txBox="1"/>
          <p:nvPr/>
        </p:nvSpPr>
        <p:spPr>
          <a:xfrm>
            <a:off x="1629282" y="2139822"/>
            <a:ext cx="77787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dirty="0">
                <a:latin typeface="Arial"/>
                <a:cs typeface="Arial"/>
              </a:rPr>
              <a:t>3</a:t>
            </a:r>
            <a:r>
              <a:rPr sz="1200" b="1" spc="-30" dirty="0">
                <a:latin typeface="Arial"/>
                <a:cs typeface="Arial"/>
              </a:rPr>
              <a:t> </a:t>
            </a:r>
            <a:r>
              <a:rPr sz="1200" b="1" dirty="0">
                <a:latin typeface="Arial"/>
                <a:cs typeface="Arial"/>
              </a:rPr>
              <a:t>Days </a:t>
            </a:r>
            <a:r>
              <a:rPr sz="1200" b="1" spc="-20" dirty="0">
                <a:latin typeface="Arial"/>
                <a:cs typeface="Arial"/>
              </a:rPr>
              <a:t>p.i.</a:t>
            </a:r>
            <a:endParaRPr sz="1200">
              <a:latin typeface="Arial"/>
              <a:cs typeface="Arial"/>
            </a:endParaRPr>
          </a:p>
        </p:txBody>
      </p:sp>
      <p:sp>
        <p:nvSpPr>
          <p:cNvPr id="22" name="object 22"/>
          <p:cNvSpPr txBox="1"/>
          <p:nvPr/>
        </p:nvSpPr>
        <p:spPr>
          <a:xfrm>
            <a:off x="1235941" y="2621596"/>
            <a:ext cx="142875" cy="363220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spc="-10" dirty="0">
                <a:latin typeface="Arial Narrow"/>
                <a:cs typeface="Arial Narrow"/>
              </a:rPr>
              <a:t>AcEGFP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23" name="object 23"/>
          <p:cNvSpPr txBox="1"/>
          <p:nvPr/>
        </p:nvSpPr>
        <p:spPr>
          <a:xfrm>
            <a:off x="1513055" y="2405740"/>
            <a:ext cx="142875" cy="56324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dirty="0">
                <a:latin typeface="Arial Narrow"/>
                <a:cs typeface="Arial Narrow"/>
              </a:rPr>
              <a:t>AcMNPV-</a:t>
            </a:r>
            <a:r>
              <a:rPr sz="800" b="1" spc="-25" dirty="0">
                <a:latin typeface="Arial Narrow"/>
                <a:cs typeface="Arial Narrow"/>
              </a:rPr>
              <a:t>Rep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24" name="object 24"/>
          <p:cNvSpPr/>
          <p:nvPr/>
        </p:nvSpPr>
        <p:spPr>
          <a:xfrm>
            <a:off x="1854962" y="2481579"/>
            <a:ext cx="96520" cy="483870"/>
          </a:xfrm>
          <a:custGeom>
            <a:avLst/>
            <a:gdLst/>
            <a:ahLst/>
            <a:cxnLst/>
            <a:rect l="l" t="t" r="r" b="b"/>
            <a:pathLst>
              <a:path w="96519" h="483869">
                <a:moveTo>
                  <a:pt x="13462" y="77597"/>
                </a:moveTo>
                <a:lnTo>
                  <a:pt x="13335" y="66040"/>
                </a:lnTo>
                <a:lnTo>
                  <a:pt x="381" y="66167"/>
                </a:lnTo>
                <a:lnTo>
                  <a:pt x="508" y="77724"/>
                </a:lnTo>
                <a:lnTo>
                  <a:pt x="13462" y="77597"/>
                </a:lnTo>
                <a:close/>
              </a:path>
              <a:path w="96519" h="483869">
                <a:moveTo>
                  <a:pt x="55245" y="204089"/>
                </a:moveTo>
                <a:lnTo>
                  <a:pt x="54991" y="181483"/>
                </a:lnTo>
                <a:lnTo>
                  <a:pt x="41021" y="181610"/>
                </a:lnTo>
                <a:lnTo>
                  <a:pt x="41275" y="204216"/>
                </a:lnTo>
                <a:lnTo>
                  <a:pt x="55245" y="204089"/>
                </a:lnTo>
                <a:close/>
              </a:path>
              <a:path w="96519" h="483869">
                <a:moveTo>
                  <a:pt x="73406" y="60198"/>
                </a:moveTo>
                <a:lnTo>
                  <a:pt x="73279" y="47371"/>
                </a:lnTo>
                <a:lnTo>
                  <a:pt x="56642" y="42545"/>
                </a:lnTo>
                <a:lnTo>
                  <a:pt x="56603" y="38989"/>
                </a:lnTo>
                <a:lnTo>
                  <a:pt x="56426" y="22606"/>
                </a:lnTo>
                <a:lnTo>
                  <a:pt x="56388" y="18542"/>
                </a:lnTo>
                <a:lnTo>
                  <a:pt x="72898" y="13081"/>
                </a:lnTo>
                <a:lnTo>
                  <a:pt x="72771" y="0"/>
                </a:lnTo>
                <a:lnTo>
                  <a:pt x="44196" y="9728"/>
                </a:lnTo>
                <a:lnTo>
                  <a:pt x="44196" y="38989"/>
                </a:lnTo>
                <a:lnTo>
                  <a:pt x="17018" y="31115"/>
                </a:lnTo>
                <a:lnTo>
                  <a:pt x="44069" y="22606"/>
                </a:lnTo>
                <a:lnTo>
                  <a:pt x="44196" y="38989"/>
                </a:lnTo>
                <a:lnTo>
                  <a:pt x="44196" y="9728"/>
                </a:lnTo>
                <a:lnTo>
                  <a:pt x="0" y="24765"/>
                </a:lnTo>
                <a:lnTo>
                  <a:pt x="127" y="37592"/>
                </a:lnTo>
                <a:lnTo>
                  <a:pt x="73406" y="60198"/>
                </a:lnTo>
                <a:close/>
              </a:path>
              <a:path w="96519" h="483869">
                <a:moveTo>
                  <a:pt x="73533" y="76962"/>
                </a:moveTo>
                <a:lnTo>
                  <a:pt x="73406" y="65532"/>
                </a:lnTo>
                <a:lnTo>
                  <a:pt x="20447" y="66040"/>
                </a:lnTo>
                <a:lnTo>
                  <a:pt x="20574" y="77470"/>
                </a:lnTo>
                <a:lnTo>
                  <a:pt x="73533" y="76962"/>
                </a:lnTo>
                <a:close/>
              </a:path>
              <a:path w="96519" h="483869">
                <a:moveTo>
                  <a:pt x="74041" y="127381"/>
                </a:moveTo>
                <a:lnTo>
                  <a:pt x="73914" y="116205"/>
                </a:lnTo>
                <a:lnTo>
                  <a:pt x="73914" y="115824"/>
                </a:lnTo>
                <a:lnTo>
                  <a:pt x="40767" y="116205"/>
                </a:lnTo>
                <a:lnTo>
                  <a:pt x="36322" y="115316"/>
                </a:lnTo>
                <a:lnTo>
                  <a:pt x="33909" y="113792"/>
                </a:lnTo>
                <a:lnTo>
                  <a:pt x="31623" y="112141"/>
                </a:lnTo>
                <a:lnTo>
                  <a:pt x="30353" y="109855"/>
                </a:lnTo>
                <a:lnTo>
                  <a:pt x="30353" y="104140"/>
                </a:lnTo>
                <a:lnTo>
                  <a:pt x="73787" y="99314"/>
                </a:lnTo>
                <a:lnTo>
                  <a:pt x="73660" y="87884"/>
                </a:lnTo>
                <a:lnTo>
                  <a:pt x="42545" y="88138"/>
                </a:lnTo>
                <a:lnTo>
                  <a:pt x="36576" y="88138"/>
                </a:lnTo>
                <a:lnTo>
                  <a:pt x="32385" y="88519"/>
                </a:lnTo>
                <a:lnTo>
                  <a:pt x="19558" y="105664"/>
                </a:lnTo>
                <a:lnTo>
                  <a:pt x="20320" y="108077"/>
                </a:lnTo>
                <a:lnTo>
                  <a:pt x="21590" y="110236"/>
                </a:lnTo>
                <a:lnTo>
                  <a:pt x="22987" y="112522"/>
                </a:lnTo>
                <a:lnTo>
                  <a:pt x="25019" y="114427"/>
                </a:lnTo>
                <a:lnTo>
                  <a:pt x="27686" y="116332"/>
                </a:lnTo>
                <a:lnTo>
                  <a:pt x="762" y="116586"/>
                </a:lnTo>
                <a:lnTo>
                  <a:pt x="889" y="128016"/>
                </a:lnTo>
                <a:lnTo>
                  <a:pt x="74041" y="127381"/>
                </a:lnTo>
                <a:close/>
              </a:path>
              <a:path w="96519" h="483869">
                <a:moveTo>
                  <a:pt x="75311" y="270510"/>
                </a:moveTo>
                <a:lnTo>
                  <a:pt x="75184" y="259080"/>
                </a:lnTo>
                <a:lnTo>
                  <a:pt x="61214" y="259207"/>
                </a:lnTo>
                <a:lnTo>
                  <a:pt x="61341" y="270637"/>
                </a:lnTo>
                <a:lnTo>
                  <a:pt x="75311" y="270510"/>
                </a:lnTo>
                <a:close/>
              </a:path>
              <a:path w="96519" h="483869">
                <a:moveTo>
                  <a:pt x="75565" y="161798"/>
                </a:moveTo>
                <a:lnTo>
                  <a:pt x="56134" y="134747"/>
                </a:lnTo>
                <a:lnTo>
                  <a:pt x="53975" y="146050"/>
                </a:lnTo>
                <a:lnTo>
                  <a:pt x="57658" y="146685"/>
                </a:lnTo>
                <a:lnTo>
                  <a:pt x="60325" y="147701"/>
                </a:lnTo>
                <a:lnTo>
                  <a:pt x="61849" y="148971"/>
                </a:lnTo>
                <a:lnTo>
                  <a:pt x="63373" y="150368"/>
                </a:lnTo>
                <a:lnTo>
                  <a:pt x="64008" y="152146"/>
                </a:lnTo>
                <a:lnTo>
                  <a:pt x="64135" y="154305"/>
                </a:lnTo>
                <a:lnTo>
                  <a:pt x="64135" y="157226"/>
                </a:lnTo>
                <a:lnTo>
                  <a:pt x="62865" y="159639"/>
                </a:lnTo>
                <a:lnTo>
                  <a:pt x="60198" y="161290"/>
                </a:lnTo>
                <a:lnTo>
                  <a:pt x="57658" y="163068"/>
                </a:lnTo>
                <a:lnTo>
                  <a:pt x="53213" y="163957"/>
                </a:lnTo>
                <a:lnTo>
                  <a:pt x="46863" y="164084"/>
                </a:lnTo>
                <a:lnTo>
                  <a:pt x="41275" y="164084"/>
                </a:lnTo>
                <a:lnTo>
                  <a:pt x="37211" y="163322"/>
                </a:lnTo>
                <a:lnTo>
                  <a:pt x="34798" y="161544"/>
                </a:lnTo>
                <a:lnTo>
                  <a:pt x="32385" y="159893"/>
                </a:lnTo>
                <a:lnTo>
                  <a:pt x="31115" y="157607"/>
                </a:lnTo>
                <a:lnTo>
                  <a:pt x="30988" y="150368"/>
                </a:lnTo>
                <a:lnTo>
                  <a:pt x="33782" y="147701"/>
                </a:lnTo>
                <a:lnTo>
                  <a:pt x="39370" y="146812"/>
                </a:lnTo>
                <a:lnTo>
                  <a:pt x="36703" y="135509"/>
                </a:lnTo>
                <a:lnTo>
                  <a:pt x="20066" y="149987"/>
                </a:lnTo>
                <a:lnTo>
                  <a:pt x="20180" y="161544"/>
                </a:lnTo>
                <a:lnTo>
                  <a:pt x="22606" y="166370"/>
                </a:lnTo>
                <a:lnTo>
                  <a:pt x="27305" y="170180"/>
                </a:lnTo>
                <a:lnTo>
                  <a:pt x="32131" y="173990"/>
                </a:lnTo>
                <a:lnTo>
                  <a:pt x="38989" y="175895"/>
                </a:lnTo>
                <a:lnTo>
                  <a:pt x="48133" y="175768"/>
                </a:lnTo>
                <a:lnTo>
                  <a:pt x="55753" y="175768"/>
                </a:lnTo>
                <a:lnTo>
                  <a:pt x="62230" y="173990"/>
                </a:lnTo>
                <a:lnTo>
                  <a:pt x="67564" y="170561"/>
                </a:lnTo>
                <a:lnTo>
                  <a:pt x="72898" y="167005"/>
                </a:lnTo>
                <a:lnTo>
                  <a:pt x="74383" y="164084"/>
                </a:lnTo>
                <a:lnTo>
                  <a:pt x="75565" y="161798"/>
                </a:lnTo>
                <a:close/>
              </a:path>
              <a:path w="96519" h="483869">
                <a:moveTo>
                  <a:pt x="76327" y="237617"/>
                </a:moveTo>
                <a:lnTo>
                  <a:pt x="76200" y="226568"/>
                </a:lnTo>
                <a:lnTo>
                  <a:pt x="74307" y="223266"/>
                </a:lnTo>
                <a:lnTo>
                  <a:pt x="73152" y="221234"/>
                </a:lnTo>
                <a:lnTo>
                  <a:pt x="40005" y="211518"/>
                </a:lnTo>
                <a:lnTo>
                  <a:pt x="40005" y="234442"/>
                </a:lnTo>
                <a:lnTo>
                  <a:pt x="38989" y="236347"/>
                </a:lnTo>
                <a:lnTo>
                  <a:pt x="34671" y="239395"/>
                </a:lnTo>
                <a:lnTo>
                  <a:pt x="31242" y="240284"/>
                </a:lnTo>
                <a:lnTo>
                  <a:pt x="21717" y="240284"/>
                </a:lnTo>
                <a:lnTo>
                  <a:pt x="18415" y="239649"/>
                </a:lnTo>
                <a:lnTo>
                  <a:pt x="14351" y="236855"/>
                </a:lnTo>
                <a:lnTo>
                  <a:pt x="13335" y="235077"/>
                </a:lnTo>
                <a:lnTo>
                  <a:pt x="13258" y="231775"/>
                </a:lnTo>
                <a:lnTo>
                  <a:pt x="13208" y="230759"/>
                </a:lnTo>
                <a:lnTo>
                  <a:pt x="14478" y="228854"/>
                </a:lnTo>
                <a:lnTo>
                  <a:pt x="19304" y="225298"/>
                </a:lnTo>
                <a:lnTo>
                  <a:pt x="22860" y="224409"/>
                </a:lnTo>
                <a:lnTo>
                  <a:pt x="27432" y="224409"/>
                </a:lnTo>
                <a:lnTo>
                  <a:pt x="31623" y="224282"/>
                </a:lnTo>
                <a:lnTo>
                  <a:pt x="34798" y="225044"/>
                </a:lnTo>
                <a:lnTo>
                  <a:pt x="36830" y="226568"/>
                </a:lnTo>
                <a:lnTo>
                  <a:pt x="38989" y="228092"/>
                </a:lnTo>
                <a:lnTo>
                  <a:pt x="39928" y="229870"/>
                </a:lnTo>
                <a:lnTo>
                  <a:pt x="40005" y="234442"/>
                </a:lnTo>
                <a:lnTo>
                  <a:pt x="40005" y="211518"/>
                </a:lnTo>
                <a:lnTo>
                  <a:pt x="1651" y="226568"/>
                </a:lnTo>
                <a:lnTo>
                  <a:pt x="1651" y="237998"/>
                </a:lnTo>
                <a:lnTo>
                  <a:pt x="3937" y="242570"/>
                </a:lnTo>
                <a:lnTo>
                  <a:pt x="8382" y="246126"/>
                </a:lnTo>
                <a:lnTo>
                  <a:pt x="12827" y="249809"/>
                </a:lnTo>
                <a:lnTo>
                  <a:pt x="18923" y="251587"/>
                </a:lnTo>
                <a:lnTo>
                  <a:pt x="26670" y="251587"/>
                </a:lnTo>
                <a:lnTo>
                  <a:pt x="33782" y="251460"/>
                </a:lnTo>
                <a:lnTo>
                  <a:pt x="39624" y="249682"/>
                </a:lnTo>
                <a:lnTo>
                  <a:pt x="48260" y="242570"/>
                </a:lnTo>
                <a:lnTo>
                  <a:pt x="49466" y="240284"/>
                </a:lnTo>
                <a:lnTo>
                  <a:pt x="50419" y="238506"/>
                </a:lnTo>
                <a:lnTo>
                  <a:pt x="45542" y="224282"/>
                </a:lnTo>
                <a:lnTo>
                  <a:pt x="44069" y="223266"/>
                </a:lnTo>
                <a:lnTo>
                  <a:pt x="64770" y="236220"/>
                </a:lnTo>
                <a:lnTo>
                  <a:pt x="61976" y="238379"/>
                </a:lnTo>
                <a:lnTo>
                  <a:pt x="56642" y="239014"/>
                </a:lnTo>
                <a:lnTo>
                  <a:pt x="58166" y="250063"/>
                </a:lnTo>
                <a:lnTo>
                  <a:pt x="64389" y="249174"/>
                </a:lnTo>
                <a:lnTo>
                  <a:pt x="68961" y="247269"/>
                </a:lnTo>
                <a:lnTo>
                  <a:pt x="71882" y="244348"/>
                </a:lnTo>
                <a:lnTo>
                  <a:pt x="74803" y="241300"/>
                </a:lnTo>
                <a:lnTo>
                  <a:pt x="76327" y="237617"/>
                </a:lnTo>
                <a:close/>
              </a:path>
              <a:path w="96519" h="483869">
                <a:moveTo>
                  <a:pt x="76962" y="305435"/>
                </a:moveTo>
                <a:lnTo>
                  <a:pt x="76835" y="294005"/>
                </a:lnTo>
                <a:lnTo>
                  <a:pt x="75679" y="291719"/>
                </a:lnTo>
                <a:lnTo>
                  <a:pt x="74549" y="289433"/>
                </a:lnTo>
                <a:lnTo>
                  <a:pt x="65786" y="282194"/>
                </a:lnTo>
                <a:lnTo>
                  <a:pt x="65278" y="282054"/>
                </a:lnTo>
                <a:lnTo>
                  <a:pt x="65278" y="296926"/>
                </a:lnTo>
                <a:lnTo>
                  <a:pt x="65278" y="301244"/>
                </a:lnTo>
                <a:lnTo>
                  <a:pt x="64008" y="303149"/>
                </a:lnTo>
                <a:lnTo>
                  <a:pt x="59182" y="306705"/>
                </a:lnTo>
                <a:lnTo>
                  <a:pt x="55753" y="307594"/>
                </a:lnTo>
                <a:lnTo>
                  <a:pt x="46990" y="307594"/>
                </a:lnTo>
                <a:lnTo>
                  <a:pt x="38481" y="297561"/>
                </a:lnTo>
                <a:lnTo>
                  <a:pt x="39624" y="295656"/>
                </a:lnTo>
                <a:lnTo>
                  <a:pt x="43942" y="292608"/>
                </a:lnTo>
                <a:lnTo>
                  <a:pt x="47371" y="291719"/>
                </a:lnTo>
                <a:lnTo>
                  <a:pt x="56769" y="291719"/>
                </a:lnTo>
                <a:lnTo>
                  <a:pt x="60071" y="292354"/>
                </a:lnTo>
                <a:lnTo>
                  <a:pt x="62103" y="293751"/>
                </a:lnTo>
                <a:lnTo>
                  <a:pt x="64262" y="295148"/>
                </a:lnTo>
                <a:lnTo>
                  <a:pt x="65278" y="296926"/>
                </a:lnTo>
                <a:lnTo>
                  <a:pt x="65278" y="282054"/>
                </a:lnTo>
                <a:lnTo>
                  <a:pt x="59690" y="280416"/>
                </a:lnTo>
                <a:lnTo>
                  <a:pt x="51943" y="280416"/>
                </a:lnTo>
                <a:lnTo>
                  <a:pt x="44704" y="280543"/>
                </a:lnTo>
                <a:lnTo>
                  <a:pt x="38989" y="282321"/>
                </a:lnTo>
                <a:lnTo>
                  <a:pt x="30353" y="289433"/>
                </a:lnTo>
                <a:lnTo>
                  <a:pt x="28194" y="293497"/>
                </a:lnTo>
                <a:lnTo>
                  <a:pt x="28194" y="300355"/>
                </a:lnTo>
                <a:lnTo>
                  <a:pt x="28702" y="302260"/>
                </a:lnTo>
                <a:lnTo>
                  <a:pt x="29908" y="304165"/>
                </a:lnTo>
                <a:lnTo>
                  <a:pt x="30861" y="305816"/>
                </a:lnTo>
                <a:lnTo>
                  <a:pt x="32385" y="307340"/>
                </a:lnTo>
                <a:lnTo>
                  <a:pt x="34417" y="308737"/>
                </a:lnTo>
                <a:lnTo>
                  <a:pt x="26162" y="308356"/>
                </a:lnTo>
                <a:lnTo>
                  <a:pt x="13716" y="295783"/>
                </a:lnTo>
                <a:lnTo>
                  <a:pt x="16510" y="293624"/>
                </a:lnTo>
                <a:lnTo>
                  <a:pt x="21844" y="292989"/>
                </a:lnTo>
                <a:lnTo>
                  <a:pt x="20320" y="281940"/>
                </a:lnTo>
                <a:lnTo>
                  <a:pt x="14224" y="282829"/>
                </a:lnTo>
                <a:lnTo>
                  <a:pt x="9652" y="284734"/>
                </a:lnTo>
                <a:lnTo>
                  <a:pt x="3683" y="290957"/>
                </a:lnTo>
                <a:lnTo>
                  <a:pt x="2286" y="294640"/>
                </a:lnTo>
                <a:lnTo>
                  <a:pt x="2286" y="305435"/>
                </a:lnTo>
                <a:lnTo>
                  <a:pt x="40259" y="320675"/>
                </a:lnTo>
                <a:lnTo>
                  <a:pt x="49390" y="320205"/>
                </a:lnTo>
                <a:lnTo>
                  <a:pt x="75133" y="308737"/>
                </a:lnTo>
                <a:lnTo>
                  <a:pt x="75768" y="307594"/>
                </a:lnTo>
                <a:lnTo>
                  <a:pt x="76962" y="305435"/>
                </a:lnTo>
                <a:close/>
              </a:path>
              <a:path w="96519" h="483869">
                <a:moveTo>
                  <a:pt x="77343" y="483870"/>
                </a:moveTo>
                <a:lnTo>
                  <a:pt x="77216" y="471043"/>
                </a:lnTo>
                <a:lnTo>
                  <a:pt x="60579" y="466217"/>
                </a:lnTo>
                <a:lnTo>
                  <a:pt x="60553" y="462661"/>
                </a:lnTo>
                <a:lnTo>
                  <a:pt x="60464" y="446151"/>
                </a:lnTo>
                <a:lnTo>
                  <a:pt x="60452" y="442214"/>
                </a:lnTo>
                <a:lnTo>
                  <a:pt x="76962" y="436753"/>
                </a:lnTo>
                <a:lnTo>
                  <a:pt x="76835" y="423672"/>
                </a:lnTo>
                <a:lnTo>
                  <a:pt x="48260" y="433387"/>
                </a:lnTo>
                <a:lnTo>
                  <a:pt x="48260" y="462661"/>
                </a:lnTo>
                <a:lnTo>
                  <a:pt x="21082" y="454787"/>
                </a:lnTo>
                <a:lnTo>
                  <a:pt x="48133" y="446151"/>
                </a:lnTo>
                <a:lnTo>
                  <a:pt x="48260" y="462661"/>
                </a:lnTo>
                <a:lnTo>
                  <a:pt x="48260" y="433387"/>
                </a:lnTo>
                <a:lnTo>
                  <a:pt x="3937" y="448437"/>
                </a:lnTo>
                <a:lnTo>
                  <a:pt x="4064" y="461149"/>
                </a:lnTo>
                <a:lnTo>
                  <a:pt x="77343" y="483870"/>
                </a:lnTo>
                <a:close/>
              </a:path>
              <a:path w="96519" h="483869">
                <a:moveTo>
                  <a:pt x="77851" y="398526"/>
                </a:moveTo>
                <a:lnTo>
                  <a:pt x="76555" y="391058"/>
                </a:lnTo>
                <a:lnTo>
                  <a:pt x="72885" y="385229"/>
                </a:lnTo>
                <a:lnTo>
                  <a:pt x="66840" y="381063"/>
                </a:lnTo>
                <a:lnTo>
                  <a:pt x="58420" y="378587"/>
                </a:lnTo>
                <a:lnTo>
                  <a:pt x="56261" y="389890"/>
                </a:lnTo>
                <a:lnTo>
                  <a:pt x="59944" y="390525"/>
                </a:lnTo>
                <a:lnTo>
                  <a:pt x="62611" y="391414"/>
                </a:lnTo>
                <a:lnTo>
                  <a:pt x="65659" y="394208"/>
                </a:lnTo>
                <a:lnTo>
                  <a:pt x="66421" y="395986"/>
                </a:lnTo>
                <a:lnTo>
                  <a:pt x="66421" y="401066"/>
                </a:lnTo>
                <a:lnTo>
                  <a:pt x="65151" y="403352"/>
                </a:lnTo>
                <a:lnTo>
                  <a:pt x="62484" y="405130"/>
                </a:lnTo>
                <a:lnTo>
                  <a:pt x="59944" y="406908"/>
                </a:lnTo>
                <a:lnTo>
                  <a:pt x="55499" y="407797"/>
                </a:lnTo>
                <a:lnTo>
                  <a:pt x="49276" y="407924"/>
                </a:lnTo>
                <a:lnTo>
                  <a:pt x="43561" y="407924"/>
                </a:lnTo>
                <a:lnTo>
                  <a:pt x="39497" y="407162"/>
                </a:lnTo>
                <a:lnTo>
                  <a:pt x="37084" y="405384"/>
                </a:lnTo>
                <a:lnTo>
                  <a:pt x="34671" y="403733"/>
                </a:lnTo>
                <a:lnTo>
                  <a:pt x="33401" y="401447"/>
                </a:lnTo>
                <a:lnTo>
                  <a:pt x="33274" y="394208"/>
                </a:lnTo>
                <a:lnTo>
                  <a:pt x="36068" y="391541"/>
                </a:lnTo>
                <a:lnTo>
                  <a:pt x="41656" y="390652"/>
                </a:lnTo>
                <a:lnTo>
                  <a:pt x="38989" y="379349"/>
                </a:lnTo>
                <a:lnTo>
                  <a:pt x="22352" y="393700"/>
                </a:lnTo>
                <a:lnTo>
                  <a:pt x="22390" y="401066"/>
                </a:lnTo>
                <a:lnTo>
                  <a:pt x="41275" y="419735"/>
                </a:lnTo>
                <a:lnTo>
                  <a:pt x="50419" y="419608"/>
                </a:lnTo>
                <a:lnTo>
                  <a:pt x="58039" y="419608"/>
                </a:lnTo>
                <a:lnTo>
                  <a:pt x="64516" y="417830"/>
                </a:lnTo>
                <a:lnTo>
                  <a:pt x="69850" y="414274"/>
                </a:lnTo>
                <a:lnTo>
                  <a:pt x="75184" y="410845"/>
                </a:lnTo>
                <a:lnTo>
                  <a:pt x="76669" y="407924"/>
                </a:lnTo>
                <a:lnTo>
                  <a:pt x="77851" y="405638"/>
                </a:lnTo>
                <a:lnTo>
                  <a:pt x="77851" y="398526"/>
                </a:lnTo>
                <a:close/>
              </a:path>
              <a:path w="96519" h="483869">
                <a:moveTo>
                  <a:pt x="96393" y="369824"/>
                </a:moveTo>
                <a:lnTo>
                  <a:pt x="96266" y="358902"/>
                </a:lnTo>
                <a:lnTo>
                  <a:pt x="96266" y="358521"/>
                </a:lnTo>
                <a:lnTo>
                  <a:pt x="96266" y="358267"/>
                </a:lnTo>
                <a:lnTo>
                  <a:pt x="69723" y="358521"/>
                </a:lnTo>
                <a:lnTo>
                  <a:pt x="72644" y="356235"/>
                </a:lnTo>
                <a:lnTo>
                  <a:pt x="74549" y="354203"/>
                </a:lnTo>
                <a:lnTo>
                  <a:pt x="76073" y="351536"/>
                </a:lnTo>
                <a:lnTo>
                  <a:pt x="76835" y="350266"/>
                </a:lnTo>
                <a:lnTo>
                  <a:pt x="77343" y="348107"/>
                </a:lnTo>
                <a:lnTo>
                  <a:pt x="77216" y="340868"/>
                </a:lnTo>
                <a:lnTo>
                  <a:pt x="76504" y="339598"/>
                </a:lnTo>
                <a:lnTo>
                  <a:pt x="74803" y="336550"/>
                </a:lnTo>
                <a:lnTo>
                  <a:pt x="69977" y="332994"/>
                </a:lnTo>
                <a:lnTo>
                  <a:pt x="66205" y="330288"/>
                </a:lnTo>
                <a:lnTo>
                  <a:pt x="66205" y="351663"/>
                </a:lnTo>
                <a:lnTo>
                  <a:pt x="64897" y="353822"/>
                </a:lnTo>
                <a:lnTo>
                  <a:pt x="61976" y="355854"/>
                </a:lnTo>
                <a:lnTo>
                  <a:pt x="59182" y="357759"/>
                </a:lnTo>
                <a:lnTo>
                  <a:pt x="54864" y="358775"/>
                </a:lnTo>
                <a:lnTo>
                  <a:pt x="48768" y="358902"/>
                </a:lnTo>
                <a:lnTo>
                  <a:pt x="43561" y="358902"/>
                </a:lnTo>
                <a:lnTo>
                  <a:pt x="32956" y="348107"/>
                </a:lnTo>
                <a:lnTo>
                  <a:pt x="32893" y="346583"/>
                </a:lnTo>
                <a:lnTo>
                  <a:pt x="34290" y="344297"/>
                </a:lnTo>
                <a:lnTo>
                  <a:pt x="36957" y="342519"/>
                </a:lnTo>
                <a:lnTo>
                  <a:pt x="39624" y="340614"/>
                </a:lnTo>
                <a:lnTo>
                  <a:pt x="43688" y="339598"/>
                </a:lnTo>
                <a:lnTo>
                  <a:pt x="55372" y="339598"/>
                </a:lnTo>
                <a:lnTo>
                  <a:pt x="59563" y="340360"/>
                </a:lnTo>
                <a:lnTo>
                  <a:pt x="64897" y="343916"/>
                </a:lnTo>
                <a:lnTo>
                  <a:pt x="66167" y="346075"/>
                </a:lnTo>
                <a:lnTo>
                  <a:pt x="66205" y="351663"/>
                </a:lnTo>
                <a:lnTo>
                  <a:pt x="66205" y="330288"/>
                </a:lnTo>
                <a:lnTo>
                  <a:pt x="65024" y="329438"/>
                </a:lnTo>
                <a:lnTo>
                  <a:pt x="58039" y="327787"/>
                </a:lnTo>
                <a:lnTo>
                  <a:pt x="48895" y="327787"/>
                </a:lnTo>
                <a:lnTo>
                  <a:pt x="21844" y="341376"/>
                </a:lnTo>
                <a:lnTo>
                  <a:pt x="21920" y="349250"/>
                </a:lnTo>
                <a:lnTo>
                  <a:pt x="22733" y="351663"/>
                </a:lnTo>
                <a:lnTo>
                  <a:pt x="24638" y="354330"/>
                </a:lnTo>
                <a:lnTo>
                  <a:pt x="26035" y="356362"/>
                </a:lnTo>
                <a:lnTo>
                  <a:pt x="28194" y="358267"/>
                </a:lnTo>
                <a:lnTo>
                  <a:pt x="30988" y="359664"/>
                </a:lnTo>
                <a:lnTo>
                  <a:pt x="23241" y="359791"/>
                </a:lnTo>
                <a:lnTo>
                  <a:pt x="23368" y="370459"/>
                </a:lnTo>
                <a:lnTo>
                  <a:pt x="96393" y="36982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" name="object 25"/>
          <p:cNvSpPr txBox="1"/>
          <p:nvPr/>
        </p:nvSpPr>
        <p:spPr>
          <a:xfrm>
            <a:off x="2101319" y="2470091"/>
            <a:ext cx="264795" cy="50990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spc="-10" dirty="0">
                <a:latin typeface="Arial Narrow"/>
                <a:cs typeface="Arial Narrow"/>
              </a:rPr>
              <a:t>Acp6.9-</a:t>
            </a:r>
            <a:r>
              <a:rPr sz="800" b="1" spc="-20" dirty="0">
                <a:latin typeface="Arial Narrow"/>
                <a:cs typeface="Arial Narrow"/>
              </a:rPr>
              <a:t>chiA</a:t>
            </a:r>
            <a:endParaRPr sz="800">
              <a:latin typeface="Arial Narrow"/>
              <a:cs typeface="Arial Narrow"/>
            </a:endParaRPr>
          </a:p>
          <a:p>
            <a:pPr marL="12700">
              <a:lnSpc>
                <a:spcPct val="100000"/>
              </a:lnSpc>
            </a:pPr>
            <a:r>
              <a:rPr sz="800" b="1" dirty="0">
                <a:latin typeface="Arial Narrow"/>
                <a:cs typeface="Arial Narrow"/>
              </a:rPr>
              <a:t>/</a:t>
            </a:r>
            <a:r>
              <a:rPr sz="800" b="1" spc="50" dirty="0">
                <a:latin typeface="Arial Narrow"/>
                <a:cs typeface="Arial Narrow"/>
              </a:rPr>
              <a:t> </a:t>
            </a:r>
            <a:r>
              <a:rPr sz="800" b="1" spc="-10" dirty="0">
                <a:latin typeface="Arial Narrow"/>
                <a:cs typeface="Arial Narrow"/>
              </a:rPr>
              <a:t>polh-</a:t>
            </a:r>
            <a:r>
              <a:rPr sz="800" b="1" spc="-20" dirty="0">
                <a:latin typeface="Arial Narrow"/>
                <a:cs typeface="Arial Narrow"/>
              </a:rPr>
              <a:t>cath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26" name="object 26"/>
          <p:cNvSpPr txBox="1"/>
          <p:nvPr/>
        </p:nvSpPr>
        <p:spPr>
          <a:xfrm>
            <a:off x="4802736" y="2577654"/>
            <a:ext cx="142875" cy="363220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spc="-10" dirty="0">
                <a:latin typeface="Arial Narrow"/>
                <a:cs typeface="Arial Narrow"/>
              </a:rPr>
              <a:t>AcEGFP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27" name="object 27"/>
          <p:cNvSpPr/>
          <p:nvPr/>
        </p:nvSpPr>
        <p:spPr>
          <a:xfrm>
            <a:off x="5421376" y="2437637"/>
            <a:ext cx="96520" cy="483870"/>
          </a:xfrm>
          <a:custGeom>
            <a:avLst/>
            <a:gdLst/>
            <a:ahLst/>
            <a:cxnLst/>
            <a:rect l="l" t="t" r="r" b="b"/>
            <a:pathLst>
              <a:path w="96520" h="483869">
                <a:moveTo>
                  <a:pt x="13462" y="77597"/>
                </a:moveTo>
                <a:lnTo>
                  <a:pt x="13335" y="66040"/>
                </a:lnTo>
                <a:lnTo>
                  <a:pt x="381" y="66167"/>
                </a:lnTo>
                <a:lnTo>
                  <a:pt x="508" y="77724"/>
                </a:lnTo>
                <a:lnTo>
                  <a:pt x="13462" y="77597"/>
                </a:lnTo>
                <a:close/>
              </a:path>
              <a:path w="96520" h="483869">
                <a:moveTo>
                  <a:pt x="55245" y="203962"/>
                </a:moveTo>
                <a:lnTo>
                  <a:pt x="54991" y="181356"/>
                </a:lnTo>
                <a:lnTo>
                  <a:pt x="41021" y="181483"/>
                </a:lnTo>
                <a:lnTo>
                  <a:pt x="41275" y="204089"/>
                </a:lnTo>
                <a:lnTo>
                  <a:pt x="55245" y="203962"/>
                </a:lnTo>
                <a:close/>
              </a:path>
              <a:path w="96520" h="483869">
                <a:moveTo>
                  <a:pt x="73406" y="60198"/>
                </a:moveTo>
                <a:lnTo>
                  <a:pt x="73279" y="47244"/>
                </a:lnTo>
                <a:lnTo>
                  <a:pt x="56642" y="42545"/>
                </a:lnTo>
                <a:lnTo>
                  <a:pt x="56616" y="38862"/>
                </a:lnTo>
                <a:lnTo>
                  <a:pt x="56527" y="22479"/>
                </a:lnTo>
                <a:lnTo>
                  <a:pt x="56515" y="18542"/>
                </a:lnTo>
                <a:lnTo>
                  <a:pt x="73025" y="13081"/>
                </a:lnTo>
                <a:lnTo>
                  <a:pt x="72898" y="0"/>
                </a:lnTo>
                <a:lnTo>
                  <a:pt x="44323" y="9664"/>
                </a:lnTo>
                <a:lnTo>
                  <a:pt x="44323" y="38862"/>
                </a:lnTo>
                <a:lnTo>
                  <a:pt x="17145" y="30988"/>
                </a:lnTo>
                <a:lnTo>
                  <a:pt x="44196" y="22479"/>
                </a:lnTo>
                <a:lnTo>
                  <a:pt x="44323" y="38862"/>
                </a:lnTo>
                <a:lnTo>
                  <a:pt x="44323" y="9664"/>
                </a:lnTo>
                <a:lnTo>
                  <a:pt x="0" y="24638"/>
                </a:lnTo>
                <a:lnTo>
                  <a:pt x="127" y="37465"/>
                </a:lnTo>
                <a:lnTo>
                  <a:pt x="73406" y="60198"/>
                </a:lnTo>
                <a:close/>
              </a:path>
              <a:path w="96520" h="483869">
                <a:moveTo>
                  <a:pt x="73533" y="76962"/>
                </a:moveTo>
                <a:lnTo>
                  <a:pt x="73406" y="65405"/>
                </a:lnTo>
                <a:lnTo>
                  <a:pt x="20447" y="65913"/>
                </a:lnTo>
                <a:lnTo>
                  <a:pt x="20574" y="77470"/>
                </a:lnTo>
                <a:lnTo>
                  <a:pt x="73533" y="76962"/>
                </a:lnTo>
                <a:close/>
              </a:path>
              <a:path w="96520" h="483869">
                <a:moveTo>
                  <a:pt x="74041" y="127254"/>
                </a:moveTo>
                <a:lnTo>
                  <a:pt x="73914" y="116078"/>
                </a:lnTo>
                <a:lnTo>
                  <a:pt x="73914" y="115824"/>
                </a:lnTo>
                <a:lnTo>
                  <a:pt x="47371" y="116078"/>
                </a:lnTo>
                <a:lnTo>
                  <a:pt x="40894" y="116078"/>
                </a:lnTo>
                <a:lnTo>
                  <a:pt x="36449" y="115316"/>
                </a:lnTo>
                <a:lnTo>
                  <a:pt x="34036" y="113665"/>
                </a:lnTo>
                <a:lnTo>
                  <a:pt x="31623" y="112141"/>
                </a:lnTo>
                <a:lnTo>
                  <a:pt x="30353" y="109855"/>
                </a:lnTo>
                <a:lnTo>
                  <a:pt x="30353" y="104140"/>
                </a:lnTo>
                <a:lnTo>
                  <a:pt x="31369" y="102108"/>
                </a:lnTo>
                <a:lnTo>
                  <a:pt x="33655" y="100965"/>
                </a:lnTo>
                <a:lnTo>
                  <a:pt x="35179" y="100076"/>
                </a:lnTo>
                <a:lnTo>
                  <a:pt x="39243" y="99568"/>
                </a:lnTo>
                <a:lnTo>
                  <a:pt x="45720" y="99568"/>
                </a:lnTo>
                <a:lnTo>
                  <a:pt x="73787" y="99314"/>
                </a:lnTo>
                <a:lnTo>
                  <a:pt x="73660" y="87757"/>
                </a:lnTo>
                <a:lnTo>
                  <a:pt x="42545" y="88011"/>
                </a:lnTo>
                <a:lnTo>
                  <a:pt x="36703" y="88138"/>
                </a:lnTo>
                <a:lnTo>
                  <a:pt x="19634" y="99314"/>
                </a:lnTo>
                <a:lnTo>
                  <a:pt x="19685" y="105664"/>
                </a:lnTo>
                <a:lnTo>
                  <a:pt x="27686" y="116205"/>
                </a:lnTo>
                <a:lnTo>
                  <a:pt x="889" y="116459"/>
                </a:lnTo>
                <a:lnTo>
                  <a:pt x="889" y="128016"/>
                </a:lnTo>
                <a:lnTo>
                  <a:pt x="74041" y="127254"/>
                </a:lnTo>
                <a:close/>
              </a:path>
              <a:path w="96520" h="483869">
                <a:moveTo>
                  <a:pt x="75438" y="270510"/>
                </a:moveTo>
                <a:lnTo>
                  <a:pt x="75311" y="259080"/>
                </a:lnTo>
                <a:lnTo>
                  <a:pt x="61214" y="259207"/>
                </a:lnTo>
                <a:lnTo>
                  <a:pt x="61341" y="270637"/>
                </a:lnTo>
                <a:lnTo>
                  <a:pt x="75438" y="270510"/>
                </a:lnTo>
                <a:close/>
              </a:path>
              <a:path w="96520" h="483869">
                <a:moveTo>
                  <a:pt x="75565" y="154686"/>
                </a:moveTo>
                <a:lnTo>
                  <a:pt x="74269" y="147167"/>
                </a:lnTo>
                <a:lnTo>
                  <a:pt x="70624" y="141338"/>
                </a:lnTo>
                <a:lnTo>
                  <a:pt x="64604" y="137210"/>
                </a:lnTo>
                <a:lnTo>
                  <a:pt x="56261" y="134747"/>
                </a:lnTo>
                <a:lnTo>
                  <a:pt x="53975" y="146050"/>
                </a:lnTo>
                <a:lnTo>
                  <a:pt x="57785" y="146558"/>
                </a:lnTo>
                <a:lnTo>
                  <a:pt x="60325" y="147574"/>
                </a:lnTo>
                <a:lnTo>
                  <a:pt x="63373" y="150368"/>
                </a:lnTo>
                <a:lnTo>
                  <a:pt x="64135" y="152146"/>
                </a:lnTo>
                <a:lnTo>
                  <a:pt x="64135" y="157226"/>
                </a:lnTo>
                <a:lnTo>
                  <a:pt x="62865" y="159512"/>
                </a:lnTo>
                <a:lnTo>
                  <a:pt x="60325" y="161290"/>
                </a:lnTo>
                <a:lnTo>
                  <a:pt x="57658" y="163068"/>
                </a:lnTo>
                <a:lnTo>
                  <a:pt x="53213" y="163957"/>
                </a:lnTo>
                <a:lnTo>
                  <a:pt x="46990" y="163957"/>
                </a:lnTo>
                <a:lnTo>
                  <a:pt x="41275" y="164084"/>
                </a:lnTo>
                <a:lnTo>
                  <a:pt x="37211" y="163195"/>
                </a:lnTo>
                <a:lnTo>
                  <a:pt x="34798" y="161544"/>
                </a:lnTo>
                <a:lnTo>
                  <a:pt x="32385" y="159766"/>
                </a:lnTo>
                <a:lnTo>
                  <a:pt x="31115" y="157480"/>
                </a:lnTo>
                <a:lnTo>
                  <a:pt x="31115" y="150241"/>
                </a:lnTo>
                <a:lnTo>
                  <a:pt x="33782" y="147574"/>
                </a:lnTo>
                <a:lnTo>
                  <a:pt x="39370" y="146685"/>
                </a:lnTo>
                <a:lnTo>
                  <a:pt x="36830" y="135382"/>
                </a:lnTo>
                <a:lnTo>
                  <a:pt x="30988" y="136906"/>
                </a:lnTo>
                <a:lnTo>
                  <a:pt x="26670" y="139192"/>
                </a:lnTo>
                <a:lnTo>
                  <a:pt x="24003" y="142494"/>
                </a:lnTo>
                <a:lnTo>
                  <a:pt x="21336" y="145669"/>
                </a:lnTo>
                <a:lnTo>
                  <a:pt x="20066" y="149860"/>
                </a:lnTo>
                <a:lnTo>
                  <a:pt x="20104" y="157226"/>
                </a:lnTo>
                <a:lnTo>
                  <a:pt x="20193" y="161290"/>
                </a:lnTo>
                <a:lnTo>
                  <a:pt x="22606" y="166370"/>
                </a:lnTo>
                <a:lnTo>
                  <a:pt x="27305" y="170180"/>
                </a:lnTo>
                <a:lnTo>
                  <a:pt x="32131" y="173990"/>
                </a:lnTo>
                <a:lnTo>
                  <a:pt x="39116" y="175895"/>
                </a:lnTo>
                <a:lnTo>
                  <a:pt x="55753" y="175641"/>
                </a:lnTo>
                <a:lnTo>
                  <a:pt x="62230" y="173990"/>
                </a:lnTo>
                <a:lnTo>
                  <a:pt x="67564" y="170434"/>
                </a:lnTo>
                <a:lnTo>
                  <a:pt x="72898" y="167005"/>
                </a:lnTo>
                <a:lnTo>
                  <a:pt x="74358" y="164084"/>
                </a:lnTo>
                <a:lnTo>
                  <a:pt x="75565" y="161671"/>
                </a:lnTo>
                <a:lnTo>
                  <a:pt x="75565" y="154686"/>
                </a:lnTo>
                <a:close/>
              </a:path>
              <a:path w="96520" h="483869">
                <a:moveTo>
                  <a:pt x="76225" y="237871"/>
                </a:moveTo>
                <a:lnTo>
                  <a:pt x="47663" y="211645"/>
                </a:lnTo>
                <a:lnTo>
                  <a:pt x="40132" y="211391"/>
                </a:lnTo>
                <a:lnTo>
                  <a:pt x="40132" y="234315"/>
                </a:lnTo>
                <a:lnTo>
                  <a:pt x="38989" y="236220"/>
                </a:lnTo>
                <a:lnTo>
                  <a:pt x="36830" y="237871"/>
                </a:lnTo>
                <a:lnTo>
                  <a:pt x="34671" y="239395"/>
                </a:lnTo>
                <a:lnTo>
                  <a:pt x="31242" y="240157"/>
                </a:lnTo>
                <a:lnTo>
                  <a:pt x="26543" y="240284"/>
                </a:lnTo>
                <a:lnTo>
                  <a:pt x="21844" y="240284"/>
                </a:lnTo>
                <a:lnTo>
                  <a:pt x="18415" y="239649"/>
                </a:lnTo>
                <a:lnTo>
                  <a:pt x="14351" y="236855"/>
                </a:lnTo>
                <a:lnTo>
                  <a:pt x="13335" y="235077"/>
                </a:lnTo>
                <a:lnTo>
                  <a:pt x="13335" y="230759"/>
                </a:lnTo>
                <a:lnTo>
                  <a:pt x="27432" y="224282"/>
                </a:lnTo>
                <a:lnTo>
                  <a:pt x="31623" y="224282"/>
                </a:lnTo>
                <a:lnTo>
                  <a:pt x="34798" y="225044"/>
                </a:lnTo>
                <a:lnTo>
                  <a:pt x="36830" y="226568"/>
                </a:lnTo>
                <a:lnTo>
                  <a:pt x="38989" y="228092"/>
                </a:lnTo>
                <a:lnTo>
                  <a:pt x="39928" y="229743"/>
                </a:lnTo>
                <a:lnTo>
                  <a:pt x="40055" y="230759"/>
                </a:lnTo>
                <a:lnTo>
                  <a:pt x="40132" y="234315"/>
                </a:lnTo>
                <a:lnTo>
                  <a:pt x="40132" y="211391"/>
                </a:lnTo>
                <a:lnTo>
                  <a:pt x="1790" y="226187"/>
                </a:lnTo>
                <a:lnTo>
                  <a:pt x="1778" y="237998"/>
                </a:lnTo>
                <a:lnTo>
                  <a:pt x="3937" y="242443"/>
                </a:lnTo>
                <a:lnTo>
                  <a:pt x="12827" y="249809"/>
                </a:lnTo>
                <a:lnTo>
                  <a:pt x="18923" y="251587"/>
                </a:lnTo>
                <a:lnTo>
                  <a:pt x="26670" y="251460"/>
                </a:lnTo>
                <a:lnTo>
                  <a:pt x="33909" y="251460"/>
                </a:lnTo>
                <a:lnTo>
                  <a:pt x="39624" y="249682"/>
                </a:lnTo>
                <a:lnTo>
                  <a:pt x="48260" y="242570"/>
                </a:lnTo>
                <a:lnTo>
                  <a:pt x="49466" y="240284"/>
                </a:lnTo>
                <a:lnTo>
                  <a:pt x="50419" y="238506"/>
                </a:lnTo>
                <a:lnTo>
                  <a:pt x="45834" y="224282"/>
                </a:lnTo>
                <a:lnTo>
                  <a:pt x="44069" y="223139"/>
                </a:lnTo>
                <a:lnTo>
                  <a:pt x="52451" y="223520"/>
                </a:lnTo>
                <a:lnTo>
                  <a:pt x="57912" y="224536"/>
                </a:lnTo>
                <a:lnTo>
                  <a:pt x="60579" y="226187"/>
                </a:lnTo>
                <a:lnTo>
                  <a:pt x="63373" y="227711"/>
                </a:lnTo>
                <a:lnTo>
                  <a:pt x="64643" y="229870"/>
                </a:lnTo>
                <a:lnTo>
                  <a:pt x="64770" y="236220"/>
                </a:lnTo>
                <a:lnTo>
                  <a:pt x="62103" y="238379"/>
                </a:lnTo>
                <a:lnTo>
                  <a:pt x="56642" y="239014"/>
                </a:lnTo>
                <a:lnTo>
                  <a:pt x="58293" y="250063"/>
                </a:lnTo>
                <a:lnTo>
                  <a:pt x="64389" y="249174"/>
                </a:lnTo>
                <a:lnTo>
                  <a:pt x="68961" y="247269"/>
                </a:lnTo>
                <a:lnTo>
                  <a:pt x="71882" y="244221"/>
                </a:lnTo>
                <a:lnTo>
                  <a:pt x="74930" y="241300"/>
                </a:lnTo>
                <a:lnTo>
                  <a:pt x="76225" y="237871"/>
                </a:lnTo>
                <a:close/>
              </a:path>
              <a:path w="96520" h="483869">
                <a:moveTo>
                  <a:pt x="76962" y="305435"/>
                </a:moveTo>
                <a:lnTo>
                  <a:pt x="76835" y="294005"/>
                </a:lnTo>
                <a:lnTo>
                  <a:pt x="75692" y="291592"/>
                </a:lnTo>
                <a:lnTo>
                  <a:pt x="74676" y="289433"/>
                </a:lnTo>
                <a:lnTo>
                  <a:pt x="65786" y="282067"/>
                </a:lnTo>
                <a:lnTo>
                  <a:pt x="65278" y="281927"/>
                </a:lnTo>
                <a:lnTo>
                  <a:pt x="65278" y="296799"/>
                </a:lnTo>
                <a:lnTo>
                  <a:pt x="65278" y="301244"/>
                </a:lnTo>
                <a:lnTo>
                  <a:pt x="51181" y="307594"/>
                </a:lnTo>
                <a:lnTo>
                  <a:pt x="46990" y="307594"/>
                </a:lnTo>
                <a:lnTo>
                  <a:pt x="43815" y="306832"/>
                </a:lnTo>
                <a:lnTo>
                  <a:pt x="41783" y="305308"/>
                </a:lnTo>
                <a:lnTo>
                  <a:pt x="39624" y="303784"/>
                </a:lnTo>
                <a:lnTo>
                  <a:pt x="38608" y="302006"/>
                </a:lnTo>
                <a:lnTo>
                  <a:pt x="38481" y="297561"/>
                </a:lnTo>
                <a:lnTo>
                  <a:pt x="39624" y="295656"/>
                </a:lnTo>
                <a:lnTo>
                  <a:pt x="41783" y="294005"/>
                </a:lnTo>
                <a:lnTo>
                  <a:pt x="43942" y="292481"/>
                </a:lnTo>
                <a:lnTo>
                  <a:pt x="47498" y="291719"/>
                </a:lnTo>
                <a:lnTo>
                  <a:pt x="52197" y="291592"/>
                </a:lnTo>
                <a:lnTo>
                  <a:pt x="56896" y="291592"/>
                </a:lnTo>
                <a:lnTo>
                  <a:pt x="60198" y="292227"/>
                </a:lnTo>
                <a:lnTo>
                  <a:pt x="64262" y="295021"/>
                </a:lnTo>
                <a:lnTo>
                  <a:pt x="65278" y="296799"/>
                </a:lnTo>
                <a:lnTo>
                  <a:pt x="65278" y="281927"/>
                </a:lnTo>
                <a:lnTo>
                  <a:pt x="59690" y="280289"/>
                </a:lnTo>
                <a:lnTo>
                  <a:pt x="52070" y="280416"/>
                </a:lnTo>
                <a:lnTo>
                  <a:pt x="44831" y="280416"/>
                </a:lnTo>
                <a:lnTo>
                  <a:pt x="38989" y="282194"/>
                </a:lnTo>
                <a:lnTo>
                  <a:pt x="30353" y="289306"/>
                </a:lnTo>
                <a:lnTo>
                  <a:pt x="28194" y="293497"/>
                </a:lnTo>
                <a:lnTo>
                  <a:pt x="28194" y="300228"/>
                </a:lnTo>
                <a:lnTo>
                  <a:pt x="28829" y="302260"/>
                </a:lnTo>
                <a:lnTo>
                  <a:pt x="29845" y="303911"/>
                </a:lnTo>
                <a:lnTo>
                  <a:pt x="30861" y="305689"/>
                </a:lnTo>
                <a:lnTo>
                  <a:pt x="32385" y="307340"/>
                </a:lnTo>
                <a:lnTo>
                  <a:pt x="34544" y="308737"/>
                </a:lnTo>
                <a:lnTo>
                  <a:pt x="26289" y="308356"/>
                </a:lnTo>
                <a:lnTo>
                  <a:pt x="20701" y="307340"/>
                </a:lnTo>
                <a:lnTo>
                  <a:pt x="18034" y="305689"/>
                </a:lnTo>
                <a:lnTo>
                  <a:pt x="15240" y="304165"/>
                </a:lnTo>
                <a:lnTo>
                  <a:pt x="13843" y="302006"/>
                </a:lnTo>
                <a:lnTo>
                  <a:pt x="13843" y="295783"/>
                </a:lnTo>
                <a:lnTo>
                  <a:pt x="16510" y="293497"/>
                </a:lnTo>
                <a:lnTo>
                  <a:pt x="21844" y="292989"/>
                </a:lnTo>
                <a:lnTo>
                  <a:pt x="20320" y="281813"/>
                </a:lnTo>
                <a:lnTo>
                  <a:pt x="14224" y="282702"/>
                </a:lnTo>
                <a:lnTo>
                  <a:pt x="9652" y="284734"/>
                </a:lnTo>
                <a:lnTo>
                  <a:pt x="6731" y="287782"/>
                </a:lnTo>
                <a:lnTo>
                  <a:pt x="3683" y="290830"/>
                </a:lnTo>
                <a:lnTo>
                  <a:pt x="2514" y="294005"/>
                </a:lnTo>
                <a:lnTo>
                  <a:pt x="2413" y="305435"/>
                </a:lnTo>
                <a:lnTo>
                  <a:pt x="5334" y="310642"/>
                </a:lnTo>
                <a:lnTo>
                  <a:pt x="40259" y="320548"/>
                </a:lnTo>
                <a:lnTo>
                  <a:pt x="49441" y="320103"/>
                </a:lnTo>
                <a:lnTo>
                  <a:pt x="75095" y="308737"/>
                </a:lnTo>
                <a:lnTo>
                  <a:pt x="75742" y="307594"/>
                </a:lnTo>
                <a:lnTo>
                  <a:pt x="76962" y="305435"/>
                </a:lnTo>
                <a:close/>
              </a:path>
              <a:path w="96520" h="483869">
                <a:moveTo>
                  <a:pt x="77343" y="483743"/>
                </a:moveTo>
                <a:lnTo>
                  <a:pt x="77216" y="470916"/>
                </a:lnTo>
                <a:lnTo>
                  <a:pt x="60706" y="466090"/>
                </a:lnTo>
                <a:lnTo>
                  <a:pt x="60667" y="462534"/>
                </a:lnTo>
                <a:lnTo>
                  <a:pt x="60490" y="446151"/>
                </a:lnTo>
                <a:lnTo>
                  <a:pt x="60452" y="442087"/>
                </a:lnTo>
                <a:lnTo>
                  <a:pt x="76962" y="436753"/>
                </a:lnTo>
                <a:lnTo>
                  <a:pt x="76835" y="423672"/>
                </a:lnTo>
                <a:lnTo>
                  <a:pt x="48260" y="433336"/>
                </a:lnTo>
                <a:lnTo>
                  <a:pt x="48260" y="462534"/>
                </a:lnTo>
                <a:lnTo>
                  <a:pt x="21082" y="454660"/>
                </a:lnTo>
                <a:lnTo>
                  <a:pt x="48133" y="446151"/>
                </a:lnTo>
                <a:lnTo>
                  <a:pt x="48260" y="462534"/>
                </a:lnTo>
                <a:lnTo>
                  <a:pt x="48260" y="433336"/>
                </a:lnTo>
                <a:lnTo>
                  <a:pt x="3937" y="448310"/>
                </a:lnTo>
                <a:lnTo>
                  <a:pt x="4064" y="461137"/>
                </a:lnTo>
                <a:lnTo>
                  <a:pt x="77343" y="483743"/>
                </a:lnTo>
                <a:close/>
              </a:path>
              <a:path w="96520" h="483869">
                <a:moveTo>
                  <a:pt x="77851" y="398399"/>
                </a:moveTo>
                <a:lnTo>
                  <a:pt x="76555" y="390956"/>
                </a:lnTo>
                <a:lnTo>
                  <a:pt x="72910" y="385165"/>
                </a:lnTo>
                <a:lnTo>
                  <a:pt x="66890" y="381050"/>
                </a:lnTo>
                <a:lnTo>
                  <a:pt x="58547" y="378587"/>
                </a:lnTo>
                <a:lnTo>
                  <a:pt x="56261" y="389890"/>
                </a:lnTo>
                <a:lnTo>
                  <a:pt x="60071" y="390398"/>
                </a:lnTo>
                <a:lnTo>
                  <a:pt x="62611" y="391414"/>
                </a:lnTo>
                <a:lnTo>
                  <a:pt x="65659" y="394208"/>
                </a:lnTo>
                <a:lnTo>
                  <a:pt x="66421" y="395986"/>
                </a:lnTo>
                <a:lnTo>
                  <a:pt x="66421" y="401066"/>
                </a:lnTo>
                <a:lnTo>
                  <a:pt x="65151" y="403352"/>
                </a:lnTo>
                <a:lnTo>
                  <a:pt x="62611" y="405130"/>
                </a:lnTo>
                <a:lnTo>
                  <a:pt x="59944" y="406908"/>
                </a:lnTo>
                <a:lnTo>
                  <a:pt x="55499" y="407797"/>
                </a:lnTo>
                <a:lnTo>
                  <a:pt x="49276" y="407797"/>
                </a:lnTo>
                <a:lnTo>
                  <a:pt x="43561" y="407924"/>
                </a:lnTo>
                <a:lnTo>
                  <a:pt x="39497" y="407035"/>
                </a:lnTo>
                <a:lnTo>
                  <a:pt x="37084" y="405384"/>
                </a:lnTo>
                <a:lnTo>
                  <a:pt x="34671" y="403606"/>
                </a:lnTo>
                <a:lnTo>
                  <a:pt x="33401" y="401320"/>
                </a:lnTo>
                <a:lnTo>
                  <a:pt x="33401" y="394081"/>
                </a:lnTo>
                <a:lnTo>
                  <a:pt x="36068" y="391414"/>
                </a:lnTo>
                <a:lnTo>
                  <a:pt x="41656" y="390525"/>
                </a:lnTo>
                <a:lnTo>
                  <a:pt x="39116" y="379222"/>
                </a:lnTo>
                <a:lnTo>
                  <a:pt x="33274" y="380746"/>
                </a:lnTo>
                <a:lnTo>
                  <a:pt x="28956" y="383032"/>
                </a:lnTo>
                <a:lnTo>
                  <a:pt x="26289" y="386334"/>
                </a:lnTo>
                <a:lnTo>
                  <a:pt x="23622" y="389509"/>
                </a:lnTo>
                <a:lnTo>
                  <a:pt x="22352" y="393700"/>
                </a:lnTo>
                <a:lnTo>
                  <a:pt x="22479" y="405130"/>
                </a:lnTo>
                <a:lnTo>
                  <a:pt x="24892" y="410210"/>
                </a:lnTo>
                <a:lnTo>
                  <a:pt x="29591" y="414020"/>
                </a:lnTo>
                <a:lnTo>
                  <a:pt x="34417" y="417830"/>
                </a:lnTo>
                <a:lnTo>
                  <a:pt x="41402" y="419735"/>
                </a:lnTo>
                <a:lnTo>
                  <a:pt x="58039" y="419481"/>
                </a:lnTo>
                <a:lnTo>
                  <a:pt x="64516" y="417703"/>
                </a:lnTo>
                <a:lnTo>
                  <a:pt x="69850" y="414274"/>
                </a:lnTo>
                <a:lnTo>
                  <a:pt x="75311" y="410845"/>
                </a:lnTo>
                <a:lnTo>
                  <a:pt x="76695" y="407924"/>
                </a:lnTo>
                <a:lnTo>
                  <a:pt x="77851" y="405511"/>
                </a:lnTo>
                <a:lnTo>
                  <a:pt x="77851" y="398399"/>
                </a:lnTo>
                <a:close/>
              </a:path>
              <a:path w="96520" h="483869">
                <a:moveTo>
                  <a:pt x="96520" y="369697"/>
                </a:moveTo>
                <a:lnTo>
                  <a:pt x="96393" y="358902"/>
                </a:lnTo>
                <a:lnTo>
                  <a:pt x="96393" y="358521"/>
                </a:lnTo>
                <a:lnTo>
                  <a:pt x="96393" y="358267"/>
                </a:lnTo>
                <a:lnTo>
                  <a:pt x="69723" y="358521"/>
                </a:lnTo>
                <a:lnTo>
                  <a:pt x="72644" y="356235"/>
                </a:lnTo>
                <a:lnTo>
                  <a:pt x="74676" y="354076"/>
                </a:lnTo>
                <a:lnTo>
                  <a:pt x="76111" y="351409"/>
                </a:lnTo>
                <a:lnTo>
                  <a:pt x="76835" y="350139"/>
                </a:lnTo>
                <a:lnTo>
                  <a:pt x="77343" y="347980"/>
                </a:lnTo>
                <a:lnTo>
                  <a:pt x="66217" y="330301"/>
                </a:lnTo>
                <a:lnTo>
                  <a:pt x="66217" y="351536"/>
                </a:lnTo>
                <a:lnTo>
                  <a:pt x="64897" y="353822"/>
                </a:lnTo>
                <a:lnTo>
                  <a:pt x="62103" y="355727"/>
                </a:lnTo>
                <a:lnTo>
                  <a:pt x="59309" y="357759"/>
                </a:lnTo>
                <a:lnTo>
                  <a:pt x="54864" y="358775"/>
                </a:lnTo>
                <a:lnTo>
                  <a:pt x="48895" y="358775"/>
                </a:lnTo>
                <a:lnTo>
                  <a:pt x="43561" y="358902"/>
                </a:lnTo>
                <a:lnTo>
                  <a:pt x="39624" y="358013"/>
                </a:lnTo>
                <a:lnTo>
                  <a:pt x="36957" y="356108"/>
                </a:lnTo>
                <a:lnTo>
                  <a:pt x="34290" y="354330"/>
                </a:lnTo>
                <a:lnTo>
                  <a:pt x="33083" y="352171"/>
                </a:lnTo>
                <a:lnTo>
                  <a:pt x="43815" y="339598"/>
                </a:lnTo>
                <a:lnTo>
                  <a:pt x="49403" y="339598"/>
                </a:lnTo>
                <a:lnTo>
                  <a:pt x="55372" y="339471"/>
                </a:lnTo>
                <a:lnTo>
                  <a:pt x="59563" y="340360"/>
                </a:lnTo>
                <a:lnTo>
                  <a:pt x="64897" y="343916"/>
                </a:lnTo>
                <a:lnTo>
                  <a:pt x="66167" y="346075"/>
                </a:lnTo>
                <a:lnTo>
                  <a:pt x="66217" y="351536"/>
                </a:lnTo>
                <a:lnTo>
                  <a:pt x="66217" y="330301"/>
                </a:lnTo>
                <a:lnTo>
                  <a:pt x="65024" y="329438"/>
                </a:lnTo>
                <a:lnTo>
                  <a:pt x="58039" y="327660"/>
                </a:lnTo>
                <a:lnTo>
                  <a:pt x="40259" y="327914"/>
                </a:lnTo>
                <a:lnTo>
                  <a:pt x="33528" y="329692"/>
                </a:lnTo>
                <a:lnTo>
                  <a:pt x="28829" y="333375"/>
                </a:lnTo>
                <a:lnTo>
                  <a:pt x="24130" y="336931"/>
                </a:lnTo>
                <a:lnTo>
                  <a:pt x="21844" y="341249"/>
                </a:lnTo>
                <a:lnTo>
                  <a:pt x="21971" y="348996"/>
                </a:lnTo>
                <a:lnTo>
                  <a:pt x="22733" y="351536"/>
                </a:lnTo>
                <a:lnTo>
                  <a:pt x="26035" y="356362"/>
                </a:lnTo>
                <a:lnTo>
                  <a:pt x="28194" y="358267"/>
                </a:lnTo>
                <a:lnTo>
                  <a:pt x="30988" y="359664"/>
                </a:lnTo>
                <a:lnTo>
                  <a:pt x="23241" y="359791"/>
                </a:lnTo>
                <a:lnTo>
                  <a:pt x="23368" y="370459"/>
                </a:lnTo>
                <a:lnTo>
                  <a:pt x="96520" y="36969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" name="object 28"/>
          <p:cNvSpPr txBox="1"/>
          <p:nvPr/>
        </p:nvSpPr>
        <p:spPr>
          <a:xfrm>
            <a:off x="5668368" y="2426149"/>
            <a:ext cx="264795" cy="50990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spc="-10" dirty="0">
                <a:latin typeface="Arial Narrow"/>
                <a:cs typeface="Arial Narrow"/>
              </a:rPr>
              <a:t>Acp6.9-</a:t>
            </a:r>
            <a:r>
              <a:rPr sz="800" b="1" spc="-20" dirty="0">
                <a:latin typeface="Arial Narrow"/>
                <a:cs typeface="Arial Narrow"/>
              </a:rPr>
              <a:t>chiA</a:t>
            </a:r>
            <a:endParaRPr sz="800">
              <a:latin typeface="Arial Narrow"/>
              <a:cs typeface="Arial Narrow"/>
            </a:endParaRPr>
          </a:p>
          <a:p>
            <a:pPr marL="12700">
              <a:lnSpc>
                <a:spcPct val="100000"/>
              </a:lnSpc>
            </a:pPr>
            <a:r>
              <a:rPr sz="800" b="1" dirty="0">
                <a:latin typeface="Arial Narrow"/>
                <a:cs typeface="Arial Narrow"/>
              </a:rPr>
              <a:t>/</a:t>
            </a:r>
            <a:r>
              <a:rPr sz="800" b="1" spc="50" dirty="0">
                <a:latin typeface="Arial Narrow"/>
                <a:cs typeface="Arial Narrow"/>
              </a:rPr>
              <a:t> </a:t>
            </a:r>
            <a:r>
              <a:rPr sz="800" b="1" spc="-10" dirty="0">
                <a:latin typeface="Arial Narrow"/>
                <a:cs typeface="Arial Narrow"/>
              </a:rPr>
              <a:t>polh-</a:t>
            </a:r>
            <a:r>
              <a:rPr sz="800" b="1" spc="-20" dirty="0">
                <a:latin typeface="Arial Narrow"/>
                <a:cs typeface="Arial Narrow"/>
              </a:rPr>
              <a:t>cath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29" name="object 29"/>
          <p:cNvSpPr txBox="1"/>
          <p:nvPr/>
        </p:nvSpPr>
        <p:spPr>
          <a:xfrm>
            <a:off x="8620610" y="2632518"/>
            <a:ext cx="142875" cy="363220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spc="-10" dirty="0">
                <a:latin typeface="Arial Narrow"/>
                <a:cs typeface="Arial Narrow"/>
              </a:rPr>
              <a:t>AcEGFP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30" name="object 30"/>
          <p:cNvSpPr/>
          <p:nvPr/>
        </p:nvSpPr>
        <p:spPr>
          <a:xfrm>
            <a:off x="9238742" y="2492628"/>
            <a:ext cx="96520" cy="483870"/>
          </a:xfrm>
          <a:custGeom>
            <a:avLst/>
            <a:gdLst/>
            <a:ahLst/>
            <a:cxnLst/>
            <a:rect l="l" t="t" r="r" b="b"/>
            <a:pathLst>
              <a:path w="96520" h="483869">
                <a:moveTo>
                  <a:pt x="13462" y="77597"/>
                </a:moveTo>
                <a:lnTo>
                  <a:pt x="13335" y="66040"/>
                </a:lnTo>
                <a:lnTo>
                  <a:pt x="381" y="66167"/>
                </a:lnTo>
                <a:lnTo>
                  <a:pt x="508" y="77724"/>
                </a:lnTo>
                <a:lnTo>
                  <a:pt x="13462" y="77597"/>
                </a:lnTo>
                <a:close/>
              </a:path>
              <a:path w="96520" h="483869">
                <a:moveTo>
                  <a:pt x="55372" y="203962"/>
                </a:moveTo>
                <a:lnTo>
                  <a:pt x="55118" y="181356"/>
                </a:lnTo>
                <a:lnTo>
                  <a:pt x="41148" y="181483"/>
                </a:lnTo>
                <a:lnTo>
                  <a:pt x="41275" y="204089"/>
                </a:lnTo>
                <a:lnTo>
                  <a:pt x="55372" y="203962"/>
                </a:lnTo>
                <a:close/>
              </a:path>
              <a:path w="96520" h="483869">
                <a:moveTo>
                  <a:pt x="73406" y="60198"/>
                </a:moveTo>
                <a:lnTo>
                  <a:pt x="73279" y="47244"/>
                </a:lnTo>
                <a:lnTo>
                  <a:pt x="56769" y="42545"/>
                </a:lnTo>
                <a:lnTo>
                  <a:pt x="56718" y="38862"/>
                </a:lnTo>
                <a:lnTo>
                  <a:pt x="56553" y="22479"/>
                </a:lnTo>
                <a:lnTo>
                  <a:pt x="56515" y="18542"/>
                </a:lnTo>
                <a:lnTo>
                  <a:pt x="73025" y="13081"/>
                </a:lnTo>
                <a:lnTo>
                  <a:pt x="72898" y="0"/>
                </a:lnTo>
                <a:lnTo>
                  <a:pt x="44323" y="9664"/>
                </a:lnTo>
                <a:lnTo>
                  <a:pt x="44323" y="38862"/>
                </a:lnTo>
                <a:lnTo>
                  <a:pt x="17145" y="30988"/>
                </a:lnTo>
                <a:lnTo>
                  <a:pt x="44196" y="22479"/>
                </a:lnTo>
                <a:lnTo>
                  <a:pt x="44323" y="38862"/>
                </a:lnTo>
                <a:lnTo>
                  <a:pt x="44323" y="9664"/>
                </a:lnTo>
                <a:lnTo>
                  <a:pt x="0" y="24638"/>
                </a:lnTo>
                <a:lnTo>
                  <a:pt x="127" y="37465"/>
                </a:lnTo>
                <a:lnTo>
                  <a:pt x="73406" y="60198"/>
                </a:lnTo>
                <a:close/>
              </a:path>
              <a:path w="96520" h="483869">
                <a:moveTo>
                  <a:pt x="73660" y="76962"/>
                </a:moveTo>
                <a:lnTo>
                  <a:pt x="73533" y="65405"/>
                </a:lnTo>
                <a:lnTo>
                  <a:pt x="20574" y="65913"/>
                </a:lnTo>
                <a:lnTo>
                  <a:pt x="20701" y="77470"/>
                </a:lnTo>
                <a:lnTo>
                  <a:pt x="73660" y="76962"/>
                </a:lnTo>
                <a:close/>
              </a:path>
              <a:path w="96520" h="483869">
                <a:moveTo>
                  <a:pt x="74041" y="115824"/>
                </a:moveTo>
                <a:lnTo>
                  <a:pt x="47371" y="116078"/>
                </a:lnTo>
                <a:lnTo>
                  <a:pt x="40894" y="116078"/>
                </a:lnTo>
                <a:lnTo>
                  <a:pt x="36449" y="115316"/>
                </a:lnTo>
                <a:lnTo>
                  <a:pt x="34036" y="113665"/>
                </a:lnTo>
                <a:lnTo>
                  <a:pt x="31623" y="112141"/>
                </a:lnTo>
                <a:lnTo>
                  <a:pt x="30480" y="109855"/>
                </a:lnTo>
                <a:lnTo>
                  <a:pt x="30353" y="104140"/>
                </a:lnTo>
                <a:lnTo>
                  <a:pt x="31496" y="102108"/>
                </a:lnTo>
                <a:lnTo>
                  <a:pt x="35306" y="100076"/>
                </a:lnTo>
                <a:lnTo>
                  <a:pt x="39370" y="99568"/>
                </a:lnTo>
                <a:lnTo>
                  <a:pt x="45847" y="99568"/>
                </a:lnTo>
                <a:lnTo>
                  <a:pt x="73787" y="99314"/>
                </a:lnTo>
                <a:lnTo>
                  <a:pt x="73660" y="87757"/>
                </a:lnTo>
                <a:lnTo>
                  <a:pt x="42672" y="88011"/>
                </a:lnTo>
                <a:lnTo>
                  <a:pt x="36703" y="88138"/>
                </a:lnTo>
                <a:lnTo>
                  <a:pt x="32512" y="88519"/>
                </a:lnTo>
                <a:lnTo>
                  <a:pt x="30099" y="89281"/>
                </a:lnTo>
                <a:lnTo>
                  <a:pt x="26670" y="90297"/>
                </a:lnTo>
                <a:lnTo>
                  <a:pt x="24130" y="91948"/>
                </a:lnTo>
                <a:lnTo>
                  <a:pt x="22352" y="94361"/>
                </a:lnTo>
                <a:lnTo>
                  <a:pt x="20574" y="96647"/>
                </a:lnTo>
                <a:lnTo>
                  <a:pt x="19761" y="99314"/>
                </a:lnTo>
                <a:lnTo>
                  <a:pt x="19685" y="105664"/>
                </a:lnTo>
                <a:lnTo>
                  <a:pt x="20320" y="108077"/>
                </a:lnTo>
                <a:lnTo>
                  <a:pt x="21717" y="110236"/>
                </a:lnTo>
                <a:lnTo>
                  <a:pt x="22987" y="112395"/>
                </a:lnTo>
                <a:lnTo>
                  <a:pt x="25019" y="114427"/>
                </a:lnTo>
                <a:lnTo>
                  <a:pt x="27686" y="116205"/>
                </a:lnTo>
                <a:lnTo>
                  <a:pt x="889" y="116459"/>
                </a:lnTo>
                <a:lnTo>
                  <a:pt x="1016" y="128016"/>
                </a:lnTo>
                <a:lnTo>
                  <a:pt x="74041" y="127254"/>
                </a:lnTo>
                <a:lnTo>
                  <a:pt x="74041" y="116078"/>
                </a:lnTo>
                <a:lnTo>
                  <a:pt x="74041" y="115824"/>
                </a:lnTo>
                <a:close/>
              </a:path>
              <a:path w="96520" h="483869">
                <a:moveTo>
                  <a:pt x="75438" y="270510"/>
                </a:moveTo>
                <a:lnTo>
                  <a:pt x="75311" y="259080"/>
                </a:lnTo>
                <a:lnTo>
                  <a:pt x="61341" y="259207"/>
                </a:lnTo>
                <a:lnTo>
                  <a:pt x="61468" y="270637"/>
                </a:lnTo>
                <a:lnTo>
                  <a:pt x="75438" y="270510"/>
                </a:lnTo>
                <a:close/>
              </a:path>
              <a:path w="96520" h="483869">
                <a:moveTo>
                  <a:pt x="75692" y="161671"/>
                </a:moveTo>
                <a:lnTo>
                  <a:pt x="56261" y="134747"/>
                </a:lnTo>
                <a:lnTo>
                  <a:pt x="53975" y="146050"/>
                </a:lnTo>
                <a:lnTo>
                  <a:pt x="57785" y="146558"/>
                </a:lnTo>
                <a:lnTo>
                  <a:pt x="60452" y="147574"/>
                </a:lnTo>
                <a:lnTo>
                  <a:pt x="61849" y="148971"/>
                </a:lnTo>
                <a:lnTo>
                  <a:pt x="63373" y="150368"/>
                </a:lnTo>
                <a:lnTo>
                  <a:pt x="64135" y="152146"/>
                </a:lnTo>
                <a:lnTo>
                  <a:pt x="64135" y="157226"/>
                </a:lnTo>
                <a:lnTo>
                  <a:pt x="62865" y="159512"/>
                </a:lnTo>
                <a:lnTo>
                  <a:pt x="57785" y="163068"/>
                </a:lnTo>
                <a:lnTo>
                  <a:pt x="53340" y="163957"/>
                </a:lnTo>
                <a:lnTo>
                  <a:pt x="46990" y="163957"/>
                </a:lnTo>
                <a:lnTo>
                  <a:pt x="41275" y="164084"/>
                </a:lnTo>
                <a:lnTo>
                  <a:pt x="31115" y="150241"/>
                </a:lnTo>
                <a:lnTo>
                  <a:pt x="33909" y="147574"/>
                </a:lnTo>
                <a:lnTo>
                  <a:pt x="39370" y="146685"/>
                </a:lnTo>
                <a:lnTo>
                  <a:pt x="36830" y="135509"/>
                </a:lnTo>
                <a:lnTo>
                  <a:pt x="30988" y="136906"/>
                </a:lnTo>
                <a:lnTo>
                  <a:pt x="26670" y="139192"/>
                </a:lnTo>
                <a:lnTo>
                  <a:pt x="24130" y="142494"/>
                </a:lnTo>
                <a:lnTo>
                  <a:pt x="21463" y="145669"/>
                </a:lnTo>
                <a:lnTo>
                  <a:pt x="20066" y="149860"/>
                </a:lnTo>
                <a:lnTo>
                  <a:pt x="20180" y="154686"/>
                </a:lnTo>
                <a:lnTo>
                  <a:pt x="20307" y="161544"/>
                </a:lnTo>
                <a:lnTo>
                  <a:pt x="22606" y="166370"/>
                </a:lnTo>
                <a:lnTo>
                  <a:pt x="27432" y="170180"/>
                </a:lnTo>
                <a:lnTo>
                  <a:pt x="32131" y="173990"/>
                </a:lnTo>
                <a:lnTo>
                  <a:pt x="39116" y="175895"/>
                </a:lnTo>
                <a:lnTo>
                  <a:pt x="55753" y="175641"/>
                </a:lnTo>
                <a:lnTo>
                  <a:pt x="62230" y="173990"/>
                </a:lnTo>
                <a:lnTo>
                  <a:pt x="73025" y="167005"/>
                </a:lnTo>
                <a:lnTo>
                  <a:pt x="74472" y="164084"/>
                </a:lnTo>
                <a:lnTo>
                  <a:pt x="75692" y="161671"/>
                </a:lnTo>
                <a:close/>
              </a:path>
              <a:path w="96520" h="483869">
                <a:moveTo>
                  <a:pt x="76250" y="226441"/>
                </a:moveTo>
                <a:lnTo>
                  <a:pt x="74358" y="223139"/>
                </a:lnTo>
                <a:lnTo>
                  <a:pt x="73279" y="221234"/>
                </a:lnTo>
                <a:lnTo>
                  <a:pt x="67310" y="217170"/>
                </a:lnTo>
                <a:lnTo>
                  <a:pt x="62204" y="214579"/>
                </a:lnTo>
                <a:lnTo>
                  <a:pt x="55689" y="212725"/>
                </a:lnTo>
                <a:lnTo>
                  <a:pt x="47726" y="211645"/>
                </a:lnTo>
                <a:lnTo>
                  <a:pt x="40132" y="211391"/>
                </a:lnTo>
                <a:lnTo>
                  <a:pt x="40132" y="234315"/>
                </a:lnTo>
                <a:lnTo>
                  <a:pt x="39116" y="236220"/>
                </a:lnTo>
                <a:lnTo>
                  <a:pt x="36830" y="237871"/>
                </a:lnTo>
                <a:lnTo>
                  <a:pt x="34671" y="239395"/>
                </a:lnTo>
                <a:lnTo>
                  <a:pt x="31242" y="240157"/>
                </a:lnTo>
                <a:lnTo>
                  <a:pt x="26543" y="240284"/>
                </a:lnTo>
                <a:lnTo>
                  <a:pt x="21844" y="240284"/>
                </a:lnTo>
                <a:lnTo>
                  <a:pt x="18415" y="239649"/>
                </a:lnTo>
                <a:lnTo>
                  <a:pt x="14351" y="236855"/>
                </a:lnTo>
                <a:lnTo>
                  <a:pt x="13335" y="235077"/>
                </a:lnTo>
                <a:lnTo>
                  <a:pt x="13335" y="230759"/>
                </a:lnTo>
                <a:lnTo>
                  <a:pt x="14478" y="228727"/>
                </a:lnTo>
                <a:lnTo>
                  <a:pt x="17018" y="227076"/>
                </a:lnTo>
                <a:lnTo>
                  <a:pt x="19431" y="225298"/>
                </a:lnTo>
                <a:lnTo>
                  <a:pt x="22987" y="224409"/>
                </a:lnTo>
                <a:lnTo>
                  <a:pt x="27559" y="224282"/>
                </a:lnTo>
                <a:lnTo>
                  <a:pt x="31623" y="224282"/>
                </a:lnTo>
                <a:lnTo>
                  <a:pt x="40132" y="234315"/>
                </a:lnTo>
                <a:lnTo>
                  <a:pt x="40132" y="211391"/>
                </a:lnTo>
                <a:lnTo>
                  <a:pt x="1790" y="226187"/>
                </a:lnTo>
                <a:lnTo>
                  <a:pt x="1778" y="237998"/>
                </a:lnTo>
                <a:lnTo>
                  <a:pt x="4064" y="242443"/>
                </a:lnTo>
                <a:lnTo>
                  <a:pt x="12954" y="249809"/>
                </a:lnTo>
                <a:lnTo>
                  <a:pt x="19050" y="251587"/>
                </a:lnTo>
                <a:lnTo>
                  <a:pt x="26670" y="251460"/>
                </a:lnTo>
                <a:lnTo>
                  <a:pt x="33909" y="251460"/>
                </a:lnTo>
                <a:lnTo>
                  <a:pt x="39624" y="249682"/>
                </a:lnTo>
                <a:lnTo>
                  <a:pt x="48260" y="242570"/>
                </a:lnTo>
                <a:lnTo>
                  <a:pt x="49466" y="240284"/>
                </a:lnTo>
                <a:lnTo>
                  <a:pt x="50419" y="238506"/>
                </a:lnTo>
                <a:lnTo>
                  <a:pt x="50419" y="231775"/>
                </a:lnTo>
                <a:lnTo>
                  <a:pt x="49911" y="229743"/>
                </a:lnTo>
                <a:lnTo>
                  <a:pt x="48768" y="227965"/>
                </a:lnTo>
                <a:lnTo>
                  <a:pt x="47752" y="226187"/>
                </a:lnTo>
                <a:lnTo>
                  <a:pt x="46228" y="224536"/>
                </a:lnTo>
                <a:lnTo>
                  <a:pt x="45847" y="224282"/>
                </a:lnTo>
                <a:lnTo>
                  <a:pt x="44196" y="223139"/>
                </a:lnTo>
                <a:lnTo>
                  <a:pt x="52451" y="223520"/>
                </a:lnTo>
                <a:lnTo>
                  <a:pt x="57912" y="224536"/>
                </a:lnTo>
                <a:lnTo>
                  <a:pt x="60706" y="226187"/>
                </a:lnTo>
                <a:lnTo>
                  <a:pt x="63373" y="227711"/>
                </a:lnTo>
                <a:lnTo>
                  <a:pt x="64681" y="229743"/>
                </a:lnTo>
                <a:lnTo>
                  <a:pt x="64770" y="236220"/>
                </a:lnTo>
                <a:lnTo>
                  <a:pt x="62103" y="238379"/>
                </a:lnTo>
                <a:lnTo>
                  <a:pt x="56642" y="239014"/>
                </a:lnTo>
                <a:lnTo>
                  <a:pt x="58293" y="250063"/>
                </a:lnTo>
                <a:lnTo>
                  <a:pt x="64516" y="249174"/>
                </a:lnTo>
                <a:lnTo>
                  <a:pt x="68961" y="247269"/>
                </a:lnTo>
                <a:lnTo>
                  <a:pt x="74930" y="241300"/>
                </a:lnTo>
                <a:lnTo>
                  <a:pt x="76225" y="237871"/>
                </a:lnTo>
                <a:lnTo>
                  <a:pt x="76250" y="226441"/>
                </a:lnTo>
                <a:close/>
              </a:path>
              <a:path w="96520" h="483869">
                <a:moveTo>
                  <a:pt x="76962" y="305435"/>
                </a:moveTo>
                <a:lnTo>
                  <a:pt x="76835" y="294005"/>
                </a:lnTo>
                <a:lnTo>
                  <a:pt x="75692" y="291592"/>
                </a:lnTo>
                <a:lnTo>
                  <a:pt x="74676" y="289433"/>
                </a:lnTo>
                <a:lnTo>
                  <a:pt x="65786" y="282067"/>
                </a:lnTo>
                <a:lnTo>
                  <a:pt x="65405" y="281965"/>
                </a:lnTo>
                <a:lnTo>
                  <a:pt x="65405" y="301244"/>
                </a:lnTo>
                <a:lnTo>
                  <a:pt x="64135" y="303149"/>
                </a:lnTo>
                <a:lnTo>
                  <a:pt x="61722" y="304927"/>
                </a:lnTo>
                <a:lnTo>
                  <a:pt x="59309" y="306578"/>
                </a:lnTo>
                <a:lnTo>
                  <a:pt x="55753" y="307467"/>
                </a:lnTo>
                <a:lnTo>
                  <a:pt x="51181" y="307594"/>
                </a:lnTo>
                <a:lnTo>
                  <a:pt x="46990" y="307594"/>
                </a:lnTo>
                <a:lnTo>
                  <a:pt x="43942" y="306832"/>
                </a:lnTo>
                <a:lnTo>
                  <a:pt x="41783" y="305308"/>
                </a:lnTo>
                <a:lnTo>
                  <a:pt x="39751" y="303784"/>
                </a:lnTo>
                <a:lnTo>
                  <a:pt x="38608" y="302006"/>
                </a:lnTo>
                <a:lnTo>
                  <a:pt x="38608" y="297561"/>
                </a:lnTo>
                <a:lnTo>
                  <a:pt x="52324" y="291592"/>
                </a:lnTo>
                <a:lnTo>
                  <a:pt x="56896" y="291592"/>
                </a:lnTo>
                <a:lnTo>
                  <a:pt x="60198" y="292227"/>
                </a:lnTo>
                <a:lnTo>
                  <a:pt x="64262" y="295021"/>
                </a:lnTo>
                <a:lnTo>
                  <a:pt x="65278" y="296799"/>
                </a:lnTo>
                <a:lnTo>
                  <a:pt x="65405" y="301244"/>
                </a:lnTo>
                <a:lnTo>
                  <a:pt x="65405" y="281965"/>
                </a:lnTo>
                <a:lnTo>
                  <a:pt x="59817" y="280289"/>
                </a:lnTo>
                <a:lnTo>
                  <a:pt x="52070" y="280416"/>
                </a:lnTo>
                <a:lnTo>
                  <a:pt x="44831" y="280416"/>
                </a:lnTo>
                <a:lnTo>
                  <a:pt x="38989" y="282321"/>
                </a:lnTo>
                <a:lnTo>
                  <a:pt x="34671" y="285750"/>
                </a:lnTo>
                <a:lnTo>
                  <a:pt x="30353" y="289306"/>
                </a:lnTo>
                <a:lnTo>
                  <a:pt x="28194" y="293497"/>
                </a:lnTo>
                <a:lnTo>
                  <a:pt x="28321" y="300228"/>
                </a:lnTo>
                <a:lnTo>
                  <a:pt x="28829" y="302260"/>
                </a:lnTo>
                <a:lnTo>
                  <a:pt x="29845" y="303911"/>
                </a:lnTo>
                <a:lnTo>
                  <a:pt x="30861" y="305689"/>
                </a:lnTo>
                <a:lnTo>
                  <a:pt x="32512" y="307340"/>
                </a:lnTo>
                <a:lnTo>
                  <a:pt x="34544" y="308737"/>
                </a:lnTo>
                <a:lnTo>
                  <a:pt x="26289" y="308356"/>
                </a:lnTo>
                <a:lnTo>
                  <a:pt x="20828" y="307340"/>
                </a:lnTo>
                <a:lnTo>
                  <a:pt x="18034" y="305689"/>
                </a:lnTo>
                <a:lnTo>
                  <a:pt x="15240" y="304165"/>
                </a:lnTo>
                <a:lnTo>
                  <a:pt x="13843" y="302006"/>
                </a:lnTo>
                <a:lnTo>
                  <a:pt x="13843" y="295783"/>
                </a:lnTo>
                <a:lnTo>
                  <a:pt x="16510" y="293497"/>
                </a:lnTo>
                <a:lnTo>
                  <a:pt x="21971" y="292989"/>
                </a:lnTo>
                <a:lnTo>
                  <a:pt x="20320" y="281813"/>
                </a:lnTo>
                <a:lnTo>
                  <a:pt x="2413" y="305435"/>
                </a:lnTo>
                <a:lnTo>
                  <a:pt x="5461" y="310642"/>
                </a:lnTo>
                <a:lnTo>
                  <a:pt x="40259" y="320548"/>
                </a:lnTo>
                <a:lnTo>
                  <a:pt x="49441" y="320103"/>
                </a:lnTo>
                <a:lnTo>
                  <a:pt x="75095" y="308737"/>
                </a:lnTo>
                <a:lnTo>
                  <a:pt x="75742" y="307594"/>
                </a:lnTo>
                <a:lnTo>
                  <a:pt x="76962" y="305435"/>
                </a:lnTo>
                <a:close/>
              </a:path>
              <a:path w="96520" h="483869">
                <a:moveTo>
                  <a:pt x="77470" y="483743"/>
                </a:moveTo>
                <a:lnTo>
                  <a:pt x="77343" y="470916"/>
                </a:lnTo>
                <a:lnTo>
                  <a:pt x="60706" y="466102"/>
                </a:lnTo>
                <a:lnTo>
                  <a:pt x="60667" y="462546"/>
                </a:lnTo>
                <a:lnTo>
                  <a:pt x="60490" y="446151"/>
                </a:lnTo>
                <a:lnTo>
                  <a:pt x="60452" y="442087"/>
                </a:lnTo>
                <a:lnTo>
                  <a:pt x="76962" y="436753"/>
                </a:lnTo>
                <a:lnTo>
                  <a:pt x="76835" y="423672"/>
                </a:lnTo>
                <a:lnTo>
                  <a:pt x="48260" y="433349"/>
                </a:lnTo>
                <a:lnTo>
                  <a:pt x="48260" y="462546"/>
                </a:lnTo>
                <a:lnTo>
                  <a:pt x="21082" y="454660"/>
                </a:lnTo>
                <a:lnTo>
                  <a:pt x="48133" y="446151"/>
                </a:lnTo>
                <a:lnTo>
                  <a:pt x="48260" y="462546"/>
                </a:lnTo>
                <a:lnTo>
                  <a:pt x="48260" y="433349"/>
                </a:lnTo>
                <a:lnTo>
                  <a:pt x="4064" y="448310"/>
                </a:lnTo>
                <a:lnTo>
                  <a:pt x="4191" y="461137"/>
                </a:lnTo>
                <a:lnTo>
                  <a:pt x="77470" y="483743"/>
                </a:lnTo>
                <a:close/>
              </a:path>
              <a:path w="96520" h="483869">
                <a:moveTo>
                  <a:pt x="77978" y="405511"/>
                </a:moveTo>
                <a:lnTo>
                  <a:pt x="58547" y="378587"/>
                </a:lnTo>
                <a:lnTo>
                  <a:pt x="56261" y="389890"/>
                </a:lnTo>
                <a:lnTo>
                  <a:pt x="60071" y="390398"/>
                </a:lnTo>
                <a:lnTo>
                  <a:pt x="62738" y="391414"/>
                </a:lnTo>
                <a:lnTo>
                  <a:pt x="64135" y="392811"/>
                </a:lnTo>
                <a:lnTo>
                  <a:pt x="65659" y="394208"/>
                </a:lnTo>
                <a:lnTo>
                  <a:pt x="66421" y="395986"/>
                </a:lnTo>
                <a:lnTo>
                  <a:pt x="66548" y="401066"/>
                </a:lnTo>
                <a:lnTo>
                  <a:pt x="65151" y="403352"/>
                </a:lnTo>
                <a:lnTo>
                  <a:pt x="60071" y="406908"/>
                </a:lnTo>
                <a:lnTo>
                  <a:pt x="55626" y="407797"/>
                </a:lnTo>
                <a:lnTo>
                  <a:pt x="49276" y="407797"/>
                </a:lnTo>
                <a:lnTo>
                  <a:pt x="43561" y="407924"/>
                </a:lnTo>
                <a:lnTo>
                  <a:pt x="33401" y="394081"/>
                </a:lnTo>
                <a:lnTo>
                  <a:pt x="36195" y="391414"/>
                </a:lnTo>
                <a:lnTo>
                  <a:pt x="41656" y="390525"/>
                </a:lnTo>
                <a:lnTo>
                  <a:pt x="39116" y="379222"/>
                </a:lnTo>
                <a:lnTo>
                  <a:pt x="33274" y="380746"/>
                </a:lnTo>
                <a:lnTo>
                  <a:pt x="29083" y="383032"/>
                </a:lnTo>
                <a:lnTo>
                  <a:pt x="26416" y="386334"/>
                </a:lnTo>
                <a:lnTo>
                  <a:pt x="23749" y="389509"/>
                </a:lnTo>
                <a:lnTo>
                  <a:pt x="22352" y="393700"/>
                </a:lnTo>
                <a:lnTo>
                  <a:pt x="22466" y="398526"/>
                </a:lnTo>
                <a:lnTo>
                  <a:pt x="22593" y="405384"/>
                </a:lnTo>
                <a:lnTo>
                  <a:pt x="24892" y="410210"/>
                </a:lnTo>
                <a:lnTo>
                  <a:pt x="34544" y="417830"/>
                </a:lnTo>
                <a:lnTo>
                  <a:pt x="41402" y="419735"/>
                </a:lnTo>
                <a:lnTo>
                  <a:pt x="58039" y="419481"/>
                </a:lnTo>
                <a:lnTo>
                  <a:pt x="64516" y="417703"/>
                </a:lnTo>
                <a:lnTo>
                  <a:pt x="69977" y="414274"/>
                </a:lnTo>
                <a:lnTo>
                  <a:pt x="75311" y="410845"/>
                </a:lnTo>
                <a:lnTo>
                  <a:pt x="76771" y="407924"/>
                </a:lnTo>
                <a:lnTo>
                  <a:pt x="77978" y="405511"/>
                </a:lnTo>
                <a:close/>
              </a:path>
              <a:path w="96520" h="483869">
                <a:moveTo>
                  <a:pt x="96520" y="369697"/>
                </a:moveTo>
                <a:lnTo>
                  <a:pt x="96393" y="358902"/>
                </a:lnTo>
                <a:lnTo>
                  <a:pt x="96393" y="358521"/>
                </a:lnTo>
                <a:lnTo>
                  <a:pt x="96393" y="358267"/>
                </a:lnTo>
                <a:lnTo>
                  <a:pt x="69723" y="358521"/>
                </a:lnTo>
                <a:lnTo>
                  <a:pt x="72644" y="356235"/>
                </a:lnTo>
                <a:lnTo>
                  <a:pt x="74676" y="354076"/>
                </a:lnTo>
                <a:lnTo>
                  <a:pt x="75882" y="352044"/>
                </a:lnTo>
                <a:lnTo>
                  <a:pt x="76835" y="350139"/>
                </a:lnTo>
                <a:lnTo>
                  <a:pt x="77343" y="347980"/>
                </a:lnTo>
                <a:lnTo>
                  <a:pt x="77266" y="340614"/>
                </a:lnTo>
                <a:lnTo>
                  <a:pt x="76606" y="339471"/>
                </a:lnTo>
                <a:lnTo>
                  <a:pt x="74930" y="336550"/>
                </a:lnTo>
                <a:lnTo>
                  <a:pt x="69977" y="332994"/>
                </a:lnTo>
                <a:lnTo>
                  <a:pt x="66294" y="330288"/>
                </a:lnTo>
                <a:lnTo>
                  <a:pt x="66294" y="346075"/>
                </a:lnTo>
                <a:lnTo>
                  <a:pt x="66217" y="351536"/>
                </a:lnTo>
                <a:lnTo>
                  <a:pt x="64897" y="353822"/>
                </a:lnTo>
                <a:lnTo>
                  <a:pt x="62103" y="355727"/>
                </a:lnTo>
                <a:lnTo>
                  <a:pt x="59309" y="357759"/>
                </a:lnTo>
                <a:lnTo>
                  <a:pt x="54864" y="358775"/>
                </a:lnTo>
                <a:lnTo>
                  <a:pt x="48895" y="358775"/>
                </a:lnTo>
                <a:lnTo>
                  <a:pt x="43561" y="358902"/>
                </a:lnTo>
                <a:lnTo>
                  <a:pt x="39624" y="358013"/>
                </a:lnTo>
                <a:lnTo>
                  <a:pt x="37084" y="356108"/>
                </a:lnTo>
                <a:lnTo>
                  <a:pt x="34417" y="354330"/>
                </a:lnTo>
                <a:lnTo>
                  <a:pt x="33096" y="352171"/>
                </a:lnTo>
                <a:lnTo>
                  <a:pt x="33020" y="346583"/>
                </a:lnTo>
                <a:lnTo>
                  <a:pt x="34290" y="344297"/>
                </a:lnTo>
                <a:lnTo>
                  <a:pt x="36957" y="342392"/>
                </a:lnTo>
                <a:lnTo>
                  <a:pt x="39624" y="340614"/>
                </a:lnTo>
                <a:lnTo>
                  <a:pt x="43815" y="339598"/>
                </a:lnTo>
                <a:lnTo>
                  <a:pt x="49403" y="339598"/>
                </a:lnTo>
                <a:lnTo>
                  <a:pt x="55372" y="339471"/>
                </a:lnTo>
                <a:lnTo>
                  <a:pt x="59690" y="340360"/>
                </a:lnTo>
                <a:lnTo>
                  <a:pt x="62357" y="342138"/>
                </a:lnTo>
                <a:lnTo>
                  <a:pt x="64897" y="343916"/>
                </a:lnTo>
                <a:lnTo>
                  <a:pt x="66294" y="346075"/>
                </a:lnTo>
                <a:lnTo>
                  <a:pt x="66294" y="330288"/>
                </a:lnTo>
                <a:lnTo>
                  <a:pt x="65151" y="329438"/>
                </a:lnTo>
                <a:lnTo>
                  <a:pt x="58166" y="327660"/>
                </a:lnTo>
                <a:lnTo>
                  <a:pt x="40259" y="327914"/>
                </a:lnTo>
                <a:lnTo>
                  <a:pt x="33655" y="329692"/>
                </a:lnTo>
                <a:lnTo>
                  <a:pt x="28956" y="333375"/>
                </a:lnTo>
                <a:lnTo>
                  <a:pt x="24257" y="336931"/>
                </a:lnTo>
                <a:lnTo>
                  <a:pt x="21844" y="341249"/>
                </a:lnTo>
                <a:lnTo>
                  <a:pt x="21971" y="348996"/>
                </a:lnTo>
                <a:lnTo>
                  <a:pt x="22860" y="351536"/>
                </a:lnTo>
                <a:lnTo>
                  <a:pt x="24460" y="354076"/>
                </a:lnTo>
                <a:lnTo>
                  <a:pt x="26035" y="356362"/>
                </a:lnTo>
                <a:lnTo>
                  <a:pt x="28321" y="358267"/>
                </a:lnTo>
                <a:lnTo>
                  <a:pt x="31115" y="359664"/>
                </a:lnTo>
                <a:lnTo>
                  <a:pt x="23368" y="359791"/>
                </a:lnTo>
                <a:lnTo>
                  <a:pt x="23368" y="370459"/>
                </a:lnTo>
                <a:lnTo>
                  <a:pt x="96520" y="36969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" name="object 31"/>
          <p:cNvSpPr txBox="1"/>
          <p:nvPr/>
        </p:nvSpPr>
        <p:spPr>
          <a:xfrm>
            <a:off x="9485703" y="2480990"/>
            <a:ext cx="265430" cy="509905"/>
          </a:xfrm>
          <a:prstGeom prst="rect">
            <a:avLst/>
          </a:prstGeom>
        </p:spPr>
        <p:txBody>
          <a:bodyPr vert="vert270" wrap="square" lIns="0" tIns="698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5"/>
              </a:spcBef>
            </a:pPr>
            <a:r>
              <a:rPr sz="800" b="1" dirty="0">
                <a:latin typeface="Arial Narrow"/>
                <a:cs typeface="Arial Narrow"/>
              </a:rPr>
              <a:t>Acp6.9-</a:t>
            </a:r>
            <a:r>
              <a:rPr sz="800" b="1" spc="-20" dirty="0">
                <a:latin typeface="Arial Narrow"/>
                <a:cs typeface="Arial Narrow"/>
              </a:rPr>
              <a:t>chiA</a:t>
            </a:r>
            <a:endParaRPr sz="800">
              <a:latin typeface="Arial Narrow"/>
              <a:cs typeface="Arial Narrow"/>
            </a:endParaRPr>
          </a:p>
          <a:p>
            <a:pPr marL="12700">
              <a:lnSpc>
                <a:spcPct val="100000"/>
              </a:lnSpc>
            </a:pPr>
            <a:r>
              <a:rPr sz="800" b="1" dirty="0">
                <a:latin typeface="Arial Narrow"/>
                <a:cs typeface="Arial Narrow"/>
              </a:rPr>
              <a:t>/</a:t>
            </a:r>
            <a:r>
              <a:rPr sz="800" b="1" spc="50" dirty="0">
                <a:latin typeface="Arial Narrow"/>
                <a:cs typeface="Arial Narrow"/>
              </a:rPr>
              <a:t> </a:t>
            </a:r>
            <a:r>
              <a:rPr sz="800" b="1" spc="-10" dirty="0">
                <a:latin typeface="Arial Narrow"/>
                <a:cs typeface="Arial Narrow"/>
              </a:rPr>
              <a:t>polh-</a:t>
            </a:r>
            <a:r>
              <a:rPr sz="800" b="1" spc="-20" dirty="0">
                <a:latin typeface="Arial Narrow"/>
                <a:cs typeface="Arial Narrow"/>
              </a:rPr>
              <a:t>cath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32" name="object 32"/>
          <p:cNvSpPr txBox="1"/>
          <p:nvPr/>
        </p:nvSpPr>
        <p:spPr>
          <a:xfrm>
            <a:off x="1152121" y="4793296"/>
            <a:ext cx="142875" cy="363220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spc="-10" dirty="0">
                <a:latin typeface="Arial Narrow"/>
                <a:cs typeface="Arial Narrow"/>
              </a:rPr>
              <a:t>AcEGFP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33" name="object 33"/>
          <p:cNvSpPr/>
          <p:nvPr/>
        </p:nvSpPr>
        <p:spPr>
          <a:xfrm>
            <a:off x="1771269" y="4653026"/>
            <a:ext cx="96520" cy="483870"/>
          </a:xfrm>
          <a:custGeom>
            <a:avLst/>
            <a:gdLst/>
            <a:ahLst/>
            <a:cxnLst/>
            <a:rect l="l" t="t" r="r" b="b"/>
            <a:pathLst>
              <a:path w="96519" h="483870">
                <a:moveTo>
                  <a:pt x="13462" y="77597"/>
                </a:moveTo>
                <a:lnTo>
                  <a:pt x="13335" y="66040"/>
                </a:lnTo>
                <a:lnTo>
                  <a:pt x="381" y="66167"/>
                </a:lnTo>
                <a:lnTo>
                  <a:pt x="508" y="77724"/>
                </a:lnTo>
                <a:lnTo>
                  <a:pt x="13462" y="77597"/>
                </a:lnTo>
                <a:close/>
              </a:path>
              <a:path w="96519" h="483870">
                <a:moveTo>
                  <a:pt x="55245" y="204089"/>
                </a:moveTo>
                <a:lnTo>
                  <a:pt x="54991" y="181483"/>
                </a:lnTo>
                <a:lnTo>
                  <a:pt x="41021" y="181610"/>
                </a:lnTo>
                <a:lnTo>
                  <a:pt x="41275" y="204216"/>
                </a:lnTo>
                <a:lnTo>
                  <a:pt x="55245" y="204089"/>
                </a:lnTo>
                <a:close/>
              </a:path>
              <a:path w="96519" h="483870">
                <a:moveTo>
                  <a:pt x="73406" y="60198"/>
                </a:moveTo>
                <a:lnTo>
                  <a:pt x="73279" y="47371"/>
                </a:lnTo>
                <a:lnTo>
                  <a:pt x="56642" y="42545"/>
                </a:lnTo>
                <a:lnTo>
                  <a:pt x="56603" y="38989"/>
                </a:lnTo>
                <a:lnTo>
                  <a:pt x="56426" y="22606"/>
                </a:lnTo>
                <a:lnTo>
                  <a:pt x="56388" y="18542"/>
                </a:lnTo>
                <a:lnTo>
                  <a:pt x="72898" y="13208"/>
                </a:lnTo>
                <a:lnTo>
                  <a:pt x="72771" y="0"/>
                </a:lnTo>
                <a:lnTo>
                  <a:pt x="44323" y="9690"/>
                </a:lnTo>
                <a:lnTo>
                  <a:pt x="44323" y="38989"/>
                </a:lnTo>
                <a:lnTo>
                  <a:pt x="17018" y="31115"/>
                </a:lnTo>
                <a:lnTo>
                  <a:pt x="44069" y="22606"/>
                </a:lnTo>
                <a:lnTo>
                  <a:pt x="44323" y="38989"/>
                </a:lnTo>
                <a:lnTo>
                  <a:pt x="44323" y="9690"/>
                </a:lnTo>
                <a:lnTo>
                  <a:pt x="0" y="24765"/>
                </a:lnTo>
                <a:lnTo>
                  <a:pt x="127" y="37592"/>
                </a:lnTo>
                <a:lnTo>
                  <a:pt x="73406" y="60198"/>
                </a:lnTo>
                <a:close/>
              </a:path>
              <a:path w="96519" h="483870">
                <a:moveTo>
                  <a:pt x="73533" y="77089"/>
                </a:moveTo>
                <a:lnTo>
                  <a:pt x="73406" y="65532"/>
                </a:lnTo>
                <a:lnTo>
                  <a:pt x="20447" y="66040"/>
                </a:lnTo>
                <a:lnTo>
                  <a:pt x="20574" y="77597"/>
                </a:lnTo>
                <a:lnTo>
                  <a:pt x="73533" y="77089"/>
                </a:lnTo>
                <a:close/>
              </a:path>
              <a:path w="96519" h="483870">
                <a:moveTo>
                  <a:pt x="74041" y="127381"/>
                </a:moveTo>
                <a:lnTo>
                  <a:pt x="73914" y="116205"/>
                </a:lnTo>
                <a:lnTo>
                  <a:pt x="73914" y="115824"/>
                </a:lnTo>
                <a:lnTo>
                  <a:pt x="47371" y="116078"/>
                </a:lnTo>
                <a:lnTo>
                  <a:pt x="40894" y="116205"/>
                </a:lnTo>
                <a:lnTo>
                  <a:pt x="36322" y="115443"/>
                </a:lnTo>
                <a:lnTo>
                  <a:pt x="34036" y="113792"/>
                </a:lnTo>
                <a:lnTo>
                  <a:pt x="31623" y="112141"/>
                </a:lnTo>
                <a:lnTo>
                  <a:pt x="30353" y="109855"/>
                </a:lnTo>
                <a:lnTo>
                  <a:pt x="30353" y="104140"/>
                </a:lnTo>
                <a:lnTo>
                  <a:pt x="31369" y="102108"/>
                </a:lnTo>
                <a:lnTo>
                  <a:pt x="33655" y="100965"/>
                </a:lnTo>
                <a:lnTo>
                  <a:pt x="35179" y="100076"/>
                </a:lnTo>
                <a:lnTo>
                  <a:pt x="39243" y="99695"/>
                </a:lnTo>
                <a:lnTo>
                  <a:pt x="45720" y="99568"/>
                </a:lnTo>
                <a:lnTo>
                  <a:pt x="73787" y="99314"/>
                </a:lnTo>
                <a:lnTo>
                  <a:pt x="73660" y="87884"/>
                </a:lnTo>
                <a:lnTo>
                  <a:pt x="42545" y="88138"/>
                </a:lnTo>
                <a:lnTo>
                  <a:pt x="36703" y="88138"/>
                </a:lnTo>
                <a:lnTo>
                  <a:pt x="32512" y="88646"/>
                </a:lnTo>
                <a:lnTo>
                  <a:pt x="19608" y="104140"/>
                </a:lnTo>
                <a:lnTo>
                  <a:pt x="19685" y="105664"/>
                </a:lnTo>
                <a:lnTo>
                  <a:pt x="27686" y="116332"/>
                </a:lnTo>
                <a:lnTo>
                  <a:pt x="889" y="116586"/>
                </a:lnTo>
                <a:lnTo>
                  <a:pt x="889" y="128016"/>
                </a:lnTo>
                <a:lnTo>
                  <a:pt x="74041" y="127381"/>
                </a:lnTo>
                <a:close/>
              </a:path>
              <a:path w="96519" h="483870">
                <a:moveTo>
                  <a:pt x="75311" y="259080"/>
                </a:moveTo>
                <a:lnTo>
                  <a:pt x="61214" y="259207"/>
                </a:lnTo>
                <a:lnTo>
                  <a:pt x="61341" y="270764"/>
                </a:lnTo>
                <a:lnTo>
                  <a:pt x="75311" y="270637"/>
                </a:lnTo>
                <a:lnTo>
                  <a:pt x="75311" y="259080"/>
                </a:lnTo>
                <a:close/>
              </a:path>
              <a:path w="96519" h="483870">
                <a:moveTo>
                  <a:pt x="75565" y="154686"/>
                </a:moveTo>
                <a:lnTo>
                  <a:pt x="74269" y="147231"/>
                </a:lnTo>
                <a:lnTo>
                  <a:pt x="70612" y="141439"/>
                </a:lnTo>
                <a:lnTo>
                  <a:pt x="64554" y="137274"/>
                </a:lnTo>
                <a:lnTo>
                  <a:pt x="56134" y="134747"/>
                </a:lnTo>
                <a:lnTo>
                  <a:pt x="53975" y="146177"/>
                </a:lnTo>
                <a:lnTo>
                  <a:pt x="57658" y="146685"/>
                </a:lnTo>
                <a:lnTo>
                  <a:pt x="60325" y="147701"/>
                </a:lnTo>
                <a:lnTo>
                  <a:pt x="61849" y="149098"/>
                </a:lnTo>
                <a:lnTo>
                  <a:pt x="63373" y="150368"/>
                </a:lnTo>
                <a:lnTo>
                  <a:pt x="64135" y="152146"/>
                </a:lnTo>
                <a:lnTo>
                  <a:pt x="64135" y="157226"/>
                </a:lnTo>
                <a:lnTo>
                  <a:pt x="62865" y="159639"/>
                </a:lnTo>
                <a:lnTo>
                  <a:pt x="60325" y="161417"/>
                </a:lnTo>
                <a:lnTo>
                  <a:pt x="57658" y="163068"/>
                </a:lnTo>
                <a:lnTo>
                  <a:pt x="53213" y="164084"/>
                </a:lnTo>
                <a:lnTo>
                  <a:pt x="41275" y="164084"/>
                </a:lnTo>
                <a:lnTo>
                  <a:pt x="37211" y="163322"/>
                </a:lnTo>
                <a:lnTo>
                  <a:pt x="34798" y="161544"/>
                </a:lnTo>
                <a:lnTo>
                  <a:pt x="32385" y="159893"/>
                </a:lnTo>
                <a:lnTo>
                  <a:pt x="31115" y="157607"/>
                </a:lnTo>
                <a:lnTo>
                  <a:pt x="31115" y="150368"/>
                </a:lnTo>
                <a:lnTo>
                  <a:pt x="33782" y="147701"/>
                </a:lnTo>
                <a:lnTo>
                  <a:pt x="39370" y="146812"/>
                </a:lnTo>
                <a:lnTo>
                  <a:pt x="36703" y="135509"/>
                </a:lnTo>
                <a:lnTo>
                  <a:pt x="20066" y="149987"/>
                </a:lnTo>
                <a:lnTo>
                  <a:pt x="20193" y="161290"/>
                </a:lnTo>
                <a:lnTo>
                  <a:pt x="22606" y="166370"/>
                </a:lnTo>
                <a:lnTo>
                  <a:pt x="27305" y="170180"/>
                </a:lnTo>
                <a:lnTo>
                  <a:pt x="32131" y="173990"/>
                </a:lnTo>
                <a:lnTo>
                  <a:pt x="39116" y="175895"/>
                </a:lnTo>
                <a:lnTo>
                  <a:pt x="48133" y="175895"/>
                </a:lnTo>
                <a:lnTo>
                  <a:pt x="74383" y="164084"/>
                </a:lnTo>
                <a:lnTo>
                  <a:pt x="75565" y="161798"/>
                </a:lnTo>
                <a:lnTo>
                  <a:pt x="75565" y="154686"/>
                </a:lnTo>
                <a:close/>
              </a:path>
              <a:path w="96519" h="483870">
                <a:moveTo>
                  <a:pt x="76327" y="237617"/>
                </a:moveTo>
                <a:lnTo>
                  <a:pt x="76200" y="226568"/>
                </a:lnTo>
                <a:lnTo>
                  <a:pt x="74345" y="223266"/>
                </a:lnTo>
                <a:lnTo>
                  <a:pt x="73279" y="221361"/>
                </a:lnTo>
                <a:lnTo>
                  <a:pt x="40132" y="211518"/>
                </a:lnTo>
                <a:lnTo>
                  <a:pt x="40132" y="234442"/>
                </a:lnTo>
                <a:lnTo>
                  <a:pt x="38989" y="236347"/>
                </a:lnTo>
                <a:lnTo>
                  <a:pt x="34671" y="239395"/>
                </a:lnTo>
                <a:lnTo>
                  <a:pt x="31242" y="240284"/>
                </a:lnTo>
                <a:lnTo>
                  <a:pt x="21844" y="240284"/>
                </a:lnTo>
                <a:lnTo>
                  <a:pt x="18415" y="239649"/>
                </a:lnTo>
                <a:lnTo>
                  <a:pt x="14351" y="236855"/>
                </a:lnTo>
                <a:lnTo>
                  <a:pt x="13335" y="235077"/>
                </a:lnTo>
                <a:lnTo>
                  <a:pt x="13335" y="230759"/>
                </a:lnTo>
                <a:lnTo>
                  <a:pt x="14478" y="228854"/>
                </a:lnTo>
                <a:lnTo>
                  <a:pt x="19304" y="225298"/>
                </a:lnTo>
                <a:lnTo>
                  <a:pt x="22860" y="224409"/>
                </a:lnTo>
                <a:lnTo>
                  <a:pt x="27432" y="224409"/>
                </a:lnTo>
                <a:lnTo>
                  <a:pt x="31623" y="224282"/>
                </a:lnTo>
                <a:lnTo>
                  <a:pt x="34798" y="225044"/>
                </a:lnTo>
                <a:lnTo>
                  <a:pt x="36830" y="226568"/>
                </a:lnTo>
                <a:lnTo>
                  <a:pt x="38989" y="228092"/>
                </a:lnTo>
                <a:lnTo>
                  <a:pt x="40005" y="229997"/>
                </a:lnTo>
                <a:lnTo>
                  <a:pt x="40132" y="234442"/>
                </a:lnTo>
                <a:lnTo>
                  <a:pt x="40132" y="211518"/>
                </a:lnTo>
                <a:lnTo>
                  <a:pt x="1651" y="226568"/>
                </a:lnTo>
                <a:lnTo>
                  <a:pt x="1651" y="233045"/>
                </a:lnTo>
                <a:lnTo>
                  <a:pt x="18923" y="251587"/>
                </a:lnTo>
                <a:lnTo>
                  <a:pt x="26670" y="251587"/>
                </a:lnTo>
                <a:lnTo>
                  <a:pt x="33909" y="251460"/>
                </a:lnTo>
                <a:lnTo>
                  <a:pt x="39624" y="249682"/>
                </a:lnTo>
                <a:lnTo>
                  <a:pt x="48260" y="242570"/>
                </a:lnTo>
                <a:lnTo>
                  <a:pt x="49466" y="240284"/>
                </a:lnTo>
                <a:lnTo>
                  <a:pt x="50419" y="238506"/>
                </a:lnTo>
                <a:lnTo>
                  <a:pt x="45542" y="224282"/>
                </a:lnTo>
                <a:lnTo>
                  <a:pt x="44069" y="223266"/>
                </a:lnTo>
                <a:lnTo>
                  <a:pt x="64770" y="236220"/>
                </a:lnTo>
                <a:lnTo>
                  <a:pt x="62103" y="238379"/>
                </a:lnTo>
                <a:lnTo>
                  <a:pt x="56642" y="239014"/>
                </a:lnTo>
                <a:lnTo>
                  <a:pt x="58166" y="250063"/>
                </a:lnTo>
                <a:lnTo>
                  <a:pt x="64389" y="249174"/>
                </a:lnTo>
                <a:lnTo>
                  <a:pt x="68961" y="247269"/>
                </a:lnTo>
                <a:lnTo>
                  <a:pt x="74803" y="241427"/>
                </a:lnTo>
                <a:lnTo>
                  <a:pt x="76327" y="237617"/>
                </a:lnTo>
                <a:close/>
              </a:path>
              <a:path w="96519" h="483870">
                <a:moveTo>
                  <a:pt x="76885" y="305562"/>
                </a:moveTo>
                <a:lnTo>
                  <a:pt x="76835" y="294005"/>
                </a:lnTo>
                <a:lnTo>
                  <a:pt x="75679" y="291719"/>
                </a:lnTo>
                <a:lnTo>
                  <a:pt x="74549" y="289433"/>
                </a:lnTo>
                <a:lnTo>
                  <a:pt x="65786" y="282194"/>
                </a:lnTo>
                <a:lnTo>
                  <a:pt x="65278" y="282054"/>
                </a:lnTo>
                <a:lnTo>
                  <a:pt x="65278" y="296926"/>
                </a:lnTo>
                <a:lnTo>
                  <a:pt x="65278" y="301244"/>
                </a:lnTo>
                <a:lnTo>
                  <a:pt x="64135" y="303276"/>
                </a:lnTo>
                <a:lnTo>
                  <a:pt x="61722" y="304927"/>
                </a:lnTo>
                <a:lnTo>
                  <a:pt x="59182" y="306705"/>
                </a:lnTo>
                <a:lnTo>
                  <a:pt x="55753" y="307594"/>
                </a:lnTo>
                <a:lnTo>
                  <a:pt x="51054" y="307594"/>
                </a:lnTo>
                <a:lnTo>
                  <a:pt x="46990" y="307721"/>
                </a:lnTo>
                <a:lnTo>
                  <a:pt x="43815" y="306959"/>
                </a:lnTo>
                <a:lnTo>
                  <a:pt x="41783" y="305435"/>
                </a:lnTo>
                <a:lnTo>
                  <a:pt x="39624" y="303911"/>
                </a:lnTo>
                <a:lnTo>
                  <a:pt x="38671" y="302133"/>
                </a:lnTo>
                <a:lnTo>
                  <a:pt x="38557" y="299085"/>
                </a:lnTo>
                <a:lnTo>
                  <a:pt x="38481" y="297561"/>
                </a:lnTo>
                <a:lnTo>
                  <a:pt x="39624" y="295656"/>
                </a:lnTo>
                <a:lnTo>
                  <a:pt x="43942" y="292608"/>
                </a:lnTo>
                <a:lnTo>
                  <a:pt x="47371" y="291719"/>
                </a:lnTo>
                <a:lnTo>
                  <a:pt x="56769" y="291719"/>
                </a:lnTo>
                <a:lnTo>
                  <a:pt x="60198" y="292354"/>
                </a:lnTo>
                <a:lnTo>
                  <a:pt x="64262" y="295148"/>
                </a:lnTo>
                <a:lnTo>
                  <a:pt x="65278" y="296926"/>
                </a:lnTo>
                <a:lnTo>
                  <a:pt x="65278" y="282054"/>
                </a:lnTo>
                <a:lnTo>
                  <a:pt x="59690" y="280416"/>
                </a:lnTo>
                <a:lnTo>
                  <a:pt x="51943" y="280416"/>
                </a:lnTo>
                <a:lnTo>
                  <a:pt x="44831" y="280543"/>
                </a:lnTo>
                <a:lnTo>
                  <a:pt x="38989" y="282321"/>
                </a:lnTo>
                <a:lnTo>
                  <a:pt x="30353" y="289433"/>
                </a:lnTo>
                <a:lnTo>
                  <a:pt x="28194" y="293497"/>
                </a:lnTo>
                <a:lnTo>
                  <a:pt x="28194" y="300355"/>
                </a:lnTo>
                <a:lnTo>
                  <a:pt x="28829" y="302260"/>
                </a:lnTo>
                <a:lnTo>
                  <a:pt x="30861" y="305816"/>
                </a:lnTo>
                <a:lnTo>
                  <a:pt x="32385" y="307340"/>
                </a:lnTo>
                <a:lnTo>
                  <a:pt x="34544" y="308737"/>
                </a:lnTo>
                <a:lnTo>
                  <a:pt x="26162" y="308483"/>
                </a:lnTo>
                <a:lnTo>
                  <a:pt x="13843" y="295783"/>
                </a:lnTo>
                <a:lnTo>
                  <a:pt x="16510" y="293624"/>
                </a:lnTo>
                <a:lnTo>
                  <a:pt x="21844" y="292989"/>
                </a:lnTo>
                <a:lnTo>
                  <a:pt x="20320" y="281940"/>
                </a:lnTo>
                <a:lnTo>
                  <a:pt x="2413" y="305562"/>
                </a:lnTo>
                <a:lnTo>
                  <a:pt x="5334" y="310769"/>
                </a:lnTo>
                <a:lnTo>
                  <a:pt x="40259" y="320675"/>
                </a:lnTo>
                <a:lnTo>
                  <a:pt x="49441" y="320230"/>
                </a:lnTo>
                <a:lnTo>
                  <a:pt x="75692" y="307721"/>
                </a:lnTo>
                <a:lnTo>
                  <a:pt x="76885" y="305562"/>
                </a:lnTo>
                <a:close/>
              </a:path>
              <a:path w="96519" h="483870">
                <a:moveTo>
                  <a:pt x="77343" y="483870"/>
                </a:moveTo>
                <a:lnTo>
                  <a:pt x="77216" y="471043"/>
                </a:lnTo>
                <a:lnTo>
                  <a:pt x="60706" y="466217"/>
                </a:lnTo>
                <a:lnTo>
                  <a:pt x="60667" y="462661"/>
                </a:lnTo>
                <a:lnTo>
                  <a:pt x="60490" y="446278"/>
                </a:lnTo>
                <a:lnTo>
                  <a:pt x="60452" y="442214"/>
                </a:lnTo>
                <a:lnTo>
                  <a:pt x="76962" y="436753"/>
                </a:lnTo>
                <a:lnTo>
                  <a:pt x="76835" y="423672"/>
                </a:lnTo>
                <a:lnTo>
                  <a:pt x="48260" y="433387"/>
                </a:lnTo>
                <a:lnTo>
                  <a:pt x="48260" y="462661"/>
                </a:lnTo>
                <a:lnTo>
                  <a:pt x="21082" y="454787"/>
                </a:lnTo>
                <a:lnTo>
                  <a:pt x="48133" y="446278"/>
                </a:lnTo>
                <a:lnTo>
                  <a:pt x="48260" y="462661"/>
                </a:lnTo>
                <a:lnTo>
                  <a:pt x="48260" y="433387"/>
                </a:lnTo>
                <a:lnTo>
                  <a:pt x="3937" y="448437"/>
                </a:lnTo>
                <a:lnTo>
                  <a:pt x="4064" y="461264"/>
                </a:lnTo>
                <a:lnTo>
                  <a:pt x="77343" y="483870"/>
                </a:lnTo>
                <a:close/>
              </a:path>
              <a:path w="96519" h="483870">
                <a:moveTo>
                  <a:pt x="77851" y="398526"/>
                </a:moveTo>
                <a:lnTo>
                  <a:pt x="76555" y="391071"/>
                </a:lnTo>
                <a:lnTo>
                  <a:pt x="72910" y="385279"/>
                </a:lnTo>
                <a:lnTo>
                  <a:pt x="66890" y="381114"/>
                </a:lnTo>
                <a:lnTo>
                  <a:pt x="58547" y="378587"/>
                </a:lnTo>
                <a:lnTo>
                  <a:pt x="56261" y="389890"/>
                </a:lnTo>
                <a:lnTo>
                  <a:pt x="60071" y="390525"/>
                </a:lnTo>
                <a:lnTo>
                  <a:pt x="62611" y="391541"/>
                </a:lnTo>
                <a:lnTo>
                  <a:pt x="64135" y="392811"/>
                </a:lnTo>
                <a:lnTo>
                  <a:pt x="65659" y="394208"/>
                </a:lnTo>
                <a:lnTo>
                  <a:pt x="66421" y="395986"/>
                </a:lnTo>
                <a:lnTo>
                  <a:pt x="66421" y="401066"/>
                </a:lnTo>
                <a:lnTo>
                  <a:pt x="65151" y="403479"/>
                </a:lnTo>
                <a:lnTo>
                  <a:pt x="62611" y="405130"/>
                </a:lnTo>
                <a:lnTo>
                  <a:pt x="59944" y="406908"/>
                </a:lnTo>
                <a:lnTo>
                  <a:pt x="55499" y="407797"/>
                </a:lnTo>
                <a:lnTo>
                  <a:pt x="49276" y="407924"/>
                </a:lnTo>
                <a:lnTo>
                  <a:pt x="43561" y="407924"/>
                </a:lnTo>
                <a:lnTo>
                  <a:pt x="39497" y="407162"/>
                </a:lnTo>
                <a:lnTo>
                  <a:pt x="37084" y="405384"/>
                </a:lnTo>
                <a:lnTo>
                  <a:pt x="34671" y="403733"/>
                </a:lnTo>
                <a:lnTo>
                  <a:pt x="33401" y="401447"/>
                </a:lnTo>
                <a:lnTo>
                  <a:pt x="33401" y="394208"/>
                </a:lnTo>
                <a:lnTo>
                  <a:pt x="36068" y="391541"/>
                </a:lnTo>
                <a:lnTo>
                  <a:pt x="41656" y="390652"/>
                </a:lnTo>
                <a:lnTo>
                  <a:pt x="38989" y="379349"/>
                </a:lnTo>
                <a:lnTo>
                  <a:pt x="22352" y="393827"/>
                </a:lnTo>
                <a:lnTo>
                  <a:pt x="22390" y="401066"/>
                </a:lnTo>
                <a:lnTo>
                  <a:pt x="41402" y="419735"/>
                </a:lnTo>
                <a:lnTo>
                  <a:pt x="50419" y="419608"/>
                </a:lnTo>
                <a:lnTo>
                  <a:pt x="58039" y="419608"/>
                </a:lnTo>
                <a:lnTo>
                  <a:pt x="64516" y="417830"/>
                </a:lnTo>
                <a:lnTo>
                  <a:pt x="69850" y="414401"/>
                </a:lnTo>
                <a:lnTo>
                  <a:pt x="75184" y="410845"/>
                </a:lnTo>
                <a:lnTo>
                  <a:pt x="76669" y="407924"/>
                </a:lnTo>
                <a:lnTo>
                  <a:pt x="77851" y="405638"/>
                </a:lnTo>
                <a:lnTo>
                  <a:pt x="77851" y="398526"/>
                </a:lnTo>
                <a:close/>
              </a:path>
              <a:path w="96519" h="483870">
                <a:moveTo>
                  <a:pt x="96393" y="358267"/>
                </a:moveTo>
                <a:lnTo>
                  <a:pt x="69723" y="358521"/>
                </a:lnTo>
                <a:lnTo>
                  <a:pt x="72644" y="356362"/>
                </a:lnTo>
                <a:lnTo>
                  <a:pt x="74676" y="354203"/>
                </a:lnTo>
                <a:lnTo>
                  <a:pt x="75768" y="352044"/>
                </a:lnTo>
                <a:lnTo>
                  <a:pt x="76835" y="350266"/>
                </a:lnTo>
                <a:lnTo>
                  <a:pt x="77343" y="348107"/>
                </a:lnTo>
                <a:lnTo>
                  <a:pt x="77216" y="340868"/>
                </a:lnTo>
                <a:lnTo>
                  <a:pt x="76504" y="339598"/>
                </a:lnTo>
                <a:lnTo>
                  <a:pt x="74803" y="336550"/>
                </a:lnTo>
                <a:lnTo>
                  <a:pt x="69977" y="332994"/>
                </a:lnTo>
                <a:lnTo>
                  <a:pt x="66205" y="330390"/>
                </a:lnTo>
                <a:lnTo>
                  <a:pt x="66205" y="351663"/>
                </a:lnTo>
                <a:lnTo>
                  <a:pt x="64897" y="353822"/>
                </a:lnTo>
                <a:lnTo>
                  <a:pt x="62103" y="355854"/>
                </a:lnTo>
                <a:lnTo>
                  <a:pt x="59182" y="357759"/>
                </a:lnTo>
                <a:lnTo>
                  <a:pt x="54864" y="358775"/>
                </a:lnTo>
                <a:lnTo>
                  <a:pt x="48768" y="358902"/>
                </a:lnTo>
                <a:lnTo>
                  <a:pt x="43561" y="358902"/>
                </a:lnTo>
                <a:lnTo>
                  <a:pt x="33020" y="346583"/>
                </a:lnTo>
                <a:lnTo>
                  <a:pt x="34290" y="344424"/>
                </a:lnTo>
                <a:lnTo>
                  <a:pt x="39624" y="340614"/>
                </a:lnTo>
                <a:lnTo>
                  <a:pt x="43815" y="339725"/>
                </a:lnTo>
                <a:lnTo>
                  <a:pt x="49403" y="339598"/>
                </a:lnTo>
                <a:lnTo>
                  <a:pt x="55372" y="339598"/>
                </a:lnTo>
                <a:lnTo>
                  <a:pt x="59563" y="340360"/>
                </a:lnTo>
                <a:lnTo>
                  <a:pt x="64897" y="343916"/>
                </a:lnTo>
                <a:lnTo>
                  <a:pt x="66167" y="346202"/>
                </a:lnTo>
                <a:lnTo>
                  <a:pt x="66205" y="351663"/>
                </a:lnTo>
                <a:lnTo>
                  <a:pt x="66205" y="330390"/>
                </a:lnTo>
                <a:lnTo>
                  <a:pt x="65024" y="329565"/>
                </a:lnTo>
                <a:lnTo>
                  <a:pt x="58039" y="327787"/>
                </a:lnTo>
                <a:lnTo>
                  <a:pt x="48895" y="327914"/>
                </a:lnTo>
                <a:lnTo>
                  <a:pt x="40259" y="327914"/>
                </a:lnTo>
                <a:lnTo>
                  <a:pt x="33528" y="329819"/>
                </a:lnTo>
                <a:lnTo>
                  <a:pt x="28829" y="333375"/>
                </a:lnTo>
                <a:lnTo>
                  <a:pt x="24130" y="337058"/>
                </a:lnTo>
                <a:lnTo>
                  <a:pt x="21844" y="341376"/>
                </a:lnTo>
                <a:lnTo>
                  <a:pt x="21971" y="348996"/>
                </a:lnTo>
                <a:lnTo>
                  <a:pt x="22733" y="351663"/>
                </a:lnTo>
                <a:lnTo>
                  <a:pt x="24638" y="354330"/>
                </a:lnTo>
                <a:lnTo>
                  <a:pt x="26035" y="356362"/>
                </a:lnTo>
                <a:lnTo>
                  <a:pt x="28194" y="358267"/>
                </a:lnTo>
                <a:lnTo>
                  <a:pt x="30988" y="359791"/>
                </a:lnTo>
                <a:lnTo>
                  <a:pt x="23241" y="359791"/>
                </a:lnTo>
                <a:lnTo>
                  <a:pt x="23368" y="370459"/>
                </a:lnTo>
                <a:lnTo>
                  <a:pt x="96393" y="369824"/>
                </a:lnTo>
                <a:lnTo>
                  <a:pt x="96393" y="358902"/>
                </a:lnTo>
                <a:lnTo>
                  <a:pt x="96393" y="358521"/>
                </a:lnTo>
                <a:lnTo>
                  <a:pt x="96393" y="3582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" name="object 34"/>
          <p:cNvSpPr txBox="1"/>
          <p:nvPr/>
        </p:nvSpPr>
        <p:spPr>
          <a:xfrm>
            <a:off x="2017753" y="4641791"/>
            <a:ext cx="264795" cy="50990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spc="-10" dirty="0">
                <a:latin typeface="Arial Narrow"/>
                <a:cs typeface="Arial Narrow"/>
              </a:rPr>
              <a:t>Acp6.9-</a:t>
            </a:r>
            <a:r>
              <a:rPr sz="800" b="1" spc="-20" dirty="0">
                <a:latin typeface="Arial Narrow"/>
                <a:cs typeface="Arial Narrow"/>
              </a:rPr>
              <a:t>chiA</a:t>
            </a:r>
            <a:endParaRPr sz="800">
              <a:latin typeface="Arial Narrow"/>
              <a:cs typeface="Arial Narrow"/>
            </a:endParaRPr>
          </a:p>
          <a:p>
            <a:pPr marL="12700">
              <a:lnSpc>
                <a:spcPct val="100000"/>
              </a:lnSpc>
            </a:pPr>
            <a:r>
              <a:rPr sz="800" b="1" dirty="0">
                <a:latin typeface="Arial Narrow"/>
                <a:cs typeface="Arial Narrow"/>
              </a:rPr>
              <a:t>/</a:t>
            </a:r>
            <a:r>
              <a:rPr sz="800" b="1" spc="50" dirty="0">
                <a:latin typeface="Arial Narrow"/>
                <a:cs typeface="Arial Narrow"/>
              </a:rPr>
              <a:t> </a:t>
            </a:r>
            <a:r>
              <a:rPr sz="800" b="1" spc="-10" dirty="0">
                <a:latin typeface="Arial Narrow"/>
                <a:cs typeface="Arial Narrow"/>
              </a:rPr>
              <a:t>polh-</a:t>
            </a:r>
            <a:r>
              <a:rPr sz="800" b="1" spc="-20" dirty="0">
                <a:latin typeface="Arial Narrow"/>
                <a:cs typeface="Arial Narrow"/>
              </a:rPr>
              <a:t>cath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35" name="object 35"/>
          <p:cNvSpPr txBox="1"/>
          <p:nvPr/>
        </p:nvSpPr>
        <p:spPr>
          <a:xfrm>
            <a:off x="4881095" y="4886260"/>
            <a:ext cx="142875" cy="363220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spc="-10" dirty="0">
                <a:latin typeface="Arial Narrow"/>
                <a:cs typeface="Arial Narrow"/>
              </a:rPr>
              <a:t>AcEGFP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36" name="object 36"/>
          <p:cNvSpPr/>
          <p:nvPr/>
        </p:nvSpPr>
        <p:spPr>
          <a:xfrm>
            <a:off x="5499735" y="4745863"/>
            <a:ext cx="96520" cy="483870"/>
          </a:xfrm>
          <a:custGeom>
            <a:avLst/>
            <a:gdLst/>
            <a:ahLst/>
            <a:cxnLst/>
            <a:rect l="l" t="t" r="r" b="b"/>
            <a:pathLst>
              <a:path w="96520" h="483870">
                <a:moveTo>
                  <a:pt x="13462" y="77597"/>
                </a:moveTo>
                <a:lnTo>
                  <a:pt x="13335" y="66167"/>
                </a:lnTo>
                <a:lnTo>
                  <a:pt x="381" y="66167"/>
                </a:lnTo>
                <a:lnTo>
                  <a:pt x="508" y="77724"/>
                </a:lnTo>
                <a:lnTo>
                  <a:pt x="13462" y="77597"/>
                </a:lnTo>
                <a:close/>
              </a:path>
              <a:path w="96520" h="483870">
                <a:moveTo>
                  <a:pt x="55245" y="204089"/>
                </a:moveTo>
                <a:lnTo>
                  <a:pt x="55118" y="181483"/>
                </a:lnTo>
                <a:lnTo>
                  <a:pt x="41021" y="181610"/>
                </a:lnTo>
                <a:lnTo>
                  <a:pt x="41275" y="204216"/>
                </a:lnTo>
                <a:lnTo>
                  <a:pt x="55245" y="204089"/>
                </a:lnTo>
                <a:close/>
              </a:path>
              <a:path w="96520" h="483870">
                <a:moveTo>
                  <a:pt x="73406" y="60198"/>
                </a:moveTo>
                <a:lnTo>
                  <a:pt x="73279" y="47371"/>
                </a:lnTo>
                <a:lnTo>
                  <a:pt x="56769" y="42545"/>
                </a:lnTo>
                <a:lnTo>
                  <a:pt x="56730" y="38989"/>
                </a:lnTo>
                <a:lnTo>
                  <a:pt x="56553" y="22606"/>
                </a:lnTo>
                <a:lnTo>
                  <a:pt x="56515" y="18542"/>
                </a:lnTo>
                <a:lnTo>
                  <a:pt x="73025" y="13208"/>
                </a:lnTo>
                <a:lnTo>
                  <a:pt x="72898" y="0"/>
                </a:lnTo>
                <a:lnTo>
                  <a:pt x="44323" y="9715"/>
                </a:lnTo>
                <a:lnTo>
                  <a:pt x="44323" y="38989"/>
                </a:lnTo>
                <a:lnTo>
                  <a:pt x="17145" y="31115"/>
                </a:lnTo>
                <a:lnTo>
                  <a:pt x="44196" y="22606"/>
                </a:lnTo>
                <a:lnTo>
                  <a:pt x="44323" y="38989"/>
                </a:lnTo>
                <a:lnTo>
                  <a:pt x="44323" y="9715"/>
                </a:lnTo>
                <a:lnTo>
                  <a:pt x="0" y="24765"/>
                </a:lnTo>
                <a:lnTo>
                  <a:pt x="127" y="37592"/>
                </a:lnTo>
                <a:lnTo>
                  <a:pt x="73406" y="60198"/>
                </a:lnTo>
                <a:close/>
              </a:path>
              <a:path w="96520" h="483870">
                <a:moveTo>
                  <a:pt x="73660" y="77089"/>
                </a:moveTo>
                <a:lnTo>
                  <a:pt x="73533" y="65532"/>
                </a:lnTo>
                <a:lnTo>
                  <a:pt x="20574" y="66040"/>
                </a:lnTo>
                <a:lnTo>
                  <a:pt x="20701" y="77597"/>
                </a:lnTo>
                <a:lnTo>
                  <a:pt x="73660" y="77089"/>
                </a:lnTo>
                <a:close/>
              </a:path>
              <a:path w="96520" h="483870">
                <a:moveTo>
                  <a:pt x="74041" y="127381"/>
                </a:moveTo>
                <a:lnTo>
                  <a:pt x="73914" y="116205"/>
                </a:lnTo>
                <a:lnTo>
                  <a:pt x="73914" y="115824"/>
                </a:lnTo>
                <a:lnTo>
                  <a:pt x="47371" y="116078"/>
                </a:lnTo>
                <a:lnTo>
                  <a:pt x="30353" y="104140"/>
                </a:lnTo>
                <a:lnTo>
                  <a:pt x="31496" y="102235"/>
                </a:lnTo>
                <a:lnTo>
                  <a:pt x="33655" y="100965"/>
                </a:lnTo>
                <a:lnTo>
                  <a:pt x="35306" y="100203"/>
                </a:lnTo>
                <a:lnTo>
                  <a:pt x="39370" y="99695"/>
                </a:lnTo>
                <a:lnTo>
                  <a:pt x="45847" y="99695"/>
                </a:lnTo>
                <a:lnTo>
                  <a:pt x="73787" y="99441"/>
                </a:lnTo>
                <a:lnTo>
                  <a:pt x="73660" y="87884"/>
                </a:lnTo>
                <a:lnTo>
                  <a:pt x="42672" y="88138"/>
                </a:lnTo>
                <a:lnTo>
                  <a:pt x="36703" y="88265"/>
                </a:lnTo>
                <a:lnTo>
                  <a:pt x="32512" y="88646"/>
                </a:lnTo>
                <a:lnTo>
                  <a:pt x="30099" y="89408"/>
                </a:lnTo>
                <a:lnTo>
                  <a:pt x="26670" y="90424"/>
                </a:lnTo>
                <a:lnTo>
                  <a:pt x="24130" y="92075"/>
                </a:lnTo>
                <a:lnTo>
                  <a:pt x="22352" y="94488"/>
                </a:lnTo>
                <a:lnTo>
                  <a:pt x="20447" y="96774"/>
                </a:lnTo>
                <a:lnTo>
                  <a:pt x="19634" y="99441"/>
                </a:lnTo>
                <a:lnTo>
                  <a:pt x="19570" y="100203"/>
                </a:lnTo>
                <a:lnTo>
                  <a:pt x="19685" y="105664"/>
                </a:lnTo>
                <a:lnTo>
                  <a:pt x="20320" y="108077"/>
                </a:lnTo>
                <a:lnTo>
                  <a:pt x="21717" y="110363"/>
                </a:lnTo>
                <a:lnTo>
                  <a:pt x="22987" y="112522"/>
                </a:lnTo>
                <a:lnTo>
                  <a:pt x="25019" y="114554"/>
                </a:lnTo>
                <a:lnTo>
                  <a:pt x="27686" y="116332"/>
                </a:lnTo>
                <a:lnTo>
                  <a:pt x="889" y="116586"/>
                </a:lnTo>
                <a:lnTo>
                  <a:pt x="1016" y="128143"/>
                </a:lnTo>
                <a:lnTo>
                  <a:pt x="74041" y="127381"/>
                </a:lnTo>
                <a:close/>
              </a:path>
              <a:path w="96520" h="483870">
                <a:moveTo>
                  <a:pt x="75438" y="270637"/>
                </a:moveTo>
                <a:lnTo>
                  <a:pt x="75311" y="259080"/>
                </a:lnTo>
                <a:lnTo>
                  <a:pt x="61341" y="259207"/>
                </a:lnTo>
                <a:lnTo>
                  <a:pt x="61468" y="270764"/>
                </a:lnTo>
                <a:lnTo>
                  <a:pt x="75438" y="270637"/>
                </a:lnTo>
                <a:close/>
              </a:path>
              <a:path w="96520" h="483870">
                <a:moveTo>
                  <a:pt x="75692" y="161798"/>
                </a:moveTo>
                <a:lnTo>
                  <a:pt x="56261" y="134747"/>
                </a:lnTo>
                <a:lnTo>
                  <a:pt x="53975" y="146177"/>
                </a:lnTo>
                <a:lnTo>
                  <a:pt x="57785" y="146685"/>
                </a:lnTo>
                <a:lnTo>
                  <a:pt x="60452" y="147701"/>
                </a:lnTo>
                <a:lnTo>
                  <a:pt x="61849" y="149098"/>
                </a:lnTo>
                <a:lnTo>
                  <a:pt x="63373" y="150495"/>
                </a:lnTo>
                <a:lnTo>
                  <a:pt x="64135" y="152273"/>
                </a:lnTo>
                <a:lnTo>
                  <a:pt x="64135" y="157353"/>
                </a:lnTo>
                <a:lnTo>
                  <a:pt x="62865" y="159639"/>
                </a:lnTo>
                <a:lnTo>
                  <a:pt x="57785" y="163195"/>
                </a:lnTo>
                <a:lnTo>
                  <a:pt x="53340" y="164084"/>
                </a:lnTo>
                <a:lnTo>
                  <a:pt x="46990" y="164084"/>
                </a:lnTo>
                <a:lnTo>
                  <a:pt x="41275" y="164211"/>
                </a:lnTo>
                <a:lnTo>
                  <a:pt x="37211" y="163322"/>
                </a:lnTo>
                <a:lnTo>
                  <a:pt x="34798" y="161671"/>
                </a:lnTo>
                <a:lnTo>
                  <a:pt x="32385" y="159893"/>
                </a:lnTo>
                <a:lnTo>
                  <a:pt x="31115" y="157607"/>
                </a:lnTo>
                <a:lnTo>
                  <a:pt x="31115" y="150368"/>
                </a:lnTo>
                <a:lnTo>
                  <a:pt x="33909" y="147701"/>
                </a:lnTo>
                <a:lnTo>
                  <a:pt x="39370" y="146812"/>
                </a:lnTo>
                <a:lnTo>
                  <a:pt x="36830" y="135509"/>
                </a:lnTo>
                <a:lnTo>
                  <a:pt x="30988" y="137033"/>
                </a:lnTo>
                <a:lnTo>
                  <a:pt x="26670" y="139319"/>
                </a:lnTo>
                <a:lnTo>
                  <a:pt x="24003" y="142621"/>
                </a:lnTo>
                <a:lnTo>
                  <a:pt x="21336" y="145796"/>
                </a:lnTo>
                <a:lnTo>
                  <a:pt x="20066" y="149987"/>
                </a:lnTo>
                <a:lnTo>
                  <a:pt x="20193" y="161290"/>
                </a:lnTo>
                <a:lnTo>
                  <a:pt x="22606" y="166370"/>
                </a:lnTo>
                <a:lnTo>
                  <a:pt x="27432" y="170180"/>
                </a:lnTo>
                <a:lnTo>
                  <a:pt x="32131" y="174117"/>
                </a:lnTo>
                <a:lnTo>
                  <a:pt x="39116" y="175895"/>
                </a:lnTo>
                <a:lnTo>
                  <a:pt x="48260" y="175895"/>
                </a:lnTo>
                <a:lnTo>
                  <a:pt x="74447" y="164211"/>
                </a:lnTo>
                <a:lnTo>
                  <a:pt x="75692" y="161798"/>
                </a:lnTo>
                <a:close/>
              </a:path>
              <a:path w="96520" h="483870">
                <a:moveTo>
                  <a:pt x="76225" y="237871"/>
                </a:moveTo>
                <a:lnTo>
                  <a:pt x="76200" y="226568"/>
                </a:lnTo>
                <a:lnTo>
                  <a:pt x="74345" y="223266"/>
                </a:lnTo>
                <a:lnTo>
                  <a:pt x="73279" y="221361"/>
                </a:lnTo>
                <a:lnTo>
                  <a:pt x="40132" y="211518"/>
                </a:lnTo>
                <a:lnTo>
                  <a:pt x="40132" y="234442"/>
                </a:lnTo>
                <a:lnTo>
                  <a:pt x="38989" y="236347"/>
                </a:lnTo>
                <a:lnTo>
                  <a:pt x="36830" y="237871"/>
                </a:lnTo>
                <a:lnTo>
                  <a:pt x="34671" y="239522"/>
                </a:lnTo>
                <a:lnTo>
                  <a:pt x="31242" y="240284"/>
                </a:lnTo>
                <a:lnTo>
                  <a:pt x="26543" y="240284"/>
                </a:lnTo>
                <a:lnTo>
                  <a:pt x="21844" y="240411"/>
                </a:lnTo>
                <a:lnTo>
                  <a:pt x="18415" y="239649"/>
                </a:lnTo>
                <a:lnTo>
                  <a:pt x="14351" y="236855"/>
                </a:lnTo>
                <a:lnTo>
                  <a:pt x="13335" y="235204"/>
                </a:lnTo>
                <a:lnTo>
                  <a:pt x="13335" y="230759"/>
                </a:lnTo>
                <a:lnTo>
                  <a:pt x="14478" y="228854"/>
                </a:lnTo>
                <a:lnTo>
                  <a:pt x="17018" y="227076"/>
                </a:lnTo>
                <a:lnTo>
                  <a:pt x="19431" y="225298"/>
                </a:lnTo>
                <a:lnTo>
                  <a:pt x="22860" y="224409"/>
                </a:lnTo>
                <a:lnTo>
                  <a:pt x="31623" y="224409"/>
                </a:lnTo>
                <a:lnTo>
                  <a:pt x="40132" y="234442"/>
                </a:lnTo>
                <a:lnTo>
                  <a:pt x="40132" y="211518"/>
                </a:lnTo>
                <a:lnTo>
                  <a:pt x="1854" y="226187"/>
                </a:lnTo>
                <a:lnTo>
                  <a:pt x="1778" y="237998"/>
                </a:lnTo>
                <a:lnTo>
                  <a:pt x="4064" y="242570"/>
                </a:lnTo>
                <a:lnTo>
                  <a:pt x="8509" y="246253"/>
                </a:lnTo>
                <a:lnTo>
                  <a:pt x="12954" y="249809"/>
                </a:lnTo>
                <a:lnTo>
                  <a:pt x="19050" y="251714"/>
                </a:lnTo>
                <a:lnTo>
                  <a:pt x="33909" y="251460"/>
                </a:lnTo>
                <a:lnTo>
                  <a:pt x="39624" y="249682"/>
                </a:lnTo>
                <a:lnTo>
                  <a:pt x="48260" y="242570"/>
                </a:lnTo>
                <a:lnTo>
                  <a:pt x="49403" y="240411"/>
                </a:lnTo>
                <a:lnTo>
                  <a:pt x="50419" y="238506"/>
                </a:lnTo>
                <a:lnTo>
                  <a:pt x="50419" y="231775"/>
                </a:lnTo>
                <a:lnTo>
                  <a:pt x="49784" y="229870"/>
                </a:lnTo>
                <a:lnTo>
                  <a:pt x="47752" y="226314"/>
                </a:lnTo>
                <a:lnTo>
                  <a:pt x="46228" y="224663"/>
                </a:lnTo>
                <a:lnTo>
                  <a:pt x="45847" y="224409"/>
                </a:lnTo>
                <a:lnTo>
                  <a:pt x="44196" y="223266"/>
                </a:lnTo>
                <a:lnTo>
                  <a:pt x="64770" y="229870"/>
                </a:lnTo>
                <a:lnTo>
                  <a:pt x="64770" y="236220"/>
                </a:lnTo>
                <a:lnTo>
                  <a:pt x="62103" y="238506"/>
                </a:lnTo>
                <a:lnTo>
                  <a:pt x="56642" y="239014"/>
                </a:lnTo>
                <a:lnTo>
                  <a:pt x="58293" y="250190"/>
                </a:lnTo>
                <a:lnTo>
                  <a:pt x="64389" y="249301"/>
                </a:lnTo>
                <a:lnTo>
                  <a:pt x="68961" y="247269"/>
                </a:lnTo>
                <a:lnTo>
                  <a:pt x="72009" y="244348"/>
                </a:lnTo>
                <a:lnTo>
                  <a:pt x="74930" y="241427"/>
                </a:lnTo>
                <a:lnTo>
                  <a:pt x="76225" y="237871"/>
                </a:lnTo>
                <a:close/>
              </a:path>
              <a:path w="96520" h="483870">
                <a:moveTo>
                  <a:pt x="76885" y="305562"/>
                </a:moveTo>
                <a:lnTo>
                  <a:pt x="76835" y="294005"/>
                </a:lnTo>
                <a:lnTo>
                  <a:pt x="75755" y="291719"/>
                </a:lnTo>
                <a:lnTo>
                  <a:pt x="74676" y="289433"/>
                </a:lnTo>
                <a:lnTo>
                  <a:pt x="70231" y="285877"/>
                </a:lnTo>
                <a:lnTo>
                  <a:pt x="65786" y="282194"/>
                </a:lnTo>
                <a:lnTo>
                  <a:pt x="65278" y="282054"/>
                </a:lnTo>
                <a:lnTo>
                  <a:pt x="65278" y="296926"/>
                </a:lnTo>
                <a:lnTo>
                  <a:pt x="65278" y="301244"/>
                </a:lnTo>
                <a:lnTo>
                  <a:pt x="64135" y="303276"/>
                </a:lnTo>
                <a:lnTo>
                  <a:pt x="61722" y="304927"/>
                </a:lnTo>
                <a:lnTo>
                  <a:pt x="59309" y="306705"/>
                </a:lnTo>
                <a:lnTo>
                  <a:pt x="55753" y="307594"/>
                </a:lnTo>
                <a:lnTo>
                  <a:pt x="51181" y="307594"/>
                </a:lnTo>
                <a:lnTo>
                  <a:pt x="46990" y="307721"/>
                </a:lnTo>
                <a:lnTo>
                  <a:pt x="43942" y="306959"/>
                </a:lnTo>
                <a:lnTo>
                  <a:pt x="39624" y="303911"/>
                </a:lnTo>
                <a:lnTo>
                  <a:pt x="38671" y="302133"/>
                </a:lnTo>
                <a:lnTo>
                  <a:pt x="38608" y="297561"/>
                </a:lnTo>
                <a:lnTo>
                  <a:pt x="39624" y="295656"/>
                </a:lnTo>
                <a:lnTo>
                  <a:pt x="43942" y="292608"/>
                </a:lnTo>
                <a:lnTo>
                  <a:pt x="47498" y="291719"/>
                </a:lnTo>
                <a:lnTo>
                  <a:pt x="56896" y="291719"/>
                </a:lnTo>
                <a:lnTo>
                  <a:pt x="60198" y="292354"/>
                </a:lnTo>
                <a:lnTo>
                  <a:pt x="64262" y="295148"/>
                </a:lnTo>
                <a:lnTo>
                  <a:pt x="65278" y="296926"/>
                </a:lnTo>
                <a:lnTo>
                  <a:pt x="65278" y="282054"/>
                </a:lnTo>
                <a:lnTo>
                  <a:pt x="59690" y="280416"/>
                </a:lnTo>
                <a:lnTo>
                  <a:pt x="52070" y="280416"/>
                </a:lnTo>
                <a:lnTo>
                  <a:pt x="44831" y="280543"/>
                </a:lnTo>
                <a:lnTo>
                  <a:pt x="38989" y="282321"/>
                </a:lnTo>
                <a:lnTo>
                  <a:pt x="30353" y="289433"/>
                </a:lnTo>
                <a:lnTo>
                  <a:pt x="28194" y="293497"/>
                </a:lnTo>
                <a:lnTo>
                  <a:pt x="28321" y="300355"/>
                </a:lnTo>
                <a:lnTo>
                  <a:pt x="28829" y="302260"/>
                </a:lnTo>
                <a:lnTo>
                  <a:pt x="30861" y="305816"/>
                </a:lnTo>
                <a:lnTo>
                  <a:pt x="32512" y="307340"/>
                </a:lnTo>
                <a:lnTo>
                  <a:pt x="34544" y="308864"/>
                </a:lnTo>
                <a:lnTo>
                  <a:pt x="26289" y="308483"/>
                </a:lnTo>
                <a:lnTo>
                  <a:pt x="20701" y="307467"/>
                </a:lnTo>
                <a:lnTo>
                  <a:pt x="18034" y="305816"/>
                </a:lnTo>
                <a:lnTo>
                  <a:pt x="15240" y="304165"/>
                </a:lnTo>
                <a:lnTo>
                  <a:pt x="13919" y="302260"/>
                </a:lnTo>
                <a:lnTo>
                  <a:pt x="13843" y="295783"/>
                </a:lnTo>
                <a:lnTo>
                  <a:pt x="16510" y="293624"/>
                </a:lnTo>
                <a:lnTo>
                  <a:pt x="21971" y="292989"/>
                </a:lnTo>
                <a:lnTo>
                  <a:pt x="20320" y="281940"/>
                </a:lnTo>
                <a:lnTo>
                  <a:pt x="14224" y="282829"/>
                </a:lnTo>
                <a:lnTo>
                  <a:pt x="9652" y="284734"/>
                </a:lnTo>
                <a:lnTo>
                  <a:pt x="6731" y="287909"/>
                </a:lnTo>
                <a:lnTo>
                  <a:pt x="3810" y="290957"/>
                </a:lnTo>
                <a:lnTo>
                  <a:pt x="2286" y="294640"/>
                </a:lnTo>
                <a:lnTo>
                  <a:pt x="2413" y="305562"/>
                </a:lnTo>
                <a:lnTo>
                  <a:pt x="5334" y="310769"/>
                </a:lnTo>
                <a:lnTo>
                  <a:pt x="40259" y="320675"/>
                </a:lnTo>
                <a:lnTo>
                  <a:pt x="49441" y="320230"/>
                </a:lnTo>
                <a:lnTo>
                  <a:pt x="75069" y="308864"/>
                </a:lnTo>
                <a:lnTo>
                  <a:pt x="75704" y="307721"/>
                </a:lnTo>
                <a:lnTo>
                  <a:pt x="76885" y="305562"/>
                </a:lnTo>
                <a:close/>
              </a:path>
              <a:path w="96520" h="483870">
                <a:moveTo>
                  <a:pt x="77470" y="483870"/>
                </a:moveTo>
                <a:lnTo>
                  <a:pt x="77343" y="471043"/>
                </a:lnTo>
                <a:lnTo>
                  <a:pt x="60706" y="466217"/>
                </a:lnTo>
                <a:lnTo>
                  <a:pt x="60667" y="462661"/>
                </a:lnTo>
                <a:lnTo>
                  <a:pt x="60490" y="446278"/>
                </a:lnTo>
                <a:lnTo>
                  <a:pt x="60452" y="442214"/>
                </a:lnTo>
                <a:lnTo>
                  <a:pt x="76962" y="436880"/>
                </a:lnTo>
                <a:lnTo>
                  <a:pt x="76835" y="423672"/>
                </a:lnTo>
                <a:lnTo>
                  <a:pt x="48260" y="433387"/>
                </a:lnTo>
                <a:lnTo>
                  <a:pt x="48260" y="462661"/>
                </a:lnTo>
                <a:lnTo>
                  <a:pt x="21082" y="454787"/>
                </a:lnTo>
                <a:lnTo>
                  <a:pt x="48133" y="446278"/>
                </a:lnTo>
                <a:lnTo>
                  <a:pt x="48260" y="462661"/>
                </a:lnTo>
                <a:lnTo>
                  <a:pt x="48260" y="433387"/>
                </a:lnTo>
                <a:lnTo>
                  <a:pt x="3937" y="448437"/>
                </a:lnTo>
                <a:lnTo>
                  <a:pt x="4064" y="461264"/>
                </a:lnTo>
                <a:lnTo>
                  <a:pt x="77470" y="483870"/>
                </a:lnTo>
                <a:close/>
              </a:path>
              <a:path w="96520" h="483870">
                <a:moveTo>
                  <a:pt x="77978" y="405638"/>
                </a:moveTo>
                <a:lnTo>
                  <a:pt x="58547" y="378587"/>
                </a:lnTo>
                <a:lnTo>
                  <a:pt x="56261" y="390017"/>
                </a:lnTo>
                <a:lnTo>
                  <a:pt x="60071" y="390525"/>
                </a:lnTo>
                <a:lnTo>
                  <a:pt x="62738" y="391541"/>
                </a:lnTo>
                <a:lnTo>
                  <a:pt x="64135" y="392938"/>
                </a:lnTo>
                <a:lnTo>
                  <a:pt x="65659" y="394335"/>
                </a:lnTo>
                <a:lnTo>
                  <a:pt x="66421" y="396113"/>
                </a:lnTo>
                <a:lnTo>
                  <a:pt x="66421" y="401066"/>
                </a:lnTo>
                <a:lnTo>
                  <a:pt x="65151" y="403479"/>
                </a:lnTo>
                <a:lnTo>
                  <a:pt x="62611" y="405257"/>
                </a:lnTo>
                <a:lnTo>
                  <a:pt x="60071" y="406908"/>
                </a:lnTo>
                <a:lnTo>
                  <a:pt x="55626" y="407924"/>
                </a:lnTo>
                <a:lnTo>
                  <a:pt x="43561" y="407924"/>
                </a:lnTo>
                <a:lnTo>
                  <a:pt x="39497" y="407162"/>
                </a:lnTo>
                <a:lnTo>
                  <a:pt x="37084" y="405384"/>
                </a:lnTo>
                <a:lnTo>
                  <a:pt x="34671" y="403733"/>
                </a:lnTo>
                <a:lnTo>
                  <a:pt x="33528" y="401447"/>
                </a:lnTo>
                <a:lnTo>
                  <a:pt x="33401" y="394208"/>
                </a:lnTo>
                <a:lnTo>
                  <a:pt x="36195" y="391541"/>
                </a:lnTo>
                <a:lnTo>
                  <a:pt x="41656" y="390652"/>
                </a:lnTo>
                <a:lnTo>
                  <a:pt x="39116" y="379349"/>
                </a:lnTo>
                <a:lnTo>
                  <a:pt x="22352" y="393827"/>
                </a:lnTo>
                <a:lnTo>
                  <a:pt x="22479" y="398907"/>
                </a:lnTo>
                <a:lnTo>
                  <a:pt x="22593" y="405384"/>
                </a:lnTo>
                <a:lnTo>
                  <a:pt x="24892" y="410210"/>
                </a:lnTo>
                <a:lnTo>
                  <a:pt x="29718" y="414020"/>
                </a:lnTo>
                <a:lnTo>
                  <a:pt x="34417" y="417957"/>
                </a:lnTo>
                <a:lnTo>
                  <a:pt x="41402" y="419735"/>
                </a:lnTo>
                <a:lnTo>
                  <a:pt x="50546" y="419735"/>
                </a:lnTo>
                <a:lnTo>
                  <a:pt x="76796" y="407924"/>
                </a:lnTo>
                <a:lnTo>
                  <a:pt x="77978" y="405638"/>
                </a:lnTo>
                <a:close/>
              </a:path>
              <a:path w="96520" h="483870">
                <a:moveTo>
                  <a:pt x="96520" y="369824"/>
                </a:moveTo>
                <a:lnTo>
                  <a:pt x="96393" y="358902"/>
                </a:lnTo>
                <a:lnTo>
                  <a:pt x="96393" y="358521"/>
                </a:lnTo>
                <a:lnTo>
                  <a:pt x="96393" y="358267"/>
                </a:lnTo>
                <a:lnTo>
                  <a:pt x="69723" y="358521"/>
                </a:lnTo>
                <a:lnTo>
                  <a:pt x="72644" y="356362"/>
                </a:lnTo>
                <a:lnTo>
                  <a:pt x="74676" y="354203"/>
                </a:lnTo>
                <a:lnTo>
                  <a:pt x="75819" y="352298"/>
                </a:lnTo>
                <a:lnTo>
                  <a:pt x="76835" y="350266"/>
                </a:lnTo>
                <a:lnTo>
                  <a:pt x="77343" y="348107"/>
                </a:lnTo>
                <a:lnTo>
                  <a:pt x="77343" y="340868"/>
                </a:lnTo>
                <a:lnTo>
                  <a:pt x="76593" y="339598"/>
                </a:lnTo>
                <a:lnTo>
                  <a:pt x="74803" y="336550"/>
                </a:lnTo>
                <a:lnTo>
                  <a:pt x="69977" y="333121"/>
                </a:lnTo>
                <a:lnTo>
                  <a:pt x="66294" y="330415"/>
                </a:lnTo>
                <a:lnTo>
                  <a:pt x="66294" y="346202"/>
                </a:lnTo>
                <a:lnTo>
                  <a:pt x="66217" y="351663"/>
                </a:lnTo>
                <a:lnTo>
                  <a:pt x="64897" y="353949"/>
                </a:lnTo>
                <a:lnTo>
                  <a:pt x="62103" y="355854"/>
                </a:lnTo>
                <a:lnTo>
                  <a:pt x="59309" y="357886"/>
                </a:lnTo>
                <a:lnTo>
                  <a:pt x="54864" y="358902"/>
                </a:lnTo>
                <a:lnTo>
                  <a:pt x="43561" y="358902"/>
                </a:lnTo>
                <a:lnTo>
                  <a:pt x="39624" y="358013"/>
                </a:lnTo>
                <a:lnTo>
                  <a:pt x="36957" y="356235"/>
                </a:lnTo>
                <a:lnTo>
                  <a:pt x="34417" y="354457"/>
                </a:lnTo>
                <a:lnTo>
                  <a:pt x="33020" y="352044"/>
                </a:lnTo>
                <a:lnTo>
                  <a:pt x="33020" y="346710"/>
                </a:lnTo>
                <a:lnTo>
                  <a:pt x="34290" y="344424"/>
                </a:lnTo>
                <a:lnTo>
                  <a:pt x="39624" y="340614"/>
                </a:lnTo>
                <a:lnTo>
                  <a:pt x="43815" y="339725"/>
                </a:lnTo>
                <a:lnTo>
                  <a:pt x="49403" y="339598"/>
                </a:lnTo>
                <a:lnTo>
                  <a:pt x="55372" y="339598"/>
                </a:lnTo>
                <a:lnTo>
                  <a:pt x="59690" y="340487"/>
                </a:lnTo>
                <a:lnTo>
                  <a:pt x="62230" y="342265"/>
                </a:lnTo>
                <a:lnTo>
                  <a:pt x="64897" y="343916"/>
                </a:lnTo>
                <a:lnTo>
                  <a:pt x="66294" y="346202"/>
                </a:lnTo>
                <a:lnTo>
                  <a:pt x="66294" y="330415"/>
                </a:lnTo>
                <a:lnTo>
                  <a:pt x="65151" y="329565"/>
                </a:lnTo>
                <a:lnTo>
                  <a:pt x="58039" y="327787"/>
                </a:lnTo>
                <a:lnTo>
                  <a:pt x="49022" y="327914"/>
                </a:lnTo>
                <a:lnTo>
                  <a:pt x="40259" y="327914"/>
                </a:lnTo>
                <a:lnTo>
                  <a:pt x="33655" y="329819"/>
                </a:lnTo>
                <a:lnTo>
                  <a:pt x="28956" y="333502"/>
                </a:lnTo>
                <a:lnTo>
                  <a:pt x="24257" y="337058"/>
                </a:lnTo>
                <a:lnTo>
                  <a:pt x="21844" y="341376"/>
                </a:lnTo>
                <a:lnTo>
                  <a:pt x="21971" y="349123"/>
                </a:lnTo>
                <a:lnTo>
                  <a:pt x="22733" y="351663"/>
                </a:lnTo>
                <a:lnTo>
                  <a:pt x="24472" y="354203"/>
                </a:lnTo>
                <a:lnTo>
                  <a:pt x="26035" y="356362"/>
                </a:lnTo>
                <a:lnTo>
                  <a:pt x="28321" y="358267"/>
                </a:lnTo>
                <a:lnTo>
                  <a:pt x="31115" y="359791"/>
                </a:lnTo>
                <a:lnTo>
                  <a:pt x="23241" y="359791"/>
                </a:lnTo>
                <a:lnTo>
                  <a:pt x="23368" y="370459"/>
                </a:lnTo>
                <a:lnTo>
                  <a:pt x="96520" y="36982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" name="object 37"/>
          <p:cNvSpPr txBox="1"/>
          <p:nvPr/>
        </p:nvSpPr>
        <p:spPr>
          <a:xfrm>
            <a:off x="5746727" y="4734755"/>
            <a:ext cx="264795" cy="50990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spc="-10" dirty="0">
                <a:latin typeface="Arial Narrow"/>
                <a:cs typeface="Arial Narrow"/>
              </a:rPr>
              <a:t>Acp6.9-</a:t>
            </a:r>
            <a:r>
              <a:rPr sz="800" b="1" spc="-20" dirty="0">
                <a:latin typeface="Arial Narrow"/>
                <a:cs typeface="Arial Narrow"/>
              </a:rPr>
              <a:t>chiA</a:t>
            </a:r>
            <a:endParaRPr sz="800">
              <a:latin typeface="Arial Narrow"/>
              <a:cs typeface="Arial Narrow"/>
            </a:endParaRPr>
          </a:p>
          <a:p>
            <a:pPr marL="12700">
              <a:lnSpc>
                <a:spcPct val="100000"/>
              </a:lnSpc>
            </a:pPr>
            <a:r>
              <a:rPr sz="800" b="1" dirty="0">
                <a:latin typeface="Arial Narrow"/>
                <a:cs typeface="Arial Narrow"/>
              </a:rPr>
              <a:t>/</a:t>
            </a:r>
            <a:r>
              <a:rPr sz="800" b="1" spc="50" dirty="0">
                <a:latin typeface="Arial Narrow"/>
                <a:cs typeface="Arial Narrow"/>
              </a:rPr>
              <a:t> </a:t>
            </a:r>
            <a:r>
              <a:rPr sz="800" b="1" spc="-10" dirty="0">
                <a:latin typeface="Arial Narrow"/>
                <a:cs typeface="Arial Narrow"/>
              </a:rPr>
              <a:t>polh-</a:t>
            </a:r>
            <a:r>
              <a:rPr sz="800" b="1" spc="-20" dirty="0">
                <a:latin typeface="Arial Narrow"/>
                <a:cs typeface="Arial Narrow"/>
              </a:rPr>
              <a:t>cath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38" name="object 38"/>
          <p:cNvSpPr txBox="1"/>
          <p:nvPr/>
        </p:nvSpPr>
        <p:spPr>
          <a:xfrm>
            <a:off x="8620610" y="4818823"/>
            <a:ext cx="142875" cy="363220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spc="-10" dirty="0">
                <a:latin typeface="Arial Narrow"/>
                <a:cs typeface="Arial Narrow"/>
              </a:rPr>
              <a:t>AcEGFP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39" name="object 39"/>
          <p:cNvSpPr/>
          <p:nvPr/>
        </p:nvSpPr>
        <p:spPr>
          <a:xfrm>
            <a:off x="9238742" y="4678552"/>
            <a:ext cx="96520" cy="483870"/>
          </a:xfrm>
          <a:custGeom>
            <a:avLst/>
            <a:gdLst/>
            <a:ahLst/>
            <a:cxnLst/>
            <a:rect l="l" t="t" r="r" b="b"/>
            <a:pathLst>
              <a:path w="96520" h="483870">
                <a:moveTo>
                  <a:pt x="13462" y="77597"/>
                </a:moveTo>
                <a:lnTo>
                  <a:pt x="13335" y="66040"/>
                </a:lnTo>
                <a:lnTo>
                  <a:pt x="381" y="66167"/>
                </a:lnTo>
                <a:lnTo>
                  <a:pt x="508" y="77724"/>
                </a:lnTo>
                <a:lnTo>
                  <a:pt x="13462" y="77597"/>
                </a:lnTo>
                <a:close/>
              </a:path>
              <a:path w="96520" h="483870">
                <a:moveTo>
                  <a:pt x="55372" y="203962"/>
                </a:moveTo>
                <a:lnTo>
                  <a:pt x="55118" y="181356"/>
                </a:lnTo>
                <a:lnTo>
                  <a:pt x="41148" y="181610"/>
                </a:lnTo>
                <a:lnTo>
                  <a:pt x="41275" y="204089"/>
                </a:lnTo>
                <a:lnTo>
                  <a:pt x="55372" y="203962"/>
                </a:lnTo>
                <a:close/>
              </a:path>
              <a:path w="96520" h="483870">
                <a:moveTo>
                  <a:pt x="73406" y="60198"/>
                </a:moveTo>
                <a:lnTo>
                  <a:pt x="73279" y="47244"/>
                </a:lnTo>
                <a:lnTo>
                  <a:pt x="56769" y="42545"/>
                </a:lnTo>
                <a:lnTo>
                  <a:pt x="56718" y="38862"/>
                </a:lnTo>
                <a:lnTo>
                  <a:pt x="56553" y="22479"/>
                </a:lnTo>
                <a:lnTo>
                  <a:pt x="56515" y="18542"/>
                </a:lnTo>
                <a:lnTo>
                  <a:pt x="73025" y="13081"/>
                </a:lnTo>
                <a:lnTo>
                  <a:pt x="72898" y="0"/>
                </a:lnTo>
                <a:lnTo>
                  <a:pt x="44323" y="9664"/>
                </a:lnTo>
                <a:lnTo>
                  <a:pt x="44323" y="38862"/>
                </a:lnTo>
                <a:lnTo>
                  <a:pt x="17145" y="31115"/>
                </a:lnTo>
                <a:lnTo>
                  <a:pt x="44196" y="22479"/>
                </a:lnTo>
                <a:lnTo>
                  <a:pt x="44323" y="38862"/>
                </a:lnTo>
                <a:lnTo>
                  <a:pt x="44323" y="9664"/>
                </a:lnTo>
                <a:lnTo>
                  <a:pt x="0" y="24638"/>
                </a:lnTo>
                <a:lnTo>
                  <a:pt x="127" y="37465"/>
                </a:lnTo>
                <a:lnTo>
                  <a:pt x="73406" y="60198"/>
                </a:lnTo>
                <a:close/>
              </a:path>
              <a:path w="96520" h="483870">
                <a:moveTo>
                  <a:pt x="73660" y="76962"/>
                </a:moveTo>
                <a:lnTo>
                  <a:pt x="73533" y="65532"/>
                </a:lnTo>
                <a:lnTo>
                  <a:pt x="20574" y="65913"/>
                </a:lnTo>
                <a:lnTo>
                  <a:pt x="20701" y="77470"/>
                </a:lnTo>
                <a:lnTo>
                  <a:pt x="73660" y="76962"/>
                </a:lnTo>
                <a:close/>
              </a:path>
              <a:path w="96520" h="483870">
                <a:moveTo>
                  <a:pt x="74041" y="115824"/>
                </a:moveTo>
                <a:lnTo>
                  <a:pt x="47371" y="116078"/>
                </a:lnTo>
                <a:lnTo>
                  <a:pt x="40894" y="116078"/>
                </a:lnTo>
                <a:lnTo>
                  <a:pt x="36449" y="115316"/>
                </a:lnTo>
                <a:lnTo>
                  <a:pt x="34036" y="113665"/>
                </a:lnTo>
                <a:lnTo>
                  <a:pt x="31623" y="112141"/>
                </a:lnTo>
                <a:lnTo>
                  <a:pt x="30480" y="109855"/>
                </a:lnTo>
                <a:lnTo>
                  <a:pt x="30353" y="104140"/>
                </a:lnTo>
                <a:lnTo>
                  <a:pt x="31496" y="102108"/>
                </a:lnTo>
                <a:lnTo>
                  <a:pt x="35306" y="100076"/>
                </a:lnTo>
                <a:lnTo>
                  <a:pt x="39370" y="99695"/>
                </a:lnTo>
                <a:lnTo>
                  <a:pt x="45847" y="99568"/>
                </a:lnTo>
                <a:lnTo>
                  <a:pt x="73787" y="99314"/>
                </a:lnTo>
                <a:lnTo>
                  <a:pt x="73660" y="87757"/>
                </a:lnTo>
                <a:lnTo>
                  <a:pt x="42672" y="88138"/>
                </a:lnTo>
                <a:lnTo>
                  <a:pt x="36703" y="88138"/>
                </a:lnTo>
                <a:lnTo>
                  <a:pt x="32512" y="88519"/>
                </a:lnTo>
                <a:lnTo>
                  <a:pt x="30099" y="89281"/>
                </a:lnTo>
                <a:lnTo>
                  <a:pt x="26670" y="90297"/>
                </a:lnTo>
                <a:lnTo>
                  <a:pt x="24130" y="92075"/>
                </a:lnTo>
                <a:lnTo>
                  <a:pt x="20574" y="96647"/>
                </a:lnTo>
                <a:lnTo>
                  <a:pt x="19761" y="99314"/>
                </a:lnTo>
                <a:lnTo>
                  <a:pt x="19685" y="105664"/>
                </a:lnTo>
                <a:lnTo>
                  <a:pt x="20320" y="108077"/>
                </a:lnTo>
                <a:lnTo>
                  <a:pt x="21717" y="110236"/>
                </a:lnTo>
                <a:lnTo>
                  <a:pt x="22987" y="112395"/>
                </a:lnTo>
                <a:lnTo>
                  <a:pt x="25019" y="114427"/>
                </a:lnTo>
                <a:lnTo>
                  <a:pt x="27686" y="116205"/>
                </a:lnTo>
                <a:lnTo>
                  <a:pt x="889" y="116459"/>
                </a:lnTo>
                <a:lnTo>
                  <a:pt x="1016" y="128016"/>
                </a:lnTo>
                <a:lnTo>
                  <a:pt x="74041" y="127381"/>
                </a:lnTo>
                <a:lnTo>
                  <a:pt x="74041" y="116078"/>
                </a:lnTo>
                <a:lnTo>
                  <a:pt x="74041" y="115824"/>
                </a:lnTo>
                <a:close/>
              </a:path>
              <a:path w="96520" h="483870">
                <a:moveTo>
                  <a:pt x="75438" y="270510"/>
                </a:moveTo>
                <a:lnTo>
                  <a:pt x="75311" y="259080"/>
                </a:lnTo>
                <a:lnTo>
                  <a:pt x="61341" y="259207"/>
                </a:lnTo>
                <a:lnTo>
                  <a:pt x="61468" y="270637"/>
                </a:lnTo>
                <a:lnTo>
                  <a:pt x="75438" y="270510"/>
                </a:lnTo>
                <a:close/>
              </a:path>
              <a:path w="96520" h="483870">
                <a:moveTo>
                  <a:pt x="75692" y="161671"/>
                </a:moveTo>
                <a:lnTo>
                  <a:pt x="56261" y="134747"/>
                </a:lnTo>
                <a:lnTo>
                  <a:pt x="53975" y="146050"/>
                </a:lnTo>
                <a:lnTo>
                  <a:pt x="57785" y="146685"/>
                </a:lnTo>
                <a:lnTo>
                  <a:pt x="60452" y="147574"/>
                </a:lnTo>
                <a:lnTo>
                  <a:pt x="61849" y="148971"/>
                </a:lnTo>
                <a:lnTo>
                  <a:pt x="63373" y="150368"/>
                </a:lnTo>
                <a:lnTo>
                  <a:pt x="64135" y="152146"/>
                </a:lnTo>
                <a:lnTo>
                  <a:pt x="64135" y="157226"/>
                </a:lnTo>
                <a:lnTo>
                  <a:pt x="62865" y="159512"/>
                </a:lnTo>
                <a:lnTo>
                  <a:pt x="57785" y="163068"/>
                </a:lnTo>
                <a:lnTo>
                  <a:pt x="53340" y="163957"/>
                </a:lnTo>
                <a:lnTo>
                  <a:pt x="46990" y="164084"/>
                </a:lnTo>
                <a:lnTo>
                  <a:pt x="41275" y="164084"/>
                </a:lnTo>
                <a:lnTo>
                  <a:pt x="31115" y="150241"/>
                </a:lnTo>
                <a:lnTo>
                  <a:pt x="33909" y="147701"/>
                </a:lnTo>
                <a:lnTo>
                  <a:pt x="39370" y="146812"/>
                </a:lnTo>
                <a:lnTo>
                  <a:pt x="36830" y="135509"/>
                </a:lnTo>
                <a:lnTo>
                  <a:pt x="30988" y="136906"/>
                </a:lnTo>
                <a:lnTo>
                  <a:pt x="26670" y="139319"/>
                </a:lnTo>
                <a:lnTo>
                  <a:pt x="24130" y="142494"/>
                </a:lnTo>
                <a:lnTo>
                  <a:pt x="21463" y="145669"/>
                </a:lnTo>
                <a:lnTo>
                  <a:pt x="20066" y="149860"/>
                </a:lnTo>
                <a:lnTo>
                  <a:pt x="20180" y="154686"/>
                </a:lnTo>
                <a:lnTo>
                  <a:pt x="20307" y="161544"/>
                </a:lnTo>
                <a:lnTo>
                  <a:pt x="22606" y="166370"/>
                </a:lnTo>
                <a:lnTo>
                  <a:pt x="27432" y="170180"/>
                </a:lnTo>
                <a:lnTo>
                  <a:pt x="32131" y="173990"/>
                </a:lnTo>
                <a:lnTo>
                  <a:pt x="39116" y="175895"/>
                </a:lnTo>
                <a:lnTo>
                  <a:pt x="48260" y="175768"/>
                </a:lnTo>
                <a:lnTo>
                  <a:pt x="55753" y="175768"/>
                </a:lnTo>
                <a:lnTo>
                  <a:pt x="62230" y="173990"/>
                </a:lnTo>
                <a:lnTo>
                  <a:pt x="73025" y="167005"/>
                </a:lnTo>
                <a:lnTo>
                  <a:pt x="74485" y="164084"/>
                </a:lnTo>
                <a:lnTo>
                  <a:pt x="75692" y="161671"/>
                </a:lnTo>
                <a:close/>
              </a:path>
              <a:path w="96520" h="483870">
                <a:moveTo>
                  <a:pt x="76327" y="226568"/>
                </a:moveTo>
                <a:lnTo>
                  <a:pt x="74358" y="223139"/>
                </a:lnTo>
                <a:lnTo>
                  <a:pt x="73279" y="221234"/>
                </a:lnTo>
                <a:lnTo>
                  <a:pt x="67310" y="217170"/>
                </a:lnTo>
                <a:lnTo>
                  <a:pt x="62204" y="214579"/>
                </a:lnTo>
                <a:lnTo>
                  <a:pt x="55689" y="212725"/>
                </a:lnTo>
                <a:lnTo>
                  <a:pt x="47726" y="211645"/>
                </a:lnTo>
                <a:lnTo>
                  <a:pt x="40132" y="211391"/>
                </a:lnTo>
                <a:lnTo>
                  <a:pt x="40132" y="234315"/>
                </a:lnTo>
                <a:lnTo>
                  <a:pt x="39116" y="236220"/>
                </a:lnTo>
                <a:lnTo>
                  <a:pt x="36830" y="237871"/>
                </a:lnTo>
                <a:lnTo>
                  <a:pt x="34671" y="239395"/>
                </a:lnTo>
                <a:lnTo>
                  <a:pt x="31242" y="240157"/>
                </a:lnTo>
                <a:lnTo>
                  <a:pt x="26543" y="240284"/>
                </a:lnTo>
                <a:lnTo>
                  <a:pt x="21844" y="240284"/>
                </a:lnTo>
                <a:lnTo>
                  <a:pt x="18415" y="239649"/>
                </a:lnTo>
                <a:lnTo>
                  <a:pt x="14351" y="236855"/>
                </a:lnTo>
                <a:lnTo>
                  <a:pt x="13335" y="235077"/>
                </a:lnTo>
                <a:lnTo>
                  <a:pt x="13335" y="230759"/>
                </a:lnTo>
                <a:lnTo>
                  <a:pt x="14478" y="228727"/>
                </a:lnTo>
                <a:lnTo>
                  <a:pt x="17018" y="227076"/>
                </a:lnTo>
                <a:lnTo>
                  <a:pt x="19431" y="225298"/>
                </a:lnTo>
                <a:lnTo>
                  <a:pt x="22987" y="224409"/>
                </a:lnTo>
                <a:lnTo>
                  <a:pt x="27559" y="224282"/>
                </a:lnTo>
                <a:lnTo>
                  <a:pt x="31623" y="224282"/>
                </a:lnTo>
                <a:lnTo>
                  <a:pt x="40132" y="234315"/>
                </a:lnTo>
                <a:lnTo>
                  <a:pt x="40132" y="211391"/>
                </a:lnTo>
                <a:lnTo>
                  <a:pt x="1854" y="226187"/>
                </a:lnTo>
                <a:lnTo>
                  <a:pt x="1778" y="237998"/>
                </a:lnTo>
                <a:lnTo>
                  <a:pt x="4064" y="242443"/>
                </a:lnTo>
                <a:lnTo>
                  <a:pt x="12954" y="249809"/>
                </a:lnTo>
                <a:lnTo>
                  <a:pt x="19050" y="251587"/>
                </a:lnTo>
                <a:lnTo>
                  <a:pt x="26670" y="251460"/>
                </a:lnTo>
                <a:lnTo>
                  <a:pt x="33909" y="251460"/>
                </a:lnTo>
                <a:lnTo>
                  <a:pt x="39624" y="249682"/>
                </a:lnTo>
                <a:lnTo>
                  <a:pt x="48260" y="242570"/>
                </a:lnTo>
                <a:lnTo>
                  <a:pt x="49466" y="240284"/>
                </a:lnTo>
                <a:lnTo>
                  <a:pt x="50419" y="238506"/>
                </a:lnTo>
                <a:lnTo>
                  <a:pt x="50419" y="231775"/>
                </a:lnTo>
                <a:lnTo>
                  <a:pt x="49911" y="229743"/>
                </a:lnTo>
                <a:lnTo>
                  <a:pt x="48768" y="227965"/>
                </a:lnTo>
                <a:lnTo>
                  <a:pt x="47752" y="226187"/>
                </a:lnTo>
                <a:lnTo>
                  <a:pt x="46228" y="224536"/>
                </a:lnTo>
                <a:lnTo>
                  <a:pt x="45847" y="224282"/>
                </a:lnTo>
                <a:lnTo>
                  <a:pt x="44196" y="223139"/>
                </a:lnTo>
                <a:lnTo>
                  <a:pt x="52451" y="223520"/>
                </a:lnTo>
                <a:lnTo>
                  <a:pt x="57912" y="224536"/>
                </a:lnTo>
                <a:lnTo>
                  <a:pt x="60706" y="226187"/>
                </a:lnTo>
                <a:lnTo>
                  <a:pt x="63373" y="227711"/>
                </a:lnTo>
                <a:lnTo>
                  <a:pt x="64681" y="229743"/>
                </a:lnTo>
                <a:lnTo>
                  <a:pt x="64770" y="236220"/>
                </a:lnTo>
                <a:lnTo>
                  <a:pt x="62103" y="238379"/>
                </a:lnTo>
                <a:lnTo>
                  <a:pt x="56642" y="239014"/>
                </a:lnTo>
                <a:lnTo>
                  <a:pt x="58293" y="250063"/>
                </a:lnTo>
                <a:lnTo>
                  <a:pt x="76225" y="237871"/>
                </a:lnTo>
                <a:lnTo>
                  <a:pt x="76327" y="226568"/>
                </a:lnTo>
                <a:close/>
              </a:path>
              <a:path w="96520" h="483870">
                <a:moveTo>
                  <a:pt x="76962" y="305435"/>
                </a:moveTo>
                <a:lnTo>
                  <a:pt x="76835" y="294005"/>
                </a:lnTo>
                <a:lnTo>
                  <a:pt x="75692" y="291592"/>
                </a:lnTo>
                <a:lnTo>
                  <a:pt x="74676" y="289433"/>
                </a:lnTo>
                <a:lnTo>
                  <a:pt x="65786" y="282067"/>
                </a:lnTo>
                <a:lnTo>
                  <a:pt x="65405" y="281965"/>
                </a:lnTo>
                <a:lnTo>
                  <a:pt x="65405" y="301244"/>
                </a:lnTo>
                <a:lnTo>
                  <a:pt x="64135" y="303149"/>
                </a:lnTo>
                <a:lnTo>
                  <a:pt x="59309" y="306705"/>
                </a:lnTo>
                <a:lnTo>
                  <a:pt x="55753" y="307594"/>
                </a:lnTo>
                <a:lnTo>
                  <a:pt x="46990" y="307594"/>
                </a:lnTo>
                <a:lnTo>
                  <a:pt x="43942" y="306832"/>
                </a:lnTo>
                <a:lnTo>
                  <a:pt x="41783" y="305308"/>
                </a:lnTo>
                <a:lnTo>
                  <a:pt x="39751" y="303911"/>
                </a:lnTo>
                <a:lnTo>
                  <a:pt x="38684" y="302133"/>
                </a:lnTo>
                <a:lnTo>
                  <a:pt x="38608" y="297561"/>
                </a:lnTo>
                <a:lnTo>
                  <a:pt x="39624" y="295656"/>
                </a:lnTo>
                <a:lnTo>
                  <a:pt x="41783" y="294005"/>
                </a:lnTo>
                <a:lnTo>
                  <a:pt x="44069" y="292481"/>
                </a:lnTo>
                <a:lnTo>
                  <a:pt x="47498" y="291719"/>
                </a:lnTo>
                <a:lnTo>
                  <a:pt x="52324" y="291719"/>
                </a:lnTo>
                <a:lnTo>
                  <a:pt x="56896" y="291592"/>
                </a:lnTo>
                <a:lnTo>
                  <a:pt x="60198" y="292354"/>
                </a:lnTo>
                <a:lnTo>
                  <a:pt x="64262" y="295148"/>
                </a:lnTo>
                <a:lnTo>
                  <a:pt x="65278" y="296926"/>
                </a:lnTo>
                <a:lnTo>
                  <a:pt x="65405" y="301244"/>
                </a:lnTo>
                <a:lnTo>
                  <a:pt x="65405" y="281965"/>
                </a:lnTo>
                <a:lnTo>
                  <a:pt x="59817" y="280289"/>
                </a:lnTo>
                <a:lnTo>
                  <a:pt x="52070" y="280416"/>
                </a:lnTo>
                <a:lnTo>
                  <a:pt x="44831" y="280416"/>
                </a:lnTo>
                <a:lnTo>
                  <a:pt x="38989" y="282321"/>
                </a:lnTo>
                <a:lnTo>
                  <a:pt x="34671" y="285750"/>
                </a:lnTo>
                <a:lnTo>
                  <a:pt x="30353" y="289306"/>
                </a:lnTo>
                <a:lnTo>
                  <a:pt x="28194" y="293497"/>
                </a:lnTo>
                <a:lnTo>
                  <a:pt x="28321" y="300228"/>
                </a:lnTo>
                <a:lnTo>
                  <a:pt x="34544" y="308737"/>
                </a:lnTo>
                <a:lnTo>
                  <a:pt x="26289" y="308356"/>
                </a:lnTo>
                <a:lnTo>
                  <a:pt x="13843" y="295783"/>
                </a:lnTo>
                <a:lnTo>
                  <a:pt x="16510" y="293497"/>
                </a:lnTo>
                <a:lnTo>
                  <a:pt x="21971" y="292989"/>
                </a:lnTo>
                <a:lnTo>
                  <a:pt x="20320" y="281813"/>
                </a:lnTo>
                <a:lnTo>
                  <a:pt x="2413" y="305435"/>
                </a:lnTo>
                <a:lnTo>
                  <a:pt x="5461" y="310642"/>
                </a:lnTo>
                <a:lnTo>
                  <a:pt x="40259" y="320548"/>
                </a:lnTo>
                <a:lnTo>
                  <a:pt x="49441" y="320103"/>
                </a:lnTo>
                <a:lnTo>
                  <a:pt x="75095" y="308737"/>
                </a:lnTo>
                <a:lnTo>
                  <a:pt x="75742" y="307594"/>
                </a:lnTo>
                <a:lnTo>
                  <a:pt x="76962" y="305435"/>
                </a:lnTo>
                <a:close/>
              </a:path>
              <a:path w="96520" h="483870">
                <a:moveTo>
                  <a:pt x="77470" y="483870"/>
                </a:moveTo>
                <a:lnTo>
                  <a:pt x="77343" y="470916"/>
                </a:lnTo>
                <a:lnTo>
                  <a:pt x="60706" y="466217"/>
                </a:lnTo>
                <a:lnTo>
                  <a:pt x="60655" y="462534"/>
                </a:lnTo>
                <a:lnTo>
                  <a:pt x="60490" y="446151"/>
                </a:lnTo>
                <a:lnTo>
                  <a:pt x="60452" y="442214"/>
                </a:lnTo>
                <a:lnTo>
                  <a:pt x="76962" y="436753"/>
                </a:lnTo>
                <a:lnTo>
                  <a:pt x="76835" y="423672"/>
                </a:lnTo>
                <a:lnTo>
                  <a:pt x="48260" y="433349"/>
                </a:lnTo>
                <a:lnTo>
                  <a:pt x="48260" y="462534"/>
                </a:lnTo>
                <a:lnTo>
                  <a:pt x="21082" y="454660"/>
                </a:lnTo>
                <a:lnTo>
                  <a:pt x="48133" y="446151"/>
                </a:lnTo>
                <a:lnTo>
                  <a:pt x="48260" y="462534"/>
                </a:lnTo>
                <a:lnTo>
                  <a:pt x="48260" y="433349"/>
                </a:lnTo>
                <a:lnTo>
                  <a:pt x="4064" y="448310"/>
                </a:lnTo>
                <a:lnTo>
                  <a:pt x="4191" y="461137"/>
                </a:lnTo>
                <a:lnTo>
                  <a:pt x="77470" y="483870"/>
                </a:lnTo>
                <a:close/>
              </a:path>
              <a:path w="96520" h="483870">
                <a:moveTo>
                  <a:pt x="77978" y="405511"/>
                </a:moveTo>
                <a:lnTo>
                  <a:pt x="58547" y="378587"/>
                </a:lnTo>
                <a:lnTo>
                  <a:pt x="56261" y="389890"/>
                </a:lnTo>
                <a:lnTo>
                  <a:pt x="60071" y="390398"/>
                </a:lnTo>
                <a:lnTo>
                  <a:pt x="62738" y="391414"/>
                </a:lnTo>
                <a:lnTo>
                  <a:pt x="64135" y="392811"/>
                </a:lnTo>
                <a:lnTo>
                  <a:pt x="65659" y="394208"/>
                </a:lnTo>
                <a:lnTo>
                  <a:pt x="66421" y="395986"/>
                </a:lnTo>
                <a:lnTo>
                  <a:pt x="49276" y="407924"/>
                </a:lnTo>
                <a:lnTo>
                  <a:pt x="43561" y="407924"/>
                </a:lnTo>
                <a:lnTo>
                  <a:pt x="33401" y="394081"/>
                </a:lnTo>
                <a:lnTo>
                  <a:pt x="36195" y="391414"/>
                </a:lnTo>
                <a:lnTo>
                  <a:pt x="41656" y="390525"/>
                </a:lnTo>
                <a:lnTo>
                  <a:pt x="39116" y="379349"/>
                </a:lnTo>
                <a:lnTo>
                  <a:pt x="33274" y="380746"/>
                </a:lnTo>
                <a:lnTo>
                  <a:pt x="29083" y="383032"/>
                </a:lnTo>
                <a:lnTo>
                  <a:pt x="26416" y="386334"/>
                </a:lnTo>
                <a:lnTo>
                  <a:pt x="23749" y="389509"/>
                </a:lnTo>
                <a:lnTo>
                  <a:pt x="22352" y="393700"/>
                </a:lnTo>
                <a:lnTo>
                  <a:pt x="22466" y="398526"/>
                </a:lnTo>
                <a:lnTo>
                  <a:pt x="22593" y="405384"/>
                </a:lnTo>
                <a:lnTo>
                  <a:pt x="24892" y="410210"/>
                </a:lnTo>
                <a:lnTo>
                  <a:pt x="34544" y="417830"/>
                </a:lnTo>
                <a:lnTo>
                  <a:pt x="41402" y="419735"/>
                </a:lnTo>
                <a:lnTo>
                  <a:pt x="50546" y="419608"/>
                </a:lnTo>
                <a:lnTo>
                  <a:pt x="58039" y="419608"/>
                </a:lnTo>
                <a:lnTo>
                  <a:pt x="64516" y="417830"/>
                </a:lnTo>
                <a:lnTo>
                  <a:pt x="75311" y="410845"/>
                </a:lnTo>
                <a:lnTo>
                  <a:pt x="76771" y="407924"/>
                </a:lnTo>
                <a:lnTo>
                  <a:pt x="77978" y="405511"/>
                </a:lnTo>
                <a:close/>
              </a:path>
              <a:path w="96520" h="483870">
                <a:moveTo>
                  <a:pt x="96520" y="369697"/>
                </a:moveTo>
                <a:lnTo>
                  <a:pt x="96393" y="358902"/>
                </a:lnTo>
                <a:lnTo>
                  <a:pt x="96393" y="358521"/>
                </a:lnTo>
                <a:lnTo>
                  <a:pt x="96393" y="358267"/>
                </a:lnTo>
                <a:lnTo>
                  <a:pt x="69723" y="358521"/>
                </a:lnTo>
                <a:lnTo>
                  <a:pt x="72644" y="356235"/>
                </a:lnTo>
                <a:lnTo>
                  <a:pt x="74676" y="354203"/>
                </a:lnTo>
                <a:lnTo>
                  <a:pt x="75882" y="352044"/>
                </a:lnTo>
                <a:lnTo>
                  <a:pt x="76835" y="350139"/>
                </a:lnTo>
                <a:lnTo>
                  <a:pt x="77343" y="347980"/>
                </a:lnTo>
                <a:lnTo>
                  <a:pt x="77266" y="340614"/>
                </a:lnTo>
                <a:lnTo>
                  <a:pt x="76606" y="339471"/>
                </a:lnTo>
                <a:lnTo>
                  <a:pt x="74930" y="336550"/>
                </a:lnTo>
                <a:lnTo>
                  <a:pt x="69977" y="332994"/>
                </a:lnTo>
                <a:lnTo>
                  <a:pt x="66294" y="330288"/>
                </a:lnTo>
                <a:lnTo>
                  <a:pt x="66294" y="346075"/>
                </a:lnTo>
                <a:lnTo>
                  <a:pt x="66294" y="351536"/>
                </a:lnTo>
                <a:lnTo>
                  <a:pt x="64897" y="353822"/>
                </a:lnTo>
                <a:lnTo>
                  <a:pt x="62103" y="355854"/>
                </a:lnTo>
                <a:lnTo>
                  <a:pt x="59309" y="357759"/>
                </a:lnTo>
                <a:lnTo>
                  <a:pt x="54864" y="358775"/>
                </a:lnTo>
                <a:lnTo>
                  <a:pt x="48895" y="358775"/>
                </a:lnTo>
                <a:lnTo>
                  <a:pt x="43561" y="358902"/>
                </a:lnTo>
                <a:lnTo>
                  <a:pt x="39624" y="358013"/>
                </a:lnTo>
                <a:lnTo>
                  <a:pt x="37084" y="356108"/>
                </a:lnTo>
                <a:lnTo>
                  <a:pt x="34417" y="354330"/>
                </a:lnTo>
                <a:lnTo>
                  <a:pt x="33096" y="352171"/>
                </a:lnTo>
                <a:lnTo>
                  <a:pt x="33020" y="346583"/>
                </a:lnTo>
                <a:lnTo>
                  <a:pt x="34290" y="344297"/>
                </a:lnTo>
                <a:lnTo>
                  <a:pt x="36957" y="342392"/>
                </a:lnTo>
                <a:lnTo>
                  <a:pt x="39624" y="340614"/>
                </a:lnTo>
                <a:lnTo>
                  <a:pt x="43815" y="339598"/>
                </a:lnTo>
                <a:lnTo>
                  <a:pt x="49403" y="339598"/>
                </a:lnTo>
                <a:lnTo>
                  <a:pt x="55372" y="339471"/>
                </a:lnTo>
                <a:lnTo>
                  <a:pt x="59690" y="340360"/>
                </a:lnTo>
                <a:lnTo>
                  <a:pt x="62357" y="342138"/>
                </a:lnTo>
                <a:lnTo>
                  <a:pt x="64897" y="343916"/>
                </a:lnTo>
                <a:lnTo>
                  <a:pt x="66294" y="346075"/>
                </a:lnTo>
                <a:lnTo>
                  <a:pt x="66294" y="330288"/>
                </a:lnTo>
                <a:lnTo>
                  <a:pt x="65151" y="329438"/>
                </a:lnTo>
                <a:lnTo>
                  <a:pt x="58166" y="327787"/>
                </a:lnTo>
                <a:lnTo>
                  <a:pt x="49022" y="327787"/>
                </a:lnTo>
                <a:lnTo>
                  <a:pt x="40259" y="327914"/>
                </a:lnTo>
                <a:lnTo>
                  <a:pt x="33655" y="329692"/>
                </a:lnTo>
                <a:lnTo>
                  <a:pt x="28956" y="333375"/>
                </a:lnTo>
                <a:lnTo>
                  <a:pt x="24257" y="336931"/>
                </a:lnTo>
                <a:lnTo>
                  <a:pt x="21844" y="341249"/>
                </a:lnTo>
                <a:lnTo>
                  <a:pt x="21971" y="348996"/>
                </a:lnTo>
                <a:lnTo>
                  <a:pt x="22860" y="351536"/>
                </a:lnTo>
                <a:lnTo>
                  <a:pt x="24638" y="354330"/>
                </a:lnTo>
                <a:lnTo>
                  <a:pt x="26035" y="356362"/>
                </a:lnTo>
                <a:lnTo>
                  <a:pt x="28321" y="358267"/>
                </a:lnTo>
                <a:lnTo>
                  <a:pt x="31115" y="359664"/>
                </a:lnTo>
                <a:lnTo>
                  <a:pt x="23368" y="359791"/>
                </a:lnTo>
                <a:lnTo>
                  <a:pt x="23368" y="370459"/>
                </a:lnTo>
                <a:lnTo>
                  <a:pt x="96520" y="36969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0" name="object 40"/>
          <p:cNvSpPr txBox="1"/>
          <p:nvPr/>
        </p:nvSpPr>
        <p:spPr>
          <a:xfrm>
            <a:off x="9485703" y="4667294"/>
            <a:ext cx="265430" cy="509905"/>
          </a:xfrm>
          <a:prstGeom prst="rect">
            <a:avLst/>
          </a:prstGeom>
        </p:spPr>
        <p:txBody>
          <a:bodyPr vert="vert270" wrap="square" lIns="0" tIns="698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5"/>
              </a:spcBef>
            </a:pPr>
            <a:r>
              <a:rPr sz="800" b="1" spc="-10" dirty="0">
                <a:latin typeface="Arial Narrow"/>
                <a:cs typeface="Arial Narrow"/>
              </a:rPr>
              <a:t>Acp6.9-</a:t>
            </a:r>
            <a:r>
              <a:rPr sz="800" b="1" spc="-20" dirty="0">
                <a:latin typeface="Arial Narrow"/>
                <a:cs typeface="Arial Narrow"/>
              </a:rPr>
              <a:t>chiA</a:t>
            </a:r>
            <a:endParaRPr sz="800">
              <a:latin typeface="Arial Narrow"/>
              <a:cs typeface="Arial Narrow"/>
            </a:endParaRPr>
          </a:p>
          <a:p>
            <a:pPr marL="12700">
              <a:lnSpc>
                <a:spcPct val="100000"/>
              </a:lnSpc>
            </a:pPr>
            <a:r>
              <a:rPr sz="800" b="1" dirty="0">
                <a:latin typeface="Arial Narrow"/>
                <a:cs typeface="Arial Narrow"/>
              </a:rPr>
              <a:t>/</a:t>
            </a:r>
            <a:r>
              <a:rPr sz="800" b="1" spc="50" dirty="0">
                <a:latin typeface="Arial Narrow"/>
                <a:cs typeface="Arial Narrow"/>
              </a:rPr>
              <a:t> </a:t>
            </a:r>
            <a:r>
              <a:rPr sz="800" b="1" spc="-10" dirty="0">
                <a:latin typeface="Arial Narrow"/>
                <a:cs typeface="Arial Narrow"/>
              </a:rPr>
              <a:t>polh-</a:t>
            </a:r>
            <a:r>
              <a:rPr sz="800" b="1" spc="-20" dirty="0">
                <a:latin typeface="Arial Narrow"/>
                <a:cs typeface="Arial Narrow"/>
              </a:rPr>
              <a:t>cath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41" name="object 41"/>
          <p:cNvSpPr txBox="1"/>
          <p:nvPr/>
        </p:nvSpPr>
        <p:spPr>
          <a:xfrm>
            <a:off x="10096477" y="4794185"/>
            <a:ext cx="142875" cy="363220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spc="-10" dirty="0">
                <a:latin typeface="Arial Narrow"/>
                <a:cs typeface="Arial Narrow"/>
              </a:rPr>
              <a:t>AcEGFP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42" name="object 42"/>
          <p:cNvSpPr/>
          <p:nvPr/>
        </p:nvSpPr>
        <p:spPr>
          <a:xfrm>
            <a:off x="10714355" y="4653914"/>
            <a:ext cx="96520" cy="483870"/>
          </a:xfrm>
          <a:custGeom>
            <a:avLst/>
            <a:gdLst/>
            <a:ahLst/>
            <a:cxnLst/>
            <a:rect l="l" t="t" r="r" b="b"/>
            <a:pathLst>
              <a:path w="96520" h="483870">
                <a:moveTo>
                  <a:pt x="13462" y="77597"/>
                </a:moveTo>
                <a:lnTo>
                  <a:pt x="13335" y="66167"/>
                </a:lnTo>
                <a:lnTo>
                  <a:pt x="381" y="66167"/>
                </a:lnTo>
                <a:lnTo>
                  <a:pt x="508" y="77724"/>
                </a:lnTo>
                <a:lnTo>
                  <a:pt x="13462" y="77597"/>
                </a:lnTo>
                <a:close/>
              </a:path>
              <a:path w="96520" h="483870">
                <a:moveTo>
                  <a:pt x="55372" y="204089"/>
                </a:moveTo>
                <a:lnTo>
                  <a:pt x="55118" y="181483"/>
                </a:lnTo>
                <a:lnTo>
                  <a:pt x="41148" y="181610"/>
                </a:lnTo>
                <a:lnTo>
                  <a:pt x="41275" y="204216"/>
                </a:lnTo>
                <a:lnTo>
                  <a:pt x="55372" y="204089"/>
                </a:lnTo>
                <a:close/>
              </a:path>
              <a:path w="96520" h="483870">
                <a:moveTo>
                  <a:pt x="73533" y="60198"/>
                </a:moveTo>
                <a:lnTo>
                  <a:pt x="73406" y="47371"/>
                </a:lnTo>
                <a:lnTo>
                  <a:pt x="56769" y="42545"/>
                </a:lnTo>
                <a:lnTo>
                  <a:pt x="56730" y="38989"/>
                </a:lnTo>
                <a:lnTo>
                  <a:pt x="56553" y="22606"/>
                </a:lnTo>
                <a:lnTo>
                  <a:pt x="56515" y="18542"/>
                </a:lnTo>
                <a:lnTo>
                  <a:pt x="73025" y="13208"/>
                </a:lnTo>
                <a:lnTo>
                  <a:pt x="72898" y="0"/>
                </a:lnTo>
                <a:lnTo>
                  <a:pt x="44323" y="9715"/>
                </a:lnTo>
                <a:lnTo>
                  <a:pt x="44323" y="38989"/>
                </a:lnTo>
                <a:lnTo>
                  <a:pt x="17145" y="31115"/>
                </a:lnTo>
                <a:lnTo>
                  <a:pt x="44196" y="22606"/>
                </a:lnTo>
                <a:lnTo>
                  <a:pt x="44323" y="38989"/>
                </a:lnTo>
                <a:lnTo>
                  <a:pt x="44323" y="9715"/>
                </a:lnTo>
                <a:lnTo>
                  <a:pt x="0" y="24765"/>
                </a:lnTo>
                <a:lnTo>
                  <a:pt x="127" y="37592"/>
                </a:lnTo>
                <a:lnTo>
                  <a:pt x="73533" y="60198"/>
                </a:lnTo>
                <a:close/>
              </a:path>
              <a:path w="96520" h="483870">
                <a:moveTo>
                  <a:pt x="73660" y="77089"/>
                </a:moveTo>
                <a:lnTo>
                  <a:pt x="73533" y="65532"/>
                </a:lnTo>
                <a:lnTo>
                  <a:pt x="20574" y="66040"/>
                </a:lnTo>
                <a:lnTo>
                  <a:pt x="20701" y="77597"/>
                </a:lnTo>
                <a:lnTo>
                  <a:pt x="73660" y="77089"/>
                </a:lnTo>
                <a:close/>
              </a:path>
              <a:path w="96520" h="483870">
                <a:moveTo>
                  <a:pt x="74041" y="115824"/>
                </a:moveTo>
                <a:lnTo>
                  <a:pt x="31623" y="112141"/>
                </a:lnTo>
                <a:lnTo>
                  <a:pt x="30353" y="104140"/>
                </a:lnTo>
                <a:lnTo>
                  <a:pt x="31496" y="102235"/>
                </a:lnTo>
                <a:lnTo>
                  <a:pt x="33655" y="100965"/>
                </a:lnTo>
                <a:lnTo>
                  <a:pt x="35306" y="100203"/>
                </a:lnTo>
                <a:lnTo>
                  <a:pt x="39370" y="99695"/>
                </a:lnTo>
                <a:lnTo>
                  <a:pt x="45847" y="99695"/>
                </a:lnTo>
                <a:lnTo>
                  <a:pt x="73787" y="99441"/>
                </a:lnTo>
                <a:lnTo>
                  <a:pt x="73787" y="87884"/>
                </a:lnTo>
                <a:lnTo>
                  <a:pt x="42672" y="88138"/>
                </a:lnTo>
                <a:lnTo>
                  <a:pt x="36703" y="88265"/>
                </a:lnTo>
                <a:lnTo>
                  <a:pt x="32512" y="88646"/>
                </a:lnTo>
                <a:lnTo>
                  <a:pt x="30099" y="89408"/>
                </a:lnTo>
                <a:lnTo>
                  <a:pt x="26670" y="90424"/>
                </a:lnTo>
                <a:lnTo>
                  <a:pt x="24130" y="92075"/>
                </a:lnTo>
                <a:lnTo>
                  <a:pt x="22352" y="94488"/>
                </a:lnTo>
                <a:lnTo>
                  <a:pt x="20574" y="96774"/>
                </a:lnTo>
                <a:lnTo>
                  <a:pt x="19761" y="99441"/>
                </a:lnTo>
                <a:lnTo>
                  <a:pt x="19685" y="105664"/>
                </a:lnTo>
                <a:lnTo>
                  <a:pt x="20320" y="108077"/>
                </a:lnTo>
                <a:lnTo>
                  <a:pt x="21717" y="110363"/>
                </a:lnTo>
                <a:lnTo>
                  <a:pt x="22987" y="112522"/>
                </a:lnTo>
                <a:lnTo>
                  <a:pt x="25019" y="114554"/>
                </a:lnTo>
                <a:lnTo>
                  <a:pt x="27686" y="116332"/>
                </a:lnTo>
                <a:lnTo>
                  <a:pt x="889" y="116586"/>
                </a:lnTo>
                <a:lnTo>
                  <a:pt x="1016" y="128143"/>
                </a:lnTo>
                <a:lnTo>
                  <a:pt x="74041" y="127381"/>
                </a:lnTo>
                <a:lnTo>
                  <a:pt x="74041" y="116205"/>
                </a:lnTo>
                <a:lnTo>
                  <a:pt x="74041" y="115824"/>
                </a:lnTo>
                <a:close/>
              </a:path>
              <a:path w="96520" h="483870">
                <a:moveTo>
                  <a:pt x="75438" y="270637"/>
                </a:moveTo>
                <a:lnTo>
                  <a:pt x="75311" y="259080"/>
                </a:lnTo>
                <a:lnTo>
                  <a:pt x="61341" y="259207"/>
                </a:lnTo>
                <a:lnTo>
                  <a:pt x="61468" y="270764"/>
                </a:lnTo>
                <a:lnTo>
                  <a:pt x="75438" y="270637"/>
                </a:lnTo>
                <a:close/>
              </a:path>
              <a:path w="96520" h="483870">
                <a:moveTo>
                  <a:pt x="75692" y="161798"/>
                </a:moveTo>
                <a:lnTo>
                  <a:pt x="56261" y="134747"/>
                </a:lnTo>
                <a:lnTo>
                  <a:pt x="53975" y="146177"/>
                </a:lnTo>
                <a:lnTo>
                  <a:pt x="57785" y="146685"/>
                </a:lnTo>
                <a:lnTo>
                  <a:pt x="60452" y="147701"/>
                </a:lnTo>
                <a:lnTo>
                  <a:pt x="61976" y="149098"/>
                </a:lnTo>
                <a:lnTo>
                  <a:pt x="63373" y="150495"/>
                </a:lnTo>
                <a:lnTo>
                  <a:pt x="64135" y="152273"/>
                </a:lnTo>
                <a:lnTo>
                  <a:pt x="64262" y="157226"/>
                </a:lnTo>
                <a:lnTo>
                  <a:pt x="62992" y="159639"/>
                </a:lnTo>
                <a:lnTo>
                  <a:pt x="60325" y="161417"/>
                </a:lnTo>
                <a:lnTo>
                  <a:pt x="57785" y="163068"/>
                </a:lnTo>
                <a:lnTo>
                  <a:pt x="53340" y="164084"/>
                </a:lnTo>
                <a:lnTo>
                  <a:pt x="46990" y="164084"/>
                </a:lnTo>
                <a:lnTo>
                  <a:pt x="41275" y="164211"/>
                </a:lnTo>
                <a:lnTo>
                  <a:pt x="37211" y="163322"/>
                </a:lnTo>
                <a:lnTo>
                  <a:pt x="34798" y="161544"/>
                </a:lnTo>
                <a:lnTo>
                  <a:pt x="32385" y="159893"/>
                </a:lnTo>
                <a:lnTo>
                  <a:pt x="31242" y="157607"/>
                </a:lnTo>
                <a:lnTo>
                  <a:pt x="31115" y="150368"/>
                </a:lnTo>
                <a:lnTo>
                  <a:pt x="33909" y="147701"/>
                </a:lnTo>
                <a:lnTo>
                  <a:pt x="39370" y="146812"/>
                </a:lnTo>
                <a:lnTo>
                  <a:pt x="36830" y="135509"/>
                </a:lnTo>
                <a:lnTo>
                  <a:pt x="30988" y="137033"/>
                </a:lnTo>
                <a:lnTo>
                  <a:pt x="26797" y="139319"/>
                </a:lnTo>
                <a:lnTo>
                  <a:pt x="24130" y="142621"/>
                </a:lnTo>
                <a:lnTo>
                  <a:pt x="21463" y="145796"/>
                </a:lnTo>
                <a:lnTo>
                  <a:pt x="20066" y="149987"/>
                </a:lnTo>
                <a:lnTo>
                  <a:pt x="20180" y="154813"/>
                </a:lnTo>
                <a:lnTo>
                  <a:pt x="20307" y="161544"/>
                </a:lnTo>
                <a:lnTo>
                  <a:pt x="22606" y="166370"/>
                </a:lnTo>
                <a:lnTo>
                  <a:pt x="27432" y="170180"/>
                </a:lnTo>
                <a:lnTo>
                  <a:pt x="32258" y="174117"/>
                </a:lnTo>
                <a:lnTo>
                  <a:pt x="39116" y="175895"/>
                </a:lnTo>
                <a:lnTo>
                  <a:pt x="48260" y="175895"/>
                </a:lnTo>
                <a:lnTo>
                  <a:pt x="74447" y="164211"/>
                </a:lnTo>
                <a:lnTo>
                  <a:pt x="75692" y="161798"/>
                </a:lnTo>
                <a:close/>
              </a:path>
              <a:path w="96520" h="483870">
                <a:moveTo>
                  <a:pt x="76327" y="226568"/>
                </a:moveTo>
                <a:lnTo>
                  <a:pt x="74383" y="223266"/>
                </a:lnTo>
                <a:lnTo>
                  <a:pt x="73279" y="221361"/>
                </a:lnTo>
                <a:lnTo>
                  <a:pt x="67437" y="217297"/>
                </a:lnTo>
                <a:lnTo>
                  <a:pt x="62255" y="214655"/>
                </a:lnTo>
                <a:lnTo>
                  <a:pt x="55702" y="212813"/>
                </a:lnTo>
                <a:lnTo>
                  <a:pt x="47726" y="211747"/>
                </a:lnTo>
                <a:lnTo>
                  <a:pt x="40132" y="211518"/>
                </a:lnTo>
                <a:lnTo>
                  <a:pt x="40132" y="234442"/>
                </a:lnTo>
                <a:lnTo>
                  <a:pt x="39116" y="236347"/>
                </a:lnTo>
                <a:lnTo>
                  <a:pt x="36957" y="237871"/>
                </a:lnTo>
                <a:lnTo>
                  <a:pt x="34671" y="239522"/>
                </a:lnTo>
                <a:lnTo>
                  <a:pt x="31242" y="240284"/>
                </a:lnTo>
                <a:lnTo>
                  <a:pt x="26543" y="240284"/>
                </a:lnTo>
                <a:lnTo>
                  <a:pt x="21844" y="240411"/>
                </a:lnTo>
                <a:lnTo>
                  <a:pt x="18542" y="239649"/>
                </a:lnTo>
                <a:lnTo>
                  <a:pt x="14478" y="236855"/>
                </a:lnTo>
                <a:lnTo>
                  <a:pt x="13335" y="235077"/>
                </a:lnTo>
                <a:lnTo>
                  <a:pt x="13335" y="230759"/>
                </a:lnTo>
                <a:lnTo>
                  <a:pt x="14605" y="228854"/>
                </a:lnTo>
                <a:lnTo>
                  <a:pt x="19431" y="225298"/>
                </a:lnTo>
                <a:lnTo>
                  <a:pt x="22987" y="224409"/>
                </a:lnTo>
                <a:lnTo>
                  <a:pt x="31750" y="224409"/>
                </a:lnTo>
                <a:lnTo>
                  <a:pt x="40132" y="234442"/>
                </a:lnTo>
                <a:lnTo>
                  <a:pt x="40132" y="211518"/>
                </a:lnTo>
                <a:lnTo>
                  <a:pt x="1854" y="226187"/>
                </a:lnTo>
                <a:lnTo>
                  <a:pt x="1778" y="237998"/>
                </a:lnTo>
                <a:lnTo>
                  <a:pt x="4064" y="242570"/>
                </a:lnTo>
                <a:lnTo>
                  <a:pt x="8509" y="246253"/>
                </a:lnTo>
                <a:lnTo>
                  <a:pt x="12954" y="249809"/>
                </a:lnTo>
                <a:lnTo>
                  <a:pt x="19050" y="251714"/>
                </a:lnTo>
                <a:lnTo>
                  <a:pt x="33909" y="251460"/>
                </a:lnTo>
                <a:lnTo>
                  <a:pt x="39751" y="249682"/>
                </a:lnTo>
                <a:lnTo>
                  <a:pt x="48387" y="242570"/>
                </a:lnTo>
                <a:lnTo>
                  <a:pt x="49466" y="240411"/>
                </a:lnTo>
                <a:lnTo>
                  <a:pt x="50419" y="238506"/>
                </a:lnTo>
                <a:lnTo>
                  <a:pt x="50419" y="231775"/>
                </a:lnTo>
                <a:lnTo>
                  <a:pt x="49911" y="229870"/>
                </a:lnTo>
                <a:lnTo>
                  <a:pt x="48768" y="228092"/>
                </a:lnTo>
                <a:lnTo>
                  <a:pt x="47752" y="226314"/>
                </a:lnTo>
                <a:lnTo>
                  <a:pt x="46228" y="224663"/>
                </a:lnTo>
                <a:lnTo>
                  <a:pt x="45847" y="224409"/>
                </a:lnTo>
                <a:lnTo>
                  <a:pt x="44196" y="223266"/>
                </a:lnTo>
                <a:lnTo>
                  <a:pt x="64770" y="229870"/>
                </a:lnTo>
                <a:lnTo>
                  <a:pt x="64770" y="236220"/>
                </a:lnTo>
                <a:lnTo>
                  <a:pt x="62103" y="238506"/>
                </a:lnTo>
                <a:lnTo>
                  <a:pt x="56642" y="239014"/>
                </a:lnTo>
                <a:lnTo>
                  <a:pt x="58293" y="250190"/>
                </a:lnTo>
                <a:lnTo>
                  <a:pt x="64516" y="249301"/>
                </a:lnTo>
                <a:lnTo>
                  <a:pt x="69088" y="247269"/>
                </a:lnTo>
                <a:lnTo>
                  <a:pt x="74930" y="241427"/>
                </a:lnTo>
                <a:lnTo>
                  <a:pt x="76225" y="237871"/>
                </a:lnTo>
                <a:lnTo>
                  <a:pt x="76327" y="226568"/>
                </a:lnTo>
                <a:close/>
              </a:path>
              <a:path w="96520" h="483870">
                <a:moveTo>
                  <a:pt x="76962" y="294005"/>
                </a:moveTo>
                <a:lnTo>
                  <a:pt x="75819" y="291719"/>
                </a:lnTo>
                <a:lnTo>
                  <a:pt x="74676" y="289433"/>
                </a:lnTo>
                <a:lnTo>
                  <a:pt x="70231" y="285877"/>
                </a:lnTo>
                <a:lnTo>
                  <a:pt x="65786" y="282194"/>
                </a:lnTo>
                <a:lnTo>
                  <a:pt x="65405" y="282092"/>
                </a:lnTo>
                <a:lnTo>
                  <a:pt x="65405" y="301244"/>
                </a:lnTo>
                <a:lnTo>
                  <a:pt x="64135" y="303276"/>
                </a:lnTo>
                <a:lnTo>
                  <a:pt x="61722" y="304927"/>
                </a:lnTo>
                <a:lnTo>
                  <a:pt x="59309" y="306705"/>
                </a:lnTo>
                <a:lnTo>
                  <a:pt x="55753" y="307594"/>
                </a:lnTo>
                <a:lnTo>
                  <a:pt x="51181" y="307594"/>
                </a:lnTo>
                <a:lnTo>
                  <a:pt x="46990" y="307721"/>
                </a:lnTo>
                <a:lnTo>
                  <a:pt x="43942" y="306959"/>
                </a:lnTo>
                <a:lnTo>
                  <a:pt x="41783" y="305435"/>
                </a:lnTo>
                <a:lnTo>
                  <a:pt x="39751" y="303911"/>
                </a:lnTo>
                <a:lnTo>
                  <a:pt x="38684" y="302133"/>
                </a:lnTo>
                <a:lnTo>
                  <a:pt x="38608" y="297561"/>
                </a:lnTo>
                <a:lnTo>
                  <a:pt x="39624" y="295656"/>
                </a:lnTo>
                <a:lnTo>
                  <a:pt x="41910" y="294132"/>
                </a:lnTo>
                <a:lnTo>
                  <a:pt x="44069" y="292608"/>
                </a:lnTo>
                <a:lnTo>
                  <a:pt x="47498" y="291719"/>
                </a:lnTo>
                <a:lnTo>
                  <a:pt x="56896" y="291719"/>
                </a:lnTo>
                <a:lnTo>
                  <a:pt x="60198" y="292354"/>
                </a:lnTo>
                <a:lnTo>
                  <a:pt x="64262" y="295148"/>
                </a:lnTo>
                <a:lnTo>
                  <a:pt x="65278" y="296926"/>
                </a:lnTo>
                <a:lnTo>
                  <a:pt x="65405" y="301244"/>
                </a:lnTo>
                <a:lnTo>
                  <a:pt x="65405" y="282092"/>
                </a:lnTo>
                <a:lnTo>
                  <a:pt x="59817" y="280416"/>
                </a:lnTo>
                <a:lnTo>
                  <a:pt x="52070" y="280416"/>
                </a:lnTo>
                <a:lnTo>
                  <a:pt x="28194" y="293497"/>
                </a:lnTo>
                <a:lnTo>
                  <a:pt x="28321" y="300355"/>
                </a:lnTo>
                <a:lnTo>
                  <a:pt x="34544" y="308864"/>
                </a:lnTo>
                <a:lnTo>
                  <a:pt x="26289" y="308483"/>
                </a:lnTo>
                <a:lnTo>
                  <a:pt x="13843" y="295783"/>
                </a:lnTo>
                <a:lnTo>
                  <a:pt x="16510" y="293624"/>
                </a:lnTo>
                <a:lnTo>
                  <a:pt x="21971" y="292989"/>
                </a:lnTo>
                <a:lnTo>
                  <a:pt x="20320" y="281940"/>
                </a:lnTo>
                <a:lnTo>
                  <a:pt x="2413" y="305562"/>
                </a:lnTo>
                <a:lnTo>
                  <a:pt x="5461" y="310769"/>
                </a:lnTo>
                <a:lnTo>
                  <a:pt x="40259" y="320675"/>
                </a:lnTo>
                <a:lnTo>
                  <a:pt x="49441" y="320230"/>
                </a:lnTo>
                <a:lnTo>
                  <a:pt x="75069" y="308864"/>
                </a:lnTo>
                <a:lnTo>
                  <a:pt x="75704" y="307721"/>
                </a:lnTo>
                <a:lnTo>
                  <a:pt x="76885" y="305562"/>
                </a:lnTo>
                <a:lnTo>
                  <a:pt x="76962" y="294005"/>
                </a:lnTo>
                <a:close/>
              </a:path>
              <a:path w="96520" h="483870">
                <a:moveTo>
                  <a:pt x="77470" y="483870"/>
                </a:moveTo>
                <a:lnTo>
                  <a:pt x="77343" y="471043"/>
                </a:lnTo>
                <a:lnTo>
                  <a:pt x="60706" y="466217"/>
                </a:lnTo>
                <a:lnTo>
                  <a:pt x="60667" y="462661"/>
                </a:lnTo>
                <a:lnTo>
                  <a:pt x="60490" y="446278"/>
                </a:lnTo>
                <a:lnTo>
                  <a:pt x="60452" y="442214"/>
                </a:lnTo>
                <a:lnTo>
                  <a:pt x="76962" y="436880"/>
                </a:lnTo>
                <a:lnTo>
                  <a:pt x="76835" y="423672"/>
                </a:lnTo>
                <a:lnTo>
                  <a:pt x="48387" y="433362"/>
                </a:lnTo>
                <a:lnTo>
                  <a:pt x="48387" y="462661"/>
                </a:lnTo>
                <a:lnTo>
                  <a:pt x="21082" y="454787"/>
                </a:lnTo>
                <a:lnTo>
                  <a:pt x="48133" y="446278"/>
                </a:lnTo>
                <a:lnTo>
                  <a:pt x="48387" y="462661"/>
                </a:lnTo>
                <a:lnTo>
                  <a:pt x="48387" y="433362"/>
                </a:lnTo>
                <a:lnTo>
                  <a:pt x="4064" y="448437"/>
                </a:lnTo>
                <a:lnTo>
                  <a:pt x="4191" y="461264"/>
                </a:lnTo>
                <a:lnTo>
                  <a:pt x="77470" y="483870"/>
                </a:lnTo>
                <a:close/>
              </a:path>
              <a:path w="96520" h="483870">
                <a:moveTo>
                  <a:pt x="77978" y="405638"/>
                </a:moveTo>
                <a:lnTo>
                  <a:pt x="58547" y="378587"/>
                </a:lnTo>
                <a:lnTo>
                  <a:pt x="56388" y="390017"/>
                </a:lnTo>
                <a:lnTo>
                  <a:pt x="60071" y="390525"/>
                </a:lnTo>
                <a:lnTo>
                  <a:pt x="62738" y="391541"/>
                </a:lnTo>
                <a:lnTo>
                  <a:pt x="64262" y="392938"/>
                </a:lnTo>
                <a:lnTo>
                  <a:pt x="65659" y="394335"/>
                </a:lnTo>
                <a:lnTo>
                  <a:pt x="66421" y="396113"/>
                </a:lnTo>
                <a:lnTo>
                  <a:pt x="66548" y="401066"/>
                </a:lnTo>
                <a:lnTo>
                  <a:pt x="65278" y="403479"/>
                </a:lnTo>
                <a:lnTo>
                  <a:pt x="62611" y="405257"/>
                </a:lnTo>
                <a:lnTo>
                  <a:pt x="60071" y="406908"/>
                </a:lnTo>
                <a:lnTo>
                  <a:pt x="55626" y="407924"/>
                </a:lnTo>
                <a:lnTo>
                  <a:pt x="43561" y="407924"/>
                </a:lnTo>
                <a:lnTo>
                  <a:pt x="39497" y="407162"/>
                </a:lnTo>
                <a:lnTo>
                  <a:pt x="37084" y="405384"/>
                </a:lnTo>
                <a:lnTo>
                  <a:pt x="34671" y="403733"/>
                </a:lnTo>
                <a:lnTo>
                  <a:pt x="33528" y="401447"/>
                </a:lnTo>
                <a:lnTo>
                  <a:pt x="33401" y="394208"/>
                </a:lnTo>
                <a:lnTo>
                  <a:pt x="36195" y="391541"/>
                </a:lnTo>
                <a:lnTo>
                  <a:pt x="41783" y="390652"/>
                </a:lnTo>
                <a:lnTo>
                  <a:pt x="39116" y="379349"/>
                </a:lnTo>
                <a:lnTo>
                  <a:pt x="22352" y="393827"/>
                </a:lnTo>
                <a:lnTo>
                  <a:pt x="22466" y="398653"/>
                </a:lnTo>
                <a:lnTo>
                  <a:pt x="22593" y="405384"/>
                </a:lnTo>
                <a:lnTo>
                  <a:pt x="24892" y="410210"/>
                </a:lnTo>
                <a:lnTo>
                  <a:pt x="29718" y="414020"/>
                </a:lnTo>
                <a:lnTo>
                  <a:pt x="34544" y="417957"/>
                </a:lnTo>
                <a:lnTo>
                  <a:pt x="41402" y="419735"/>
                </a:lnTo>
                <a:lnTo>
                  <a:pt x="50546" y="419735"/>
                </a:lnTo>
                <a:lnTo>
                  <a:pt x="76796" y="407924"/>
                </a:lnTo>
                <a:lnTo>
                  <a:pt x="77978" y="405638"/>
                </a:lnTo>
                <a:close/>
              </a:path>
              <a:path w="96520" h="483870">
                <a:moveTo>
                  <a:pt x="96520" y="369824"/>
                </a:moveTo>
                <a:lnTo>
                  <a:pt x="96393" y="358902"/>
                </a:lnTo>
                <a:lnTo>
                  <a:pt x="96393" y="358521"/>
                </a:lnTo>
                <a:lnTo>
                  <a:pt x="96393" y="358267"/>
                </a:lnTo>
                <a:lnTo>
                  <a:pt x="69850" y="358521"/>
                </a:lnTo>
                <a:lnTo>
                  <a:pt x="72644" y="356362"/>
                </a:lnTo>
                <a:lnTo>
                  <a:pt x="74676" y="354203"/>
                </a:lnTo>
                <a:lnTo>
                  <a:pt x="76149" y="351536"/>
                </a:lnTo>
                <a:lnTo>
                  <a:pt x="76835" y="350266"/>
                </a:lnTo>
                <a:lnTo>
                  <a:pt x="77470" y="348107"/>
                </a:lnTo>
                <a:lnTo>
                  <a:pt x="77343" y="340868"/>
                </a:lnTo>
                <a:lnTo>
                  <a:pt x="76631" y="339598"/>
                </a:lnTo>
                <a:lnTo>
                  <a:pt x="74930" y="336550"/>
                </a:lnTo>
                <a:lnTo>
                  <a:pt x="69977" y="333121"/>
                </a:lnTo>
                <a:lnTo>
                  <a:pt x="66294" y="330415"/>
                </a:lnTo>
                <a:lnTo>
                  <a:pt x="66294" y="346202"/>
                </a:lnTo>
                <a:lnTo>
                  <a:pt x="66217" y="351663"/>
                </a:lnTo>
                <a:lnTo>
                  <a:pt x="64897" y="353949"/>
                </a:lnTo>
                <a:lnTo>
                  <a:pt x="62103" y="355854"/>
                </a:lnTo>
                <a:lnTo>
                  <a:pt x="59309" y="357886"/>
                </a:lnTo>
                <a:lnTo>
                  <a:pt x="54864" y="358902"/>
                </a:lnTo>
                <a:lnTo>
                  <a:pt x="43688" y="358902"/>
                </a:lnTo>
                <a:lnTo>
                  <a:pt x="33020" y="346583"/>
                </a:lnTo>
                <a:lnTo>
                  <a:pt x="34290" y="344424"/>
                </a:lnTo>
                <a:lnTo>
                  <a:pt x="39624" y="340614"/>
                </a:lnTo>
                <a:lnTo>
                  <a:pt x="43815" y="339725"/>
                </a:lnTo>
                <a:lnTo>
                  <a:pt x="49530" y="339598"/>
                </a:lnTo>
                <a:lnTo>
                  <a:pt x="55372" y="339598"/>
                </a:lnTo>
                <a:lnTo>
                  <a:pt x="59690" y="340487"/>
                </a:lnTo>
                <a:lnTo>
                  <a:pt x="62357" y="342265"/>
                </a:lnTo>
                <a:lnTo>
                  <a:pt x="64897" y="343916"/>
                </a:lnTo>
                <a:lnTo>
                  <a:pt x="66294" y="346202"/>
                </a:lnTo>
                <a:lnTo>
                  <a:pt x="66294" y="330415"/>
                </a:lnTo>
                <a:lnTo>
                  <a:pt x="65151" y="329565"/>
                </a:lnTo>
                <a:lnTo>
                  <a:pt x="58166" y="327787"/>
                </a:lnTo>
                <a:lnTo>
                  <a:pt x="49022" y="327914"/>
                </a:lnTo>
                <a:lnTo>
                  <a:pt x="40259" y="327914"/>
                </a:lnTo>
                <a:lnTo>
                  <a:pt x="33655" y="329819"/>
                </a:lnTo>
                <a:lnTo>
                  <a:pt x="28956" y="333375"/>
                </a:lnTo>
                <a:lnTo>
                  <a:pt x="24257" y="337058"/>
                </a:lnTo>
                <a:lnTo>
                  <a:pt x="21971" y="341376"/>
                </a:lnTo>
                <a:lnTo>
                  <a:pt x="22009" y="349250"/>
                </a:lnTo>
                <a:lnTo>
                  <a:pt x="22860" y="351663"/>
                </a:lnTo>
                <a:lnTo>
                  <a:pt x="24676" y="354330"/>
                </a:lnTo>
                <a:lnTo>
                  <a:pt x="26035" y="356362"/>
                </a:lnTo>
                <a:lnTo>
                  <a:pt x="28321" y="358267"/>
                </a:lnTo>
                <a:lnTo>
                  <a:pt x="31115" y="359791"/>
                </a:lnTo>
                <a:lnTo>
                  <a:pt x="23368" y="359791"/>
                </a:lnTo>
                <a:lnTo>
                  <a:pt x="23495" y="370459"/>
                </a:lnTo>
                <a:lnTo>
                  <a:pt x="96520" y="36982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3" name="object 43"/>
          <p:cNvSpPr txBox="1"/>
          <p:nvPr/>
        </p:nvSpPr>
        <p:spPr>
          <a:xfrm>
            <a:off x="10961854" y="4642680"/>
            <a:ext cx="264795" cy="50990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spc="-10" dirty="0">
                <a:latin typeface="Arial Narrow"/>
                <a:cs typeface="Arial Narrow"/>
              </a:rPr>
              <a:t>Acp6.9-</a:t>
            </a:r>
            <a:r>
              <a:rPr sz="800" b="1" spc="-20" dirty="0">
                <a:latin typeface="Arial Narrow"/>
                <a:cs typeface="Arial Narrow"/>
              </a:rPr>
              <a:t>chiA</a:t>
            </a:r>
            <a:endParaRPr sz="800">
              <a:latin typeface="Arial Narrow"/>
              <a:cs typeface="Arial Narrow"/>
            </a:endParaRPr>
          </a:p>
          <a:p>
            <a:pPr marL="12700">
              <a:lnSpc>
                <a:spcPct val="100000"/>
              </a:lnSpc>
            </a:pPr>
            <a:r>
              <a:rPr sz="800" b="1" dirty="0">
                <a:latin typeface="Arial Narrow"/>
                <a:cs typeface="Arial Narrow"/>
              </a:rPr>
              <a:t>/</a:t>
            </a:r>
            <a:r>
              <a:rPr sz="800" b="1" spc="50" dirty="0">
                <a:latin typeface="Arial Narrow"/>
                <a:cs typeface="Arial Narrow"/>
              </a:rPr>
              <a:t> </a:t>
            </a:r>
            <a:r>
              <a:rPr sz="800" b="1" spc="-10" dirty="0">
                <a:latin typeface="Arial Narrow"/>
                <a:cs typeface="Arial Narrow"/>
              </a:rPr>
              <a:t>polh-</a:t>
            </a:r>
            <a:r>
              <a:rPr sz="800" b="1" spc="-20" dirty="0">
                <a:latin typeface="Arial Narrow"/>
                <a:cs typeface="Arial Narrow"/>
              </a:rPr>
              <a:t>cath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44" name="object 44"/>
          <p:cNvSpPr txBox="1"/>
          <p:nvPr/>
        </p:nvSpPr>
        <p:spPr>
          <a:xfrm>
            <a:off x="5046576" y="2415520"/>
            <a:ext cx="142875" cy="56324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dirty="0">
                <a:latin typeface="Arial Narrow"/>
                <a:cs typeface="Arial Narrow"/>
              </a:rPr>
              <a:t>AcMNPV-</a:t>
            </a:r>
            <a:r>
              <a:rPr sz="800" b="1" spc="-25" dirty="0">
                <a:latin typeface="Arial Narrow"/>
                <a:cs typeface="Arial Narrow"/>
              </a:rPr>
              <a:t>Rep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45" name="object 45"/>
          <p:cNvSpPr txBox="1"/>
          <p:nvPr/>
        </p:nvSpPr>
        <p:spPr>
          <a:xfrm>
            <a:off x="8932395" y="2425171"/>
            <a:ext cx="142875" cy="56324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dirty="0">
                <a:latin typeface="Arial Narrow"/>
                <a:cs typeface="Arial Narrow"/>
              </a:rPr>
              <a:t>AcMNPV-</a:t>
            </a:r>
            <a:r>
              <a:rPr sz="800" b="1" spc="-25" dirty="0">
                <a:latin typeface="Arial Narrow"/>
                <a:cs typeface="Arial Narrow"/>
              </a:rPr>
              <a:t>Rep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46" name="object 46"/>
          <p:cNvSpPr txBox="1"/>
          <p:nvPr/>
        </p:nvSpPr>
        <p:spPr>
          <a:xfrm>
            <a:off x="8908646" y="4616429"/>
            <a:ext cx="142875" cy="56324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dirty="0">
                <a:latin typeface="Arial Narrow"/>
                <a:cs typeface="Arial Narrow"/>
              </a:rPr>
              <a:t>AcMNPV-</a:t>
            </a:r>
            <a:r>
              <a:rPr sz="800" b="1" spc="-25" dirty="0">
                <a:latin typeface="Arial Narrow"/>
                <a:cs typeface="Arial Narrow"/>
              </a:rPr>
              <a:t>Rep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47" name="object 47"/>
          <p:cNvSpPr txBox="1"/>
          <p:nvPr/>
        </p:nvSpPr>
        <p:spPr>
          <a:xfrm>
            <a:off x="10378416" y="4592680"/>
            <a:ext cx="142875" cy="56324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dirty="0">
                <a:latin typeface="Arial Narrow"/>
                <a:cs typeface="Arial Narrow"/>
              </a:rPr>
              <a:t>AcMNPV-</a:t>
            </a:r>
            <a:r>
              <a:rPr sz="800" b="1" spc="-25" dirty="0">
                <a:latin typeface="Arial Narrow"/>
                <a:cs typeface="Arial Narrow"/>
              </a:rPr>
              <a:t>Rep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48" name="object 48"/>
          <p:cNvSpPr txBox="1"/>
          <p:nvPr/>
        </p:nvSpPr>
        <p:spPr>
          <a:xfrm>
            <a:off x="5144111" y="4685010"/>
            <a:ext cx="142875" cy="56324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dirty="0">
                <a:latin typeface="Arial Narrow"/>
                <a:cs typeface="Arial Narrow"/>
              </a:rPr>
              <a:t>AcMNPV-</a:t>
            </a:r>
            <a:r>
              <a:rPr sz="800" b="1" spc="-25" dirty="0">
                <a:latin typeface="Arial Narrow"/>
                <a:cs typeface="Arial Narrow"/>
              </a:rPr>
              <a:t>Rep</a:t>
            </a:r>
            <a:endParaRPr sz="800">
              <a:latin typeface="Arial Narrow"/>
              <a:cs typeface="Arial Narrow"/>
            </a:endParaRPr>
          </a:p>
        </p:txBody>
      </p:sp>
      <p:sp>
        <p:nvSpPr>
          <p:cNvPr id="49" name="object 49"/>
          <p:cNvSpPr txBox="1"/>
          <p:nvPr/>
        </p:nvSpPr>
        <p:spPr>
          <a:xfrm>
            <a:off x="1426695" y="4592680"/>
            <a:ext cx="142875" cy="563245"/>
          </a:xfrm>
          <a:prstGeom prst="rect">
            <a:avLst/>
          </a:prstGeom>
        </p:spPr>
        <p:txBody>
          <a:bodyPr vert="vert270" wrap="square" lIns="0" tIns="635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z="800" b="1" dirty="0">
                <a:latin typeface="Arial Narrow"/>
                <a:cs typeface="Arial Narrow"/>
              </a:rPr>
              <a:t>AcMNPV-</a:t>
            </a:r>
            <a:r>
              <a:rPr sz="800" b="1" spc="-25" dirty="0">
                <a:latin typeface="Arial Narrow"/>
                <a:cs typeface="Arial Narrow"/>
              </a:rPr>
              <a:t>Rep</a:t>
            </a:r>
            <a:endParaRPr sz="800">
              <a:latin typeface="Arial Narrow"/>
              <a:cs typeface="Arial Narrow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8B62D35-1F06-4A4D-89EE-43D07CCE944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2592" y="3330575"/>
            <a:ext cx="5766816" cy="18470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23685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Words>482</Words>
  <Application>Microsoft Office PowerPoint</Application>
  <PresentationFormat>Custom</PresentationFormat>
  <Paragraphs>10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Arial Narrow</vt:lpstr>
      <vt:lpstr>Calibri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ff Hodgson</dc:creator>
  <cp:lastModifiedBy>Jeffrey James Hodgson</cp:lastModifiedBy>
  <cp:revision>1</cp:revision>
  <dcterms:created xsi:type="dcterms:W3CDTF">2023-02-10T21:02:06Z</dcterms:created>
  <dcterms:modified xsi:type="dcterms:W3CDTF">2023-02-10T21:04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2-12-19T00:00:00Z</vt:filetime>
  </property>
  <property fmtid="{D5CDD505-2E9C-101B-9397-08002B2CF9AE}" pid="3" name="Creator">
    <vt:lpwstr>Microsoft® PowerPoint® 2019</vt:lpwstr>
  </property>
  <property fmtid="{D5CDD505-2E9C-101B-9397-08002B2CF9AE}" pid="4" name="LastSaved">
    <vt:filetime>2023-02-10T00:00:00Z</vt:filetime>
  </property>
  <property fmtid="{D5CDD505-2E9C-101B-9397-08002B2CF9AE}" pid="5" name="Producer">
    <vt:lpwstr>Microsoft® PowerPoint® 2019</vt:lpwstr>
  </property>
</Properties>
</file>